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9" r:id="rId2"/>
    <p:sldId id="268" r:id="rId3"/>
    <p:sldId id="256" r:id="rId4"/>
    <p:sldId id="257" r:id="rId5"/>
    <p:sldId id="258" r:id="rId6"/>
    <p:sldId id="259" r:id="rId7"/>
    <p:sldId id="260" r:id="rId8"/>
    <p:sldId id="261" r:id="rId9"/>
    <p:sldId id="262" r:id="rId10"/>
    <p:sldId id="263" r:id="rId11"/>
    <p:sldId id="274" r:id="rId12"/>
    <p:sldId id="265" r:id="rId13"/>
    <p:sldId id="266" r:id="rId14"/>
    <p:sldId id="264" r:id="rId15"/>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E2D03A3-BD66-4431-98CA-07CC4142844A}" v="21" dt="2021-06-29T15:22:37.15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154" d="100"/>
          <a:sy n="154" d="100"/>
        </p:scale>
        <p:origin x="1002" y="-40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imon Xin Min Dong" userId="6647684b-86c4-4538-a0ea-723982d85692" providerId="ADAL" clId="{B16B9F97-A12E-4551-A28C-3661979B09DE}"/>
    <pc:docChg chg="undo custSel modSld">
      <pc:chgData name="Simon Xin Min Dong" userId="6647684b-86c4-4538-a0ea-723982d85692" providerId="ADAL" clId="{B16B9F97-A12E-4551-A28C-3661979B09DE}" dt="2021-05-21T00:26:28.120" v="358" actId="20577"/>
      <pc:docMkLst>
        <pc:docMk/>
      </pc:docMkLst>
      <pc:sldChg chg="addSp delSp modSp mod">
        <pc:chgData name="Simon Xin Min Dong" userId="6647684b-86c4-4538-a0ea-723982d85692" providerId="ADAL" clId="{B16B9F97-A12E-4551-A28C-3661979B09DE}" dt="2021-05-21T00:23:19.711" v="244" actId="1076"/>
        <pc:sldMkLst>
          <pc:docMk/>
          <pc:sldMk cId="427278201" sldId="256"/>
        </pc:sldMkLst>
        <pc:spChg chg="mod">
          <ac:chgData name="Simon Xin Min Dong" userId="6647684b-86c4-4538-a0ea-723982d85692" providerId="ADAL" clId="{B16B9F97-A12E-4551-A28C-3661979B09DE}" dt="2021-05-21T00:23:19.711" v="244" actId="1076"/>
          <ac:spMkLst>
            <pc:docMk/>
            <pc:sldMk cId="427278201" sldId="256"/>
            <ac:spMk id="40" creationId="{1D589266-3798-48D8-B221-3D5C44F70777}"/>
          </ac:spMkLst>
        </pc:spChg>
        <pc:spChg chg="mod">
          <ac:chgData name="Simon Xin Min Dong" userId="6647684b-86c4-4538-a0ea-723982d85692" providerId="ADAL" clId="{B16B9F97-A12E-4551-A28C-3661979B09DE}" dt="2021-05-21T00:12:56.633" v="34" actId="14100"/>
          <ac:spMkLst>
            <pc:docMk/>
            <pc:sldMk cId="427278201" sldId="256"/>
            <ac:spMk id="41" creationId="{0578DAEC-B93C-4C0C-BEB2-3BA1F99190BC}"/>
          </ac:spMkLst>
        </pc:spChg>
        <pc:spChg chg="mod">
          <ac:chgData name="Simon Xin Min Dong" userId="6647684b-86c4-4538-a0ea-723982d85692" providerId="ADAL" clId="{B16B9F97-A12E-4551-A28C-3661979B09DE}" dt="2021-05-21T00:12:46.393" v="33" actId="14100"/>
          <ac:spMkLst>
            <pc:docMk/>
            <pc:sldMk cId="427278201" sldId="256"/>
            <ac:spMk id="42" creationId="{BC6D38F1-7409-4BA8-8A03-FB34DFB949B6}"/>
          </ac:spMkLst>
        </pc:spChg>
        <pc:picChg chg="add mod ord">
          <ac:chgData name="Simon Xin Min Dong" userId="6647684b-86c4-4538-a0ea-723982d85692" providerId="ADAL" clId="{B16B9F97-A12E-4551-A28C-3661979B09DE}" dt="2021-05-21T00:13:22.945" v="38" actId="1076"/>
          <ac:picMkLst>
            <pc:docMk/>
            <pc:sldMk cId="427278201" sldId="256"/>
            <ac:picMk id="3" creationId="{167F4265-139F-47C5-A6CA-184D0C4D0502}"/>
          </ac:picMkLst>
        </pc:picChg>
        <pc:picChg chg="del mod">
          <ac:chgData name="Simon Xin Min Dong" userId="6647684b-86c4-4538-a0ea-723982d85692" providerId="ADAL" clId="{B16B9F97-A12E-4551-A28C-3661979B09DE}" dt="2021-05-21T00:09:03.999" v="1" actId="478"/>
          <ac:picMkLst>
            <pc:docMk/>
            <pc:sldMk cId="427278201" sldId="256"/>
            <ac:picMk id="44" creationId="{515158CC-4B21-4224-B2C4-A723864A1BEC}"/>
          </ac:picMkLst>
        </pc:picChg>
      </pc:sldChg>
      <pc:sldChg chg="addSp delSp modSp mod">
        <pc:chgData name="Simon Xin Min Dong" userId="6647684b-86c4-4538-a0ea-723982d85692" providerId="ADAL" clId="{B16B9F97-A12E-4551-A28C-3661979B09DE}" dt="2021-05-21T00:23:42.063" v="273" actId="1037"/>
        <pc:sldMkLst>
          <pc:docMk/>
          <pc:sldMk cId="1524448352" sldId="257"/>
        </pc:sldMkLst>
        <pc:spChg chg="mod">
          <ac:chgData name="Simon Xin Min Dong" userId="6647684b-86c4-4538-a0ea-723982d85692" providerId="ADAL" clId="{B16B9F97-A12E-4551-A28C-3661979B09DE}" dt="2021-05-21T00:23:42.063" v="273" actId="1037"/>
          <ac:spMkLst>
            <pc:docMk/>
            <pc:sldMk cId="1524448352" sldId="257"/>
            <ac:spMk id="6" creationId="{CABC1B9C-DD10-4F45-819E-FEC0D7283BFC}"/>
          </ac:spMkLst>
        </pc:spChg>
        <pc:spChg chg="mod">
          <ac:chgData name="Simon Xin Min Dong" userId="6647684b-86c4-4538-a0ea-723982d85692" providerId="ADAL" clId="{B16B9F97-A12E-4551-A28C-3661979B09DE}" dt="2021-05-21T00:23:42.063" v="273" actId="1037"/>
          <ac:spMkLst>
            <pc:docMk/>
            <pc:sldMk cId="1524448352" sldId="257"/>
            <ac:spMk id="7" creationId="{6807DF18-A250-4879-9569-D52FE1625640}"/>
          </ac:spMkLst>
        </pc:spChg>
        <pc:spChg chg="mod">
          <ac:chgData name="Simon Xin Min Dong" userId="6647684b-86c4-4538-a0ea-723982d85692" providerId="ADAL" clId="{B16B9F97-A12E-4551-A28C-3661979B09DE}" dt="2021-05-21T00:23:42.063" v="273" actId="1037"/>
          <ac:spMkLst>
            <pc:docMk/>
            <pc:sldMk cId="1524448352" sldId="257"/>
            <ac:spMk id="8" creationId="{35527F7D-DFEF-48C9-AAFE-7F0AD97EF9EB}"/>
          </ac:spMkLst>
        </pc:spChg>
        <pc:spChg chg="mod">
          <ac:chgData name="Simon Xin Min Dong" userId="6647684b-86c4-4538-a0ea-723982d85692" providerId="ADAL" clId="{B16B9F97-A12E-4551-A28C-3661979B09DE}" dt="2021-05-21T00:23:42.063" v="273" actId="1037"/>
          <ac:spMkLst>
            <pc:docMk/>
            <pc:sldMk cId="1524448352" sldId="257"/>
            <ac:spMk id="9" creationId="{0F3C7DDE-40BC-4499-842E-3BA15400B0B8}"/>
          </ac:spMkLst>
        </pc:spChg>
        <pc:spChg chg="mod">
          <ac:chgData name="Simon Xin Min Dong" userId="6647684b-86c4-4538-a0ea-723982d85692" providerId="ADAL" clId="{B16B9F97-A12E-4551-A28C-3661979B09DE}" dt="2021-05-21T00:23:42.063" v="273" actId="1037"/>
          <ac:spMkLst>
            <pc:docMk/>
            <pc:sldMk cId="1524448352" sldId="257"/>
            <ac:spMk id="10" creationId="{17DF6728-775F-4E62-8761-2B2510B2EAAC}"/>
          </ac:spMkLst>
        </pc:spChg>
        <pc:spChg chg="mod">
          <ac:chgData name="Simon Xin Min Dong" userId="6647684b-86c4-4538-a0ea-723982d85692" providerId="ADAL" clId="{B16B9F97-A12E-4551-A28C-3661979B09DE}" dt="2021-05-21T00:23:42.063" v="273" actId="1037"/>
          <ac:spMkLst>
            <pc:docMk/>
            <pc:sldMk cId="1524448352" sldId="257"/>
            <ac:spMk id="12" creationId="{C9DB8B25-1E62-45C1-B916-C005359545CC}"/>
          </ac:spMkLst>
        </pc:spChg>
        <pc:spChg chg="mod">
          <ac:chgData name="Simon Xin Min Dong" userId="6647684b-86c4-4538-a0ea-723982d85692" providerId="ADAL" clId="{B16B9F97-A12E-4551-A28C-3661979B09DE}" dt="2021-05-21T00:23:42.063" v="273" actId="1037"/>
          <ac:spMkLst>
            <pc:docMk/>
            <pc:sldMk cId="1524448352" sldId="257"/>
            <ac:spMk id="13" creationId="{0517B030-B3E9-4210-B6ED-CA64BD5B1C72}"/>
          </ac:spMkLst>
        </pc:spChg>
        <pc:spChg chg="mod">
          <ac:chgData name="Simon Xin Min Dong" userId="6647684b-86c4-4538-a0ea-723982d85692" providerId="ADAL" clId="{B16B9F97-A12E-4551-A28C-3661979B09DE}" dt="2021-05-21T00:23:42.063" v="273" actId="1037"/>
          <ac:spMkLst>
            <pc:docMk/>
            <pc:sldMk cId="1524448352" sldId="257"/>
            <ac:spMk id="17" creationId="{32A11330-A07D-47CD-8D93-46E5D25C6E89}"/>
          </ac:spMkLst>
        </pc:spChg>
        <pc:spChg chg="mod">
          <ac:chgData name="Simon Xin Min Dong" userId="6647684b-86c4-4538-a0ea-723982d85692" providerId="ADAL" clId="{B16B9F97-A12E-4551-A28C-3661979B09DE}" dt="2021-05-21T00:23:42.063" v="273" actId="1037"/>
          <ac:spMkLst>
            <pc:docMk/>
            <pc:sldMk cId="1524448352" sldId="257"/>
            <ac:spMk id="18" creationId="{F24FF78C-B5CD-4A18-A661-F331B5B73F5F}"/>
          </ac:spMkLst>
        </pc:spChg>
        <pc:spChg chg="mod">
          <ac:chgData name="Simon Xin Min Dong" userId="6647684b-86c4-4538-a0ea-723982d85692" providerId="ADAL" clId="{B16B9F97-A12E-4551-A28C-3661979B09DE}" dt="2021-05-21T00:23:42.063" v="273" actId="1037"/>
          <ac:spMkLst>
            <pc:docMk/>
            <pc:sldMk cId="1524448352" sldId="257"/>
            <ac:spMk id="19" creationId="{A006D2C8-D66E-423C-BD79-7B205244F392}"/>
          </ac:spMkLst>
        </pc:spChg>
        <pc:spChg chg="mod">
          <ac:chgData name="Simon Xin Min Dong" userId="6647684b-86c4-4538-a0ea-723982d85692" providerId="ADAL" clId="{B16B9F97-A12E-4551-A28C-3661979B09DE}" dt="2021-05-21T00:23:42.063" v="273" actId="1037"/>
          <ac:spMkLst>
            <pc:docMk/>
            <pc:sldMk cId="1524448352" sldId="257"/>
            <ac:spMk id="20" creationId="{149380CE-5226-4D19-A4FB-F2C4BECEF37E}"/>
          </ac:spMkLst>
        </pc:spChg>
        <pc:spChg chg="mod">
          <ac:chgData name="Simon Xin Min Dong" userId="6647684b-86c4-4538-a0ea-723982d85692" providerId="ADAL" clId="{B16B9F97-A12E-4551-A28C-3661979B09DE}" dt="2021-05-21T00:23:42.063" v="273" actId="1037"/>
          <ac:spMkLst>
            <pc:docMk/>
            <pc:sldMk cId="1524448352" sldId="257"/>
            <ac:spMk id="21" creationId="{28DEC9F9-4EAE-4C7D-8D72-34A7CD26F7B5}"/>
          </ac:spMkLst>
        </pc:spChg>
        <pc:spChg chg="mod">
          <ac:chgData name="Simon Xin Min Dong" userId="6647684b-86c4-4538-a0ea-723982d85692" providerId="ADAL" clId="{B16B9F97-A12E-4551-A28C-3661979B09DE}" dt="2021-05-21T00:23:42.063" v="273" actId="1037"/>
          <ac:spMkLst>
            <pc:docMk/>
            <pc:sldMk cId="1524448352" sldId="257"/>
            <ac:spMk id="22" creationId="{03EAC110-9A8F-47F0-8933-589A38FA3B8F}"/>
          </ac:spMkLst>
        </pc:spChg>
        <pc:spChg chg="mod">
          <ac:chgData name="Simon Xin Min Dong" userId="6647684b-86c4-4538-a0ea-723982d85692" providerId="ADAL" clId="{B16B9F97-A12E-4551-A28C-3661979B09DE}" dt="2021-05-21T00:23:42.063" v="273" actId="1037"/>
          <ac:spMkLst>
            <pc:docMk/>
            <pc:sldMk cId="1524448352" sldId="257"/>
            <ac:spMk id="23" creationId="{C58C6F21-786C-4A1C-9208-4BDBA5E5D7C0}"/>
          </ac:spMkLst>
        </pc:spChg>
        <pc:spChg chg="mod">
          <ac:chgData name="Simon Xin Min Dong" userId="6647684b-86c4-4538-a0ea-723982d85692" providerId="ADAL" clId="{B16B9F97-A12E-4551-A28C-3661979B09DE}" dt="2021-05-21T00:23:42.063" v="273" actId="1037"/>
          <ac:spMkLst>
            <pc:docMk/>
            <pc:sldMk cId="1524448352" sldId="257"/>
            <ac:spMk id="26" creationId="{96698DE4-13C8-4F6D-ACA0-E594FFA6A3AB}"/>
          </ac:spMkLst>
        </pc:spChg>
        <pc:spChg chg="mod">
          <ac:chgData name="Simon Xin Min Dong" userId="6647684b-86c4-4538-a0ea-723982d85692" providerId="ADAL" clId="{B16B9F97-A12E-4551-A28C-3661979B09DE}" dt="2021-05-21T00:23:42.063" v="273" actId="1037"/>
          <ac:spMkLst>
            <pc:docMk/>
            <pc:sldMk cId="1524448352" sldId="257"/>
            <ac:spMk id="29" creationId="{C6B48D1E-B713-46E3-A3AD-963C7A304D37}"/>
          </ac:spMkLst>
        </pc:spChg>
        <pc:spChg chg="mod">
          <ac:chgData name="Simon Xin Min Dong" userId="6647684b-86c4-4538-a0ea-723982d85692" providerId="ADAL" clId="{B16B9F97-A12E-4551-A28C-3661979B09DE}" dt="2021-05-21T00:23:42.063" v="273" actId="1037"/>
          <ac:spMkLst>
            <pc:docMk/>
            <pc:sldMk cId="1524448352" sldId="257"/>
            <ac:spMk id="30" creationId="{FC1A4AB8-9A9D-410B-A80D-A5CADABE8804}"/>
          </ac:spMkLst>
        </pc:spChg>
        <pc:grpChg chg="mod">
          <ac:chgData name="Simon Xin Min Dong" userId="6647684b-86c4-4538-a0ea-723982d85692" providerId="ADAL" clId="{B16B9F97-A12E-4551-A28C-3661979B09DE}" dt="2021-05-21T00:23:42.063" v="273" actId="1037"/>
          <ac:grpSpMkLst>
            <pc:docMk/>
            <pc:sldMk cId="1524448352" sldId="257"/>
            <ac:grpSpMk id="4" creationId="{192BEC6B-DCF4-421B-9ECB-A7928E71D6A0}"/>
          </ac:grpSpMkLst>
        </pc:grpChg>
        <pc:grpChg chg="mod">
          <ac:chgData name="Simon Xin Min Dong" userId="6647684b-86c4-4538-a0ea-723982d85692" providerId="ADAL" clId="{B16B9F97-A12E-4551-A28C-3661979B09DE}" dt="2021-05-21T00:23:42.063" v="273" actId="1037"/>
          <ac:grpSpMkLst>
            <pc:docMk/>
            <pc:sldMk cId="1524448352" sldId="257"/>
            <ac:grpSpMk id="16" creationId="{23F26196-9277-473E-9D32-C84F89019923}"/>
          </ac:grpSpMkLst>
        </pc:grpChg>
        <pc:picChg chg="del">
          <ac:chgData name="Simon Xin Min Dong" userId="6647684b-86c4-4538-a0ea-723982d85692" providerId="ADAL" clId="{B16B9F97-A12E-4551-A28C-3661979B09DE}" dt="2021-05-21T00:14:11.350" v="50" actId="478"/>
          <ac:picMkLst>
            <pc:docMk/>
            <pc:sldMk cId="1524448352" sldId="257"/>
            <ac:picMk id="3" creationId="{6985AD4F-8095-4996-8D01-FAA7B4AAD214}"/>
          </ac:picMkLst>
        </pc:picChg>
        <pc:picChg chg="add mod ord">
          <ac:chgData name="Simon Xin Min Dong" userId="6647684b-86c4-4538-a0ea-723982d85692" providerId="ADAL" clId="{B16B9F97-A12E-4551-A28C-3661979B09DE}" dt="2021-05-21T00:23:42.063" v="273" actId="1037"/>
          <ac:picMkLst>
            <pc:docMk/>
            <pc:sldMk cId="1524448352" sldId="257"/>
            <ac:picMk id="5" creationId="{D712A5CA-4CFB-455C-A35A-DF8C2163B35E}"/>
          </ac:picMkLst>
        </pc:picChg>
      </pc:sldChg>
      <pc:sldChg chg="addSp modSp mod">
        <pc:chgData name="Simon Xin Min Dong" userId="6647684b-86c4-4538-a0ea-723982d85692" providerId="ADAL" clId="{B16B9F97-A12E-4551-A28C-3661979B09DE}" dt="2021-05-21T00:25:46.684" v="355" actId="1037"/>
        <pc:sldMkLst>
          <pc:docMk/>
          <pc:sldMk cId="2173231402" sldId="259"/>
        </pc:sldMkLst>
        <pc:spChg chg="mod">
          <ac:chgData name="Simon Xin Min Dong" userId="6647684b-86c4-4538-a0ea-723982d85692" providerId="ADAL" clId="{B16B9F97-A12E-4551-A28C-3661979B09DE}" dt="2021-05-21T00:25:46.684" v="355" actId="1037"/>
          <ac:spMkLst>
            <pc:docMk/>
            <pc:sldMk cId="2173231402" sldId="259"/>
            <ac:spMk id="5" creationId="{1AF6F294-6C1B-4057-A4C6-56FA929DC5BA}"/>
          </ac:spMkLst>
        </pc:spChg>
        <pc:spChg chg="mod">
          <ac:chgData name="Simon Xin Min Dong" userId="6647684b-86c4-4538-a0ea-723982d85692" providerId="ADAL" clId="{B16B9F97-A12E-4551-A28C-3661979B09DE}" dt="2021-05-21T00:25:46.684" v="355" actId="1037"/>
          <ac:spMkLst>
            <pc:docMk/>
            <pc:sldMk cId="2173231402" sldId="259"/>
            <ac:spMk id="6" creationId="{1D4AFCD0-D909-4392-9364-BF28288CC7A1}"/>
          </ac:spMkLst>
        </pc:spChg>
        <pc:spChg chg="mod">
          <ac:chgData name="Simon Xin Min Dong" userId="6647684b-86c4-4538-a0ea-723982d85692" providerId="ADAL" clId="{B16B9F97-A12E-4551-A28C-3661979B09DE}" dt="2021-05-21T00:25:46.684" v="355" actId="1037"/>
          <ac:spMkLst>
            <pc:docMk/>
            <pc:sldMk cId="2173231402" sldId="259"/>
            <ac:spMk id="7" creationId="{59CEB8EA-BE04-4C39-BE1A-4327E85F0315}"/>
          </ac:spMkLst>
        </pc:spChg>
        <pc:spChg chg="mod">
          <ac:chgData name="Simon Xin Min Dong" userId="6647684b-86c4-4538-a0ea-723982d85692" providerId="ADAL" clId="{B16B9F97-A12E-4551-A28C-3661979B09DE}" dt="2021-05-21T00:25:46.684" v="355" actId="1037"/>
          <ac:spMkLst>
            <pc:docMk/>
            <pc:sldMk cId="2173231402" sldId="259"/>
            <ac:spMk id="10" creationId="{3C3466D3-38C9-48B7-9524-007621BB828F}"/>
          </ac:spMkLst>
        </pc:spChg>
        <pc:spChg chg="mod">
          <ac:chgData name="Simon Xin Min Dong" userId="6647684b-86c4-4538-a0ea-723982d85692" providerId="ADAL" clId="{B16B9F97-A12E-4551-A28C-3661979B09DE}" dt="2021-05-21T00:25:46.684" v="355" actId="1037"/>
          <ac:spMkLst>
            <pc:docMk/>
            <pc:sldMk cId="2173231402" sldId="259"/>
            <ac:spMk id="12" creationId="{664302CB-A117-4FA2-B658-495BAFE4A506}"/>
          </ac:spMkLst>
        </pc:spChg>
        <pc:spChg chg="mod">
          <ac:chgData name="Simon Xin Min Dong" userId="6647684b-86c4-4538-a0ea-723982d85692" providerId="ADAL" clId="{B16B9F97-A12E-4551-A28C-3661979B09DE}" dt="2021-05-21T00:25:46.684" v="355" actId="1037"/>
          <ac:spMkLst>
            <pc:docMk/>
            <pc:sldMk cId="2173231402" sldId="259"/>
            <ac:spMk id="13" creationId="{05C18B95-2218-4A32-B0D6-392E2CCEDEC5}"/>
          </ac:spMkLst>
        </pc:spChg>
        <pc:spChg chg="mod">
          <ac:chgData name="Simon Xin Min Dong" userId="6647684b-86c4-4538-a0ea-723982d85692" providerId="ADAL" clId="{B16B9F97-A12E-4551-A28C-3661979B09DE}" dt="2021-05-21T00:25:46.684" v="355" actId="1037"/>
          <ac:spMkLst>
            <pc:docMk/>
            <pc:sldMk cId="2173231402" sldId="259"/>
            <ac:spMk id="14" creationId="{E8EFA767-CD91-412A-A79C-38661298F3D6}"/>
          </ac:spMkLst>
        </pc:spChg>
        <pc:spChg chg="mod">
          <ac:chgData name="Simon Xin Min Dong" userId="6647684b-86c4-4538-a0ea-723982d85692" providerId="ADAL" clId="{B16B9F97-A12E-4551-A28C-3661979B09DE}" dt="2021-05-21T00:25:46.684" v="355" actId="1037"/>
          <ac:spMkLst>
            <pc:docMk/>
            <pc:sldMk cId="2173231402" sldId="259"/>
            <ac:spMk id="16" creationId="{69B608CF-9AAC-412E-A678-0CE34896CD62}"/>
          </ac:spMkLst>
        </pc:spChg>
        <pc:spChg chg="mod">
          <ac:chgData name="Simon Xin Min Dong" userId="6647684b-86c4-4538-a0ea-723982d85692" providerId="ADAL" clId="{B16B9F97-A12E-4551-A28C-3661979B09DE}" dt="2021-05-21T00:25:46.684" v="355" actId="1037"/>
          <ac:spMkLst>
            <pc:docMk/>
            <pc:sldMk cId="2173231402" sldId="259"/>
            <ac:spMk id="17" creationId="{61735AC7-8F98-44D8-864B-95B99E0B4307}"/>
          </ac:spMkLst>
        </pc:spChg>
        <pc:spChg chg="mod">
          <ac:chgData name="Simon Xin Min Dong" userId="6647684b-86c4-4538-a0ea-723982d85692" providerId="ADAL" clId="{B16B9F97-A12E-4551-A28C-3661979B09DE}" dt="2021-05-21T00:25:46.684" v="355" actId="1037"/>
          <ac:spMkLst>
            <pc:docMk/>
            <pc:sldMk cId="2173231402" sldId="259"/>
            <ac:spMk id="18" creationId="{11D7F7FE-A51E-4FB2-96E9-449887321516}"/>
          </ac:spMkLst>
        </pc:spChg>
        <pc:spChg chg="mod">
          <ac:chgData name="Simon Xin Min Dong" userId="6647684b-86c4-4538-a0ea-723982d85692" providerId="ADAL" clId="{B16B9F97-A12E-4551-A28C-3661979B09DE}" dt="2021-05-21T00:25:46.684" v="355" actId="1037"/>
          <ac:spMkLst>
            <pc:docMk/>
            <pc:sldMk cId="2173231402" sldId="259"/>
            <ac:spMk id="29" creationId="{B18C1E08-0A08-4CF7-85C1-537521AEFC2B}"/>
          </ac:spMkLst>
        </pc:spChg>
        <pc:spChg chg="mod">
          <ac:chgData name="Simon Xin Min Dong" userId="6647684b-86c4-4538-a0ea-723982d85692" providerId="ADAL" clId="{B16B9F97-A12E-4551-A28C-3661979B09DE}" dt="2021-05-21T00:25:46.684" v="355" actId="1037"/>
          <ac:spMkLst>
            <pc:docMk/>
            <pc:sldMk cId="2173231402" sldId="259"/>
            <ac:spMk id="30" creationId="{72DCE368-4FBB-4373-AF5C-6E2651607BF8}"/>
          </ac:spMkLst>
        </pc:spChg>
        <pc:spChg chg="mod">
          <ac:chgData name="Simon Xin Min Dong" userId="6647684b-86c4-4538-a0ea-723982d85692" providerId="ADAL" clId="{B16B9F97-A12E-4551-A28C-3661979B09DE}" dt="2021-05-21T00:25:46.684" v="355" actId="1037"/>
          <ac:spMkLst>
            <pc:docMk/>
            <pc:sldMk cId="2173231402" sldId="259"/>
            <ac:spMk id="33" creationId="{B47D4765-1B17-484A-9FFD-DE4B616B23CE}"/>
          </ac:spMkLst>
        </pc:spChg>
        <pc:spChg chg="mod">
          <ac:chgData name="Simon Xin Min Dong" userId="6647684b-86c4-4538-a0ea-723982d85692" providerId="ADAL" clId="{B16B9F97-A12E-4551-A28C-3661979B09DE}" dt="2021-05-21T00:25:46.684" v="355" actId="1037"/>
          <ac:spMkLst>
            <pc:docMk/>
            <pc:sldMk cId="2173231402" sldId="259"/>
            <ac:spMk id="34" creationId="{FBC5777A-F4AC-451B-A00F-225C3910D434}"/>
          </ac:spMkLst>
        </pc:spChg>
        <pc:spChg chg="mod">
          <ac:chgData name="Simon Xin Min Dong" userId="6647684b-86c4-4538-a0ea-723982d85692" providerId="ADAL" clId="{B16B9F97-A12E-4551-A28C-3661979B09DE}" dt="2021-05-21T00:25:46.684" v="355" actId="1037"/>
          <ac:spMkLst>
            <pc:docMk/>
            <pc:sldMk cId="2173231402" sldId="259"/>
            <ac:spMk id="35" creationId="{FF2994C6-668A-45A2-BB4A-48D67BC194F1}"/>
          </ac:spMkLst>
        </pc:spChg>
        <pc:spChg chg="mod">
          <ac:chgData name="Simon Xin Min Dong" userId="6647684b-86c4-4538-a0ea-723982d85692" providerId="ADAL" clId="{B16B9F97-A12E-4551-A28C-3661979B09DE}" dt="2021-05-21T00:25:46.684" v="355" actId="1037"/>
          <ac:spMkLst>
            <pc:docMk/>
            <pc:sldMk cId="2173231402" sldId="259"/>
            <ac:spMk id="38" creationId="{BEFB24DB-990F-43D3-9FA4-490A456877BD}"/>
          </ac:spMkLst>
        </pc:spChg>
        <pc:spChg chg="mod">
          <ac:chgData name="Simon Xin Min Dong" userId="6647684b-86c4-4538-a0ea-723982d85692" providerId="ADAL" clId="{B16B9F97-A12E-4551-A28C-3661979B09DE}" dt="2021-05-21T00:25:46.684" v="355" actId="1037"/>
          <ac:spMkLst>
            <pc:docMk/>
            <pc:sldMk cId="2173231402" sldId="259"/>
            <ac:spMk id="39" creationId="{72FF14CE-31C7-4BF6-A3AE-874E2826A9F2}"/>
          </ac:spMkLst>
        </pc:spChg>
        <pc:spChg chg="mod">
          <ac:chgData name="Simon Xin Min Dong" userId="6647684b-86c4-4538-a0ea-723982d85692" providerId="ADAL" clId="{B16B9F97-A12E-4551-A28C-3661979B09DE}" dt="2021-05-21T00:25:46.684" v="355" actId="1037"/>
          <ac:spMkLst>
            <pc:docMk/>
            <pc:sldMk cId="2173231402" sldId="259"/>
            <ac:spMk id="40" creationId="{7220B53F-4A71-4672-8807-23E68E6D2929}"/>
          </ac:spMkLst>
        </pc:spChg>
        <pc:spChg chg="mod">
          <ac:chgData name="Simon Xin Min Dong" userId="6647684b-86c4-4538-a0ea-723982d85692" providerId="ADAL" clId="{B16B9F97-A12E-4551-A28C-3661979B09DE}" dt="2021-05-21T00:25:46.684" v="355" actId="1037"/>
          <ac:spMkLst>
            <pc:docMk/>
            <pc:sldMk cId="2173231402" sldId="259"/>
            <ac:spMk id="41" creationId="{038BD4C1-37C5-441D-98D2-51FAAE5646B6}"/>
          </ac:spMkLst>
        </pc:spChg>
        <pc:spChg chg="mod">
          <ac:chgData name="Simon Xin Min Dong" userId="6647684b-86c4-4538-a0ea-723982d85692" providerId="ADAL" clId="{B16B9F97-A12E-4551-A28C-3661979B09DE}" dt="2021-05-21T00:25:46.684" v="355" actId="1037"/>
          <ac:spMkLst>
            <pc:docMk/>
            <pc:sldMk cId="2173231402" sldId="259"/>
            <ac:spMk id="42" creationId="{BF805D95-E515-4A59-ADD3-4F7C334CD83E}"/>
          </ac:spMkLst>
        </pc:spChg>
        <pc:grpChg chg="add mod">
          <ac:chgData name="Simon Xin Min Dong" userId="6647684b-86c4-4538-a0ea-723982d85692" providerId="ADAL" clId="{B16B9F97-A12E-4551-A28C-3661979B09DE}" dt="2021-05-21T00:25:46.684" v="355" actId="1037"/>
          <ac:grpSpMkLst>
            <pc:docMk/>
            <pc:sldMk cId="2173231402" sldId="259"/>
            <ac:grpSpMk id="2" creationId="{516FFCA9-3B26-40D8-8EE4-819BB85899C2}"/>
          </ac:grpSpMkLst>
        </pc:grpChg>
        <pc:grpChg chg="mod">
          <ac:chgData name="Simon Xin Min Dong" userId="6647684b-86c4-4538-a0ea-723982d85692" providerId="ADAL" clId="{B16B9F97-A12E-4551-A28C-3661979B09DE}" dt="2021-05-21T00:25:46.684" v="355" actId="1037"/>
          <ac:grpSpMkLst>
            <pc:docMk/>
            <pc:sldMk cId="2173231402" sldId="259"/>
            <ac:grpSpMk id="4" creationId="{A0482A0C-84B9-41FC-B5A3-DF1C6042ADB2}"/>
          </ac:grpSpMkLst>
        </pc:grpChg>
        <pc:picChg chg="mod">
          <ac:chgData name="Simon Xin Min Dong" userId="6647684b-86c4-4538-a0ea-723982d85692" providerId="ADAL" clId="{B16B9F97-A12E-4551-A28C-3661979B09DE}" dt="2021-05-21T00:25:46.684" v="355" actId="1037"/>
          <ac:picMkLst>
            <pc:docMk/>
            <pc:sldMk cId="2173231402" sldId="259"/>
            <ac:picMk id="3" creationId="{A8BB2EE5-4756-4492-B239-1488EF601A9A}"/>
          </ac:picMkLst>
        </pc:picChg>
      </pc:sldChg>
      <pc:sldChg chg="addSp delSp modSp mod">
        <pc:chgData name="Simon Xin Min Dong" userId="6647684b-86c4-4538-a0ea-723982d85692" providerId="ADAL" clId="{B16B9F97-A12E-4551-A28C-3661979B09DE}" dt="2021-05-21T00:25:01.475" v="311" actId="1036"/>
        <pc:sldMkLst>
          <pc:docMk/>
          <pc:sldMk cId="1772152896" sldId="260"/>
        </pc:sldMkLst>
        <pc:spChg chg="mod">
          <ac:chgData name="Simon Xin Min Dong" userId="6647684b-86c4-4538-a0ea-723982d85692" providerId="ADAL" clId="{B16B9F97-A12E-4551-A28C-3661979B09DE}" dt="2021-05-21T00:24:51.955" v="275" actId="1076"/>
          <ac:spMkLst>
            <pc:docMk/>
            <pc:sldMk cId="1772152896" sldId="260"/>
            <ac:spMk id="3" creationId="{627943C9-6685-417A-981F-42B82F3F0DDF}"/>
          </ac:spMkLst>
        </pc:spChg>
        <pc:spChg chg="mod">
          <ac:chgData name="Simon Xin Min Dong" userId="6647684b-86c4-4538-a0ea-723982d85692" providerId="ADAL" clId="{B16B9F97-A12E-4551-A28C-3661979B09DE}" dt="2021-05-21T00:25:01.475" v="311" actId="1036"/>
          <ac:spMkLst>
            <pc:docMk/>
            <pc:sldMk cId="1772152896" sldId="260"/>
            <ac:spMk id="5" creationId="{450CBF0A-B779-4D3E-BFC5-500FD4AC8428}"/>
          </ac:spMkLst>
        </pc:spChg>
        <pc:spChg chg="mod">
          <ac:chgData name="Simon Xin Min Dong" userId="6647684b-86c4-4538-a0ea-723982d85692" providerId="ADAL" clId="{B16B9F97-A12E-4551-A28C-3661979B09DE}" dt="2021-05-21T00:25:01.475" v="311" actId="1036"/>
          <ac:spMkLst>
            <pc:docMk/>
            <pc:sldMk cId="1772152896" sldId="260"/>
            <ac:spMk id="6" creationId="{7C051762-4FEC-4577-AFF3-91C5DEB88EFA}"/>
          </ac:spMkLst>
        </pc:spChg>
        <pc:spChg chg="mod">
          <ac:chgData name="Simon Xin Min Dong" userId="6647684b-86c4-4538-a0ea-723982d85692" providerId="ADAL" clId="{B16B9F97-A12E-4551-A28C-3661979B09DE}" dt="2021-05-21T00:25:01.475" v="311" actId="1036"/>
          <ac:spMkLst>
            <pc:docMk/>
            <pc:sldMk cId="1772152896" sldId="260"/>
            <ac:spMk id="7" creationId="{E7B3EBDC-77BC-41F7-849F-5D89E38D87E9}"/>
          </ac:spMkLst>
        </pc:spChg>
        <pc:spChg chg="mod">
          <ac:chgData name="Simon Xin Min Dong" userId="6647684b-86c4-4538-a0ea-723982d85692" providerId="ADAL" clId="{B16B9F97-A12E-4551-A28C-3661979B09DE}" dt="2021-05-21T00:25:01.475" v="311" actId="1036"/>
          <ac:spMkLst>
            <pc:docMk/>
            <pc:sldMk cId="1772152896" sldId="260"/>
            <ac:spMk id="9" creationId="{A8F6CDD4-05CB-4B05-AB15-5B15A7D9C2C0}"/>
          </ac:spMkLst>
        </pc:spChg>
        <pc:spChg chg="mod">
          <ac:chgData name="Simon Xin Min Dong" userId="6647684b-86c4-4538-a0ea-723982d85692" providerId="ADAL" clId="{B16B9F97-A12E-4551-A28C-3661979B09DE}" dt="2021-05-21T00:25:01.475" v="311" actId="1036"/>
          <ac:spMkLst>
            <pc:docMk/>
            <pc:sldMk cId="1772152896" sldId="260"/>
            <ac:spMk id="10" creationId="{A606A06C-6A6F-4D76-8A94-A960154EE0EA}"/>
          </ac:spMkLst>
        </pc:spChg>
        <pc:spChg chg="mod">
          <ac:chgData name="Simon Xin Min Dong" userId="6647684b-86c4-4538-a0ea-723982d85692" providerId="ADAL" clId="{B16B9F97-A12E-4551-A28C-3661979B09DE}" dt="2021-05-21T00:25:01.475" v="311" actId="1036"/>
          <ac:spMkLst>
            <pc:docMk/>
            <pc:sldMk cId="1772152896" sldId="260"/>
            <ac:spMk id="11" creationId="{35EFFB0D-A4CD-4E37-B402-278BAEE97E60}"/>
          </ac:spMkLst>
        </pc:spChg>
        <pc:spChg chg="mod">
          <ac:chgData name="Simon Xin Min Dong" userId="6647684b-86c4-4538-a0ea-723982d85692" providerId="ADAL" clId="{B16B9F97-A12E-4551-A28C-3661979B09DE}" dt="2021-05-21T00:25:01.475" v="311" actId="1036"/>
          <ac:spMkLst>
            <pc:docMk/>
            <pc:sldMk cId="1772152896" sldId="260"/>
            <ac:spMk id="13" creationId="{8899516E-F47D-413D-A332-1E9357387760}"/>
          </ac:spMkLst>
        </pc:spChg>
        <pc:spChg chg="mod">
          <ac:chgData name="Simon Xin Min Dong" userId="6647684b-86c4-4538-a0ea-723982d85692" providerId="ADAL" clId="{B16B9F97-A12E-4551-A28C-3661979B09DE}" dt="2021-05-21T00:25:01.475" v="311" actId="1036"/>
          <ac:spMkLst>
            <pc:docMk/>
            <pc:sldMk cId="1772152896" sldId="260"/>
            <ac:spMk id="14" creationId="{F6C369BC-6EED-4CDD-A671-EE4D4306C0F1}"/>
          </ac:spMkLst>
        </pc:spChg>
        <pc:spChg chg="mod">
          <ac:chgData name="Simon Xin Min Dong" userId="6647684b-86c4-4538-a0ea-723982d85692" providerId="ADAL" clId="{B16B9F97-A12E-4551-A28C-3661979B09DE}" dt="2021-05-21T00:25:01.475" v="311" actId="1036"/>
          <ac:spMkLst>
            <pc:docMk/>
            <pc:sldMk cId="1772152896" sldId="260"/>
            <ac:spMk id="15" creationId="{9FF1C6AB-FE22-41BF-9538-77413A00B8E7}"/>
          </ac:spMkLst>
        </pc:spChg>
        <pc:spChg chg="mod">
          <ac:chgData name="Simon Xin Min Dong" userId="6647684b-86c4-4538-a0ea-723982d85692" providerId="ADAL" clId="{B16B9F97-A12E-4551-A28C-3661979B09DE}" dt="2021-05-21T00:25:01.475" v="311" actId="1036"/>
          <ac:spMkLst>
            <pc:docMk/>
            <pc:sldMk cId="1772152896" sldId="260"/>
            <ac:spMk id="16" creationId="{FBFC9005-E8A3-43A7-A940-50871551F99E}"/>
          </ac:spMkLst>
        </pc:spChg>
        <pc:spChg chg="mod">
          <ac:chgData name="Simon Xin Min Dong" userId="6647684b-86c4-4538-a0ea-723982d85692" providerId="ADAL" clId="{B16B9F97-A12E-4551-A28C-3661979B09DE}" dt="2021-05-21T00:25:01.475" v="311" actId="1036"/>
          <ac:spMkLst>
            <pc:docMk/>
            <pc:sldMk cId="1772152896" sldId="260"/>
            <ac:spMk id="18" creationId="{9AA93526-509F-4194-9050-01073673D0E0}"/>
          </ac:spMkLst>
        </pc:spChg>
        <pc:spChg chg="mod">
          <ac:chgData name="Simon Xin Min Dong" userId="6647684b-86c4-4538-a0ea-723982d85692" providerId="ADAL" clId="{B16B9F97-A12E-4551-A28C-3661979B09DE}" dt="2021-05-21T00:25:01.475" v="311" actId="1036"/>
          <ac:spMkLst>
            <pc:docMk/>
            <pc:sldMk cId="1772152896" sldId="260"/>
            <ac:spMk id="19" creationId="{A83BA2BA-C55A-4CBF-B7B2-C446355F09FF}"/>
          </ac:spMkLst>
        </pc:spChg>
        <pc:spChg chg="mod">
          <ac:chgData name="Simon Xin Min Dong" userId="6647684b-86c4-4538-a0ea-723982d85692" providerId="ADAL" clId="{B16B9F97-A12E-4551-A28C-3661979B09DE}" dt="2021-05-21T00:25:01.475" v="311" actId="1036"/>
          <ac:spMkLst>
            <pc:docMk/>
            <pc:sldMk cId="1772152896" sldId="260"/>
            <ac:spMk id="20" creationId="{54C4587E-2F54-4F20-84F0-5B3E8C740858}"/>
          </ac:spMkLst>
        </pc:spChg>
        <pc:spChg chg="mod">
          <ac:chgData name="Simon Xin Min Dong" userId="6647684b-86c4-4538-a0ea-723982d85692" providerId="ADAL" clId="{B16B9F97-A12E-4551-A28C-3661979B09DE}" dt="2021-05-21T00:25:01.475" v="311" actId="1036"/>
          <ac:spMkLst>
            <pc:docMk/>
            <pc:sldMk cId="1772152896" sldId="260"/>
            <ac:spMk id="21" creationId="{2FC11035-6157-48AE-A09A-23EE31DFB15C}"/>
          </ac:spMkLst>
        </pc:spChg>
        <pc:spChg chg="mod">
          <ac:chgData name="Simon Xin Min Dong" userId="6647684b-86c4-4538-a0ea-723982d85692" providerId="ADAL" clId="{B16B9F97-A12E-4551-A28C-3661979B09DE}" dt="2021-05-21T00:25:01.475" v="311" actId="1036"/>
          <ac:spMkLst>
            <pc:docMk/>
            <pc:sldMk cId="1772152896" sldId="260"/>
            <ac:spMk id="22" creationId="{B13CB6E9-EBC4-4695-BBBB-F26CF22651E6}"/>
          </ac:spMkLst>
        </pc:spChg>
        <pc:spChg chg="mod">
          <ac:chgData name="Simon Xin Min Dong" userId="6647684b-86c4-4538-a0ea-723982d85692" providerId="ADAL" clId="{B16B9F97-A12E-4551-A28C-3661979B09DE}" dt="2021-05-21T00:25:01.475" v="311" actId="1036"/>
          <ac:spMkLst>
            <pc:docMk/>
            <pc:sldMk cId="1772152896" sldId="260"/>
            <ac:spMk id="28" creationId="{6A11280C-4F58-4CDD-8985-AB8E6DEF8980}"/>
          </ac:spMkLst>
        </pc:spChg>
        <pc:spChg chg="mod">
          <ac:chgData name="Simon Xin Min Dong" userId="6647684b-86c4-4538-a0ea-723982d85692" providerId="ADAL" clId="{B16B9F97-A12E-4551-A28C-3661979B09DE}" dt="2021-05-21T00:25:01.475" v="311" actId="1036"/>
          <ac:spMkLst>
            <pc:docMk/>
            <pc:sldMk cId="1772152896" sldId="260"/>
            <ac:spMk id="29" creationId="{6E35AEE7-D84A-4EC5-8D5B-8B49FD62023A}"/>
          </ac:spMkLst>
        </pc:spChg>
        <pc:grpChg chg="add mod">
          <ac:chgData name="Simon Xin Min Dong" userId="6647684b-86c4-4538-a0ea-723982d85692" providerId="ADAL" clId="{B16B9F97-A12E-4551-A28C-3661979B09DE}" dt="2021-05-21T00:25:01.475" v="311" actId="1036"/>
          <ac:grpSpMkLst>
            <pc:docMk/>
            <pc:sldMk cId="1772152896" sldId="260"/>
            <ac:grpSpMk id="2" creationId="{5B79B87C-274A-4F31-87D8-07A926666406}"/>
          </ac:grpSpMkLst>
        </pc:grpChg>
        <pc:grpChg chg="mod">
          <ac:chgData name="Simon Xin Min Dong" userId="6647684b-86c4-4538-a0ea-723982d85692" providerId="ADAL" clId="{B16B9F97-A12E-4551-A28C-3661979B09DE}" dt="2021-05-21T00:25:01.475" v="311" actId="1036"/>
          <ac:grpSpMkLst>
            <pc:docMk/>
            <pc:sldMk cId="1772152896" sldId="260"/>
            <ac:grpSpMk id="4" creationId="{526B1F39-C014-4593-BBD1-0777D95D36F7}"/>
          </ac:grpSpMkLst>
        </pc:grpChg>
        <pc:grpChg chg="add mod">
          <ac:chgData name="Simon Xin Min Dong" userId="6647684b-86c4-4538-a0ea-723982d85692" providerId="ADAL" clId="{B16B9F97-A12E-4551-A28C-3661979B09DE}" dt="2021-05-21T00:25:01.475" v="311" actId="1036"/>
          <ac:grpSpMkLst>
            <pc:docMk/>
            <pc:sldMk cId="1772152896" sldId="260"/>
            <ac:grpSpMk id="8" creationId="{FA59C845-2D73-4E03-B2A8-7D609C19BA75}"/>
          </ac:grpSpMkLst>
        </pc:grpChg>
        <pc:picChg chg="add mod">
          <ac:chgData name="Simon Xin Min Dong" userId="6647684b-86c4-4538-a0ea-723982d85692" providerId="ADAL" clId="{B16B9F97-A12E-4551-A28C-3661979B09DE}" dt="2021-05-21T00:25:01.475" v="311" actId="1036"/>
          <ac:picMkLst>
            <pc:docMk/>
            <pc:sldMk cId="1772152896" sldId="260"/>
            <ac:picMk id="23" creationId="{A571CEE4-C521-4D63-B611-984D56631D9D}"/>
          </ac:picMkLst>
        </pc:picChg>
        <pc:picChg chg="del">
          <ac:chgData name="Simon Xin Min Dong" userId="6647684b-86c4-4538-a0ea-723982d85692" providerId="ADAL" clId="{B16B9F97-A12E-4551-A28C-3661979B09DE}" dt="2021-05-21T00:21:02.140" v="227" actId="478"/>
          <ac:picMkLst>
            <pc:docMk/>
            <pc:sldMk cId="1772152896" sldId="260"/>
            <ac:picMk id="24" creationId="{759F78B4-EA82-46FB-83E8-166EBF155B55}"/>
          </ac:picMkLst>
        </pc:picChg>
      </pc:sldChg>
      <pc:sldChg chg="addSp modSp mod">
        <pc:chgData name="Simon Xin Min Dong" userId="6647684b-86c4-4538-a0ea-723982d85692" providerId="ADAL" clId="{B16B9F97-A12E-4551-A28C-3661979B09DE}" dt="2021-05-21T00:26:28.120" v="358" actId="20577"/>
        <pc:sldMkLst>
          <pc:docMk/>
          <pc:sldMk cId="1821796093" sldId="261"/>
        </pc:sldMkLst>
        <pc:spChg chg="add mod">
          <ac:chgData name="Simon Xin Min Dong" userId="6647684b-86c4-4538-a0ea-723982d85692" providerId="ADAL" clId="{B16B9F97-A12E-4551-A28C-3661979B09DE}" dt="2021-05-21T00:26:28.120" v="358" actId="20577"/>
          <ac:spMkLst>
            <pc:docMk/>
            <pc:sldMk cId="1821796093" sldId="261"/>
            <ac:spMk id="2" creationId="{7DDC36C8-E00F-46F7-9501-2DD2798B8DCA}"/>
          </ac:spMkLst>
        </pc:spChg>
      </pc:sldChg>
    </pc:docChg>
  </pc:docChgLst>
  <pc:docChgLst>
    <pc:chgData name="Simon Xin Min Dong" userId="6647684b-86c4-4538-a0ea-723982d85692" providerId="ADAL" clId="{273A2E3A-68A0-4418-9B04-456AD733E653}"/>
    <pc:docChg chg="undo custSel addSld delSld modSld sldOrd">
      <pc:chgData name="Simon Xin Min Dong" userId="6647684b-86c4-4538-a0ea-723982d85692" providerId="ADAL" clId="{273A2E3A-68A0-4418-9B04-456AD733E653}" dt="2021-05-21T20:41:14.990" v="1583" actId="1036"/>
      <pc:docMkLst>
        <pc:docMk/>
      </pc:docMkLst>
      <pc:sldChg chg="modSp mod">
        <pc:chgData name="Simon Xin Min Dong" userId="6647684b-86c4-4538-a0ea-723982d85692" providerId="ADAL" clId="{273A2E3A-68A0-4418-9B04-456AD733E653}" dt="2021-05-21T20:37:57.319" v="1564" actId="1038"/>
        <pc:sldMkLst>
          <pc:docMk/>
          <pc:sldMk cId="427278201" sldId="256"/>
        </pc:sldMkLst>
        <pc:spChg chg="mod">
          <ac:chgData name="Simon Xin Min Dong" userId="6647684b-86c4-4538-a0ea-723982d85692" providerId="ADAL" clId="{273A2E3A-68A0-4418-9B04-456AD733E653}" dt="2021-05-21T20:37:57.319" v="1564" actId="1038"/>
          <ac:spMkLst>
            <pc:docMk/>
            <pc:sldMk cId="427278201" sldId="256"/>
            <ac:spMk id="41" creationId="{0578DAEC-B93C-4C0C-BEB2-3BA1F99190BC}"/>
          </ac:spMkLst>
        </pc:spChg>
      </pc:sldChg>
      <pc:sldChg chg="addSp modSp mod">
        <pc:chgData name="Simon Xin Min Dong" userId="6647684b-86c4-4538-a0ea-723982d85692" providerId="ADAL" clId="{273A2E3A-68A0-4418-9B04-456AD733E653}" dt="2021-05-21T02:37:53.630" v="781" actId="1036"/>
        <pc:sldMkLst>
          <pc:docMk/>
          <pc:sldMk cId="1524448352" sldId="257"/>
        </pc:sldMkLst>
        <pc:spChg chg="mod">
          <ac:chgData name="Simon Xin Min Dong" userId="6647684b-86c4-4538-a0ea-723982d85692" providerId="ADAL" clId="{273A2E3A-68A0-4418-9B04-456AD733E653}" dt="2021-05-21T02:37:53.630" v="781" actId="1036"/>
          <ac:spMkLst>
            <pc:docMk/>
            <pc:sldMk cId="1524448352" sldId="257"/>
            <ac:spMk id="6" creationId="{CABC1B9C-DD10-4F45-819E-FEC0D7283BFC}"/>
          </ac:spMkLst>
        </pc:spChg>
        <pc:spChg chg="mod">
          <ac:chgData name="Simon Xin Min Dong" userId="6647684b-86c4-4538-a0ea-723982d85692" providerId="ADAL" clId="{273A2E3A-68A0-4418-9B04-456AD733E653}" dt="2021-05-21T02:37:53.630" v="781" actId="1036"/>
          <ac:spMkLst>
            <pc:docMk/>
            <pc:sldMk cId="1524448352" sldId="257"/>
            <ac:spMk id="7" creationId="{6807DF18-A250-4879-9569-D52FE1625640}"/>
          </ac:spMkLst>
        </pc:spChg>
        <pc:spChg chg="mod">
          <ac:chgData name="Simon Xin Min Dong" userId="6647684b-86c4-4538-a0ea-723982d85692" providerId="ADAL" clId="{273A2E3A-68A0-4418-9B04-456AD733E653}" dt="2021-05-21T02:37:53.630" v="781" actId="1036"/>
          <ac:spMkLst>
            <pc:docMk/>
            <pc:sldMk cId="1524448352" sldId="257"/>
            <ac:spMk id="8" creationId="{35527F7D-DFEF-48C9-AAFE-7F0AD97EF9EB}"/>
          </ac:spMkLst>
        </pc:spChg>
        <pc:spChg chg="mod">
          <ac:chgData name="Simon Xin Min Dong" userId="6647684b-86c4-4538-a0ea-723982d85692" providerId="ADAL" clId="{273A2E3A-68A0-4418-9B04-456AD733E653}" dt="2021-05-21T02:37:53.630" v="781" actId="1036"/>
          <ac:spMkLst>
            <pc:docMk/>
            <pc:sldMk cId="1524448352" sldId="257"/>
            <ac:spMk id="9" creationId="{0F3C7DDE-40BC-4499-842E-3BA15400B0B8}"/>
          </ac:spMkLst>
        </pc:spChg>
        <pc:spChg chg="mod">
          <ac:chgData name="Simon Xin Min Dong" userId="6647684b-86c4-4538-a0ea-723982d85692" providerId="ADAL" clId="{273A2E3A-68A0-4418-9B04-456AD733E653}" dt="2021-05-21T02:37:53.630" v="781" actId="1036"/>
          <ac:spMkLst>
            <pc:docMk/>
            <pc:sldMk cId="1524448352" sldId="257"/>
            <ac:spMk id="10" creationId="{17DF6728-775F-4E62-8761-2B2510B2EAAC}"/>
          </ac:spMkLst>
        </pc:spChg>
        <pc:spChg chg="mod">
          <ac:chgData name="Simon Xin Min Dong" userId="6647684b-86c4-4538-a0ea-723982d85692" providerId="ADAL" clId="{273A2E3A-68A0-4418-9B04-456AD733E653}" dt="2021-05-21T02:37:53.630" v="781" actId="1036"/>
          <ac:spMkLst>
            <pc:docMk/>
            <pc:sldMk cId="1524448352" sldId="257"/>
            <ac:spMk id="12" creationId="{C9DB8B25-1E62-45C1-B916-C005359545CC}"/>
          </ac:spMkLst>
        </pc:spChg>
        <pc:spChg chg="mod">
          <ac:chgData name="Simon Xin Min Dong" userId="6647684b-86c4-4538-a0ea-723982d85692" providerId="ADAL" clId="{273A2E3A-68A0-4418-9B04-456AD733E653}" dt="2021-05-21T02:37:53.630" v="781" actId="1036"/>
          <ac:spMkLst>
            <pc:docMk/>
            <pc:sldMk cId="1524448352" sldId="257"/>
            <ac:spMk id="13" creationId="{0517B030-B3E9-4210-B6ED-CA64BD5B1C72}"/>
          </ac:spMkLst>
        </pc:spChg>
        <pc:spChg chg="mod">
          <ac:chgData name="Simon Xin Min Dong" userId="6647684b-86c4-4538-a0ea-723982d85692" providerId="ADAL" clId="{273A2E3A-68A0-4418-9B04-456AD733E653}" dt="2021-05-21T02:37:53.630" v="781" actId="1036"/>
          <ac:spMkLst>
            <pc:docMk/>
            <pc:sldMk cId="1524448352" sldId="257"/>
            <ac:spMk id="17" creationId="{32A11330-A07D-47CD-8D93-46E5D25C6E89}"/>
          </ac:spMkLst>
        </pc:spChg>
        <pc:spChg chg="mod">
          <ac:chgData name="Simon Xin Min Dong" userId="6647684b-86c4-4538-a0ea-723982d85692" providerId="ADAL" clId="{273A2E3A-68A0-4418-9B04-456AD733E653}" dt="2021-05-21T02:37:53.630" v="781" actId="1036"/>
          <ac:spMkLst>
            <pc:docMk/>
            <pc:sldMk cId="1524448352" sldId="257"/>
            <ac:spMk id="18" creationId="{F24FF78C-B5CD-4A18-A661-F331B5B73F5F}"/>
          </ac:spMkLst>
        </pc:spChg>
        <pc:spChg chg="mod">
          <ac:chgData name="Simon Xin Min Dong" userId="6647684b-86c4-4538-a0ea-723982d85692" providerId="ADAL" clId="{273A2E3A-68A0-4418-9B04-456AD733E653}" dt="2021-05-21T02:37:53.630" v="781" actId="1036"/>
          <ac:spMkLst>
            <pc:docMk/>
            <pc:sldMk cId="1524448352" sldId="257"/>
            <ac:spMk id="19" creationId="{A006D2C8-D66E-423C-BD79-7B205244F392}"/>
          </ac:spMkLst>
        </pc:spChg>
        <pc:spChg chg="mod">
          <ac:chgData name="Simon Xin Min Dong" userId="6647684b-86c4-4538-a0ea-723982d85692" providerId="ADAL" clId="{273A2E3A-68A0-4418-9B04-456AD733E653}" dt="2021-05-21T02:37:53.630" v="781" actId="1036"/>
          <ac:spMkLst>
            <pc:docMk/>
            <pc:sldMk cId="1524448352" sldId="257"/>
            <ac:spMk id="20" creationId="{149380CE-5226-4D19-A4FB-F2C4BECEF37E}"/>
          </ac:spMkLst>
        </pc:spChg>
        <pc:spChg chg="mod">
          <ac:chgData name="Simon Xin Min Dong" userId="6647684b-86c4-4538-a0ea-723982d85692" providerId="ADAL" clId="{273A2E3A-68A0-4418-9B04-456AD733E653}" dt="2021-05-21T02:37:53.630" v="781" actId="1036"/>
          <ac:spMkLst>
            <pc:docMk/>
            <pc:sldMk cId="1524448352" sldId="257"/>
            <ac:spMk id="21" creationId="{28DEC9F9-4EAE-4C7D-8D72-34A7CD26F7B5}"/>
          </ac:spMkLst>
        </pc:spChg>
        <pc:spChg chg="mod">
          <ac:chgData name="Simon Xin Min Dong" userId="6647684b-86c4-4538-a0ea-723982d85692" providerId="ADAL" clId="{273A2E3A-68A0-4418-9B04-456AD733E653}" dt="2021-05-21T02:37:53.630" v="781" actId="1036"/>
          <ac:spMkLst>
            <pc:docMk/>
            <pc:sldMk cId="1524448352" sldId="257"/>
            <ac:spMk id="22" creationId="{03EAC110-9A8F-47F0-8933-589A38FA3B8F}"/>
          </ac:spMkLst>
        </pc:spChg>
        <pc:spChg chg="mod">
          <ac:chgData name="Simon Xin Min Dong" userId="6647684b-86c4-4538-a0ea-723982d85692" providerId="ADAL" clId="{273A2E3A-68A0-4418-9B04-456AD733E653}" dt="2021-05-21T02:37:53.630" v="781" actId="1036"/>
          <ac:spMkLst>
            <pc:docMk/>
            <pc:sldMk cId="1524448352" sldId="257"/>
            <ac:spMk id="23" creationId="{C58C6F21-786C-4A1C-9208-4BDBA5E5D7C0}"/>
          </ac:spMkLst>
        </pc:spChg>
        <pc:spChg chg="mod">
          <ac:chgData name="Simon Xin Min Dong" userId="6647684b-86c4-4538-a0ea-723982d85692" providerId="ADAL" clId="{273A2E3A-68A0-4418-9B04-456AD733E653}" dt="2021-05-21T02:37:53.630" v="781" actId="1036"/>
          <ac:spMkLst>
            <pc:docMk/>
            <pc:sldMk cId="1524448352" sldId="257"/>
            <ac:spMk id="25" creationId="{5CD08A4A-1306-4A74-88FD-0A5E5053BDB1}"/>
          </ac:spMkLst>
        </pc:spChg>
        <pc:spChg chg="mod">
          <ac:chgData name="Simon Xin Min Dong" userId="6647684b-86c4-4538-a0ea-723982d85692" providerId="ADAL" clId="{273A2E3A-68A0-4418-9B04-456AD733E653}" dt="2021-05-21T02:37:53.630" v="781" actId="1036"/>
          <ac:spMkLst>
            <pc:docMk/>
            <pc:sldMk cId="1524448352" sldId="257"/>
            <ac:spMk id="26" creationId="{96698DE4-13C8-4F6D-ACA0-E594FFA6A3AB}"/>
          </ac:spMkLst>
        </pc:spChg>
        <pc:spChg chg="mod">
          <ac:chgData name="Simon Xin Min Dong" userId="6647684b-86c4-4538-a0ea-723982d85692" providerId="ADAL" clId="{273A2E3A-68A0-4418-9B04-456AD733E653}" dt="2021-05-21T02:37:53.630" v="781" actId="1036"/>
          <ac:spMkLst>
            <pc:docMk/>
            <pc:sldMk cId="1524448352" sldId="257"/>
            <ac:spMk id="27" creationId="{9A1E90CB-CBB9-457B-84B6-2AD12D49801A}"/>
          </ac:spMkLst>
        </pc:spChg>
        <pc:spChg chg="mod">
          <ac:chgData name="Simon Xin Min Dong" userId="6647684b-86c4-4538-a0ea-723982d85692" providerId="ADAL" clId="{273A2E3A-68A0-4418-9B04-456AD733E653}" dt="2021-05-21T02:37:53.630" v="781" actId="1036"/>
          <ac:spMkLst>
            <pc:docMk/>
            <pc:sldMk cId="1524448352" sldId="257"/>
            <ac:spMk id="28" creationId="{A941FE8C-4D15-47CF-A939-82D70870E0BA}"/>
          </ac:spMkLst>
        </pc:spChg>
        <pc:spChg chg="mod">
          <ac:chgData name="Simon Xin Min Dong" userId="6647684b-86c4-4538-a0ea-723982d85692" providerId="ADAL" clId="{273A2E3A-68A0-4418-9B04-456AD733E653}" dt="2021-05-21T02:37:53.630" v="781" actId="1036"/>
          <ac:spMkLst>
            <pc:docMk/>
            <pc:sldMk cId="1524448352" sldId="257"/>
            <ac:spMk id="29" creationId="{C6B48D1E-B713-46E3-A3AD-963C7A304D37}"/>
          </ac:spMkLst>
        </pc:spChg>
        <pc:spChg chg="mod">
          <ac:chgData name="Simon Xin Min Dong" userId="6647684b-86c4-4538-a0ea-723982d85692" providerId="ADAL" clId="{273A2E3A-68A0-4418-9B04-456AD733E653}" dt="2021-05-21T02:37:53.630" v="781" actId="1036"/>
          <ac:spMkLst>
            <pc:docMk/>
            <pc:sldMk cId="1524448352" sldId="257"/>
            <ac:spMk id="30" creationId="{FC1A4AB8-9A9D-410B-A80D-A5CADABE8804}"/>
          </ac:spMkLst>
        </pc:spChg>
        <pc:spChg chg="mod">
          <ac:chgData name="Simon Xin Min Dong" userId="6647684b-86c4-4538-a0ea-723982d85692" providerId="ADAL" clId="{273A2E3A-68A0-4418-9B04-456AD733E653}" dt="2021-05-21T02:37:53.630" v="781" actId="1036"/>
          <ac:spMkLst>
            <pc:docMk/>
            <pc:sldMk cId="1524448352" sldId="257"/>
            <ac:spMk id="31" creationId="{57FB2952-ABCE-4815-9426-0070102EFB6A}"/>
          </ac:spMkLst>
        </pc:spChg>
        <pc:spChg chg="mod">
          <ac:chgData name="Simon Xin Min Dong" userId="6647684b-86c4-4538-a0ea-723982d85692" providerId="ADAL" clId="{273A2E3A-68A0-4418-9B04-456AD733E653}" dt="2021-05-21T02:37:53.630" v="781" actId="1036"/>
          <ac:spMkLst>
            <pc:docMk/>
            <pc:sldMk cId="1524448352" sldId="257"/>
            <ac:spMk id="32" creationId="{3139F859-386D-4AAE-8FEE-54B4A042242A}"/>
          </ac:spMkLst>
        </pc:spChg>
        <pc:spChg chg="mod">
          <ac:chgData name="Simon Xin Min Dong" userId="6647684b-86c4-4538-a0ea-723982d85692" providerId="ADAL" clId="{273A2E3A-68A0-4418-9B04-456AD733E653}" dt="2021-05-21T02:37:53.630" v="781" actId="1036"/>
          <ac:spMkLst>
            <pc:docMk/>
            <pc:sldMk cId="1524448352" sldId="257"/>
            <ac:spMk id="33" creationId="{CC80B6DD-ECB1-4A4F-91D5-45E4266D459B}"/>
          </ac:spMkLst>
        </pc:spChg>
        <pc:grpChg chg="mod">
          <ac:chgData name="Simon Xin Min Dong" userId="6647684b-86c4-4538-a0ea-723982d85692" providerId="ADAL" clId="{273A2E3A-68A0-4418-9B04-456AD733E653}" dt="2021-05-21T02:37:53.630" v="781" actId="1036"/>
          <ac:grpSpMkLst>
            <pc:docMk/>
            <pc:sldMk cId="1524448352" sldId="257"/>
            <ac:grpSpMk id="4" creationId="{192BEC6B-DCF4-421B-9ECB-A7928E71D6A0}"/>
          </ac:grpSpMkLst>
        </pc:grpChg>
        <pc:grpChg chg="mod">
          <ac:chgData name="Simon Xin Min Dong" userId="6647684b-86c4-4538-a0ea-723982d85692" providerId="ADAL" clId="{273A2E3A-68A0-4418-9B04-456AD733E653}" dt="2021-05-21T02:37:53.630" v="781" actId="1036"/>
          <ac:grpSpMkLst>
            <pc:docMk/>
            <pc:sldMk cId="1524448352" sldId="257"/>
            <ac:grpSpMk id="16" creationId="{23F26196-9277-473E-9D32-C84F89019923}"/>
          </ac:grpSpMkLst>
        </pc:grpChg>
        <pc:grpChg chg="add mod">
          <ac:chgData name="Simon Xin Min Dong" userId="6647684b-86c4-4538-a0ea-723982d85692" providerId="ADAL" clId="{273A2E3A-68A0-4418-9B04-456AD733E653}" dt="2021-05-21T02:37:53.630" v="781" actId="1036"/>
          <ac:grpSpMkLst>
            <pc:docMk/>
            <pc:sldMk cId="1524448352" sldId="257"/>
            <ac:grpSpMk id="24" creationId="{BDA0A74B-5B13-4A2A-9CB4-BA5BEABFA8A6}"/>
          </ac:grpSpMkLst>
        </pc:grpChg>
        <pc:picChg chg="mod">
          <ac:chgData name="Simon Xin Min Dong" userId="6647684b-86c4-4538-a0ea-723982d85692" providerId="ADAL" clId="{273A2E3A-68A0-4418-9B04-456AD733E653}" dt="2021-05-21T02:37:53.630" v="781" actId="1036"/>
          <ac:picMkLst>
            <pc:docMk/>
            <pc:sldMk cId="1524448352" sldId="257"/>
            <ac:picMk id="5" creationId="{D712A5CA-4CFB-455C-A35A-DF8C2163B35E}"/>
          </ac:picMkLst>
        </pc:picChg>
      </pc:sldChg>
      <pc:sldChg chg="modSp">
        <pc:chgData name="Simon Xin Min Dong" userId="6647684b-86c4-4538-a0ea-723982d85692" providerId="ADAL" clId="{273A2E3A-68A0-4418-9B04-456AD733E653}" dt="2021-05-21T20:39:06.959" v="1571" actId="1035"/>
        <pc:sldMkLst>
          <pc:docMk/>
          <pc:sldMk cId="24903166" sldId="258"/>
        </pc:sldMkLst>
        <pc:spChg chg="mod">
          <ac:chgData name="Simon Xin Min Dong" userId="6647684b-86c4-4538-a0ea-723982d85692" providerId="ADAL" clId="{273A2E3A-68A0-4418-9B04-456AD733E653}" dt="2021-05-21T02:37:32.431" v="752" actId="1036"/>
          <ac:spMkLst>
            <pc:docMk/>
            <pc:sldMk cId="24903166" sldId="258"/>
            <ac:spMk id="9" creationId="{BC54CE21-2343-4D89-9B65-62D8A1F02028}"/>
          </ac:spMkLst>
        </pc:spChg>
        <pc:spChg chg="mod">
          <ac:chgData name="Simon Xin Min Dong" userId="6647684b-86c4-4538-a0ea-723982d85692" providerId="ADAL" clId="{273A2E3A-68A0-4418-9B04-456AD733E653}" dt="2021-05-21T02:37:32.431" v="752" actId="1036"/>
          <ac:spMkLst>
            <pc:docMk/>
            <pc:sldMk cId="24903166" sldId="258"/>
            <ac:spMk id="10" creationId="{76EC011B-F837-4122-A461-72C365A3292E}"/>
          </ac:spMkLst>
        </pc:spChg>
        <pc:spChg chg="mod">
          <ac:chgData name="Simon Xin Min Dong" userId="6647684b-86c4-4538-a0ea-723982d85692" providerId="ADAL" clId="{273A2E3A-68A0-4418-9B04-456AD733E653}" dt="2021-05-21T02:37:32.431" v="752" actId="1036"/>
          <ac:spMkLst>
            <pc:docMk/>
            <pc:sldMk cId="24903166" sldId="258"/>
            <ac:spMk id="11" creationId="{3416C2B4-AED9-4174-981F-F39E54845FD5}"/>
          </ac:spMkLst>
        </pc:spChg>
        <pc:spChg chg="mod">
          <ac:chgData name="Simon Xin Min Dong" userId="6647684b-86c4-4538-a0ea-723982d85692" providerId="ADAL" clId="{273A2E3A-68A0-4418-9B04-456AD733E653}" dt="2021-05-21T02:37:32.431" v="752" actId="1036"/>
          <ac:spMkLst>
            <pc:docMk/>
            <pc:sldMk cId="24903166" sldId="258"/>
            <ac:spMk id="12" creationId="{8E00BDF3-B2D3-49B7-8079-B6F49C956344}"/>
          </ac:spMkLst>
        </pc:spChg>
        <pc:spChg chg="mod">
          <ac:chgData name="Simon Xin Min Dong" userId="6647684b-86c4-4538-a0ea-723982d85692" providerId="ADAL" clId="{273A2E3A-68A0-4418-9B04-456AD733E653}" dt="2021-05-21T02:37:32.431" v="752" actId="1036"/>
          <ac:spMkLst>
            <pc:docMk/>
            <pc:sldMk cId="24903166" sldId="258"/>
            <ac:spMk id="13" creationId="{3727B104-C384-4412-9933-666D6BCF690D}"/>
          </ac:spMkLst>
        </pc:spChg>
        <pc:spChg chg="mod">
          <ac:chgData name="Simon Xin Min Dong" userId="6647684b-86c4-4538-a0ea-723982d85692" providerId="ADAL" clId="{273A2E3A-68A0-4418-9B04-456AD733E653}" dt="2021-05-21T02:37:32.431" v="752" actId="1036"/>
          <ac:spMkLst>
            <pc:docMk/>
            <pc:sldMk cId="24903166" sldId="258"/>
            <ac:spMk id="15" creationId="{C6C64BB5-69B0-4368-92BC-F999F4B7B2C4}"/>
          </ac:spMkLst>
        </pc:spChg>
        <pc:spChg chg="mod">
          <ac:chgData name="Simon Xin Min Dong" userId="6647684b-86c4-4538-a0ea-723982d85692" providerId="ADAL" clId="{273A2E3A-68A0-4418-9B04-456AD733E653}" dt="2021-05-21T02:37:32.431" v="752" actId="1036"/>
          <ac:spMkLst>
            <pc:docMk/>
            <pc:sldMk cId="24903166" sldId="258"/>
            <ac:spMk id="16" creationId="{F8F198F4-A560-4DB9-99E9-15EF052D26D2}"/>
          </ac:spMkLst>
        </pc:spChg>
        <pc:spChg chg="mod">
          <ac:chgData name="Simon Xin Min Dong" userId="6647684b-86c4-4538-a0ea-723982d85692" providerId="ADAL" clId="{273A2E3A-68A0-4418-9B04-456AD733E653}" dt="2021-05-21T02:37:32.431" v="752" actId="1036"/>
          <ac:spMkLst>
            <pc:docMk/>
            <pc:sldMk cId="24903166" sldId="258"/>
            <ac:spMk id="17" creationId="{5160FB62-B5DA-4D95-B50A-5B9A5DF65C74}"/>
          </ac:spMkLst>
        </pc:spChg>
        <pc:spChg chg="mod">
          <ac:chgData name="Simon Xin Min Dong" userId="6647684b-86c4-4538-a0ea-723982d85692" providerId="ADAL" clId="{273A2E3A-68A0-4418-9B04-456AD733E653}" dt="2021-05-21T02:37:32.431" v="752" actId="1036"/>
          <ac:spMkLst>
            <pc:docMk/>
            <pc:sldMk cId="24903166" sldId="258"/>
            <ac:spMk id="18" creationId="{376A89F4-0CED-44FC-980C-F847F554699A}"/>
          </ac:spMkLst>
        </pc:spChg>
        <pc:spChg chg="mod">
          <ac:chgData name="Simon Xin Min Dong" userId="6647684b-86c4-4538-a0ea-723982d85692" providerId="ADAL" clId="{273A2E3A-68A0-4418-9B04-456AD733E653}" dt="2021-05-21T02:37:32.431" v="752" actId="1036"/>
          <ac:spMkLst>
            <pc:docMk/>
            <pc:sldMk cId="24903166" sldId="258"/>
            <ac:spMk id="19" creationId="{014E83B0-209B-4413-A4AC-A22C49009050}"/>
          </ac:spMkLst>
        </pc:spChg>
        <pc:spChg chg="mod">
          <ac:chgData name="Simon Xin Min Dong" userId="6647684b-86c4-4538-a0ea-723982d85692" providerId="ADAL" clId="{273A2E3A-68A0-4418-9B04-456AD733E653}" dt="2021-05-21T02:37:32.431" v="752" actId="1036"/>
          <ac:spMkLst>
            <pc:docMk/>
            <pc:sldMk cId="24903166" sldId="258"/>
            <ac:spMk id="20" creationId="{C1269DFE-4D5D-4A76-89EA-7485FD36A53D}"/>
          </ac:spMkLst>
        </pc:spChg>
        <pc:spChg chg="mod">
          <ac:chgData name="Simon Xin Min Dong" userId="6647684b-86c4-4538-a0ea-723982d85692" providerId="ADAL" clId="{273A2E3A-68A0-4418-9B04-456AD733E653}" dt="2021-05-21T02:37:32.431" v="752" actId="1036"/>
          <ac:spMkLst>
            <pc:docMk/>
            <pc:sldMk cId="24903166" sldId="258"/>
            <ac:spMk id="21" creationId="{4E60D663-1967-4319-8E35-E99E3DBAA729}"/>
          </ac:spMkLst>
        </pc:spChg>
        <pc:spChg chg="mod">
          <ac:chgData name="Simon Xin Min Dong" userId="6647684b-86c4-4538-a0ea-723982d85692" providerId="ADAL" clId="{273A2E3A-68A0-4418-9B04-456AD733E653}" dt="2021-05-21T02:37:32.431" v="752" actId="1036"/>
          <ac:spMkLst>
            <pc:docMk/>
            <pc:sldMk cId="24903166" sldId="258"/>
            <ac:spMk id="22" creationId="{872D9243-86C9-48B2-8897-91B8E5E9821E}"/>
          </ac:spMkLst>
        </pc:spChg>
        <pc:spChg chg="mod">
          <ac:chgData name="Simon Xin Min Dong" userId="6647684b-86c4-4538-a0ea-723982d85692" providerId="ADAL" clId="{273A2E3A-68A0-4418-9B04-456AD733E653}" dt="2021-05-21T02:37:32.431" v="752" actId="1036"/>
          <ac:spMkLst>
            <pc:docMk/>
            <pc:sldMk cId="24903166" sldId="258"/>
            <ac:spMk id="23" creationId="{BC7FDF84-2C85-4814-912C-708A739A85DB}"/>
          </ac:spMkLst>
        </pc:spChg>
        <pc:spChg chg="mod">
          <ac:chgData name="Simon Xin Min Dong" userId="6647684b-86c4-4538-a0ea-723982d85692" providerId="ADAL" clId="{273A2E3A-68A0-4418-9B04-456AD733E653}" dt="2021-05-21T02:37:32.431" v="752" actId="1036"/>
          <ac:spMkLst>
            <pc:docMk/>
            <pc:sldMk cId="24903166" sldId="258"/>
            <ac:spMk id="24" creationId="{48DF8348-E3D2-4078-8582-39BDE87C0E74}"/>
          </ac:spMkLst>
        </pc:spChg>
        <pc:spChg chg="mod">
          <ac:chgData name="Simon Xin Min Dong" userId="6647684b-86c4-4538-a0ea-723982d85692" providerId="ADAL" clId="{273A2E3A-68A0-4418-9B04-456AD733E653}" dt="2021-05-21T20:39:06.959" v="1571" actId="1035"/>
          <ac:spMkLst>
            <pc:docMk/>
            <pc:sldMk cId="24903166" sldId="258"/>
            <ac:spMk id="26" creationId="{74E60019-D739-49D2-9ADF-959D1ED6C208}"/>
          </ac:spMkLst>
        </pc:spChg>
        <pc:spChg chg="mod">
          <ac:chgData name="Simon Xin Min Dong" userId="6647684b-86c4-4538-a0ea-723982d85692" providerId="ADAL" clId="{273A2E3A-68A0-4418-9B04-456AD733E653}" dt="2021-05-21T20:39:06.959" v="1571" actId="1035"/>
          <ac:spMkLst>
            <pc:docMk/>
            <pc:sldMk cId="24903166" sldId="258"/>
            <ac:spMk id="28" creationId="{88AF072C-AB15-48CB-AC5E-BC4E1F8F1ED7}"/>
          </ac:spMkLst>
        </pc:spChg>
        <pc:spChg chg="mod">
          <ac:chgData name="Simon Xin Min Dong" userId="6647684b-86c4-4538-a0ea-723982d85692" providerId="ADAL" clId="{273A2E3A-68A0-4418-9B04-456AD733E653}" dt="2021-05-21T02:37:32.431" v="752" actId="1036"/>
          <ac:spMkLst>
            <pc:docMk/>
            <pc:sldMk cId="24903166" sldId="258"/>
            <ac:spMk id="30" creationId="{D45E8919-BA32-40F3-AC04-BD68E173ECB6}"/>
          </ac:spMkLst>
        </pc:spChg>
        <pc:spChg chg="mod">
          <ac:chgData name="Simon Xin Min Dong" userId="6647684b-86c4-4538-a0ea-723982d85692" providerId="ADAL" clId="{273A2E3A-68A0-4418-9B04-456AD733E653}" dt="2021-05-21T02:37:32.431" v="752" actId="1036"/>
          <ac:spMkLst>
            <pc:docMk/>
            <pc:sldMk cId="24903166" sldId="258"/>
            <ac:spMk id="31" creationId="{6A96258D-A092-4BA8-A632-B7CFB4ED94CC}"/>
          </ac:spMkLst>
        </pc:spChg>
        <pc:spChg chg="mod">
          <ac:chgData name="Simon Xin Min Dong" userId="6647684b-86c4-4538-a0ea-723982d85692" providerId="ADAL" clId="{273A2E3A-68A0-4418-9B04-456AD733E653}" dt="2021-05-21T02:37:32.431" v="752" actId="1036"/>
          <ac:spMkLst>
            <pc:docMk/>
            <pc:sldMk cId="24903166" sldId="258"/>
            <ac:spMk id="32" creationId="{4F02C9A2-15F8-4A0A-AC33-3C197476F876}"/>
          </ac:spMkLst>
        </pc:spChg>
        <pc:grpChg chg="mod">
          <ac:chgData name="Simon Xin Min Dong" userId="6647684b-86c4-4538-a0ea-723982d85692" providerId="ADAL" clId="{273A2E3A-68A0-4418-9B04-456AD733E653}" dt="2021-05-21T02:37:32.431" v="752" actId="1036"/>
          <ac:grpSpMkLst>
            <pc:docMk/>
            <pc:sldMk cId="24903166" sldId="258"/>
            <ac:grpSpMk id="8" creationId="{1330D5C4-F491-461E-9A88-17C8BF6B2F04}"/>
          </ac:grpSpMkLst>
        </pc:grpChg>
        <pc:grpChg chg="mod">
          <ac:chgData name="Simon Xin Min Dong" userId="6647684b-86c4-4538-a0ea-723982d85692" providerId="ADAL" clId="{273A2E3A-68A0-4418-9B04-456AD733E653}" dt="2021-05-21T02:37:32.431" v="752" actId="1036"/>
          <ac:grpSpMkLst>
            <pc:docMk/>
            <pc:sldMk cId="24903166" sldId="258"/>
            <ac:grpSpMk id="14" creationId="{52FF0975-ECE9-4689-B5B6-4B2E9D199DB2}"/>
          </ac:grpSpMkLst>
        </pc:grpChg>
        <pc:grpChg chg="mod">
          <ac:chgData name="Simon Xin Min Dong" userId="6647684b-86c4-4538-a0ea-723982d85692" providerId="ADAL" clId="{273A2E3A-68A0-4418-9B04-456AD733E653}" dt="2021-05-21T20:39:06.959" v="1571" actId="1035"/>
          <ac:grpSpMkLst>
            <pc:docMk/>
            <pc:sldMk cId="24903166" sldId="258"/>
            <ac:grpSpMk id="25" creationId="{85AC889D-BA63-4E5F-8269-5481D62255AB}"/>
          </ac:grpSpMkLst>
        </pc:grpChg>
        <pc:picChg chg="mod">
          <ac:chgData name="Simon Xin Min Dong" userId="6647684b-86c4-4538-a0ea-723982d85692" providerId="ADAL" clId="{273A2E3A-68A0-4418-9B04-456AD733E653}" dt="2021-05-21T02:37:32.431" v="752" actId="1036"/>
          <ac:picMkLst>
            <pc:docMk/>
            <pc:sldMk cId="24903166" sldId="258"/>
            <ac:picMk id="7" creationId="{346975D3-1D78-4F3F-ACE8-1142FFB6354E}"/>
          </ac:picMkLst>
        </pc:picChg>
      </pc:sldChg>
      <pc:sldChg chg="delSp modSp">
        <pc:chgData name="Simon Xin Min Dong" userId="6647684b-86c4-4538-a0ea-723982d85692" providerId="ADAL" clId="{273A2E3A-68A0-4418-9B04-456AD733E653}" dt="2021-05-21T00:51:56.733" v="217" actId="165"/>
        <pc:sldMkLst>
          <pc:docMk/>
          <pc:sldMk cId="2173231402" sldId="259"/>
        </pc:sldMkLst>
        <pc:spChg chg="mod">
          <ac:chgData name="Simon Xin Min Dong" userId="6647684b-86c4-4538-a0ea-723982d85692" providerId="ADAL" clId="{273A2E3A-68A0-4418-9B04-456AD733E653}" dt="2021-05-21T00:51:56.733" v="217" actId="165"/>
          <ac:spMkLst>
            <pc:docMk/>
            <pc:sldMk cId="2173231402" sldId="259"/>
            <ac:spMk id="5" creationId="{1AF6F294-6C1B-4057-A4C6-56FA929DC5BA}"/>
          </ac:spMkLst>
        </pc:spChg>
        <pc:spChg chg="mod">
          <ac:chgData name="Simon Xin Min Dong" userId="6647684b-86c4-4538-a0ea-723982d85692" providerId="ADAL" clId="{273A2E3A-68A0-4418-9B04-456AD733E653}" dt="2021-05-21T00:51:56.733" v="217" actId="165"/>
          <ac:spMkLst>
            <pc:docMk/>
            <pc:sldMk cId="2173231402" sldId="259"/>
            <ac:spMk id="6" creationId="{1D4AFCD0-D909-4392-9364-BF28288CC7A1}"/>
          </ac:spMkLst>
        </pc:spChg>
        <pc:spChg chg="mod">
          <ac:chgData name="Simon Xin Min Dong" userId="6647684b-86c4-4538-a0ea-723982d85692" providerId="ADAL" clId="{273A2E3A-68A0-4418-9B04-456AD733E653}" dt="2021-05-21T00:51:56.733" v="217" actId="165"/>
          <ac:spMkLst>
            <pc:docMk/>
            <pc:sldMk cId="2173231402" sldId="259"/>
            <ac:spMk id="7" creationId="{59CEB8EA-BE04-4C39-BE1A-4327E85F0315}"/>
          </ac:spMkLst>
        </pc:spChg>
        <pc:spChg chg="mod">
          <ac:chgData name="Simon Xin Min Dong" userId="6647684b-86c4-4538-a0ea-723982d85692" providerId="ADAL" clId="{273A2E3A-68A0-4418-9B04-456AD733E653}" dt="2021-05-21T00:51:56.733" v="217" actId="165"/>
          <ac:spMkLst>
            <pc:docMk/>
            <pc:sldMk cId="2173231402" sldId="259"/>
            <ac:spMk id="10" creationId="{3C3466D3-38C9-48B7-9524-007621BB828F}"/>
          </ac:spMkLst>
        </pc:spChg>
        <pc:spChg chg="mod">
          <ac:chgData name="Simon Xin Min Dong" userId="6647684b-86c4-4538-a0ea-723982d85692" providerId="ADAL" clId="{273A2E3A-68A0-4418-9B04-456AD733E653}" dt="2021-05-21T00:51:56.733" v="217" actId="165"/>
          <ac:spMkLst>
            <pc:docMk/>
            <pc:sldMk cId="2173231402" sldId="259"/>
            <ac:spMk id="12" creationId="{664302CB-A117-4FA2-B658-495BAFE4A506}"/>
          </ac:spMkLst>
        </pc:spChg>
        <pc:spChg chg="mod">
          <ac:chgData name="Simon Xin Min Dong" userId="6647684b-86c4-4538-a0ea-723982d85692" providerId="ADAL" clId="{273A2E3A-68A0-4418-9B04-456AD733E653}" dt="2021-05-21T00:51:56.733" v="217" actId="165"/>
          <ac:spMkLst>
            <pc:docMk/>
            <pc:sldMk cId="2173231402" sldId="259"/>
            <ac:spMk id="13" creationId="{05C18B95-2218-4A32-B0D6-392E2CCEDEC5}"/>
          </ac:spMkLst>
        </pc:spChg>
        <pc:spChg chg="mod">
          <ac:chgData name="Simon Xin Min Dong" userId="6647684b-86c4-4538-a0ea-723982d85692" providerId="ADAL" clId="{273A2E3A-68A0-4418-9B04-456AD733E653}" dt="2021-05-21T00:51:56.733" v="217" actId="165"/>
          <ac:spMkLst>
            <pc:docMk/>
            <pc:sldMk cId="2173231402" sldId="259"/>
            <ac:spMk id="14" creationId="{E8EFA767-CD91-412A-A79C-38661298F3D6}"/>
          </ac:spMkLst>
        </pc:spChg>
        <pc:spChg chg="mod topLvl">
          <ac:chgData name="Simon Xin Min Dong" userId="6647684b-86c4-4538-a0ea-723982d85692" providerId="ADAL" clId="{273A2E3A-68A0-4418-9B04-456AD733E653}" dt="2021-05-21T00:51:56.733" v="217" actId="165"/>
          <ac:spMkLst>
            <pc:docMk/>
            <pc:sldMk cId="2173231402" sldId="259"/>
            <ac:spMk id="16" creationId="{69B608CF-9AAC-412E-A678-0CE34896CD62}"/>
          </ac:spMkLst>
        </pc:spChg>
        <pc:spChg chg="mod topLvl">
          <ac:chgData name="Simon Xin Min Dong" userId="6647684b-86c4-4538-a0ea-723982d85692" providerId="ADAL" clId="{273A2E3A-68A0-4418-9B04-456AD733E653}" dt="2021-05-21T00:51:56.733" v="217" actId="165"/>
          <ac:spMkLst>
            <pc:docMk/>
            <pc:sldMk cId="2173231402" sldId="259"/>
            <ac:spMk id="17" creationId="{61735AC7-8F98-44D8-864B-95B99E0B4307}"/>
          </ac:spMkLst>
        </pc:spChg>
        <pc:spChg chg="mod topLvl">
          <ac:chgData name="Simon Xin Min Dong" userId="6647684b-86c4-4538-a0ea-723982d85692" providerId="ADAL" clId="{273A2E3A-68A0-4418-9B04-456AD733E653}" dt="2021-05-21T00:51:56.733" v="217" actId="165"/>
          <ac:spMkLst>
            <pc:docMk/>
            <pc:sldMk cId="2173231402" sldId="259"/>
            <ac:spMk id="18" creationId="{11D7F7FE-A51E-4FB2-96E9-449887321516}"/>
          </ac:spMkLst>
        </pc:spChg>
        <pc:spChg chg="mod topLvl">
          <ac:chgData name="Simon Xin Min Dong" userId="6647684b-86c4-4538-a0ea-723982d85692" providerId="ADAL" clId="{273A2E3A-68A0-4418-9B04-456AD733E653}" dt="2021-05-21T00:51:56.733" v="217" actId="165"/>
          <ac:spMkLst>
            <pc:docMk/>
            <pc:sldMk cId="2173231402" sldId="259"/>
            <ac:spMk id="29" creationId="{B18C1E08-0A08-4CF7-85C1-537521AEFC2B}"/>
          </ac:spMkLst>
        </pc:spChg>
        <pc:spChg chg="mod topLvl">
          <ac:chgData name="Simon Xin Min Dong" userId="6647684b-86c4-4538-a0ea-723982d85692" providerId="ADAL" clId="{273A2E3A-68A0-4418-9B04-456AD733E653}" dt="2021-05-21T00:51:56.733" v="217" actId="165"/>
          <ac:spMkLst>
            <pc:docMk/>
            <pc:sldMk cId="2173231402" sldId="259"/>
            <ac:spMk id="30" creationId="{72DCE368-4FBB-4373-AF5C-6E2651607BF8}"/>
          </ac:spMkLst>
        </pc:spChg>
        <pc:spChg chg="mod topLvl">
          <ac:chgData name="Simon Xin Min Dong" userId="6647684b-86c4-4538-a0ea-723982d85692" providerId="ADAL" clId="{273A2E3A-68A0-4418-9B04-456AD733E653}" dt="2021-05-21T00:51:56.733" v="217" actId="165"/>
          <ac:spMkLst>
            <pc:docMk/>
            <pc:sldMk cId="2173231402" sldId="259"/>
            <ac:spMk id="33" creationId="{B47D4765-1B17-484A-9FFD-DE4B616B23CE}"/>
          </ac:spMkLst>
        </pc:spChg>
        <pc:spChg chg="mod topLvl">
          <ac:chgData name="Simon Xin Min Dong" userId="6647684b-86c4-4538-a0ea-723982d85692" providerId="ADAL" clId="{273A2E3A-68A0-4418-9B04-456AD733E653}" dt="2021-05-21T00:51:56.733" v="217" actId="165"/>
          <ac:spMkLst>
            <pc:docMk/>
            <pc:sldMk cId="2173231402" sldId="259"/>
            <ac:spMk id="34" creationId="{FBC5777A-F4AC-451B-A00F-225C3910D434}"/>
          </ac:spMkLst>
        </pc:spChg>
        <pc:spChg chg="mod topLvl">
          <ac:chgData name="Simon Xin Min Dong" userId="6647684b-86c4-4538-a0ea-723982d85692" providerId="ADAL" clId="{273A2E3A-68A0-4418-9B04-456AD733E653}" dt="2021-05-21T00:51:56.733" v="217" actId="165"/>
          <ac:spMkLst>
            <pc:docMk/>
            <pc:sldMk cId="2173231402" sldId="259"/>
            <ac:spMk id="35" creationId="{FF2994C6-668A-45A2-BB4A-48D67BC194F1}"/>
          </ac:spMkLst>
        </pc:spChg>
        <pc:spChg chg="mod topLvl">
          <ac:chgData name="Simon Xin Min Dong" userId="6647684b-86c4-4538-a0ea-723982d85692" providerId="ADAL" clId="{273A2E3A-68A0-4418-9B04-456AD733E653}" dt="2021-05-21T00:51:56.733" v="217" actId="165"/>
          <ac:spMkLst>
            <pc:docMk/>
            <pc:sldMk cId="2173231402" sldId="259"/>
            <ac:spMk id="38" creationId="{BEFB24DB-990F-43D3-9FA4-490A456877BD}"/>
          </ac:spMkLst>
        </pc:spChg>
        <pc:spChg chg="mod topLvl">
          <ac:chgData name="Simon Xin Min Dong" userId="6647684b-86c4-4538-a0ea-723982d85692" providerId="ADAL" clId="{273A2E3A-68A0-4418-9B04-456AD733E653}" dt="2021-05-21T00:51:56.733" v="217" actId="165"/>
          <ac:spMkLst>
            <pc:docMk/>
            <pc:sldMk cId="2173231402" sldId="259"/>
            <ac:spMk id="39" creationId="{72FF14CE-31C7-4BF6-A3AE-874E2826A9F2}"/>
          </ac:spMkLst>
        </pc:spChg>
        <pc:spChg chg="mod topLvl">
          <ac:chgData name="Simon Xin Min Dong" userId="6647684b-86c4-4538-a0ea-723982d85692" providerId="ADAL" clId="{273A2E3A-68A0-4418-9B04-456AD733E653}" dt="2021-05-21T00:51:56.733" v="217" actId="165"/>
          <ac:spMkLst>
            <pc:docMk/>
            <pc:sldMk cId="2173231402" sldId="259"/>
            <ac:spMk id="40" creationId="{7220B53F-4A71-4672-8807-23E68E6D2929}"/>
          </ac:spMkLst>
        </pc:spChg>
        <pc:spChg chg="mod topLvl">
          <ac:chgData name="Simon Xin Min Dong" userId="6647684b-86c4-4538-a0ea-723982d85692" providerId="ADAL" clId="{273A2E3A-68A0-4418-9B04-456AD733E653}" dt="2021-05-21T00:51:56.733" v="217" actId="165"/>
          <ac:spMkLst>
            <pc:docMk/>
            <pc:sldMk cId="2173231402" sldId="259"/>
            <ac:spMk id="41" creationId="{038BD4C1-37C5-441D-98D2-51FAAE5646B6}"/>
          </ac:spMkLst>
        </pc:spChg>
        <pc:spChg chg="mod topLvl">
          <ac:chgData name="Simon Xin Min Dong" userId="6647684b-86c4-4538-a0ea-723982d85692" providerId="ADAL" clId="{273A2E3A-68A0-4418-9B04-456AD733E653}" dt="2021-05-21T00:51:56.733" v="217" actId="165"/>
          <ac:spMkLst>
            <pc:docMk/>
            <pc:sldMk cId="2173231402" sldId="259"/>
            <ac:spMk id="42" creationId="{BF805D95-E515-4A59-ADD3-4F7C334CD83E}"/>
          </ac:spMkLst>
        </pc:spChg>
        <pc:grpChg chg="del mod">
          <ac:chgData name="Simon Xin Min Dong" userId="6647684b-86c4-4538-a0ea-723982d85692" providerId="ADAL" clId="{273A2E3A-68A0-4418-9B04-456AD733E653}" dt="2021-05-21T00:51:56.733" v="217" actId="165"/>
          <ac:grpSpMkLst>
            <pc:docMk/>
            <pc:sldMk cId="2173231402" sldId="259"/>
            <ac:grpSpMk id="2" creationId="{516FFCA9-3B26-40D8-8EE4-819BB85899C2}"/>
          </ac:grpSpMkLst>
        </pc:grpChg>
        <pc:grpChg chg="mod topLvl">
          <ac:chgData name="Simon Xin Min Dong" userId="6647684b-86c4-4538-a0ea-723982d85692" providerId="ADAL" clId="{273A2E3A-68A0-4418-9B04-456AD733E653}" dt="2021-05-21T00:51:56.733" v="217" actId="165"/>
          <ac:grpSpMkLst>
            <pc:docMk/>
            <pc:sldMk cId="2173231402" sldId="259"/>
            <ac:grpSpMk id="4" creationId="{A0482A0C-84B9-41FC-B5A3-DF1C6042ADB2}"/>
          </ac:grpSpMkLst>
        </pc:grpChg>
        <pc:picChg chg="mod topLvl">
          <ac:chgData name="Simon Xin Min Dong" userId="6647684b-86c4-4538-a0ea-723982d85692" providerId="ADAL" clId="{273A2E3A-68A0-4418-9B04-456AD733E653}" dt="2021-05-21T00:51:56.733" v="217" actId="165"/>
          <ac:picMkLst>
            <pc:docMk/>
            <pc:sldMk cId="2173231402" sldId="259"/>
            <ac:picMk id="3" creationId="{A8BB2EE5-4756-4492-B239-1488EF601A9A}"/>
          </ac:picMkLst>
        </pc:picChg>
      </pc:sldChg>
      <pc:sldChg chg="modSp mod">
        <pc:chgData name="Simon Xin Min Dong" userId="6647684b-86c4-4538-a0ea-723982d85692" providerId="ADAL" clId="{273A2E3A-68A0-4418-9B04-456AD733E653}" dt="2021-05-21T00:32:19.424" v="56" actId="14100"/>
        <pc:sldMkLst>
          <pc:docMk/>
          <pc:sldMk cId="1772152896" sldId="260"/>
        </pc:sldMkLst>
        <pc:spChg chg="mod">
          <ac:chgData name="Simon Xin Min Dong" userId="6647684b-86c4-4538-a0ea-723982d85692" providerId="ADAL" clId="{273A2E3A-68A0-4418-9B04-456AD733E653}" dt="2021-05-21T00:32:10.298" v="55" actId="1038"/>
          <ac:spMkLst>
            <pc:docMk/>
            <pc:sldMk cId="1772152896" sldId="260"/>
            <ac:spMk id="28" creationId="{6A11280C-4F58-4CDD-8985-AB8E6DEF8980}"/>
          </ac:spMkLst>
        </pc:spChg>
        <pc:spChg chg="mod">
          <ac:chgData name="Simon Xin Min Dong" userId="6647684b-86c4-4538-a0ea-723982d85692" providerId="ADAL" clId="{273A2E3A-68A0-4418-9B04-456AD733E653}" dt="2021-05-21T00:32:19.424" v="56" actId="14100"/>
          <ac:spMkLst>
            <pc:docMk/>
            <pc:sldMk cId="1772152896" sldId="260"/>
            <ac:spMk id="29" creationId="{6E35AEE7-D84A-4EC5-8D5B-8B49FD62023A}"/>
          </ac:spMkLst>
        </pc:spChg>
      </pc:sldChg>
      <pc:sldChg chg="addSp delSp modSp mod">
        <pc:chgData name="Simon Xin Min Dong" userId="6647684b-86c4-4538-a0ea-723982d85692" providerId="ADAL" clId="{273A2E3A-68A0-4418-9B04-456AD733E653}" dt="2021-05-21T00:48:40.952" v="204" actId="1036"/>
        <pc:sldMkLst>
          <pc:docMk/>
          <pc:sldMk cId="1821796093" sldId="261"/>
        </pc:sldMkLst>
        <pc:spChg chg="mod">
          <ac:chgData name="Simon Xin Min Dong" userId="6647684b-86c4-4538-a0ea-723982d85692" providerId="ADAL" clId="{273A2E3A-68A0-4418-9B04-456AD733E653}" dt="2021-05-21T00:47:16.013" v="165"/>
          <ac:spMkLst>
            <pc:docMk/>
            <pc:sldMk cId="1821796093" sldId="261"/>
            <ac:spMk id="2" creationId="{7DDC36C8-E00F-46F7-9501-2DD2798B8DCA}"/>
          </ac:spMkLst>
        </pc:spChg>
        <pc:spChg chg="mod">
          <ac:chgData name="Simon Xin Min Dong" userId="6647684b-86c4-4538-a0ea-723982d85692" providerId="ADAL" clId="{273A2E3A-68A0-4418-9B04-456AD733E653}" dt="2021-05-21T00:36:46.842" v="69" actId="6549"/>
          <ac:spMkLst>
            <pc:docMk/>
            <pc:sldMk cId="1821796093" sldId="261"/>
            <ac:spMk id="6" creationId="{9A967DDE-FAB2-4C70-A6CA-EEACA6714B12}"/>
          </ac:spMkLst>
        </pc:spChg>
        <pc:spChg chg="mod">
          <ac:chgData name="Simon Xin Min Dong" userId="6647684b-86c4-4538-a0ea-723982d85692" providerId="ADAL" clId="{273A2E3A-68A0-4418-9B04-456AD733E653}" dt="2021-05-21T00:36:44.130" v="66" actId="1076"/>
          <ac:spMkLst>
            <pc:docMk/>
            <pc:sldMk cId="1821796093" sldId="261"/>
            <ac:spMk id="7" creationId="{7F55AEED-BB6D-4CAD-B107-DA849D24E8D9}"/>
          </ac:spMkLst>
        </pc:spChg>
        <pc:spChg chg="mod">
          <ac:chgData name="Simon Xin Min Dong" userId="6647684b-86c4-4538-a0ea-723982d85692" providerId="ADAL" clId="{273A2E3A-68A0-4418-9B04-456AD733E653}" dt="2021-05-21T00:36:44.130" v="66" actId="1076"/>
          <ac:spMkLst>
            <pc:docMk/>
            <pc:sldMk cId="1821796093" sldId="261"/>
            <ac:spMk id="8" creationId="{33AD27ED-EB02-4C46-B2FA-AE2D3077989F}"/>
          </ac:spMkLst>
        </pc:spChg>
        <pc:spChg chg="mod">
          <ac:chgData name="Simon Xin Min Dong" userId="6647684b-86c4-4538-a0ea-723982d85692" providerId="ADAL" clId="{273A2E3A-68A0-4418-9B04-456AD733E653}" dt="2021-05-21T00:36:44.130" v="66" actId="1076"/>
          <ac:spMkLst>
            <pc:docMk/>
            <pc:sldMk cId="1821796093" sldId="261"/>
            <ac:spMk id="9" creationId="{70B9CACC-9A86-404C-BA7C-CC6E8A5D8E16}"/>
          </ac:spMkLst>
        </pc:spChg>
        <pc:spChg chg="mod">
          <ac:chgData name="Simon Xin Min Dong" userId="6647684b-86c4-4538-a0ea-723982d85692" providerId="ADAL" clId="{273A2E3A-68A0-4418-9B04-456AD733E653}" dt="2021-05-21T00:36:44.130" v="66" actId="1076"/>
          <ac:spMkLst>
            <pc:docMk/>
            <pc:sldMk cId="1821796093" sldId="261"/>
            <ac:spMk id="10" creationId="{AE5FC1C7-0A14-4E63-95BE-AC94F9472C22}"/>
          </ac:spMkLst>
        </pc:spChg>
        <pc:spChg chg="mod">
          <ac:chgData name="Simon Xin Min Dong" userId="6647684b-86c4-4538-a0ea-723982d85692" providerId="ADAL" clId="{273A2E3A-68A0-4418-9B04-456AD733E653}" dt="2021-05-21T00:48:16.642" v="201" actId="1036"/>
          <ac:spMkLst>
            <pc:docMk/>
            <pc:sldMk cId="1821796093" sldId="261"/>
            <ac:spMk id="12" creationId="{C61D9882-14A6-4411-9277-FBEB76A117D0}"/>
          </ac:spMkLst>
        </pc:spChg>
        <pc:spChg chg="mod">
          <ac:chgData name="Simon Xin Min Dong" userId="6647684b-86c4-4538-a0ea-723982d85692" providerId="ADAL" clId="{273A2E3A-68A0-4418-9B04-456AD733E653}" dt="2021-05-21T00:48:16.642" v="201" actId="1036"/>
          <ac:spMkLst>
            <pc:docMk/>
            <pc:sldMk cId="1821796093" sldId="261"/>
            <ac:spMk id="13" creationId="{CBE86A7F-F30F-4F26-94C0-E1D46A73DFD8}"/>
          </ac:spMkLst>
        </pc:spChg>
        <pc:spChg chg="mod">
          <ac:chgData name="Simon Xin Min Dong" userId="6647684b-86c4-4538-a0ea-723982d85692" providerId="ADAL" clId="{273A2E3A-68A0-4418-9B04-456AD733E653}" dt="2021-05-21T00:48:16.642" v="201" actId="1036"/>
          <ac:spMkLst>
            <pc:docMk/>
            <pc:sldMk cId="1821796093" sldId="261"/>
            <ac:spMk id="14" creationId="{89409F9F-E46D-4981-9439-08382A75594F}"/>
          </ac:spMkLst>
        </pc:spChg>
        <pc:spChg chg="del mod">
          <ac:chgData name="Simon Xin Min Dong" userId="6647684b-86c4-4538-a0ea-723982d85692" providerId="ADAL" clId="{273A2E3A-68A0-4418-9B04-456AD733E653}" dt="2021-05-21T00:38:09.547" v="81" actId="478"/>
          <ac:spMkLst>
            <pc:docMk/>
            <pc:sldMk cId="1821796093" sldId="261"/>
            <ac:spMk id="15" creationId="{A9CE8680-1E37-47AF-8306-2527262ED543}"/>
          </ac:spMkLst>
        </pc:spChg>
        <pc:spChg chg="mod">
          <ac:chgData name="Simon Xin Min Dong" userId="6647684b-86c4-4538-a0ea-723982d85692" providerId="ADAL" clId="{273A2E3A-68A0-4418-9B04-456AD733E653}" dt="2021-05-21T00:48:16.642" v="201" actId="1036"/>
          <ac:spMkLst>
            <pc:docMk/>
            <pc:sldMk cId="1821796093" sldId="261"/>
            <ac:spMk id="16" creationId="{4E941C80-3CE6-4784-BBAB-73C60ABB184C}"/>
          </ac:spMkLst>
        </pc:spChg>
        <pc:spChg chg="del mod">
          <ac:chgData name="Simon Xin Min Dong" userId="6647684b-86c4-4538-a0ea-723982d85692" providerId="ADAL" clId="{273A2E3A-68A0-4418-9B04-456AD733E653}" dt="2021-05-21T00:37:29.679" v="75" actId="478"/>
          <ac:spMkLst>
            <pc:docMk/>
            <pc:sldMk cId="1821796093" sldId="261"/>
            <ac:spMk id="17" creationId="{A75715CA-467F-4952-9A40-60326DA2BCE8}"/>
          </ac:spMkLst>
        </pc:spChg>
        <pc:spChg chg="mod">
          <ac:chgData name="Simon Xin Min Dong" userId="6647684b-86c4-4538-a0ea-723982d85692" providerId="ADAL" clId="{273A2E3A-68A0-4418-9B04-456AD733E653}" dt="2021-05-21T00:48:16.642" v="201" actId="1036"/>
          <ac:spMkLst>
            <pc:docMk/>
            <pc:sldMk cId="1821796093" sldId="261"/>
            <ac:spMk id="18" creationId="{9E5C0F92-4FCC-44F5-8FAF-CDBF560753AF}"/>
          </ac:spMkLst>
        </pc:spChg>
        <pc:spChg chg="del mod">
          <ac:chgData name="Simon Xin Min Dong" userId="6647684b-86c4-4538-a0ea-723982d85692" providerId="ADAL" clId="{273A2E3A-68A0-4418-9B04-456AD733E653}" dt="2021-05-21T00:37:22.301" v="73" actId="478"/>
          <ac:spMkLst>
            <pc:docMk/>
            <pc:sldMk cId="1821796093" sldId="261"/>
            <ac:spMk id="19" creationId="{CB914ED7-A241-4EA0-A549-B4D32C5CCEAC}"/>
          </ac:spMkLst>
        </pc:spChg>
        <pc:spChg chg="del mod">
          <ac:chgData name="Simon Xin Min Dong" userId="6647684b-86c4-4538-a0ea-723982d85692" providerId="ADAL" clId="{273A2E3A-68A0-4418-9B04-456AD733E653}" dt="2021-05-21T00:37:25.473" v="74" actId="478"/>
          <ac:spMkLst>
            <pc:docMk/>
            <pc:sldMk cId="1821796093" sldId="261"/>
            <ac:spMk id="20" creationId="{1E83883D-6D73-409F-84DF-4DFD4D3AEC7D}"/>
          </ac:spMkLst>
        </pc:spChg>
        <pc:spChg chg="mod">
          <ac:chgData name="Simon Xin Min Dong" userId="6647684b-86c4-4538-a0ea-723982d85692" providerId="ADAL" clId="{273A2E3A-68A0-4418-9B04-456AD733E653}" dt="2021-05-21T00:48:16.642" v="201" actId="1036"/>
          <ac:spMkLst>
            <pc:docMk/>
            <pc:sldMk cId="1821796093" sldId="261"/>
            <ac:spMk id="21" creationId="{E6538EFA-7F08-4EA9-A6F1-C218FEF49087}"/>
          </ac:spMkLst>
        </pc:spChg>
        <pc:spChg chg="add mod">
          <ac:chgData name="Simon Xin Min Dong" userId="6647684b-86c4-4538-a0ea-723982d85692" providerId="ADAL" clId="{273A2E3A-68A0-4418-9B04-456AD733E653}" dt="2021-05-21T00:48:40.952" v="204" actId="1036"/>
          <ac:spMkLst>
            <pc:docMk/>
            <pc:sldMk cId="1821796093" sldId="261"/>
            <ac:spMk id="22" creationId="{FF164BD7-51D2-411D-9006-FF480847CE6A}"/>
          </ac:spMkLst>
        </pc:spChg>
        <pc:spChg chg="add mod">
          <ac:chgData name="Simon Xin Min Dong" userId="6647684b-86c4-4538-a0ea-723982d85692" providerId="ADAL" clId="{273A2E3A-68A0-4418-9B04-456AD733E653}" dt="2021-05-21T00:48:16.642" v="201" actId="1036"/>
          <ac:spMkLst>
            <pc:docMk/>
            <pc:sldMk cId="1821796093" sldId="261"/>
            <ac:spMk id="23" creationId="{34532B50-85C1-4F81-B91B-8C054C37D343}"/>
          </ac:spMkLst>
        </pc:spChg>
        <pc:spChg chg="add mod">
          <ac:chgData name="Simon Xin Min Dong" userId="6647684b-86c4-4538-a0ea-723982d85692" providerId="ADAL" clId="{273A2E3A-68A0-4418-9B04-456AD733E653}" dt="2021-05-21T00:48:16.642" v="201" actId="1036"/>
          <ac:spMkLst>
            <pc:docMk/>
            <pc:sldMk cId="1821796093" sldId="261"/>
            <ac:spMk id="24" creationId="{AE966E9C-5841-4B25-B4C2-E204DD0064D5}"/>
          </ac:spMkLst>
        </pc:spChg>
        <pc:spChg chg="add mod">
          <ac:chgData name="Simon Xin Min Dong" userId="6647684b-86c4-4538-a0ea-723982d85692" providerId="ADAL" clId="{273A2E3A-68A0-4418-9B04-456AD733E653}" dt="2021-05-21T00:48:16.642" v="201" actId="1036"/>
          <ac:spMkLst>
            <pc:docMk/>
            <pc:sldMk cId="1821796093" sldId="261"/>
            <ac:spMk id="25" creationId="{40158B20-83DE-4193-A1CF-1DBFA13649F6}"/>
          </ac:spMkLst>
        </pc:spChg>
        <pc:spChg chg="mod topLvl">
          <ac:chgData name="Simon Xin Min Dong" userId="6647684b-86c4-4538-a0ea-723982d85692" providerId="ADAL" clId="{273A2E3A-68A0-4418-9B04-456AD733E653}" dt="2021-05-21T00:48:16.642" v="201" actId="1036"/>
          <ac:spMkLst>
            <pc:docMk/>
            <pc:sldMk cId="1821796093" sldId="261"/>
            <ac:spMk id="27" creationId="{9F590C0A-7889-404C-B35B-07869ADB6A50}"/>
          </ac:spMkLst>
        </pc:spChg>
        <pc:spChg chg="mod topLvl">
          <ac:chgData name="Simon Xin Min Dong" userId="6647684b-86c4-4538-a0ea-723982d85692" providerId="ADAL" clId="{273A2E3A-68A0-4418-9B04-456AD733E653}" dt="2021-05-21T00:48:16.642" v="201" actId="1036"/>
          <ac:spMkLst>
            <pc:docMk/>
            <pc:sldMk cId="1821796093" sldId="261"/>
            <ac:spMk id="28" creationId="{02C3E9E9-D2CF-4BE7-9F8C-EBE9DDE33A97}"/>
          </ac:spMkLst>
        </pc:spChg>
        <pc:spChg chg="mod topLvl">
          <ac:chgData name="Simon Xin Min Dong" userId="6647684b-86c4-4538-a0ea-723982d85692" providerId="ADAL" clId="{273A2E3A-68A0-4418-9B04-456AD733E653}" dt="2021-05-21T00:48:16.642" v="201" actId="1036"/>
          <ac:spMkLst>
            <pc:docMk/>
            <pc:sldMk cId="1821796093" sldId="261"/>
            <ac:spMk id="29" creationId="{169A13F7-BF2F-4D78-A78D-6DD913E8ABCE}"/>
          </ac:spMkLst>
        </pc:spChg>
        <pc:spChg chg="del mod">
          <ac:chgData name="Simon Xin Min Dong" userId="6647684b-86c4-4538-a0ea-723982d85692" providerId="ADAL" clId="{273A2E3A-68A0-4418-9B04-456AD733E653}" dt="2021-05-21T00:43:58.152" v="147" actId="478"/>
          <ac:spMkLst>
            <pc:docMk/>
            <pc:sldMk cId="1821796093" sldId="261"/>
            <ac:spMk id="30" creationId="{A4E6871E-264F-4162-B543-9BAF94871D50}"/>
          </ac:spMkLst>
        </pc:spChg>
        <pc:spChg chg="del mod">
          <ac:chgData name="Simon Xin Min Dong" userId="6647684b-86c4-4538-a0ea-723982d85692" providerId="ADAL" clId="{273A2E3A-68A0-4418-9B04-456AD733E653}" dt="2021-05-21T00:44:02.967" v="148" actId="478"/>
          <ac:spMkLst>
            <pc:docMk/>
            <pc:sldMk cId="1821796093" sldId="261"/>
            <ac:spMk id="31" creationId="{5C8D5DDA-D614-4D9F-B8B4-694D3388F508}"/>
          </ac:spMkLst>
        </pc:spChg>
        <pc:spChg chg="add mod">
          <ac:chgData name="Simon Xin Min Dong" userId="6647684b-86c4-4538-a0ea-723982d85692" providerId="ADAL" clId="{273A2E3A-68A0-4418-9B04-456AD733E653}" dt="2021-05-21T00:48:16.642" v="201" actId="1036"/>
          <ac:spMkLst>
            <pc:docMk/>
            <pc:sldMk cId="1821796093" sldId="261"/>
            <ac:spMk id="32" creationId="{A6AF8001-5684-4918-906B-B84839C0A950}"/>
          </ac:spMkLst>
        </pc:spChg>
        <pc:spChg chg="add mod">
          <ac:chgData name="Simon Xin Min Dong" userId="6647684b-86c4-4538-a0ea-723982d85692" providerId="ADAL" clId="{273A2E3A-68A0-4418-9B04-456AD733E653}" dt="2021-05-21T00:48:16.642" v="201" actId="1036"/>
          <ac:spMkLst>
            <pc:docMk/>
            <pc:sldMk cId="1821796093" sldId="261"/>
            <ac:spMk id="33" creationId="{6EEF4BCE-3881-4BFC-804A-549759B3FBBF}"/>
          </ac:spMkLst>
        </pc:spChg>
        <pc:grpChg chg="add del mod">
          <ac:chgData name="Simon Xin Min Dong" userId="6647684b-86c4-4538-a0ea-723982d85692" providerId="ADAL" clId="{273A2E3A-68A0-4418-9B04-456AD733E653}" dt="2021-05-21T00:36:51.915" v="70" actId="478"/>
          <ac:grpSpMkLst>
            <pc:docMk/>
            <pc:sldMk cId="1821796093" sldId="261"/>
            <ac:grpSpMk id="5" creationId="{FE5CA298-D9E4-4C5D-818D-F2D82890B54A}"/>
          </ac:grpSpMkLst>
        </pc:grpChg>
        <pc:grpChg chg="add mod">
          <ac:chgData name="Simon Xin Min Dong" userId="6647684b-86c4-4538-a0ea-723982d85692" providerId="ADAL" clId="{273A2E3A-68A0-4418-9B04-456AD733E653}" dt="2021-05-21T00:48:16.642" v="201" actId="1036"/>
          <ac:grpSpMkLst>
            <pc:docMk/>
            <pc:sldMk cId="1821796093" sldId="261"/>
            <ac:grpSpMk id="11" creationId="{141B4968-AA10-4A59-B6FE-410FFD4EA1CB}"/>
          </ac:grpSpMkLst>
        </pc:grpChg>
        <pc:grpChg chg="add del mod">
          <ac:chgData name="Simon Xin Min Dong" userId="6647684b-86c4-4538-a0ea-723982d85692" providerId="ADAL" clId="{273A2E3A-68A0-4418-9B04-456AD733E653}" dt="2021-05-21T00:44:20.811" v="150" actId="165"/>
          <ac:grpSpMkLst>
            <pc:docMk/>
            <pc:sldMk cId="1821796093" sldId="261"/>
            <ac:grpSpMk id="26" creationId="{3FEA6077-171A-4ABC-9F97-9E600B14FDF6}"/>
          </ac:grpSpMkLst>
        </pc:grpChg>
        <pc:grpChg chg="add mod">
          <ac:chgData name="Simon Xin Min Dong" userId="6647684b-86c4-4538-a0ea-723982d85692" providerId="ADAL" clId="{273A2E3A-68A0-4418-9B04-456AD733E653}" dt="2021-05-21T00:48:16.642" v="201" actId="1036"/>
          <ac:grpSpMkLst>
            <pc:docMk/>
            <pc:sldMk cId="1821796093" sldId="261"/>
            <ac:grpSpMk id="34" creationId="{D720D761-D8C3-4992-9163-537313A65F82}"/>
          </ac:grpSpMkLst>
        </pc:grpChg>
        <pc:picChg chg="add mod">
          <ac:chgData name="Simon Xin Min Dong" userId="6647684b-86c4-4538-a0ea-723982d85692" providerId="ADAL" clId="{273A2E3A-68A0-4418-9B04-456AD733E653}" dt="2021-05-21T00:48:16.642" v="201" actId="1036"/>
          <ac:picMkLst>
            <pc:docMk/>
            <pc:sldMk cId="1821796093" sldId="261"/>
            <ac:picMk id="4" creationId="{9DB19AAE-2E04-4986-B8B4-65F7AE005B5F}"/>
          </ac:picMkLst>
        </pc:picChg>
      </pc:sldChg>
      <pc:sldChg chg="addSp delSp modSp mod">
        <pc:chgData name="Simon Xin Min Dong" userId="6647684b-86c4-4538-a0ea-723982d85692" providerId="ADAL" clId="{273A2E3A-68A0-4418-9B04-456AD733E653}" dt="2021-05-21T01:14:28.097" v="505" actId="164"/>
        <pc:sldMkLst>
          <pc:docMk/>
          <pc:sldMk cId="2054106518" sldId="262"/>
        </pc:sldMkLst>
        <pc:spChg chg="mod topLvl">
          <ac:chgData name="Simon Xin Min Dong" userId="6647684b-86c4-4538-a0ea-723982d85692" providerId="ADAL" clId="{273A2E3A-68A0-4418-9B04-456AD733E653}" dt="2021-05-21T01:14:28.097" v="505" actId="164"/>
          <ac:spMkLst>
            <pc:docMk/>
            <pc:sldMk cId="2054106518" sldId="262"/>
            <ac:spMk id="5" creationId="{7AA2C46C-A044-4322-B883-9DEEFA7520FB}"/>
          </ac:spMkLst>
        </pc:spChg>
        <pc:spChg chg="mod topLvl">
          <ac:chgData name="Simon Xin Min Dong" userId="6647684b-86c4-4538-a0ea-723982d85692" providerId="ADAL" clId="{273A2E3A-68A0-4418-9B04-456AD733E653}" dt="2021-05-21T01:14:28.097" v="505" actId="164"/>
          <ac:spMkLst>
            <pc:docMk/>
            <pc:sldMk cId="2054106518" sldId="262"/>
            <ac:spMk id="6" creationId="{72727A91-6947-4042-A121-DB7E8F862D53}"/>
          </ac:spMkLst>
        </pc:spChg>
        <pc:spChg chg="mod topLvl">
          <ac:chgData name="Simon Xin Min Dong" userId="6647684b-86c4-4538-a0ea-723982d85692" providerId="ADAL" clId="{273A2E3A-68A0-4418-9B04-456AD733E653}" dt="2021-05-21T01:14:28.097" v="505" actId="164"/>
          <ac:spMkLst>
            <pc:docMk/>
            <pc:sldMk cId="2054106518" sldId="262"/>
            <ac:spMk id="7" creationId="{AB34E1AA-E761-429E-980E-968971F34514}"/>
          </ac:spMkLst>
        </pc:spChg>
        <pc:spChg chg="mod topLvl">
          <ac:chgData name="Simon Xin Min Dong" userId="6647684b-86c4-4538-a0ea-723982d85692" providerId="ADAL" clId="{273A2E3A-68A0-4418-9B04-456AD733E653}" dt="2021-05-21T01:14:28.097" v="505" actId="164"/>
          <ac:spMkLst>
            <pc:docMk/>
            <pc:sldMk cId="2054106518" sldId="262"/>
            <ac:spMk id="8" creationId="{F0114DAC-1C89-4D95-BF49-B26F8F0C18C2}"/>
          </ac:spMkLst>
        </pc:spChg>
        <pc:spChg chg="mod topLvl">
          <ac:chgData name="Simon Xin Min Dong" userId="6647684b-86c4-4538-a0ea-723982d85692" providerId="ADAL" clId="{273A2E3A-68A0-4418-9B04-456AD733E653}" dt="2021-05-21T01:14:28.097" v="505" actId="164"/>
          <ac:spMkLst>
            <pc:docMk/>
            <pc:sldMk cId="2054106518" sldId="262"/>
            <ac:spMk id="9" creationId="{2161B6B5-1F9B-44E1-AE0D-85D1C81B09EC}"/>
          </ac:spMkLst>
        </pc:spChg>
        <pc:spChg chg="mod topLvl">
          <ac:chgData name="Simon Xin Min Dong" userId="6647684b-86c4-4538-a0ea-723982d85692" providerId="ADAL" clId="{273A2E3A-68A0-4418-9B04-456AD733E653}" dt="2021-05-21T01:14:28.097" v="505" actId="164"/>
          <ac:spMkLst>
            <pc:docMk/>
            <pc:sldMk cId="2054106518" sldId="262"/>
            <ac:spMk id="10" creationId="{5C9868BD-E3A2-4A9B-9FB5-223883157DE7}"/>
          </ac:spMkLst>
        </pc:spChg>
        <pc:spChg chg="mod topLvl">
          <ac:chgData name="Simon Xin Min Dong" userId="6647684b-86c4-4538-a0ea-723982d85692" providerId="ADAL" clId="{273A2E3A-68A0-4418-9B04-456AD733E653}" dt="2021-05-21T01:14:28.097" v="505" actId="164"/>
          <ac:spMkLst>
            <pc:docMk/>
            <pc:sldMk cId="2054106518" sldId="262"/>
            <ac:spMk id="11" creationId="{DFD23B46-D6C5-497A-AD52-0C91482CE90A}"/>
          </ac:spMkLst>
        </pc:spChg>
        <pc:spChg chg="add mod">
          <ac:chgData name="Simon Xin Min Dong" userId="6647684b-86c4-4538-a0ea-723982d85692" providerId="ADAL" clId="{273A2E3A-68A0-4418-9B04-456AD733E653}" dt="2021-05-21T01:14:28.097" v="505" actId="164"/>
          <ac:spMkLst>
            <pc:docMk/>
            <pc:sldMk cId="2054106518" sldId="262"/>
            <ac:spMk id="12" creationId="{ADC61AFF-EDA0-40C3-95BF-1289BD2DCA80}"/>
          </ac:spMkLst>
        </pc:spChg>
        <pc:spChg chg="add mod">
          <ac:chgData name="Simon Xin Min Dong" userId="6647684b-86c4-4538-a0ea-723982d85692" providerId="ADAL" clId="{273A2E3A-68A0-4418-9B04-456AD733E653}" dt="2021-05-21T01:14:28.097" v="505" actId="164"/>
          <ac:spMkLst>
            <pc:docMk/>
            <pc:sldMk cId="2054106518" sldId="262"/>
            <ac:spMk id="13" creationId="{3C9F54FF-8BA5-4143-86DD-974BB7A4B7FD}"/>
          </ac:spMkLst>
        </pc:spChg>
        <pc:spChg chg="add mod">
          <ac:chgData name="Simon Xin Min Dong" userId="6647684b-86c4-4538-a0ea-723982d85692" providerId="ADAL" clId="{273A2E3A-68A0-4418-9B04-456AD733E653}" dt="2021-05-21T01:14:28.097" v="505" actId="164"/>
          <ac:spMkLst>
            <pc:docMk/>
            <pc:sldMk cId="2054106518" sldId="262"/>
            <ac:spMk id="14" creationId="{246EF169-BF36-495F-9EB0-06DB1DC2CEBC}"/>
          </ac:spMkLst>
        </pc:spChg>
        <pc:spChg chg="add mod">
          <ac:chgData name="Simon Xin Min Dong" userId="6647684b-86c4-4538-a0ea-723982d85692" providerId="ADAL" clId="{273A2E3A-68A0-4418-9B04-456AD733E653}" dt="2021-05-21T01:08:27.064" v="465" actId="1037"/>
          <ac:spMkLst>
            <pc:docMk/>
            <pc:sldMk cId="2054106518" sldId="262"/>
            <ac:spMk id="15" creationId="{5DC67747-ACD7-458C-B2AD-B6827C1F385C}"/>
          </ac:spMkLst>
        </pc:spChg>
        <pc:spChg chg="add mod">
          <ac:chgData name="Simon Xin Min Dong" userId="6647684b-86c4-4538-a0ea-723982d85692" providerId="ADAL" clId="{273A2E3A-68A0-4418-9B04-456AD733E653}" dt="2021-05-21T01:08:27.064" v="465" actId="1037"/>
          <ac:spMkLst>
            <pc:docMk/>
            <pc:sldMk cId="2054106518" sldId="262"/>
            <ac:spMk id="16" creationId="{8E6ACC51-C26E-478D-A127-0F7BC57607E5}"/>
          </ac:spMkLst>
        </pc:spChg>
        <pc:spChg chg="mod">
          <ac:chgData name="Simon Xin Min Dong" userId="6647684b-86c4-4538-a0ea-723982d85692" providerId="ADAL" clId="{273A2E3A-68A0-4418-9B04-456AD733E653}" dt="2021-05-21T01:08:27.064" v="465" actId="1037"/>
          <ac:spMkLst>
            <pc:docMk/>
            <pc:sldMk cId="2054106518" sldId="262"/>
            <ac:spMk id="18" creationId="{52F8CCAA-8B98-4736-BAC9-5DDFCB4872D2}"/>
          </ac:spMkLst>
        </pc:spChg>
        <pc:spChg chg="mod">
          <ac:chgData name="Simon Xin Min Dong" userId="6647684b-86c4-4538-a0ea-723982d85692" providerId="ADAL" clId="{273A2E3A-68A0-4418-9B04-456AD733E653}" dt="2021-05-21T01:08:27.064" v="465" actId="1037"/>
          <ac:spMkLst>
            <pc:docMk/>
            <pc:sldMk cId="2054106518" sldId="262"/>
            <ac:spMk id="19" creationId="{50A859B4-B2A8-499B-BCBE-0549C0BC1865}"/>
          </ac:spMkLst>
        </pc:spChg>
        <pc:spChg chg="mod">
          <ac:chgData name="Simon Xin Min Dong" userId="6647684b-86c4-4538-a0ea-723982d85692" providerId="ADAL" clId="{273A2E3A-68A0-4418-9B04-456AD733E653}" dt="2021-05-21T01:08:27.064" v="465" actId="1037"/>
          <ac:spMkLst>
            <pc:docMk/>
            <pc:sldMk cId="2054106518" sldId="262"/>
            <ac:spMk id="20" creationId="{6EBC1FD8-8DF3-4548-B6F8-9EDCF19CCD8C}"/>
          </ac:spMkLst>
        </pc:spChg>
        <pc:spChg chg="mod">
          <ac:chgData name="Simon Xin Min Dong" userId="6647684b-86c4-4538-a0ea-723982d85692" providerId="ADAL" clId="{273A2E3A-68A0-4418-9B04-456AD733E653}" dt="2021-05-21T01:08:27.064" v="465" actId="1037"/>
          <ac:spMkLst>
            <pc:docMk/>
            <pc:sldMk cId="2054106518" sldId="262"/>
            <ac:spMk id="21" creationId="{5E742EDE-2FD0-441E-8BA5-0B6C2EE700FF}"/>
          </ac:spMkLst>
        </pc:spChg>
        <pc:spChg chg="del mod">
          <ac:chgData name="Simon Xin Min Dong" userId="6647684b-86c4-4538-a0ea-723982d85692" providerId="ADAL" clId="{273A2E3A-68A0-4418-9B04-456AD733E653}" dt="2021-05-21T00:57:11.070" v="290" actId="478"/>
          <ac:spMkLst>
            <pc:docMk/>
            <pc:sldMk cId="2054106518" sldId="262"/>
            <ac:spMk id="22" creationId="{A1C0AA98-901F-470C-B448-5E4DC96C67E4}"/>
          </ac:spMkLst>
        </pc:spChg>
        <pc:spChg chg="add mod">
          <ac:chgData name="Simon Xin Min Dong" userId="6647684b-86c4-4538-a0ea-723982d85692" providerId="ADAL" clId="{273A2E3A-68A0-4418-9B04-456AD733E653}" dt="2021-05-21T01:08:27.064" v="465" actId="1037"/>
          <ac:spMkLst>
            <pc:docMk/>
            <pc:sldMk cId="2054106518" sldId="262"/>
            <ac:spMk id="23" creationId="{B88F499C-2F5E-4E77-9A69-ED606D7CE37F}"/>
          </ac:spMkLst>
        </pc:spChg>
        <pc:spChg chg="add mod">
          <ac:chgData name="Simon Xin Min Dong" userId="6647684b-86c4-4538-a0ea-723982d85692" providerId="ADAL" clId="{273A2E3A-68A0-4418-9B04-456AD733E653}" dt="2021-05-21T01:08:27.064" v="465" actId="1037"/>
          <ac:spMkLst>
            <pc:docMk/>
            <pc:sldMk cId="2054106518" sldId="262"/>
            <ac:spMk id="24" creationId="{894C239C-5CA3-41EF-A1C5-558BD39311D7}"/>
          </ac:spMkLst>
        </pc:spChg>
        <pc:spChg chg="add mod">
          <ac:chgData name="Simon Xin Min Dong" userId="6647684b-86c4-4538-a0ea-723982d85692" providerId="ADAL" clId="{273A2E3A-68A0-4418-9B04-456AD733E653}" dt="2021-05-21T01:08:27.064" v="465" actId="1037"/>
          <ac:spMkLst>
            <pc:docMk/>
            <pc:sldMk cId="2054106518" sldId="262"/>
            <ac:spMk id="27" creationId="{EAA81835-A83F-4EF4-96D8-684DAEADB838}"/>
          </ac:spMkLst>
        </pc:spChg>
        <pc:grpChg chg="add del mod">
          <ac:chgData name="Simon Xin Min Dong" userId="6647684b-86c4-4538-a0ea-723982d85692" providerId="ADAL" clId="{273A2E3A-68A0-4418-9B04-456AD733E653}" dt="2021-05-21T01:02:19.616" v="353" actId="165"/>
          <ac:grpSpMkLst>
            <pc:docMk/>
            <pc:sldMk cId="2054106518" sldId="262"/>
            <ac:grpSpMk id="4" creationId="{7433779B-5256-4493-98CB-BD0683DE4FDC}"/>
          </ac:grpSpMkLst>
        </pc:grpChg>
        <pc:grpChg chg="add mod">
          <ac:chgData name="Simon Xin Min Dong" userId="6647684b-86c4-4538-a0ea-723982d85692" providerId="ADAL" clId="{273A2E3A-68A0-4418-9B04-456AD733E653}" dt="2021-05-21T01:08:27.064" v="465" actId="1037"/>
          <ac:grpSpMkLst>
            <pc:docMk/>
            <pc:sldMk cId="2054106518" sldId="262"/>
            <ac:grpSpMk id="17" creationId="{B64A4DA6-2F08-4791-BBDE-72B0CE3C8148}"/>
          </ac:grpSpMkLst>
        </pc:grpChg>
        <pc:grpChg chg="add mod">
          <ac:chgData name="Simon Xin Min Dong" userId="6647684b-86c4-4538-a0ea-723982d85692" providerId="ADAL" clId="{273A2E3A-68A0-4418-9B04-456AD733E653}" dt="2021-05-21T01:14:28.097" v="505" actId="164"/>
          <ac:grpSpMkLst>
            <pc:docMk/>
            <pc:sldMk cId="2054106518" sldId="262"/>
            <ac:grpSpMk id="28" creationId="{6837091D-B36F-4AA4-9A63-C99CDACCD68B}"/>
          </ac:grpSpMkLst>
        </pc:grpChg>
        <pc:picChg chg="add del mod ord">
          <ac:chgData name="Simon Xin Min Dong" userId="6647684b-86c4-4538-a0ea-723982d85692" providerId="ADAL" clId="{273A2E3A-68A0-4418-9B04-456AD733E653}" dt="2021-05-21T01:01:25.016" v="328" actId="478"/>
          <ac:picMkLst>
            <pc:docMk/>
            <pc:sldMk cId="2054106518" sldId="262"/>
            <ac:picMk id="3" creationId="{F27C75E6-B9C5-48A1-B708-246B2D0A9E0D}"/>
          </ac:picMkLst>
        </pc:picChg>
        <pc:picChg chg="add mod ord">
          <ac:chgData name="Simon Xin Min Dong" userId="6647684b-86c4-4538-a0ea-723982d85692" providerId="ADAL" clId="{273A2E3A-68A0-4418-9B04-456AD733E653}" dt="2021-05-21T01:08:27.064" v="465" actId="1037"/>
          <ac:picMkLst>
            <pc:docMk/>
            <pc:sldMk cId="2054106518" sldId="262"/>
            <ac:picMk id="26" creationId="{4122D89A-29E4-4866-AFBB-D95915AED6A6}"/>
          </ac:picMkLst>
        </pc:picChg>
      </pc:sldChg>
      <pc:sldChg chg="addSp delSp modSp mod">
        <pc:chgData name="Simon Xin Min Dong" userId="6647684b-86c4-4538-a0ea-723982d85692" providerId="ADAL" clId="{273A2E3A-68A0-4418-9B04-456AD733E653}" dt="2021-05-21T02:28:47.459" v="624" actId="1036"/>
        <pc:sldMkLst>
          <pc:docMk/>
          <pc:sldMk cId="1828249279" sldId="263"/>
        </pc:sldMkLst>
        <pc:spChg chg="add mod">
          <ac:chgData name="Simon Xin Min Dong" userId="6647684b-86c4-4538-a0ea-723982d85692" providerId="ADAL" clId="{273A2E3A-68A0-4418-9B04-456AD733E653}" dt="2021-05-21T01:09:43.941" v="481" actId="1076"/>
          <ac:spMkLst>
            <pc:docMk/>
            <pc:sldMk cId="1828249279" sldId="263"/>
            <ac:spMk id="2" creationId="{2638570E-A0FA-4776-821E-230831E07F8E}"/>
          </ac:spMkLst>
        </pc:spChg>
        <pc:spChg chg="add mod">
          <ac:chgData name="Simon Xin Min Dong" userId="6647684b-86c4-4538-a0ea-723982d85692" providerId="ADAL" clId="{273A2E3A-68A0-4418-9B04-456AD733E653}" dt="2021-05-21T01:13:52.415" v="503" actId="1076"/>
          <ac:spMkLst>
            <pc:docMk/>
            <pc:sldMk cId="1828249279" sldId="263"/>
            <ac:spMk id="7" creationId="{EE2FE8EA-0EB6-4CBC-A902-357FAA5FA0E9}"/>
          </ac:spMkLst>
        </pc:spChg>
        <pc:spChg chg="add mod">
          <ac:chgData name="Simon Xin Min Dong" userId="6647684b-86c4-4538-a0ea-723982d85692" providerId="ADAL" clId="{273A2E3A-68A0-4418-9B04-456AD733E653}" dt="2021-05-21T01:14:01.425" v="504" actId="1076"/>
          <ac:spMkLst>
            <pc:docMk/>
            <pc:sldMk cId="1828249279" sldId="263"/>
            <ac:spMk id="9" creationId="{83D6EAA8-71CF-4F9C-9A8E-B32DC93CE91E}"/>
          </ac:spMkLst>
        </pc:spChg>
        <pc:spChg chg="mod">
          <ac:chgData name="Simon Xin Min Dong" userId="6647684b-86c4-4538-a0ea-723982d85692" providerId="ADAL" clId="{273A2E3A-68A0-4418-9B04-456AD733E653}" dt="2021-05-21T02:28:47.459" v="624" actId="1036"/>
          <ac:spMkLst>
            <pc:docMk/>
            <pc:sldMk cId="1828249279" sldId="263"/>
            <ac:spMk id="12" creationId="{BFDCA857-1E36-4ED0-B2B4-49B408B23550}"/>
          </ac:spMkLst>
        </pc:spChg>
        <pc:spChg chg="mod">
          <ac:chgData name="Simon Xin Min Dong" userId="6647684b-86c4-4538-a0ea-723982d85692" providerId="ADAL" clId="{273A2E3A-68A0-4418-9B04-456AD733E653}" dt="2021-05-21T02:28:47.459" v="624" actId="1036"/>
          <ac:spMkLst>
            <pc:docMk/>
            <pc:sldMk cId="1828249279" sldId="263"/>
            <ac:spMk id="13" creationId="{D77CB056-9C66-4C8C-8D26-013D20F42106}"/>
          </ac:spMkLst>
        </pc:spChg>
        <pc:spChg chg="mod">
          <ac:chgData name="Simon Xin Min Dong" userId="6647684b-86c4-4538-a0ea-723982d85692" providerId="ADAL" clId="{273A2E3A-68A0-4418-9B04-456AD733E653}" dt="2021-05-21T02:28:47.459" v="624" actId="1036"/>
          <ac:spMkLst>
            <pc:docMk/>
            <pc:sldMk cId="1828249279" sldId="263"/>
            <ac:spMk id="14" creationId="{A7001076-2BC7-484B-B0C1-0C477CDC3282}"/>
          </ac:spMkLst>
        </pc:spChg>
        <pc:spChg chg="mod">
          <ac:chgData name="Simon Xin Min Dong" userId="6647684b-86c4-4538-a0ea-723982d85692" providerId="ADAL" clId="{273A2E3A-68A0-4418-9B04-456AD733E653}" dt="2021-05-21T02:28:47.459" v="624" actId="1036"/>
          <ac:spMkLst>
            <pc:docMk/>
            <pc:sldMk cId="1828249279" sldId="263"/>
            <ac:spMk id="15" creationId="{9EAC1014-DC37-41F4-8096-9BA55EA453DE}"/>
          </ac:spMkLst>
        </pc:spChg>
        <pc:spChg chg="mod">
          <ac:chgData name="Simon Xin Min Dong" userId="6647684b-86c4-4538-a0ea-723982d85692" providerId="ADAL" clId="{273A2E3A-68A0-4418-9B04-456AD733E653}" dt="2021-05-21T02:28:47.459" v="624" actId="1036"/>
          <ac:spMkLst>
            <pc:docMk/>
            <pc:sldMk cId="1828249279" sldId="263"/>
            <ac:spMk id="16" creationId="{40DDBAC3-4287-42A6-B6CF-27BA860A8F94}"/>
          </ac:spMkLst>
        </pc:spChg>
        <pc:spChg chg="mod">
          <ac:chgData name="Simon Xin Min Dong" userId="6647684b-86c4-4538-a0ea-723982d85692" providerId="ADAL" clId="{273A2E3A-68A0-4418-9B04-456AD733E653}" dt="2021-05-21T02:28:47.459" v="624" actId="1036"/>
          <ac:spMkLst>
            <pc:docMk/>
            <pc:sldMk cId="1828249279" sldId="263"/>
            <ac:spMk id="17" creationId="{15D4D507-CFDF-4506-A0B7-B954A64DE253}"/>
          </ac:spMkLst>
        </pc:spChg>
        <pc:spChg chg="mod">
          <ac:chgData name="Simon Xin Min Dong" userId="6647684b-86c4-4538-a0ea-723982d85692" providerId="ADAL" clId="{273A2E3A-68A0-4418-9B04-456AD733E653}" dt="2021-05-21T02:28:47.459" v="624" actId="1036"/>
          <ac:spMkLst>
            <pc:docMk/>
            <pc:sldMk cId="1828249279" sldId="263"/>
            <ac:spMk id="18" creationId="{408436DB-41FA-4D24-B6CB-FCAF3DB6F897}"/>
          </ac:spMkLst>
        </pc:spChg>
        <pc:spChg chg="mod">
          <ac:chgData name="Simon Xin Min Dong" userId="6647684b-86c4-4538-a0ea-723982d85692" providerId="ADAL" clId="{273A2E3A-68A0-4418-9B04-456AD733E653}" dt="2021-05-21T02:28:47.459" v="624" actId="1036"/>
          <ac:spMkLst>
            <pc:docMk/>
            <pc:sldMk cId="1828249279" sldId="263"/>
            <ac:spMk id="19" creationId="{8A2A3178-20ED-4DE0-AA5C-8D5223073F06}"/>
          </ac:spMkLst>
        </pc:spChg>
        <pc:spChg chg="mod">
          <ac:chgData name="Simon Xin Min Dong" userId="6647684b-86c4-4538-a0ea-723982d85692" providerId="ADAL" clId="{273A2E3A-68A0-4418-9B04-456AD733E653}" dt="2021-05-21T02:28:47.459" v="624" actId="1036"/>
          <ac:spMkLst>
            <pc:docMk/>
            <pc:sldMk cId="1828249279" sldId="263"/>
            <ac:spMk id="20" creationId="{FACAE207-8365-4C51-BD80-97583BBA09A5}"/>
          </ac:spMkLst>
        </pc:spChg>
        <pc:spChg chg="mod">
          <ac:chgData name="Simon Xin Min Dong" userId="6647684b-86c4-4538-a0ea-723982d85692" providerId="ADAL" clId="{273A2E3A-68A0-4418-9B04-456AD733E653}" dt="2021-05-21T02:28:47.459" v="624" actId="1036"/>
          <ac:spMkLst>
            <pc:docMk/>
            <pc:sldMk cId="1828249279" sldId="263"/>
            <ac:spMk id="21" creationId="{C99F4AB0-A2B2-462E-AA0C-6531968F1DAA}"/>
          </ac:spMkLst>
        </pc:spChg>
        <pc:spChg chg="mod">
          <ac:chgData name="Simon Xin Min Dong" userId="6647684b-86c4-4538-a0ea-723982d85692" providerId="ADAL" clId="{273A2E3A-68A0-4418-9B04-456AD733E653}" dt="2021-05-21T02:26:05.933" v="555"/>
          <ac:spMkLst>
            <pc:docMk/>
            <pc:sldMk cId="1828249279" sldId="263"/>
            <ac:spMk id="23" creationId="{100086DB-4408-4279-9192-FFBB086AC3F7}"/>
          </ac:spMkLst>
        </pc:spChg>
        <pc:spChg chg="mod">
          <ac:chgData name="Simon Xin Min Dong" userId="6647684b-86c4-4538-a0ea-723982d85692" providerId="ADAL" clId="{273A2E3A-68A0-4418-9B04-456AD733E653}" dt="2021-05-21T02:26:34.998" v="584" actId="408"/>
          <ac:spMkLst>
            <pc:docMk/>
            <pc:sldMk cId="1828249279" sldId="263"/>
            <ac:spMk id="24" creationId="{6EBD361A-26E2-4BF8-8392-94E1915E96FE}"/>
          </ac:spMkLst>
        </pc:spChg>
        <pc:spChg chg="mod">
          <ac:chgData name="Simon Xin Min Dong" userId="6647684b-86c4-4538-a0ea-723982d85692" providerId="ADAL" clId="{273A2E3A-68A0-4418-9B04-456AD733E653}" dt="2021-05-21T02:26:51.478" v="596" actId="20577"/>
          <ac:spMkLst>
            <pc:docMk/>
            <pc:sldMk cId="1828249279" sldId="263"/>
            <ac:spMk id="25" creationId="{1A2F7B42-B00F-4BFD-843E-B0C72D671E1A}"/>
          </ac:spMkLst>
        </pc:spChg>
        <pc:spChg chg="mod">
          <ac:chgData name="Simon Xin Min Dong" userId="6647684b-86c4-4538-a0ea-723982d85692" providerId="ADAL" clId="{273A2E3A-68A0-4418-9B04-456AD733E653}" dt="2021-05-21T02:26:34.998" v="584" actId="408"/>
          <ac:spMkLst>
            <pc:docMk/>
            <pc:sldMk cId="1828249279" sldId="263"/>
            <ac:spMk id="26" creationId="{6A482138-FA0E-447C-8A0E-BFCC50715B7F}"/>
          </ac:spMkLst>
        </pc:spChg>
        <pc:spChg chg="mod">
          <ac:chgData name="Simon Xin Min Dong" userId="6647684b-86c4-4538-a0ea-723982d85692" providerId="ADAL" clId="{273A2E3A-68A0-4418-9B04-456AD733E653}" dt="2021-05-21T02:27:02.654" v="608" actId="20577"/>
          <ac:spMkLst>
            <pc:docMk/>
            <pc:sldMk cId="1828249279" sldId="263"/>
            <ac:spMk id="27" creationId="{31FAA2E1-896A-4881-99EF-A3837D4A76A0}"/>
          </ac:spMkLst>
        </pc:spChg>
        <pc:spChg chg="add mod">
          <ac:chgData name="Simon Xin Min Dong" userId="6647684b-86c4-4538-a0ea-723982d85692" providerId="ADAL" clId="{273A2E3A-68A0-4418-9B04-456AD733E653}" dt="2021-05-21T02:28:10.579" v="616" actId="14100"/>
          <ac:spMkLst>
            <pc:docMk/>
            <pc:sldMk cId="1828249279" sldId="263"/>
            <ac:spMk id="28" creationId="{5423DBAF-69B2-44B1-808B-F19F249DCA06}"/>
          </ac:spMkLst>
        </pc:spChg>
        <pc:spChg chg="add mod">
          <ac:chgData name="Simon Xin Min Dong" userId="6647684b-86c4-4538-a0ea-723982d85692" providerId="ADAL" clId="{273A2E3A-68A0-4418-9B04-456AD733E653}" dt="2021-05-21T02:28:20.492" v="620" actId="1037"/>
          <ac:spMkLst>
            <pc:docMk/>
            <pc:sldMk cId="1828249279" sldId="263"/>
            <ac:spMk id="29" creationId="{48373F1A-F0C9-4BFC-A8DC-42F23EECF823}"/>
          </ac:spMkLst>
        </pc:spChg>
        <pc:grpChg chg="add mod">
          <ac:chgData name="Simon Xin Min Dong" userId="6647684b-86c4-4538-a0ea-723982d85692" providerId="ADAL" clId="{273A2E3A-68A0-4418-9B04-456AD733E653}" dt="2021-05-21T02:28:47.459" v="624" actId="1036"/>
          <ac:grpSpMkLst>
            <pc:docMk/>
            <pc:sldMk cId="1828249279" sldId="263"/>
            <ac:grpSpMk id="11" creationId="{CE9E04BA-4A87-4CD0-A26C-73F2A86AD92E}"/>
          </ac:grpSpMkLst>
        </pc:grpChg>
        <pc:grpChg chg="add mod">
          <ac:chgData name="Simon Xin Min Dong" userId="6647684b-86c4-4538-a0ea-723982d85692" providerId="ADAL" clId="{273A2E3A-68A0-4418-9B04-456AD733E653}" dt="2021-05-21T02:26:16.112" v="582" actId="1038"/>
          <ac:grpSpMkLst>
            <pc:docMk/>
            <pc:sldMk cId="1828249279" sldId="263"/>
            <ac:grpSpMk id="22" creationId="{274F8303-FEDB-465C-A251-5DA0EF6A7C46}"/>
          </ac:grpSpMkLst>
        </pc:grpChg>
        <pc:picChg chg="add del mod">
          <ac:chgData name="Simon Xin Min Dong" userId="6647684b-86c4-4538-a0ea-723982d85692" providerId="ADAL" clId="{273A2E3A-68A0-4418-9B04-456AD733E653}" dt="2021-05-21T01:12:19.945" v="489" actId="21"/>
          <ac:picMkLst>
            <pc:docMk/>
            <pc:sldMk cId="1828249279" sldId="263"/>
            <ac:picMk id="4" creationId="{3D320943-6322-4A44-B5A2-2611A865FFE9}"/>
          </ac:picMkLst>
        </pc:picChg>
        <pc:picChg chg="add mod">
          <ac:chgData name="Simon Xin Min Dong" userId="6647684b-86c4-4538-a0ea-723982d85692" providerId="ADAL" clId="{273A2E3A-68A0-4418-9B04-456AD733E653}" dt="2021-05-21T02:28:14.757" v="619" actId="1035"/>
          <ac:picMkLst>
            <pc:docMk/>
            <pc:sldMk cId="1828249279" sldId="263"/>
            <ac:picMk id="6" creationId="{5696E89B-9918-4493-8600-BF8DF36FE26F}"/>
          </ac:picMkLst>
        </pc:picChg>
        <pc:cxnChg chg="add del mod">
          <ac:chgData name="Simon Xin Min Dong" userId="6647684b-86c4-4538-a0ea-723982d85692" providerId="ADAL" clId="{273A2E3A-68A0-4418-9B04-456AD733E653}" dt="2021-05-21T01:13:47.474" v="502" actId="478"/>
          <ac:cxnSpMkLst>
            <pc:docMk/>
            <pc:sldMk cId="1828249279" sldId="263"/>
            <ac:cxnSpMk id="8" creationId="{C6C8FCAF-C129-4A38-9C64-3FCE5020ACBD}"/>
          </ac:cxnSpMkLst>
        </pc:cxnChg>
        <pc:cxnChg chg="add del mod">
          <ac:chgData name="Simon Xin Min Dong" userId="6647684b-86c4-4538-a0ea-723982d85692" providerId="ADAL" clId="{273A2E3A-68A0-4418-9B04-456AD733E653}" dt="2021-05-21T01:13:44.509" v="501" actId="478"/>
          <ac:cxnSpMkLst>
            <pc:docMk/>
            <pc:sldMk cId="1828249279" sldId="263"/>
            <ac:cxnSpMk id="10" creationId="{991B9744-9901-4FE8-AED8-04A09FB31F6F}"/>
          </ac:cxnSpMkLst>
        </pc:cxnChg>
      </pc:sldChg>
      <pc:sldChg chg="addSp delSp modSp mod ord">
        <pc:chgData name="Simon Xin Min Dong" userId="6647684b-86c4-4538-a0ea-723982d85692" providerId="ADAL" clId="{273A2E3A-68A0-4418-9B04-456AD733E653}" dt="2021-05-21T03:17:48.321" v="1528" actId="20577"/>
        <pc:sldMkLst>
          <pc:docMk/>
          <pc:sldMk cId="1101007786" sldId="264"/>
        </pc:sldMkLst>
        <pc:spChg chg="add mod">
          <ac:chgData name="Simon Xin Min Dong" userId="6647684b-86c4-4538-a0ea-723982d85692" providerId="ADAL" clId="{273A2E3A-68A0-4418-9B04-456AD733E653}" dt="2021-05-21T03:17:48.321" v="1528" actId="20577"/>
          <ac:spMkLst>
            <pc:docMk/>
            <pc:sldMk cId="1101007786" sldId="264"/>
            <ac:spMk id="8" creationId="{BA336ADC-DE94-41A0-8DFA-7FA91808680B}"/>
          </ac:spMkLst>
        </pc:spChg>
        <pc:spChg chg="add mod">
          <ac:chgData name="Simon Xin Min Dong" userId="6647684b-86c4-4538-a0ea-723982d85692" providerId="ADAL" clId="{273A2E3A-68A0-4418-9B04-456AD733E653}" dt="2021-05-21T03:11:44.461" v="1460" actId="1076"/>
          <ac:spMkLst>
            <pc:docMk/>
            <pc:sldMk cId="1101007786" sldId="264"/>
            <ac:spMk id="9" creationId="{677E2BB0-F612-4BF5-8715-65763F6C04AB}"/>
          </ac:spMkLst>
        </pc:spChg>
        <pc:spChg chg="mod">
          <ac:chgData name="Simon Xin Min Dong" userId="6647684b-86c4-4538-a0ea-723982d85692" providerId="ADAL" clId="{273A2E3A-68A0-4418-9B04-456AD733E653}" dt="2021-05-21T03:15:55.132" v="1513"/>
          <ac:spMkLst>
            <pc:docMk/>
            <pc:sldMk cId="1101007786" sldId="264"/>
            <ac:spMk id="11" creationId="{7E286101-6712-4B3B-9E95-F9913F7984A1}"/>
          </ac:spMkLst>
        </pc:spChg>
        <pc:spChg chg="mod">
          <ac:chgData name="Simon Xin Min Dong" userId="6647684b-86c4-4538-a0ea-723982d85692" providerId="ADAL" clId="{273A2E3A-68A0-4418-9B04-456AD733E653}" dt="2021-05-21T03:15:55.132" v="1513"/>
          <ac:spMkLst>
            <pc:docMk/>
            <pc:sldMk cId="1101007786" sldId="264"/>
            <ac:spMk id="12" creationId="{91842274-16ED-4FF2-86DC-2F56EF39AB7D}"/>
          </ac:spMkLst>
        </pc:spChg>
        <pc:spChg chg="mod">
          <ac:chgData name="Simon Xin Min Dong" userId="6647684b-86c4-4538-a0ea-723982d85692" providerId="ADAL" clId="{273A2E3A-68A0-4418-9B04-456AD733E653}" dt="2021-05-21T03:15:55.132" v="1513"/>
          <ac:spMkLst>
            <pc:docMk/>
            <pc:sldMk cId="1101007786" sldId="264"/>
            <ac:spMk id="13" creationId="{CB05D86C-513B-4DC7-B1C3-A28E719DEBB4}"/>
          </ac:spMkLst>
        </pc:spChg>
        <pc:spChg chg="mod">
          <ac:chgData name="Simon Xin Min Dong" userId="6647684b-86c4-4538-a0ea-723982d85692" providerId="ADAL" clId="{273A2E3A-68A0-4418-9B04-456AD733E653}" dt="2021-05-21T03:15:55.132" v="1513"/>
          <ac:spMkLst>
            <pc:docMk/>
            <pc:sldMk cId="1101007786" sldId="264"/>
            <ac:spMk id="14" creationId="{2EB4F3EB-1245-461F-B84D-C8C6D0EA7FA9}"/>
          </ac:spMkLst>
        </pc:spChg>
        <pc:spChg chg="mod">
          <ac:chgData name="Simon Xin Min Dong" userId="6647684b-86c4-4538-a0ea-723982d85692" providerId="ADAL" clId="{273A2E3A-68A0-4418-9B04-456AD733E653}" dt="2021-05-21T03:15:55.132" v="1513"/>
          <ac:spMkLst>
            <pc:docMk/>
            <pc:sldMk cId="1101007786" sldId="264"/>
            <ac:spMk id="15" creationId="{5D473B39-7795-447E-AA24-F0BB3BECAB2B}"/>
          </ac:spMkLst>
        </pc:spChg>
        <pc:spChg chg="mod">
          <ac:chgData name="Simon Xin Min Dong" userId="6647684b-86c4-4538-a0ea-723982d85692" providerId="ADAL" clId="{273A2E3A-68A0-4418-9B04-456AD733E653}" dt="2021-05-21T03:16:33.390" v="1516" actId="1076"/>
          <ac:spMkLst>
            <pc:docMk/>
            <pc:sldMk cId="1101007786" sldId="264"/>
            <ac:spMk id="17" creationId="{09D7BC16-064E-4200-B88D-BA88E8389E96}"/>
          </ac:spMkLst>
        </pc:spChg>
        <pc:spChg chg="mod">
          <ac:chgData name="Simon Xin Min Dong" userId="6647684b-86c4-4538-a0ea-723982d85692" providerId="ADAL" clId="{273A2E3A-68A0-4418-9B04-456AD733E653}" dt="2021-05-21T03:16:33.390" v="1516" actId="1076"/>
          <ac:spMkLst>
            <pc:docMk/>
            <pc:sldMk cId="1101007786" sldId="264"/>
            <ac:spMk id="18" creationId="{1DFBF0DC-60E5-4EA0-8873-84C563DA9715}"/>
          </ac:spMkLst>
        </pc:spChg>
        <pc:spChg chg="mod">
          <ac:chgData name="Simon Xin Min Dong" userId="6647684b-86c4-4538-a0ea-723982d85692" providerId="ADAL" clId="{273A2E3A-68A0-4418-9B04-456AD733E653}" dt="2021-05-21T03:16:33.390" v="1516" actId="1076"/>
          <ac:spMkLst>
            <pc:docMk/>
            <pc:sldMk cId="1101007786" sldId="264"/>
            <ac:spMk id="19" creationId="{7DC21CF7-99D5-461E-A429-C703D7365CB7}"/>
          </ac:spMkLst>
        </pc:spChg>
        <pc:spChg chg="mod">
          <ac:chgData name="Simon Xin Min Dong" userId="6647684b-86c4-4538-a0ea-723982d85692" providerId="ADAL" clId="{273A2E3A-68A0-4418-9B04-456AD733E653}" dt="2021-05-21T03:16:33.390" v="1516" actId="1076"/>
          <ac:spMkLst>
            <pc:docMk/>
            <pc:sldMk cId="1101007786" sldId="264"/>
            <ac:spMk id="20" creationId="{D0C03511-42EA-4F23-9511-9ABC2C0D2648}"/>
          </ac:spMkLst>
        </pc:spChg>
        <pc:spChg chg="mod">
          <ac:chgData name="Simon Xin Min Dong" userId="6647684b-86c4-4538-a0ea-723982d85692" providerId="ADAL" clId="{273A2E3A-68A0-4418-9B04-456AD733E653}" dt="2021-05-21T03:16:33.390" v="1516" actId="1076"/>
          <ac:spMkLst>
            <pc:docMk/>
            <pc:sldMk cId="1101007786" sldId="264"/>
            <ac:spMk id="21" creationId="{8625F5CC-5E5A-419A-8D23-8BB5BA26DA77}"/>
          </ac:spMkLst>
        </pc:spChg>
        <pc:spChg chg="mod">
          <ac:chgData name="Simon Xin Min Dong" userId="6647684b-86c4-4538-a0ea-723982d85692" providerId="ADAL" clId="{273A2E3A-68A0-4418-9B04-456AD733E653}" dt="2021-05-21T03:16:33.390" v="1516" actId="1076"/>
          <ac:spMkLst>
            <pc:docMk/>
            <pc:sldMk cId="1101007786" sldId="264"/>
            <ac:spMk id="22" creationId="{98E99B90-967A-44E4-9F4B-5449BCB07299}"/>
          </ac:spMkLst>
        </pc:spChg>
        <pc:spChg chg="mod">
          <ac:chgData name="Simon Xin Min Dong" userId="6647684b-86c4-4538-a0ea-723982d85692" providerId="ADAL" clId="{273A2E3A-68A0-4418-9B04-456AD733E653}" dt="2021-05-21T03:16:33.390" v="1516" actId="1076"/>
          <ac:spMkLst>
            <pc:docMk/>
            <pc:sldMk cId="1101007786" sldId="264"/>
            <ac:spMk id="23" creationId="{773289DC-A496-44B7-8110-79EC7634F485}"/>
          </ac:spMkLst>
        </pc:spChg>
        <pc:spChg chg="mod">
          <ac:chgData name="Simon Xin Min Dong" userId="6647684b-86c4-4538-a0ea-723982d85692" providerId="ADAL" clId="{273A2E3A-68A0-4418-9B04-456AD733E653}" dt="2021-05-21T03:16:33.390" v="1516" actId="1076"/>
          <ac:spMkLst>
            <pc:docMk/>
            <pc:sldMk cId="1101007786" sldId="264"/>
            <ac:spMk id="24" creationId="{4DCF7213-8B7B-4E23-B796-510AE03C5B80}"/>
          </ac:spMkLst>
        </pc:spChg>
        <pc:spChg chg="mod">
          <ac:chgData name="Simon Xin Min Dong" userId="6647684b-86c4-4538-a0ea-723982d85692" providerId="ADAL" clId="{273A2E3A-68A0-4418-9B04-456AD733E653}" dt="2021-05-21T03:16:33.390" v="1516" actId="1076"/>
          <ac:spMkLst>
            <pc:docMk/>
            <pc:sldMk cId="1101007786" sldId="264"/>
            <ac:spMk id="25" creationId="{80301F91-93F3-423C-8AE3-E2AA859628AC}"/>
          </ac:spMkLst>
        </pc:spChg>
        <pc:spChg chg="mod">
          <ac:chgData name="Simon Xin Min Dong" userId="6647684b-86c4-4538-a0ea-723982d85692" providerId="ADAL" clId="{273A2E3A-68A0-4418-9B04-456AD733E653}" dt="2021-05-21T03:16:33.390" v="1516" actId="1076"/>
          <ac:spMkLst>
            <pc:docMk/>
            <pc:sldMk cId="1101007786" sldId="264"/>
            <ac:spMk id="26" creationId="{6EFE6E0B-5C49-49BE-8BE0-BE6169EEF14C}"/>
          </ac:spMkLst>
        </pc:spChg>
        <pc:spChg chg="mod">
          <ac:chgData name="Simon Xin Min Dong" userId="6647684b-86c4-4538-a0ea-723982d85692" providerId="ADAL" clId="{273A2E3A-68A0-4418-9B04-456AD733E653}" dt="2021-05-21T03:16:45.583" v="1518"/>
          <ac:spMkLst>
            <pc:docMk/>
            <pc:sldMk cId="1101007786" sldId="264"/>
            <ac:spMk id="28" creationId="{E026072B-F2AF-4C80-A7C1-F930342C4FE7}"/>
          </ac:spMkLst>
        </pc:spChg>
        <pc:spChg chg="mod">
          <ac:chgData name="Simon Xin Min Dong" userId="6647684b-86c4-4538-a0ea-723982d85692" providerId="ADAL" clId="{273A2E3A-68A0-4418-9B04-456AD733E653}" dt="2021-05-21T03:16:45.583" v="1518"/>
          <ac:spMkLst>
            <pc:docMk/>
            <pc:sldMk cId="1101007786" sldId="264"/>
            <ac:spMk id="29" creationId="{9BC8C34D-6349-48C3-A67A-AF674BD7C3B8}"/>
          </ac:spMkLst>
        </pc:spChg>
        <pc:spChg chg="mod">
          <ac:chgData name="Simon Xin Min Dong" userId="6647684b-86c4-4538-a0ea-723982d85692" providerId="ADAL" clId="{273A2E3A-68A0-4418-9B04-456AD733E653}" dt="2021-05-21T03:16:45.583" v="1518"/>
          <ac:spMkLst>
            <pc:docMk/>
            <pc:sldMk cId="1101007786" sldId="264"/>
            <ac:spMk id="30" creationId="{12E2320D-A0AC-4B79-A412-222E16C07B12}"/>
          </ac:spMkLst>
        </pc:spChg>
        <pc:spChg chg="mod">
          <ac:chgData name="Simon Xin Min Dong" userId="6647684b-86c4-4538-a0ea-723982d85692" providerId="ADAL" clId="{273A2E3A-68A0-4418-9B04-456AD733E653}" dt="2021-05-21T03:16:45.583" v="1518"/>
          <ac:spMkLst>
            <pc:docMk/>
            <pc:sldMk cId="1101007786" sldId="264"/>
            <ac:spMk id="31" creationId="{BD55BAE0-D82A-41AA-A317-90FF2C474E7F}"/>
          </ac:spMkLst>
        </pc:spChg>
        <pc:spChg chg="mod">
          <ac:chgData name="Simon Xin Min Dong" userId="6647684b-86c4-4538-a0ea-723982d85692" providerId="ADAL" clId="{273A2E3A-68A0-4418-9B04-456AD733E653}" dt="2021-05-21T03:16:45.583" v="1518"/>
          <ac:spMkLst>
            <pc:docMk/>
            <pc:sldMk cId="1101007786" sldId="264"/>
            <ac:spMk id="32" creationId="{90E83E9D-25D5-4A18-B1F0-7E9EEFC59B03}"/>
          </ac:spMkLst>
        </pc:spChg>
        <pc:spChg chg="mod">
          <ac:chgData name="Simon Xin Min Dong" userId="6647684b-86c4-4538-a0ea-723982d85692" providerId="ADAL" clId="{273A2E3A-68A0-4418-9B04-456AD733E653}" dt="2021-05-21T03:16:45.583" v="1518"/>
          <ac:spMkLst>
            <pc:docMk/>
            <pc:sldMk cId="1101007786" sldId="264"/>
            <ac:spMk id="33" creationId="{8A56B544-833A-4DE1-921E-03878890BECD}"/>
          </ac:spMkLst>
        </pc:spChg>
        <pc:spChg chg="mod">
          <ac:chgData name="Simon Xin Min Dong" userId="6647684b-86c4-4538-a0ea-723982d85692" providerId="ADAL" clId="{273A2E3A-68A0-4418-9B04-456AD733E653}" dt="2021-05-21T03:16:45.583" v="1518"/>
          <ac:spMkLst>
            <pc:docMk/>
            <pc:sldMk cId="1101007786" sldId="264"/>
            <ac:spMk id="34" creationId="{C89AB3B7-2EA4-4DAF-9A3D-DC5F67B5D050}"/>
          </ac:spMkLst>
        </pc:spChg>
        <pc:spChg chg="mod">
          <ac:chgData name="Simon Xin Min Dong" userId="6647684b-86c4-4538-a0ea-723982d85692" providerId="ADAL" clId="{273A2E3A-68A0-4418-9B04-456AD733E653}" dt="2021-05-21T03:16:45.583" v="1518"/>
          <ac:spMkLst>
            <pc:docMk/>
            <pc:sldMk cId="1101007786" sldId="264"/>
            <ac:spMk id="35" creationId="{F6BC9DDE-A599-43F0-9B08-7EC6F630F4AF}"/>
          </ac:spMkLst>
        </pc:spChg>
        <pc:spChg chg="mod">
          <ac:chgData name="Simon Xin Min Dong" userId="6647684b-86c4-4538-a0ea-723982d85692" providerId="ADAL" clId="{273A2E3A-68A0-4418-9B04-456AD733E653}" dt="2021-05-21T03:16:45.583" v="1518"/>
          <ac:spMkLst>
            <pc:docMk/>
            <pc:sldMk cId="1101007786" sldId="264"/>
            <ac:spMk id="36" creationId="{B9CCD030-A494-43E5-AD47-38798C77AC3C}"/>
          </ac:spMkLst>
        </pc:spChg>
        <pc:spChg chg="mod">
          <ac:chgData name="Simon Xin Min Dong" userId="6647684b-86c4-4538-a0ea-723982d85692" providerId="ADAL" clId="{273A2E3A-68A0-4418-9B04-456AD733E653}" dt="2021-05-21T03:16:45.583" v="1518"/>
          <ac:spMkLst>
            <pc:docMk/>
            <pc:sldMk cId="1101007786" sldId="264"/>
            <ac:spMk id="37" creationId="{5E80303E-7372-40BC-ADE5-A62C55AA3A0B}"/>
          </ac:spMkLst>
        </pc:spChg>
        <pc:spChg chg="add mod">
          <ac:chgData name="Simon Xin Min Dong" userId="6647684b-86c4-4538-a0ea-723982d85692" providerId="ADAL" clId="{273A2E3A-68A0-4418-9B04-456AD733E653}" dt="2021-05-21T03:17:13.252" v="1521" actId="1076"/>
          <ac:spMkLst>
            <pc:docMk/>
            <pc:sldMk cId="1101007786" sldId="264"/>
            <ac:spMk id="38" creationId="{8126FD95-6997-480B-99D0-6A58BF6FF6A8}"/>
          </ac:spMkLst>
        </pc:spChg>
        <pc:spChg chg="add mod">
          <ac:chgData name="Simon Xin Min Dong" userId="6647684b-86c4-4538-a0ea-723982d85692" providerId="ADAL" clId="{273A2E3A-68A0-4418-9B04-456AD733E653}" dt="2021-05-21T03:17:13.252" v="1521" actId="1076"/>
          <ac:spMkLst>
            <pc:docMk/>
            <pc:sldMk cId="1101007786" sldId="264"/>
            <ac:spMk id="39" creationId="{777174FE-448F-4964-9FFC-4A4AD4211BFA}"/>
          </ac:spMkLst>
        </pc:spChg>
        <pc:grpChg chg="add mod">
          <ac:chgData name="Simon Xin Min Dong" userId="6647684b-86c4-4538-a0ea-723982d85692" providerId="ADAL" clId="{273A2E3A-68A0-4418-9B04-456AD733E653}" dt="2021-05-21T03:16:03.029" v="1514" actId="1076"/>
          <ac:grpSpMkLst>
            <pc:docMk/>
            <pc:sldMk cId="1101007786" sldId="264"/>
            <ac:grpSpMk id="10" creationId="{BB4E658C-59FF-4331-A44A-E2E4C846B615}"/>
          </ac:grpSpMkLst>
        </pc:grpChg>
        <pc:grpChg chg="add mod">
          <ac:chgData name="Simon Xin Min Dong" userId="6647684b-86c4-4538-a0ea-723982d85692" providerId="ADAL" clId="{273A2E3A-68A0-4418-9B04-456AD733E653}" dt="2021-05-21T03:16:33.390" v="1516" actId="1076"/>
          <ac:grpSpMkLst>
            <pc:docMk/>
            <pc:sldMk cId="1101007786" sldId="264"/>
            <ac:grpSpMk id="16" creationId="{73AC21B2-E25B-45D0-B7E2-66E95EE6E54D}"/>
          </ac:grpSpMkLst>
        </pc:grpChg>
        <pc:grpChg chg="add del mod">
          <ac:chgData name="Simon Xin Min Dong" userId="6647684b-86c4-4538-a0ea-723982d85692" providerId="ADAL" clId="{273A2E3A-68A0-4418-9B04-456AD733E653}" dt="2021-05-21T03:16:48.554" v="1519"/>
          <ac:grpSpMkLst>
            <pc:docMk/>
            <pc:sldMk cId="1101007786" sldId="264"/>
            <ac:grpSpMk id="27" creationId="{5A58CF69-6E9A-4253-809C-9F7CD2B97E78}"/>
          </ac:grpSpMkLst>
        </pc:grpChg>
        <pc:picChg chg="add del mod">
          <ac:chgData name="Simon Xin Min Dong" userId="6647684b-86c4-4538-a0ea-723982d85692" providerId="ADAL" clId="{273A2E3A-68A0-4418-9B04-456AD733E653}" dt="2021-05-21T02:41:27.061" v="831" actId="21"/>
          <ac:picMkLst>
            <pc:docMk/>
            <pc:sldMk cId="1101007786" sldId="264"/>
            <ac:picMk id="2" creationId="{A1B5CEF2-EA6C-45E1-A0DB-94B967605A06}"/>
          </ac:picMkLst>
        </pc:picChg>
        <pc:picChg chg="add del mod">
          <ac:chgData name="Simon Xin Min Dong" userId="6647684b-86c4-4538-a0ea-723982d85692" providerId="ADAL" clId="{273A2E3A-68A0-4418-9B04-456AD733E653}" dt="2021-05-21T02:46:10.283" v="833"/>
          <ac:picMkLst>
            <pc:docMk/>
            <pc:sldMk cId="1101007786" sldId="264"/>
            <ac:picMk id="3" creationId="{D0090E69-807B-4CA5-A90D-E211D77D459A}"/>
          </ac:picMkLst>
        </pc:picChg>
        <pc:picChg chg="add del mod">
          <ac:chgData name="Simon Xin Min Dong" userId="6647684b-86c4-4538-a0ea-723982d85692" providerId="ADAL" clId="{273A2E3A-68A0-4418-9B04-456AD733E653}" dt="2021-05-21T02:46:59.915" v="873" actId="478"/>
          <ac:picMkLst>
            <pc:docMk/>
            <pc:sldMk cId="1101007786" sldId="264"/>
            <ac:picMk id="4" creationId="{EF3806EC-3A73-429B-BCCA-15026DBFBB9D}"/>
          </ac:picMkLst>
        </pc:picChg>
        <pc:picChg chg="add del mod">
          <ac:chgData name="Simon Xin Min Dong" userId="6647684b-86c4-4538-a0ea-723982d85692" providerId="ADAL" clId="{273A2E3A-68A0-4418-9B04-456AD733E653}" dt="2021-05-21T02:51:26.907" v="896" actId="478"/>
          <ac:picMkLst>
            <pc:docMk/>
            <pc:sldMk cId="1101007786" sldId="264"/>
            <ac:picMk id="6" creationId="{A552877B-AD80-4410-A7C9-AECAD2624339}"/>
          </ac:picMkLst>
        </pc:picChg>
        <pc:picChg chg="add mod">
          <ac:chgData name="Simon Xin Min Dong" userId="6647684b-86c4-4538-a0ea-723982d85692" providerId="ADAL" clId="{273A2E3A-68A0-4418-9B04-456AD733E653}" dt="2021-05-21T02:51:37.426" v="898" actId="1076"/>
          <ac:picMkLst>
            <pc:docMk/>
            <pc:sldMk cId="1101007786" sldId="264"/>
            <ac:picMk id="7" creationId="{C4EB1C16-740E-4252-AF31-500F3366A6A2}"/>
          </ac:picMkLst>
        </pc:picChg>
      </pc:sldChg>
      <pc:sldChg chg="addSp delSp modSp add del mod">
        <pc:chgData name="Simon Xin Min Dong" userId="6647684b-86c4-4538-a0ea-723982d85692" providerId="ADAL" clId="{273A2E3A-68A0-4418-9B04-456AD733E653}" dt="2021-05-21T20:41:02.494" v="1577" actId="1036"/>
        <pc:sldMkLst>
          <pc:docMk/>
          <pc:sldMk cId="2581434553" sldId="265"/>
        </pc:sldMkLst>
        <pc:spChg chg="mod">
          <ac:chgData name="Simon Xin Min Dong" userId="6647684b-86c4-4538-a0ea-723982d85692" providerId="ADAL" clId="{273A2E3A-68A0-4418-9B04-456AD733E653}" dt="2021-05-21T20:41:02.494" v="1577" actId="1036"/>
          <ac:spMkLst>
            <pc:docMk/>
            <pc:sldMk cId="2581434553" sldId="265"/>
            <ac:spMk id="9" creationId="{5ACEFFEF-BD31-4312-A024-2F3D21A8D52C}"/>
          </ac:spMkLst>
        </pc:spChg>
        <pc:spChg chg="mod">
          <ac:chgData name="Simon Xin Min Dong" userId="6647684b-86c4-4538-a0ea-723982d85692" providerId="ADAL" clId="{273A2E3A-68A0-4418-9B04-456AD733E653}" dt="2021-05-21T20:41:02.494" v="1577" actId="1036"/>
          <ac:spMkLst>
            <pc:docMk/>
            <pc:sldMk cId="2581434553" sldId="265"/>
            <ac:spMk id="10" creationId="{B5DC7838-50A8-4B57-BDBC-C0E51DEE882F}"/>
          </ac:spMkLst>
        </pc:spChg>
        <pc:spChg chg="mod">
          <ac:chgData name="Simon Xin Min Dong" userId="6647684b-86c4-4538-a0ea-723982d85692" providerId="ADAL" clId="{273A2E3A-68A0-4418-9B04-456AD733E653}" dt="2021-05-21T20:41:02.494" v="1577" actId="1036"/>
          <ac:spMkLst>
            <pc:docMk/>
            <pc:sldMk cId="2581434553" sldId="265"/>
            <ac:spMk id="11" creationId="{1E5A8AE9-A264-4A17-8C0F-AF41A628FE56}"/>
          </ac:spMkLst>
        </pc:spChg>
        <pc:spChg chg="mod">
          <ac:chgData name="Simon Xin Min Dong" userId="6647684b-86c4-4538-a0ea-723982d85692" providerId="ADAL" clId="{273A2E3A-68A0-4418-9B04-456AD733E653}" dt="2021-05-21T20:41:02.494" v="1577" actId="1036"/>
          <ac:spMkLst>
            <pc:docMk/>
            <pc:sldMk cId="2581434553" sldId="265"/>
            <ac:spMk id="12" creationId="{C53782EA-A1DC-4EF4-9050-480B859B8A50}"/>
          </ac:spMkLst>
        </pc:spChg>
        <pc:spChg chg="mod">
          <ac:chgData name="Simon Xin Min Dong" userId="6647684b-86c4-4538-a0ea-723982d85692" providerId="ADAL" clId="{273A2E3A-68A0-4418-9B04-456AD733E653}" dt="2021-05-21T20:41:02.494" v="1577" actId="1036"/>
          <ac:spMkLst>
            <pc:docMk/>
            <pc:sldMk cId="2581434553" sldId="265"/>
            <ac:spMk id="13" creationId="{CB08EDDB-EEF9-487D-9C9E-8EBCD5D52105}"/>
          </ac:spMkLst>
        </pc:spChg>
        <pc:spChg chg="mod">
          <ac:chgData name="Simon Xin Min Dong" userId="6647684b-86c4-4538-a0ea-723982d85692" providerId="ADAL" clId="{273A2E3A-68A0-4418-9B04-456AD733E653}" dt="2021-05-21T20:41:02.494" v="1577" actId="1036"/>
          <ac:spMkLst>
            <pc:docMk/>
            <pc:sldMk cId="2581434553" sldId="265"/>
            <ac:spMk id="14" creationId="{2FE9CFEE-6A66-4F33-B7EA-EE2E504A2FBA}"/>
          </ac:spMkLst>
        </pc:spChg>
        <pc:spChg chg="mod">
          <ac:chgData name="Simon Xin Min Dong" userId="6647684b-86c4-4538-a0ea-723982d85692" providerId="ADAL" clId="{273A2E3A-68A0-4418-9B04-456AD733E653}" dt="2021-05-21T20:41:02.494" v="1577" actId="1036"/>
          <ac:spMkLst>
            <pc:docMk/>
            <pc:sldMk cId="2581434553" sldId="265"/>
            <ac:spMk id="15" creationId="{ABE995F5-2112-4956-AE3B-5B7311D5ECCE}"/>
          </ac:spMkLst>
        </pc:spChg>
        <pc:spChg chg="mod">
          <ac:chgData name="Simon Xin Min Dong" userId="6647684b-86c4-4538-a0ea-723982d85692" providerId="ADAL" clId="{273A2E3A-68A0-4418-9B04-456AD733E653}" dt="2021-05-21T20:41:02.494" v="1577" actId="1036"/>
          <ac:spMkLst>
            <pc:docMk/>
            <pc:sldMk cId="2581434553" sldId="265"/>
            <ac:spMk id="16" creationId="{7B15D83A-7D56-4DAA-91C4-F8A2C4BAEFC9}"/>
          </ac:spMkLst>
        </pc:spChg>
        <pc:spChg chg="mod">
          <ac:chgData name="Simon Xin Min Dong" userId="6647684b-86c4-4538-a0ea-723982d85692" providerId="ADAL" clId="{273A2E3A-68A0-4418-9B04-456AD733E653}" dt="2021-05-21T20:41:02.494" v="1577" actId="1036"/>
          <ac:spMkLst>
            <pc:docMk/>
            <pc:sldMk cId="2581434553" sldId="265"/>
            <ac:spMk id="17" creationId="{C7DC72A4-799C-49C1-8924-AE21D50DB250}"/>
          </ac:spMkLst>
        </pc:spChg>
        <pc:spChg chg="mod">
          <ac:chgData name="Simon Xin Min Dong" userId="6647684b-86c4-4538-a0ea-723982d85692" providerId="ADAL" clId="{273A2E3A-68A0-4418-9B04-456AD733E653}" dt="2021-05-21T20:41:02.494" v="1577" actId="1036"/>
          <ac:spMkLst>
            <pc:docMk/>
            <pc:sldMk cId="2581434553" sldId="265"/>
            <ac:spMk id="18" creationId="{B65ABE72-0D67-479D-B62B-BB17DD5D699B}"/>
          </ac:spMkLst>
        </pc:spChg>
        <pc:spChg chg="add mod">
          <ac:chgData name="Simon Xin Min Dong" userId="6647684b-86c4-4538-a0ea-723982d85692" providerId="ADAL" clId="{273A2E3A-68A0-4418-9B04-456AD733E653}" dt="2021-05-21T02:56:42.369" v="988" actId="1076"/>
          <ac:spMkLst>
            <pc:docMk/>
            <pc:sldMk cId="2581434553" sldId="265"/>
            <ac:spMk id="19" creationId="{158287E1-32D8-40E9-AA2B-ED5F05525607}"/>
          </ac:spMkLst>
        </pc:spChg>
        <pc:spChg chg="add mod">
          <ac:chgData name="Simon Xin Min Dong" userId="6647684b-86c4-4538-a0ea-723982d85692" providerId="ADAL" clId="{273A2E3A-68A0-4418-9B04-456AD733E653}" dt="2021-05-21T02:56:42.369" v="988" actId="1076"/>
          <ac:spMkLst>
            <pc:docMk/>
            <pc:sldMk cId="2581434553" sldId="265"/>
            <ac:spMk id="20" creationId="{FD159075-4E2C-4DEE-B383-4934598C92F4}"/>
          </ac:spMkLst>
        </pc:spChg>
        <pc:spChg chg="mod">
          <ac:chgData name="Simon Xin Min Dong" userId="6647684b-86c4-4538-a0ea-723982d85692" providerId="ADAL" clId="{273A2E3A-68A0-4418-9B04-456AD733E653}" dt="2021-05-21T02:57:21.266" v="1034" actId="1036"/>
          <ac:spMkLst>
            <pc:docMk/>
            <pc:sldMk cId="2581434553" sldId="265"/>
            <ac:spMk id="22" creationId="{D3FB8F25-D97C-4DD5-B3AF-84043943BB91}"/>
          </ac:spMkLst>
        </pc:spChg>
        <pc:spChg chg="mod">
          <ac:chgData name="Simon Xin Min Dong" userId="6647684b-86c4-4538-a0ea-723982d85692" providerId="ADAL" clId="{273A2E3A-68A0-4418-9B04-456AD733E653}" dt="2021-05-21T03:06:17.721" v="1323" actId="408"/>
          <ac:spMkLst>
            <pc:docMk/>
            <pc:sldMk cId="2581434553" sldId="265"/>
            <ac:spMk id="23" creationId="{2D8BBF3B-382D-48AE-AC28-06ED4FDA7BD4}"/>
          </ac:spMkLst>
        </pc:spChg>
        <pc:spChg chg="mod">
          <ac:chgData name="Simon Xin Min Dong" userId="6647684b-86c4-4538-a0ea-723982d85692" providerId="ADAL" clId="{273A2E3A-68A0-4418-9B04-456AD733E653}" dt="2021-05-21T03:06:17.721" v="1323" actId="408"/>
          <ac:spMkLst>
            <pc:docMk/>
            <pc:sldMk cId="2581434553" sldId="265"/>
            <ac:spMk id="24" creationId="{ECD64F72-706F-4822-91AD-6BD23F88D524}"/>
          </ac:spMkLst>
        </pc:spChg>
        <pc:spChg chg="mod">
          <ac:chgData name="Simon Xin Min Dong" userId="6647684b-86c4-4538-a0ea-723982d85692" providerId="ADAL" clId="{273A2E3A-68A0-4418-9B04-456AD733E653}" dt="2021-05-21T03:06:17.721" v="1323" actId="408"/>
          <ac:spMkLst>
            <pc:docMk/>
            <pc:sldMk cId="2581434553" sldId="265"/>
            <ac:spMk id="25" creationId="{2983058E-FC1F-4DFD-A428-50273C1DFE99}"/>
          </ac:spMkLst>
        </pc:spChg>
        <pc:spChg chg="mod">
          <ac:chgData name="Simon Xin Min Dong" userId="6647684b-86c4-4538-a0ea-723982d85692" providerId="ADAL" clId="{273A2E3A-68A0-4418-9B04-456AD733E653}" dt="2021-05-21T03:06:00.546" v="1322" actId="1076"/>
          <ac:spMkLst>
            <pc:docMk/>
            <pc:sldMk cId="2581434553" sldId="265"/>
            <ac:spMk id="26" creationId="{52374572-C219-4248-B0F4-C2E3FA75AD71}"/>
          </ac:spMkLst>
        </pc:spChg>
        <pc:spChg chg="add mod">
          <ac:chgData name="Simon Xin Min Dong" userId="6647684b-86c4-4538-a0ea-723982d85692" providerId="ADAL" clId="{273A2E3A-68A0-4418-9B04-456AD733E653}" dt="2021-05-21T03:18:34.455" v="1549" actId="20577"/>
          <ac:spMkLst>
            <pc:docMk/>
            <pc:sldMk cId="2581434553" sldId="265"/>
            <ac:spMk id="27" creationId="{EB0A639F-0D24-484F-B27A-3EC7B6AC4E80}"/>
          </ac:spMkLst>
        </pc:spChg>
        <pc:grpChg chg="add mod">
          <ac:chgData name="Simon Xin Min Dong" userId="6647684b-86c4-4538-a0ea-723982d85692" providerId="ADAL" clId="{273A2E3A-68A0-4418-9B04-456AD733E653}" dt="2021-05-21T20:41:02.494" v="1577" actId="1036"/>
          <ac:grpSpMkLst>
            <pc:docMk/>
            <pc:sldMk cId="2581434553" sldId="265"/>
            <ac:grpSpMk id="8" creationId="{B16E2B2E-E8A1-4414-973F-43911322E89D}"/>
          </ac:grpSpMkLst>
        </pc:grpChg>
        <pc:grpChg chg="add mod">
          <ac:chgData name="Simon Xin Min Dong" userId="6647684b-86c4-4538-a0ea-723982d85692" providerId="ADAL" clId="{273A2E3A-68A0-4418-9B04-456AD733E653}" dt="2021-05-21T03:05:54.583" v="1321" actId="1076"/>
          <ac:grpSpMkLst>
            <pc:docMk/>
            <pc:sldMk cId="2581434553" sldId="265"/>
            <ac:grpSpMk id="21" creationId="{31F01EBC-B456-4C25-AA4E-91596421D963}"/>
          </ac:grpSpMkLst>
        </pc:grpChg>
        <pc:picChg chg="add del mod">
          <ac:chgData name="Simon Xin Min Dong" userId="6647684b-86c4-4538-a0ea-723982d85692" providerId="ADAL" clId="{273A2E3A-68A0-4418-9B04-456AD733E653}" dt="2021-05-21T02:52:53.336" v="912" actId="478"/>
          <ac:picMkLst>
            <pc:docMk/>
            <pc:sldMk cId="2581434553" sldId="265"/>
            <ac:picMk id="3" creationId="{6AB824E8-16A9-48BB-912F-7272274E5F7C}"/>
          </ac:picMkLst>
        </pc:picChg>
        <pc:picChg chg="add del mod">
          <ac:chgData name="Simon Xin Min Dong" userId="6647684b-86c4-4538-a0ea-723982d85692" providerId="ADAL" clId="{273A2E3A-68A0-4418-9B04-456AD733E653}" dt="2021-05-21T02:52:07.073" v="904" actId="478"/>
          <ac:picMkLst>
            <pc:docMk/>
            <pc:sldMk cId="2581434553" sldId="265"/>
            <ac:picMk id="5" creationId="{5C2A343C-1CBE-4FBA-BCEA-5B84907CA7CA}"/>
          </ac:picMkLst>
        </pc:picChg>
        <pc:picChg chg="add mod">
          <ac:chgData name="Simon Xin Min Dong" userId="6647684b-86c4-4538-a0ea-723982d85692" providerId="ADAL" clId="{273A2E3A-68A0-4418-9B04-456AD733E653}" dt="2021-05-21T02:56:42.369" v="988" actId="1076"/>
          <ac:picMkLst>
            <pc:docMk/>
            <pc:sldMk cId="2581434553" sldId="265"/>
            <ac:picMk id="7" creationId="{8811492D-41AD-4985-9F75-D5C1B9AE1E5B}"/>
          </ac:picMkLst>
        </pc:picChg>
      </pc:sldChg>
      <pc:sldChg chg="addSp delSp modSp mod ord">
        <pc:chgData name="Simon Xin Min Dong" userId="6647684b-86c4-4538-a0ea-723982d85692" providerId="ADAL" clId="{273A2E3A-68A0-4418-9B04-456AD733E653}" dt="2021-05-21T20:41:14.990" v="1583" actId="1036"/>
        <pc:sldMkLst>
          <pc:docMk/>
          <pc:sldMk cId="2632378769" sldId="266"/>
        </pc:sldMkLst>
        <pc:spChg chg="add mod">
          <ac:chgData name="Simon Xin Min Dong" userId="6647684b-86c4-4538-a0ea-723982d85692" providerId="ADAL" clId="{273A2E3A-68A0-4418-9B04-456AD733E653}" dt="2021-05-21T03:17:42.939" v="1525" actId="20577"/>
          <ac:spMkLst>
            <pc:docMk/>
            <pc:sldMk cId="2632378769" sldId="266"/>
            <ac:spMk id="5" creationId="{51F68246-C516-47F5-B674-42AD1DD8D780}"/>
          </ac:spMkLst>
        </pc:spChg>
        <pc:spChg chg="add del mod">
          <ac:chgData name="Simon Xin Min Dong" userId="6647684b-86c4-4538-a0ea-723982d85692" providerId="ADAL" clId="{273A2E3A-68A0-4418-9B04-456AD733E653}" dt="2021-05-21T03:06:39.438" v="1324" actId="478"/>
          <ac:spMkLst>
            <pc:docMk/>
            <pc:sldMk cId="2632378769" sldId="266"/>
            <ac:spMk id="6" creationId="{1B20B6EC-51E5-4095-B034-1DC87EF3BE61}"/>
          </ac:spMkLst>
        </pc:spChg>
        <pc:spChg chg="add mod">
          <ac:chgData name="Simon Xin Min Dong" userId="6647684b-86c4-4538-a0ea-723982d85692" providerId="ADAL" clId="{273A2E3A-68A0-4418-9B04-456AD733E653}" dt="2021-05-21T03:11:29.628" v="1458" actId="14100"/>
          <ac:spMkLst>
            <pc:docMk/>
            <pc:sldMk cId="2632378769" sldId="266"/>
            <ac:spMk id="7" creationId="{0EDB539A-11AC-4A02-8DE6-71610AACB6B4}"/>
          </ac:spMkLst>
        </pc:spChg>
        <pc:spChg chg="mod">
          <ac:chgData name="Simon Xin Min Dong" userId="6647684b-86c4-4538-a0ea-723982d85692" providerId="ADAL" clId="{273A2E3A-68A0-4418-9B04-456AD733E653}" dt="2021-05-21T20:41:14.990" v="1583" actId="1036"/>
          <ac:spMkLst>
            <pc:docMk/>
            <pc:sldMk cId="2632378769" sldId="266"/>
            <ac:spMk id="9" creationId="{09FFAA76-1A56-4C65-81E2-0FC7F7FF227A}"/>
          </ac:spMkLst>
        </pc:spChg>
        <pc:spChg chg="mod">
          <ac:chgData name="Simon Xin Min Dong" userId="6647684b-86c4-4538-a0ea-723982d85692" providerId="ADAL" clId="{273A2E3A-68A0-4418-9B04-456AD733E653}" dt="2021-05-21T20:41:14.990" v="1583" actId="1036"/>
          <ac:spMkLst>
            <pc:docMk/>
            <pc:sldMk cId="2632378769" sldId="266"/>
            <ac:spMk id="10" creationId="{7DF4302B-12F4-4B43-8537-2A9436D779C0}"/>
          </ac:spMkLst>
        </pc:spChg>
        <pc:spChg chg="mod">
          <ac:chgData name="Simon Xin Min Dong" userId="6647684b-86c4-4538-a0ea-723982d85692" providerId="ADAL" clId="{273A2E3A-68A0-4418-9B04-456AD733E653}" dt="2021-05-21T20:41:14.990" v="1583" actId="1036"/>
          <ac:spMkLst>
            <pc:docMk/>
            <pc:sldMk cId="2632378769" sldId="266"/>
            <ac:spMk id="11" creationId="{E350659E-4B99-47FE-872C-2C32701834D6}"/>
          </ac:spMkLst>
        </pc:spChg>
        <pc:spChg chg="mod">
          <ac:chgData name="Simon Xin Min Dong" userId="6647684b-86c4-4538-a0ea-723982d85692" providerId="ADAL" clId="{273A2E3A-68A0-4418-9B04-456AD733E653}" dt="2021-05-21T20:41:14.990" v="1583" actId="1036"/>
          <ac:spMkLst>
            <pc:docMk/>
            <pc:sldMk cId="2632378769" sldId="266"/>
            <ac:spMk id="12" creationId="{56EDF024-E04C-4A9F-A1CE-0D52D7CF63D6}"/>
          </ac:spMkLst>
        </pc:spChg>
        <pc:spChg chg="mod">
          <ac:chgData name="Simon Xin Min Dong" userId="6647684b-86c4-4538-a0ea-723982d85692" providerId="ADAL" clId="{273A2E3A-68A0-4418-9B04-456AD733E653}" dt="2021-05-21T20:41:14.990" v="1583" actId="1036"/>
          <ac:spMkLst>
            <pc:docMk/>
            <pc:sldMk cId="2632378769" sldId="266"/>
            <ac:spMk id="13" creationId="{B409C642-BCC4-4D73-B8FF-332965D5055A}"/>
          </ac:spMkLst>
        </pc:spChg>
        <pc:spChg chg="mod">
          <ac:chgData name="Simon Xin Min Dong" userId="6647684b-86c4-4538-a0ea-723982d85692" providerId="ADAL" clId="{273A2E3A-68A0-4418-9B04-456AD733E653}" dt="2021-05-21T20:41:14.990" v="1583" actId="1036"/>
          <ac:spMkLst>
            <pc:docMk/>
            <pc:sldMk cId="2632378769" sldId="266"/>
            <ac:spMk id="14" creationId="{1606C358-A850-49B6-9B3A-AAED2E3B8ADF}"/>
          </ac:spMkLst>
        </pc:spChg>
        <pc:spChg chg="mod">
          <ac:chgData name="Simon Xin Min Dong" userId="6647684b-86c4-4538-a0ea-723982d85692" providerId="ADAL" clId="{273A2E3A-68A0-4418-9B04-456AD733E653}" dt="2021-05-21T20:41:14.990" v="1583" actId="1036"/>
          <ac:spMkLst>
            <pc:docMk/>
            <pc:sldMk cId="2632378769" sldId="266"/>
            <ac:spMk id="15" creationId="{65B994BD-C10B-40E2-BD9E-B06EE820C515}"/>
          </ac:spMkLst>
        </pc:spChg>
        <pc:spChg chg="mod">
          <ac:chgData name="Simon Xin Min Dong" userId="6647684b-86c4-4538-a0ea-723982d85692" providerId="ADAL" clId="{273A2E3A-68A0-4418-9B04-456AD733E653}" dt="2021-05-21T20:41:14.990" v="1583" actId="1036"/>
          <ac:spMkLst>
            <pc:docMk/>
            <pc:sldMk cId="2632378769" sldId="266"/>
            <ac:spMk id="16" creationId="{936C2E64-2053-4B21-BC38-FFCB5ADB5EF3}"/>
          </ac:spMkLst>
        </pc:spChg>
        <pc:spChg chg="mod">
          <ac:chgData name="Simon Xin Min Dong" userId="6647684b-86c4-4538-a0ea-723982d85692" providerId="ADAL" clId="{273A2E3A-68A0-4418-9B04-456AD733E653}" dt="2021-05-21T20:41:14.990" v="1583" actId="1036"/>
          <ac:spMkLst>
            <pc:docMk/>
            <pc:sldMk cId="2632378769" sldId="266"/>
            <ac:spMk id="17" creationId="{8A49C004-CDFD-481D-917A-FBCEBB4DFA7A}"/>
          </ac:spMkLst>
        </pc:spChg>
        <pc:spChg chg="mod">
          <ac:chgData name="Simon Xin Min Dong" userId="6647684b-86c4-4538-a0ea-723982d85692" providerId="ADAL" clId="{273A2E3A-68A0-4418-9B04-456AD733E653}" dt="2021-05-21T20:41:14.990" v="1583" actId="1036"/>
          <ac:spMkLst>
            <pc:docMk/>
            <pc:sldMk cId="2632378769" sldId="266"/>
            <ac:spMk id="18" creationId="{D316CA78-A921-447B-A3A5-BE8068AFEB28}"/>
          </ac:spMkLst>
        </pc:spChg>
        <pc:spChg chg="add mod">
          <ac:chgData name="Simon Xin Min Dong" userId="6647684b-86c4-4538-a0ea-723982d85692" providerId="ADAL" clId="{273A2E3A-68A0-4418-9B04-456AD733E653}" dt="2021-05-21T03:19:07.865" v="1557" actId="1036"/>
          <ac:spMkLst>
            <pc:docMk/>
            <pc:sldMk cId="2632378769" sldId="266"/>
            <ac:spMk id="19" creationId="{98D566AF-EBCA-49F4-AF8A-728CB46E1A08}"/>
          </ac:spMkLst>
        </pc:spChg>
        <pc:spChg chg="add mod">
          <ac:chgData name="Simon Xin Min Dong" userId="6647684b-86c4-4538-a0ea-723982d85692" providerId="ADAL" clId="{273A2E3A-68A0-4418-9B04-456AD733E653}" dt="2021-05-21T03:19:12.492" v="1563" actId="1035"/>
          <ac:spMkLst>
            <pc:docMk/>
            <pc:sldMk cId="2632378769" sldId="266"/>
            <ac:spMk id="20" creationId="{F22B9B40-E3F5-411A-933B-BB38CB8368FB}"/>
          </ac:spMkLst>
        </pc:spChg>
        <pc:spChg chg="mod">
          <ac:chgData name="Simon Xin Min Dong" userId="6647684b-86c4-4538-a0ea-723982d85692" providerId="ADAL" clId="{273A2E3A-68A0-4418-9B04-456AD733E653}" dt="2021-05-21T03:15:41.578" v="1511"/>
          <ac:spMkLst>
            <pc:docMk/>
            <pc:sldMk cId="2632378769" sldId="266"/>
            <ac:spMk id="22" creationId="{1424F1D2-EF15-4F00-A0E7-5D8B4B9BB905}"/>
          </ac:spMkLst>
        </pc:spChg>
        <pc:spChg chg="mod">
          <ac:chgData name="Simon Xin Min Dong" userId="6647684b-86c4-4538-a0ea-723982d85692" providerId="ADAL" clId="{273A2E3A-68A0-4418-9B04-456AD733E653}" dt="2021-05-21T03:15:41.578" v="1511"/>
          <ac:spMkLst>
            <pc:docMk/>
            <pc:sldMk cId="2632378769" sldId="266"/>
            <ac:spMk id="23" creationId="{F8E1435E-A1CF-4C19-8220-D083730DDB1E}"/>
          </ac:spMkLst>
        </pc:spChg>
        <pc:spChg chg="mod">
          <ac:chgData name="Simon Xin Min Dong" userId="6647684b-86c4-4538-a0ea-723982d85692" providerId="ADAL" clId="{273A2E3A-68A0-4418-9B04-456AD733E653}" dt="2021-05-21T03:15:41.578" v="1511"/>
          <ac:spMkLst>
            <pc:docMk/>
            <pc:sldMk cId="2632378769" sldId="266"/>
            <ac:spMk id="24" creationId="{54A8F275-C135-4E75-AEA6-420CBDBD5A43}"/>
          </ac:spMkLst>
        </pc:spChg>
        <pc:spChg chg="mod">
          <ac:chgData name="Simon Xin Min Dong" userId="6647684b-86c4-4538-a0ea-723982d85692" providerId="ADAL" clId="{273A2E3A-68A0-4418-9B04-456AD733E653}" dt="2021-05-21T03:15:41.578" v="1511"/>
          <ac:spMkLst>
            <pc:docMk/>
            <pc:sldMk cId="2632378769" sldId="266"/>
            <ac:spMk id="25" creationId="{111E9012-7102-4E95-BB47-6245817020AA}"/>
          </ac:spMkLst>
        </pc:spChg>
        <pc:spChg chg="mod">
          <ac:chgData name="Simon Xin Min Dong" userId="6647684b-86c4-4538-a0ea-723982d85692" providerId="ADAL" clId="{273A2E3A-68A0-4418-9B04-456AD733E653}" dt="2021-05-21T03:15:41.578" v="1511"/>
          <ac:spMkLst>
            <pc:docMk/>
            <pc:sldMk cId="2632378769" sldId="266"/>
            <ac:spMk id="26" creationId="{AA4E7DD3-FF76-42E3-915F-3FA116EEE8D5}"/>
          </ac:spMkLst>
        </pc:spChg>
        <pc:spChg chg="mod">
          <ac:chgData name="Simon Xin Min Dong" userId="6647684b-86c4-4538-a0ea-723982d85692" providerId="ADAL" clId="{273A2E3A-68A0-4418-9B04-456AD733E653}" dt="2021-05-21T03:16:42.300" v="1517"/>
          <ac:spMkLst>
            <pc:docMk/>
            <pc:sldMk cId="2632378769" sldId="266"/>
            <ac:spMk id="28" creationId="{BE87A802-0538-4A59-9F62-790ED4C85B22}"/>
          </ac:spMkLst>
        </pc:spChg>
        <pc:spChg chg="mod">
          <ac:chgData name="Simon Xin Min Dong" userId="6647684b-86c4-4538-a0ea-723982d85692" providerId="ADAL" clId="{273A2E3A-68A0-4418-9B04-456AD733E653}" dt="2021-05-21T03:16:42.300" v="1517"/>
          <ac:spMkLst>
            <pc:docMk/>
            <pc:sldMk cId="2632378769" sldId="266"/>
            <ac:spMk id="29" creationId="{83B6EEE9-C6D7-46FF-A24F-E5185706097E}"/>
          </ac:spMkLst>
        </pc:spChg>
        <pc:spChg chg="mod">
          <ac:chgData name="Simon Xin Min Dong" userId="6647684b-86c4-4538-a0ea-723982d85692" providerId="ADAL" clId="{273A2E3A-68A0-4418-9B04-456AD733E653}" dt="2021-05-21T03:16:42.300" v="1517"/>
          <ac:spMkLst>
            <pc:docMk/>
            <pc:sldMk cId="2632378769" sldId="266"/>
            <ac:spMk id="30" creationId="{BABAA24A-041F-4A8B-802C-80C9D5DF7877}"/>
          </ac:spMkLst>
        </pc:spChg>
        <pc:spChg chg="mod">
          <ac:chgData name="Simon Xin Min Dong" userId="6647684b-86c4-4538-a0ea-723982d85692" providerId="ADAL" clId="{273A2E3A-68A0-4418-9B04-456AD733E653}" dt="2021-05-21T03:16:42.300" v="1517"/>
          <ac:spMkLst>
            <pc:docMk/>
            <pc:sldMk cId="2632378769" sldId="266"/>
            <ac:spMk id="31" creationId="{D4AB6FFD-0417-476C-8858-5AAF4639C34A}"/>
          </ac:spMkLst>
        </pc:spChg>
        <pc:spChg chg="mod">
          <ac:chgData name="Simon Xin Min Dong" userId="6647684b-86c4-4538-a0ea-723982d85692" providerId="ADAL" clId="{273A2E3A-68A0-4418-9B04-456AD733E653}" dt="2021-05-21T03:16:42.300" v="1517"/>
          <ac:spMkLst>
            <pc:docMk/>
            <pc:sldMk cId="2632378769" sldId="266"/>
            <ac:spMk id="32" creationId="{0D4FD2D8-6278-4EE9-AA23-D6BA873858DD}"/>
          </ac:spMkLst>
        </pc:spChg>
        <pc:spChg chg="mod">
          <ac:chgData name="Simon Xin Min Dong" userId="6647684b-86c4-4538-a0ea-723982d85692" providerId="ADAL" clId="{273A2E3A-68A0-4418-9B04-456AD733E653}" dt="2021-05-21T03:16:42.300" v="1517"/>
          <ac:spMkLst>
            <pc:docMk/>
            <pc:sldMk cId="2632378769" sldId="266"/>
            <ac:spMk id="33" creationId="{C818B8FF-EE0A-482D-B087-5AE7A229B9AA}"/>
          </ac:spMkLst>
        </pc:spChg>
        <pc:spChg chg="mod">
          <ac:chgData name="Simon Xin Min Dong" userId="6647684b-86c4-4538-a0ea-723982d85692" providerId="ADAL" clId="{273A2E3A-68A0-4418-9B04-456AD733E653}" dt="2021-05-21T03:16:42.300" v="1517"/>
          <ac:spMkLst>
            <pc:docMk/>
            <pc:sldMk cId="2632378769" sldId="266"/>
            <ac:spMk id="34" creationId="{313F0C94-95D4-4FE7-B99E-6C7444ABA0CA}"/>
          </ac:spMkLst>
        </pc:spChg>
        <pc:spChg chg="mod">
          <ac:chgData name="Simon Xin Min Dong" userId="6647684b-86c4-4538-a0ea-723982d85692" providerId="ADAL" clId="{273A2E3A-68A0-4418-9B04-456AD733E653}" dt="2021-05-21T03:16:42.300" v="1517"/>
          <ac:spMkLst>
            <pc:docMk/>
            <pc:sldMk cId="2632378769" sldId="266"/>
            <ac:spMk id="35" creationId="{795F21D5-FA25-4A75-9FCE-CB1A703D91A7}"/>
          </ac:spMkLst>
        </pc:spChg>
        <pc:spChg chg="mod">
          <ac:chgData name="Simon Xin Min Dong" userId="6647684b-86c4-4538-a0ea-723982d85692" providerId="ADAL" clId="{273A2E3A-68A0-4418-9B04-456AD733E653}" dt="2021-05-21T03:16:42.300" v="1517"/>
          <ac:spMkLst>
            <pc:docMk/>
            <pc:sldMk cId="2632378769" sldId="266"/>
            <ac:spMk id="36" creationId="{C976E3DE-075D-4BE4-B416-7F978665FB6B}"/>
          </ac:spMkLst>
        </pc:spChg>
        <pc:spChg chg="mod">
          <ac:chgData name="Simon Xin Min Dong" userId="6647684b-86c4-4538-a0ea-723982d85692" providerId="ADAL" clId="{273A2E3A-68A0-4418-9B04-456AD733E653}" dt="2021-05-21T03:16:42.300" v="1517"/>
          <ac:spMkLst>
            <pc:docMk/>
            <pc:sldMk cId="2632378769" sldId="266"/>
            <ac:spMk id="37" creationId="{87A9AAFF-29BA-4E1A-AA0C-82B05CEEF825}"/>
          </ac:spMkLst>
        </pc:spChg>
        <pc:grpChg chg="add mod">
          <ac:chgData name="Simon Xin Min Dong" userId="6647684b-86c4-4538-a0ea-723982d85692" providerId="ADAL" clId="{273A2E3A-68A0-4418-9B04-456AD733E653}" dt="2021-05-21T20:41:14.990" v="1583" actId="1036"/>
          <ac:grpSpMkLst>
            <pc:docMk/>
            <pc:sldMk cId="2632378769" sldId="266"/>
            <ac:grpSpMk id="8" creationId="{DD8B3C93-AB03-4A53-A0E3-6E5872478A00}"/>
          </ac:grpSpMkLst>
        </pc:grpChg>
        <pc:grpChg chg="add mod">
          <ac:chgData name="Simon Xin Min Dong" userId="6647684b-86c4-4538-a0ea-723982d85692" providerId="ADAL" clId="{273A2E3A-68A0-4418-9B04-456AD733E653}" dt="2021-05-21T03:15:51.539" v="1512" actId="1076"/>
          <ac:grpSpMkLst>
            <pc:docMk/>
            <pc:sldMk cId="2632378769" sldId="266"/>
            <ac:grpSpMk id="21" creationId="{DA679B68-CA27-459A-BB05-12C681EDEBBF}"/>
          </ac:grpSpMkLst>
        </pc:grpChg>
        <pc:grpChg chg="add del mod">
          <ac:chgData name="Simon Xin Min Dong" userId="6647684b-86c4-4538-a0ea-723982d85692" providerId="ADAL" clId="{273A2E3A-68A0-4418-9B04-456AD733E653}" dt="2021-05-21T03:18:50.547" v="1550" actId="478"/>
          <ac:grpSpMkLst>
            <pc:docMk/>
            <pc:sldMk cId="2632378769" sldId="266"/>
            <ac:grpSpMk id="27" creationId="{56EDCBF1-CE2A-4B9E-B94C-F20C783B6D5A}"/>
          </ac:grpSpMkLst>
        </pc:grpChg>
        <pc:picChg chg="add del mod">
          <ac:chgData name="Simon Xin Min Dong" userId="6647684b-86c4-4538-a0ea-723982d85692" providerId="ADAL" clId="{273A2E3A-68A0-4418-9B04-456AD733E653}" dt="2021-05-21T02:52:10.716" v="905" actId="478"/>
          <ac:picMkLst>
            <pc:docMk/>
            <pc:sldMk cId="2632378769" sldId="266"/>
            <ac:picMk id="3" creationId="{ED528EBA-F2B8-4E17-A5DE-4747CD0E1103}"/>
          </ac:picMkLst>
        </pc:picChg>
        <pc:picChg chg="add mod">
          <ac:chgData name="Simon Xin Min Dong" userId="6647684b-86c4-4538-a0ea-723982d85692" providerId="ADAL" clId="{273A2E3A-68A0-4418-9B04-456AD733E653}" dt="2021-05-21T02:52:19.644" v="906"/>
          <ac:picMkLst>
            <pc:docMk/>
            <pc:sldMk cId="2632378769" sldId="266"/>
            <ac:picMk id="4" creationId="{DCB8BB63-5F3E-4A3A-ABDC-8B3E9454A119}"/>
          </ac:picMkLst>
        </pc:picChg>
      </pc:sldChg>
      <pc:sldChg chg="del">
        <pc:chgData name="Simon Xin Min Dong" userId="6647684b-86c4-4538-a0ea-723982d85692" providerId="ADAL" clId="{273A2E3A-68A0-4418-9B04-456AD733E653}" dt="2021-05-21T02:37:00.994" v="731" actId="47"/>
        <pc:sldMkLst>
          <pc:docMk/>
          <pc:sldMk cId="2599586786" sldId="267"/>
        </pc:sldMkLst>
      </pc:sldChg>
      <pc:sldChg chg="modSp mod">
        <pc:chgData name="Simon Xin Min Dong" userId="6647684b-86c4-4538-a0ea-723982d85692" providerId="ADAL" clId="{273A2E3A-68A0-4418-9B04-456AD733E653}" dt="2021-05-21T02:38:08.927" v="798" actId="1036"/>
        <pc:sldMkLst>
          <pc:docMk/>
          <pc:sldMk cId="386154674" sldId="268"/>
        </pc:sldMkLst>
        <pc:spChg chg="mod">
          <ac:chgData name="Simon Xin Min Dong" userId="6647684b-86c4-4538-a0ea-723982d85692" providerId="ADAL" clId="{273A2E3A-68A0-4418-9B04-456AD733E653}" dt="2021-05-21T02:38:08.927" v="798" actId="1036"/>
          <ac:spMkLst>
            <pc:docMk/>
            <pc:sldMk cId="386154674" sldId="268"/>
            <ac:spMk id="7" creationId="{BF51C8F7-0F82-4D6C-8DB5-D5F51244EDBF}"/>
          </ac:spMkLst>
        </pc:spChg>
        <pc:spChg chg="mod">
          <ac:chgData name="Simon Xin Min Dong" userId="6647684b-86c4-4538-a0ea-723982d85692" providerId="ADAL" clId="{273A2E3A-68A0-4418-9B04-456AD733E653}" dt="2021-05-21T02:38:08.927" v="798" actId="1036"/>
          <ac:spMkLst>
            <pc:docMk/>
            <pc:sldMk cId="386154674" sldId="268"/>
            <ac:spMk id="8" creationId="{A4F5D02A-DDC1-4942-9F31-82328107ABC2}"/>
          </ac:spMkLst>
        </pc:spChg>
        <pc:spChg chg="mod">
          <ac:chgData name="Simon Xin Min Dong" userId="6647684b-86c4-4538-a0ea-723982d85692" providerId="ADAL" clId="{273A2E3A-68A0-4418-9B04-456AD733E653}" dt="2021-05-21T02:38:08.927" v="798" actId="1036"/>
          <ac:spMkLst>
            <pc:docMk/>
            <pc:sldMk cId="386154674" sldId="268"/>
            <ac:spMk id="9" creationId="{1E635D08-765D-4290-80AE-78637EC41617}"/>
          </ac:spMkLst>
        </pc:spChg>
        <pc:spChg chg="mod">
          <ac:chgData name="Simon Xin Min Dong" userId="6647684b-86c4-4538-a0ea-723982d85692" providerId="ADAL" clId="{273A2E3A-68A0-4418-9B04-456AD733E653}" dt="2021-05-21T02:38:08.927" v="798" actId="1036"/>
          <ac:spMkLst>
            <pc:docMk/>
            <pc:sldMk cId="386154674" sldId="268"/>
            <ac:spMk id="11" creationId="{42208BB2-589F-47E0-B2E4-C7976CDF08B0}"/>
          </ac:spMkLst>
        </pc:spChg>
        <pc:spChg chg="mod">
          <ac:chgData name="Simon Xin Min Dong" userId="6647684b-86c4-4538-a0ea-723982d85692" providerId="ADAL" clId="{273A2E3A-68A0-4418-9B04-456AD733E653}" dt="2021-05-21T02:38:08.927" v="798" actId="1036"/>
          <ac:spMkLst>
            <pc:docMk/>
            <pc:sldMk cId="386154674" sldId="268"/>
            <ac:spMk id="14" creationId="{7B8E200B-3FC0-4B67-AE9D-1C600380E74D}"/>
          </ac:spMkLst>
        </pc:spChg>
        <pc:spChg chg="mod">
          <ac:chgData name="Simon Xin Min Dong" userId="6647684b-86c4-4538-a0ea-723982d85692" providerId="ADAL" clId="{273A2E3A-68A0-4418-9B04-456AD733E653}" dt="2021-05-21T02:38:08.927" v="798" actId="1036"/>
          <ac:spMkLst>
            <pc:docMk/>
            <pc:sldMk cId="386154674" sldId="268"/>
            <ac:spMk id="15" creationId="{6E77F925-7E79-476D-9A02-5702EC256B89}"/>
          </ac:spMkLst>
        </pc:spChg>
        <pc:spChg chg="mod">
          <ac:chgData name="Simon Xin Min Dong" userId="6647684b-86c4-4538-a0ea-723982d85692" providerId="ADAL" clId="{273A2E3A-68A0-4418-9B04-456AD733E653}" dt="2021-05-21T02:38:08.927" v="798" actId="1036"/>
          <ac:spMkLst>
            <pc:docMk/>
            <pc:sldMk cId="386154674" sldId="268"/>
            <ac:spMk id="16" creationId="{E593EF28-03AC-4586-BD5E-4DB4496A0682}"/>
          </ac:spMkLst>
        </pc:spChg>
        <pc:spChg chg="mod">
          <ac:chgData name="Simon Xin Min Dong" userId="6647684b-86c4-4538-a0ea-723982d85692" providerId="ADAL" clId="{273A2E3A-68A0-4418-9B04-456AD733E653}" dt="2021-05-21T02:38:08.927" v="798" actId="1036"/>
          <ac:spMkLst>
            <pc:docMk/>
            <pc:sldMk cId="386154674" sldId="268"/>
            <ac:spMk id="20" creationId="{6F7BAB0E-50A6-497C-848C-24B56DFCD149}"/>
          </ac:spMkLst>
        </pc:spChg>
        <pc:spChg chg="mod">
          <ac:chgData name="Simon Xin Min Dong" userId="6647684b-86c4-4538-a0ea-723982d85692" providerId="ADAL" clId="{273A2E3A-68A0-4418-9B04-456AD733E653}" dt="2021-05-21T02:38:08.927" v="798" actId="1036"/>
          <ac:spMkLst>
            <pc:docMk/>
            <pc:sldMk cId="386154674" sldId="268"/>
            <ac:spMk id="22" creationId="{19085A89-6CBE-48D4-AF85-1BA8A1D762C5}"/>
          </ac:spMkLst>
        </pc:spChg>
        <pc:graphicFrameChg chg="mod">
          <ac:chgData name="Simon Xin Min Dong" userId="6647684b-86c4-4538-a0ea-723982d85692" providerId="ADAL" clId="{273A2E3A-68A0-4418-9B04-456AD733E653}" dt="2021-05-21T02:38:08.927" v="798" actId="1036"/>
          <ac:graphicFrameMkLst>
            <pc:docMk/>
            <pc:sldMk cId="386154674" sldId="268"/>
            <ac:graphicFrameMk id="5" creationId="{9C9CCE01-E603-4CD5-B011-3C5897506CAC}"/>
          </ac:graphicFrameMkLst>
        </pc:graphicFrameChg>
        <pc:graphicFrameChg chg="mod">
          <ac:chgData name="Simon Xin Min Dong" userId="6647684b-86c4-4538-a0ea-723982d85692" providerId="ADAL" clId="{273A2E3A-68A0-4418-9B04-456AD733E653}" dt="2021-05-21T02:38:08.927" v="798" actId="1036"/>
          <ac:graphicFrameMkLst>
            <pc:docMk/>
            <pc:sldMk cId="386154674" sldId="268"/>
            <ac:graphicFrameMk id="10" creationId="{712473BE-B3F0-48BD-8681-C3DDC0697BED}"/>
          </ac:graphicFrameMkLst>
        </pc:graphicFrameChg>
        <pc:graphicFrameChg chg="mod">
          <ac:chgData name="Simon Xin Min Dong" userId="6647684b-86c4-4538-a0ea-723982d85692" providerId="ADAL" clId="{273A2E3A-68A0-4418-9B04-456AD733E653}" dt="2021-05-21T02:38:08.927" v="798" actId="1036"/>
          <ac:graphicFrameMkLst>
            <pc:docMk/>
            <pc:sldMk cId="386154674" sldId="268"/>
            <ac:graphicFrameMk id="12" creationId="{47CA1F48-7A48-470B-B2CC-FC21FCDB55CE}"/>
          </ac:graphicFrameMkLst>
        </pc:graphicFrameChg>
        <pc:graphicFrameChg chg="mod">
          <ac:chgData name="Simon Xin Min Dong" userId="6647684b-86c4-4538-a0ea-723982d85692" providerId="ADAL" clId="{273A2E3A-68A0-4418-9B04-456AD733E653}" dt="2021-05-21T02:38:08.927" v="798" actId="1036"/>
          <ac:graphicFrameMkLst>
            <pc:docMk/>
            <pc:sldMk cId="386154674" sldId="268"/>
            <ac:graphicFrameMk id="17" creationId="{F0ED5E9D-420E-45BB-9B29-8A8D2C3B2D93}"/>
          </ac:graphicFrameMkLst>
        </pc:graphicFrameChg>
        <pc:graphicFrameChg chg="mod">
          <ac:chgData name="Simon Xin Min Dong" userId="6647684b-86c4-4538-a0ea-723982d85692" providerId="ADAL" clId="{273A2E3A-68A0-4418-9B04-456AD733E653}" dt="2021-05-21T02:38:08.927" v="798" actId="1036"/>
          <ac:graphicFrameMkLst>
            <pc:docMk/>
            <pc:sldMk cId="386154674" sldId="268"/>
            <ac:graphicFrameMk id="18" creationId="{12190B15-DAA8-4C48-80C6-B562DDCDCED8}"/>
          </ac:graphicFrameMkLst>
        </pc:graphicFrameChg>
        <pc:graphicFrameChg chg="mod">
          <ac:chgData name="Simon Xin Min Dong" userId="6647684b-86c4-4538-a0ea-723982d85692" providerId="ADAL" clId="{273A2E3A-68A0-4418-9B04-456AD733E653}" dt="2021-05-21T02:38:08.927" v="798" actId="1036"/>
          <ac:graphicFrameMkLst>
            <pc:docMk/>
            <pc:sldMk cId="386154674" sldId="268"/>
            <ac:graphicFrameMk id="19" creationId="{F669824A-1A86-4AAF-8A5C-DF100EA378D7}"/>
          </ac:graphicFrameMkLst>
        </pc:graphicFrameChg>
        <pc:picChg chg="mod">
          <ac:chgData name="Simon Xin Min Dong" userId="6647684b-86c4-4538-a0ea-723982d85692" providerId="ADAL" clId="{273A2E3A-68A0-4418-9B04-456AD733E653}" dt="2021-05-21T02:38:08.927" v="798" actId="1036"/>
          <ac:picMkLst>
            <pc:docMk/>
            <pc:sldMk cId="386154674" sldId="268"/>
            <ac:picMk id="6" creationId="{C4746B79-A64E-4617-AFFB-F5D294291C9A}"/>
          </ac:picMkLst>
        </pc:picChg>
        <pc:picChg chg="mod">
          <ac:chgData name="Simon Xin Min Dong" userId="6647684b-86c4-4538-a0ea-723982d85692" providerId="ADAL" clId="{273A2E3A-68A0-4418-9B04-456AD733E653}" dt="2021-05-21T02:38:08.927" v="798" actId="1036"/>
          <ac:picMkLst>
            <pc:docMk/>
            <pc:sldMk cId="386154674" sldId="268"/>
            <ac:picMk id="13" creationId="{2C562D5E-B0FC-4D01-A994-C15D4610522B}"/>
          </ac:picMkLst>
        </pc:picChg>
      </pc:sldChg>
      <pc:sldChg chg="modSp mod">
        <pc:chgData name="Simon Xin Min Dong" userId="6647684b-86c4-4538-a0ea-723982d85692" providerId="ADAL" clId="{273A2E3A-68A0-4418-9B04-456AD733E653}" dt="2021-05-21T02:38:27.056" v="829" actId="1036"/>
        <pc:sldMkLst>
          <pc:docMk/>
          <pc:sldMk cId="1882904827" sldId="269"/>
        </pc:sldMkLst>
        <pc:spChg chg="mod">
          <ac:chgData name="Simon Xin Min Dong" userId="6647684b-86c4-4538-a0ea-723982d85692" providerId="ADAL" clId="{273A2E3A-68A0-4418-9B04-456AD733E653}" dt="2021-05-21T02:38:27.056" v="829" actId="1036"/>
          <ac:spMkLst>
            <pc:docMk/>
            <pc:sldMk cId="1882904827" sldId="269"/>
            <ac:spMk id="25" creationId="{CD0137B2-2F2C-4EBC-A913-32CBC6D040D7}"/>
          </ac:spMkLst>
        </pc:spChg>
        <pc:grpChg chg="mod">
          <ac:chgData name="Simon Xin Min Dong" userId="6647684b-86c4-4538-a0ea-723982d85692" providerId="ADAL" clId="{273A2E3A-68A0-4418-9B04-456AD733E653}" dt="2021-05-21T02:38:27.056" v="829" actId="1036"/>
          <ac:grpSpMkLst>
            <pc:docMk/>
            <pc:sldMk cId="1882904827" sldId="269"/>
            <ac:grpSpMk id="3" creationId="{5E3217C8-2DBE-4930-A28B-46069AA75B10}"/>
          </ac:grpSpMkLst>
        </pc:grpChg>
        <pc:grpChg chg="mod">
          <ac:chgData name="Simon Xin Min Dong" userId="6647684b-86c4-4538-a0ea-723982d85692" providerId="ADAL" clId="{273A2E3A-68A0-4418-9B04-456AD733E653}" dt="2021-05-21T02:38:27.056" v="829" actId="1036"/>
          <ac:grpSpMkLst>
            <pc:docMk/>
            <pc:sldMk cId="1882904827" sldId="269"/>
            <ac:grpSpMk id="4" creationId="{43EF9634-FC4E-44D6-8389-159A6DACBF2F}"/>
          </ac:grpSpMkLst>
        </pc:grpChg>
        <pc:grpChg chg="mod">
          <ac:chgData name="Simon Xin Min Dong" userId="6647684b-86c4-4538-a0ea-723982d85692" providerId="ADAL" clId="{273A2E3A-68A0-4418-9B04-456AD733E653}" dt="2021-05-21T02:38:27.056" v="829" actId="1036"/>
          <ac:grpSpMkLst>
            <pc:docMk/>
            <pc:sldMk cId="1882904827" sldId="269"/>
            <ac:grpSpMk id="5" creationId="{C99BD2B1-4FB5-4D6C-8F73-F8F0FBE69A21}"/>
          </ac:grpSpMkLst>
        </pc:grpChg>
        <pc:grpChg chg="mod">
          <ac:chgData name="Simon Xin Min Dong" userId="6647684b-86c4-4538-a0ea-723982d85692" providerId="ADAL" clId="{273A2E3A-68A0-4418-9B04-456AD733E653}" dt="2021-05-21T02:38:27.056" v="829" actId="1036"/>
          <ac:grpSpMkLst>
            <pc:docMk/>
            <pc:sldMk cId="1882904827" sldId="269"/>
            <ac:grpSpMk id="6" creationId="{8EF80B08-6188-43CB-89D9-3AFEE08B0750}"/>
          </ac:grpSpMkLst>
        </pc:grpChg>
        <pc:grpChg chg="mod">
          <ac:chgData name="Simon Xin Min Dong" userId="6647684b-86c4-4538-a0ea-723982d85692" providerId="ADAL" clId="{273A2E3A-68A0-4418-9B04-456AD733E653}" dt="2021-05-21T02:38:27.056" v="829" actId="1036"/>
          <ac:grpSpMkLst>
            <pc:docMk/>
            <pc:sldMk cId="1882904827" sldId="269"/>
            <ac:grpSpMk id="7" creationId="{D549CB17-09BF-440E-B341-799227569F7A}"/>
          </ac:grpSpMkLst>
        </pc:grpChg>
        <pc:grpChg chg="mod">
          <ac:chgData name="Simon Xin Min Dong" userId="6647684b-86c4-4538-a0ea-723982d85692" providerId="ADAL" clId="{273A2E3A-68A0-4418-9B04-456AD733E653}" dt="2021-05-21T02:38:27.056" v="829" actId="1036"/>
          <ac:grpSpMkLst>
            <pc:docMk/>
            <pc:sldMk cId="1882904827" sldId="269"/>
            <ac:grpSpMk id="8" creationId="{B97CCEE2-F9C9-4AD2-9622-8822C86FFFDA}"/>
          </ac:grpSpMkLst>
        </pc:grpChg>
        <pc:grpChg chg="mod">
          <ac:chgData name="Simon Xin Min Dong" userId="6647684b-86c4-4538-a0ea-723982d85692" providerId="ADAL" clId="{273A2E3A-68A0-4418-9B04-456AD733E653}" dt="2021-05-21T02:38:27.056" v="829" actId="1036"/>
          <ac:grpSpMkLst>
            <pc:docMk/>
            <pc:sldMk cId="1882904827" sldId="269"/>
            <ac:grpSpMk id="9" creationId="{E6083CA3-7516-42A1-AC04-FF38BE01E017}"/>
          </ac:grpSpMkLst>
        </pc:grpChg>
      </pc:sldChg>
      <pc:sldChg chg="del">
        <pc:chgData name="Simon Xin Min Dong" userId="6647684b-86c4-4538-a0ea-723982d85692" providerId="ADAL" clId="{273A2E3A-68A0-4418-9B04-456AD733E653}" dt="2021-05-21T02:37:00.994" v="731" actId="47"/>
        <pc:sldMkLst>
          <pc:docMk/>
          <pc:sldMk cId="1876042219" sldId="270"/>
        </pc:sldMkLst>
      </pc:sldChg>
      <pc:sldChg chg="del">
        <pc:chgData name="Simon Xin Min Dong" userId="6647684b-86c4-4538-a0ea-723982d85692" providerId="ADAL" clId="{273A2E3A-68A0-4418-9B04-456AD733E653}" dt="2021-05-21T02:37:00.994" v="731" actId="47"/>
        <pc:sldMkLst>
          <pc:docMk/>
          <pc:sldMk cId="711753569" sldId="271"/>
        </pc:sldMkLst>
      </pc:sldChg>
      <pc:sldChg chg="del">
        <pc:chgData name="Simon Xin Min Dong" userId="6647684b-86c4-4538-a0ea-723982d85692" providerId="ADAL" clId="{273A2E3A-68A0-4418-9B04-456AD733E653}" dt="2021-05-21T02:37:00.994" v="731" actId="47"/>
        <pc:sldMkLst>
          <pc:docMk/>
          <pc:sldMk cId="3645070339" sldId="272"/>
        </pc:sldMkLst>
      </pc:sldChg>
      <pc:sldChg chg="del">
        <pc:chgData name="Simon Xin Min Dong" userId="6647684b-86c4-4538-a0ea-723982d85692" providerId="ADAL" clId="{273A2E3A-68A0-4418-9B04-456AD733E653}" dt="2021-05-21T02:37:00.994" v="731" actId="47"/>
        <pc:sldMkLst>
          <pc:docMk/>
          <pc:sldMk cId="481503842" sldId="273"/>
        </pc:sldMkLst>
      </pc:sldChg>
      <pc:sldChg chg="addSp delSp modSp mod">
        <pc:chgData name="Simon Xin Min Dong" userId="6647684b-86c4-4538-a0ea-723982d85692" providerId="ADAL" clId="{273A2E3A-68A0-4418-9B04-456AD733E653}" dt="2021-05-21T02:46:37.761" v="871" actId="1035"/>
        <pc:sldMkLst>
          <pc:docMk/>
          <pc:sldMk cId="853088657" sldId="274"/>
        </pc:sldMkLst>
        <pc:spChg chg="mod">
          <ac:chgData name="Simon Xin Min Dong" userId="6647684b-86c4-4538-a0ea-723982d85692" providerId="ADAL" clId="{273A2E3A-68A0-4418-9B04-456AD733E653}" dt="2021-05-21T02:46:37.761" v="871" actId="1035"/>
          <ac:spMkLst>
            <pc:docMk/>
            <pc:sldMk cId="853088657" sldId="274"/>
            <ac:spMk id="6" creationId="{CABC1B9C-DD10-4F45-819E-FEC0D7283BFC}"/>
          </ac:spMkLst>
        </pc:spChg>
        <pc:spChg chg="mod">
          <ac:chgData name="Simon Xin Min Dong" userId="6647684b-86c4-4538-a0ea-723982d85692" providerId="ADAL" clId="{273A2E3A-68A0-4418-9B04-456AD733E653}" dt="2021-05-21T02:46:37.761" v="871" actId="1035"/>
          <ac:spMkLst>
            <pc:docMk/>
            <pc:sldMk cId="853088657" sldId="274"/>
            <ac:spMk id="7" creationId="{6807DF18-A250-4879-9569-D52FE1625640}"/>
          </ac:spMkLst>
        </pc:spChg>
        <pc:spChg chg="mod">
          <ac:chgData name="Simon Xin Min Dong" userId="6647684b-86c4-4538-a0ea-723982d85692" providerId="ADAL" clId="{273A2E3A-68A0-4418-9B04-456AD733E653}" dt="2021-05-21T02:46:37.761" v="871" actId="1035"/>
          <ac:spMkLst>
            <pc:docMk/>
            <pc:sldMk cId="853088657" sldId="274"/>
            <ac:spMk id="8" creationId="{35527F7D-DFEF-48C9-AAFE-7F0AD97EF9EB}"/>
          </ac:spMkLst>
        </pc:spChg>
        <pc:spChg chg="mod">
          <ac:chgData name="Simon Xin Min Dong" userId="6647684b-86c4-4538-a0ea-723982d85692" providerId="ADAL" clId="{273A2E3A-68A0-4418-9B04-456AD733E653}" dt="2021-05-21T02:46:37.761" v="871" actId="1035"/>
          <ac:spMkLst>
            <pc:docMk/>
            <pc:sldMk cId="853088657" sldId="274"/>
            <ac:spMk id="9" creationId="{0F3C7DDE-40BC-4499-842E-3BA15400B0B8}"/>
          </ac:spMkLst>
        </pc:spChg>
        <pc:spChg chg="mod">
          <ac:chgData name="Simon Xin Min Dong" userId="6647684b-86c4-4538-a0ea-723982d85692" providerId="ADAL" clId="{273A2E3A-68A0-4418-9B04-456AD733E653}" dt="2021-05-21T02:46:37.761" v="871" actId="1035"/>
          <ac:spMkLst>
            <pc:docMk/>
            <pc:sldMk cId="853088657" sldId="274"/>
            <ac:spMk id="10" creationId="{17DF6728-775F-4E62-8761-2B2510B2EAAC}"/>
          </ac:spMkLst>
        </pc:spChg>
        <pc:spChg chg="mod">
          <ac:chgData name="Simon Xin Min Dong" userId="6647684b-86c4-4538-a0ea-723982d85692" providerId="ADAL" clId="{273A2E3A-68A0-4418-9B04-456AD733E653}" dt="2021-05-21T02:46:37.761" v="871" actId="1035"/>
          <ac:spMkLst>
            <pc:docMk/>
            <pc:sldMk cId="853088657" sldId="274"/>
            <ac:spMk id="12" creationId="{C9DB8B25-1E62-45C1-B916-C005359545CC}"/>
          </ac:spMkLst>
        </pc:spChg>
        <pc:spChg chg="mod">
          <ac:chgData name="Simon Xin Min Dong" userId="6647684b-86c4-4538-a0ea-723982d85692" providerId="ADAL" clId="{273A2E3A-68A0-4418-9B04-456AD733E653}" dt="2021-05-21T02:46:37.761" v="871" actId="1035"/>
          <ac:spMkLst>
            <pc:docMk/>
            <pc:sldMk cId="853088657" sldId="274"/>
            <ac:spMk id="13" creationId="{0517B030-B3E9-4210-B6ED-CA64BD5B1C72}"/>
          </ac:spMkLst>
        </pc:spChg>
        <pc:spChg chg="mod">
          <ac:chgData name="Simon Xin Min Dong" userId="6647684b-86c4-4538-a0ea-723982d85692" providerId="ADAL" clId="{273A2E3A-68A0-4418-9B04-456AD733E653}" dt="2021-05-21T02:46:37.761" v="871" actId="1035"/>
          <ac:spMkLst>
            <pc:docMk/>
            <pc:sldMk cId="853088657" sldId="274"/>
            <ac:spMk id="17" creationId="{32A11330-A07D-47CD-8D93-46E5D25C6E89}"/>
          </ac:spMkLst>
        </pc:spChg>
        <pc:spChg chg="mod">
          <ac:chgData name="Simon Xin Min Dong" userId="6647684b-86c4-4538-a0ea-723982d85692" providerId="ADAL" clId="{273A2E3A-68A0-4418-9B04-456AD733E653}" dt="2021-05-21T02:46:37.761" v="871" actId="1035"/>
          <ac:spMkLst>
            <pc:docMk/>
            <pc:sldMk cId="853088657" sldId="274"/>
            <ac:spMk id="18" creationId="{F24FF78C-B5CD-4A18-A661-F331B5B73F5F}"/>
          </ac:spMkLst>
        </pc:spChg>
        <pc:spChg chg="mod">
          <ac:chgData name="Simon Xin Min Dong" userId="6647684b-86c4-4538-a0ea-723982d85692" providerId="ADAL" clId="{273A2E3A-68A0-4418-9B04-456AD733E653}" dt="2021-05-21T02:46:37.761" v="871" actId="1035"/>
          <ac:spMkLst>
            <pc:docMk/>
            <pc:sldMk cId="853088657" sldId="274"/>
            <ac:spMk id="19" creationId="{A006D2C8-D66E-423C-BD79-7B205244F392}"/>
          </ac:spMkLst>
        </pc:spChg>
        <pc:spChg chg="mod">
          <ac:chgData name="Simon Xin Min Dong" userId="6647684b-86c4-4538-a0ea-723982d85692" providerId="ADAL" clId="{273A2E3A-68A0-4418-9B04-456AD733E653}" dt="2021-05-21T02:46:37.761" v="871" actId="1035"/>
          <ac:spMkLst>
            <pc:docMk/>
            <pc:sldMk cId="853088657" sldId="274"/>
            <ac:spMk id="20" creationId="{149380CE-5226-4D19-A4FB-F2C4BECEF37E}"/>
          </ac:spMkLst>
        </pc:spChg>
        <pc:spChg chg="mod">
          <ac:chgData name="Simon Xin Min Dong" userId="6647684b-86c4-4538-a0ea-723982d85692" providerId="ADAL" clId="{273A2E3A-68A0-4418-9B04-456AD733E653}" dt="2021-05-21T02:46:37.761" v="871" actId="1035"/>
          <ac:spMkLst>
            <pc:docMk/>
            <pc:sldMk cId="853088657" sldId="274"/>
            <ac:spMk id="21" creationId="{28DEC9F9-4EAE-4C7D-8D72-34A7CD26F7B5}"/>
          </ac:spMkLst>
        </pc:spChg>
        <pc:spChg chg="mod">
          <ac:chgData name="Simon Xin Min Dong" userId="6647684b-86c4-4538-a0ea-723982d85692" providerId="ADAL" clId="{273A2E3A-68A0-4418-9B04-456AD733E653}" dt="2021-05-21T02:46:37.761" v="871" actId="1035"/>
          <ac:spMkLst>
            <pc:docMk/>
            <pc:sldMk cId="853088657" sldId="274"/>
            <ac:spMk id="22" creationId="{03EAC110-9A8F-47F0-8933-589A38FA3B8F}"/>
          </ac:spMkLst>
        </pc:spChg>
        <pc:spChg chg="mod">
          <ac:chgData name="Simon Xin Min Dong" userId="6647684b-86c4-4538-a0ea-723982d85692" providerId="ADAL" clId="{273A2E3A-68A0-4418-9B04-456AD733E653}" dt="2021-05-21T02:46:37.761" v="871" actId="1035"/>
          <ac:spMkLst>
            <pc:docMk/>
            <pc:sldMk cId="853088657" sldId="274"/>
            <ac:spMk id="23" creationId="{C58C6F21-786C-4A1C-9208-4BDBA5E5D7C0}"/>
          </ac:spMkLst>
        </pc:spChg>
        <pc:spChg chg="mod topLvl">
          <ac:chgData name="Simon Xin Min Dong" userId="6647684b-86c4-4538-a0ea-723982d85692" providerId="ADAL" clId="{273A2E3A-68A0-4418-9B04-456AD733E653}" dt="2021-05-21T02:46:37.761" v="871" actId="1035"/>
          <ac:spMkLst>
            <pc:docMk/>
            <pc:sldMk cId="853088657" sldId="274"/>
            <ac:spMk id="25" creationId="{C54DF889-EFD6-4A90-8C0E-D72AC786D35F}"/>
          </ac:spMkLst>
        </pc:spChg>
        <pc:spChg chg="mod">
          <ac:chgData name="Simon Xin Min Dong" userId="6647684b-86c4-4538-a0ea-723982d85692" providerId="ADAL" clId="{273A2E3A-68A0-4418-9B04-456AD733E653}" dt="2021-05-21T02:46:37.761" v="871" actId="1035"/>
          <ac:spMkLst>
            <pc:docMk/>
            <pc:sldMk cId="853088657" sldId="274"/>
            <ac:spMk id="26" creationId="{96698DE4-13C8-4F6D-ACA0-E594FFA6A3AB}"/>
          </ac:spMkLst>
        </pc:spChg>
        <pc:spChg chg="mod topLvl">
          <ac:chgData name="Simon Xin Min Dong" userId="6647684b-86c4-4538-a0ea-723982d85692" providerId="ADAL" clId="{273A2E3A-68A0-4418-9B04-456AD733E653}" dt="2021-05-21T02:46:37.761" v="871" actId="1035"/>
          <ac:spMkLst>
            <pc:docMk/>
            <pc:sldMk cId="853088657" sldId="274"/>
            <ac:spMk id="27" creationId="{9213A078-6C66-4F64-BE54-70868DBC960D}"/>
          </ac:spMkLst>
        </pc:spChg>
        <pc:spChg chg="mod">
          <ac:chgData name="Simon Xin Min Dong" userId="6647684b-86c4-4538-a0ea-723982d85692" providerId="ADAL" clId="{273A2E3A-68A0-4418-9B04-456AD733E653}" dt="2021-05-21T02:46:37.761" v="871" actId="1035"/>
          <ac:spMkLst>
            <pc:docMk/>
            <pc:sldMk cId="853088657" sldId="274"/>
            <ac:spMk id="28" creationId="{A941FE8C-4D15-47CF-A939-82D70870E0BA}"/>
          </ac:spMkLst>
        </pc:spChg>
        <pc:spChg chg="mod">
          <ac:chgData name="Simon Xin Min Dong" userId="6647684b-86c4-4538-a0ea-723982d85692" providerId="ADAL" clId="{273A2E3A-68A0-4418-9B04-456AD733E653}" dt="2021-05-21T02:46:37.761" v="871" actId="1035"/>
          <ac:spMkLst>
            <pc:docMk/>
            <pc:sldMk cId="853088657" sldId="274"/>
            <ac:spMk id="29" creationId="{C6B48D1E-B713-46E3-A3AD-963C7A304D37}"/>
          </ac:spMkLst>
        </pc:spChg>
        <pc:spChg chg="mod">
          <ac:chgData name="Simon Xin Min Dong" userId="6647684b-86c4-4538-a0ea-723982d85692" providerId="ADAL" clId="{273A2E3A-68A0-4418-9B04-456AD733E653}" dt="2021-05-21T02:46:37.761" v="871" actId="1035"/>
          <ac:spMkLst>
            <pc:docMk/>
            <pc:sldMk cId="853088657" sldId="274"/>
            <ac:spMk id="30" creationId="{FC1A4AB8-9A9D-410B-A80D-A5CADABE8804}"/>
          </ac:spMkLst>
        </pc:spChg>
        <pc:spChg chg="mod topLvl">
          <ac:chgData name="Simon Xin Min Dong" userId="6647684b-86c4-4538-a0ea-723982d85692" providerId="ADAL" clId="{273A2E3A-68A0-4418-9B04-456AD733E653}" dt="2021-05-21T02:46:37.761" v="871" actId="1035"/>
          <ac:spMkLst>
            <pc:docMk/>
            <pc:sldMk cId="853088657" sldId="274"/>
            <ac:spMk id="31" creationId="{E71A23E9-5282-4EB8-8162-6A7DBCA8DBD2}"/>
          </ac:spMkLst>
        </pc:spChg>
        <pc:spChg chg="mod topLvl">
          <ac:chgData name="Simon Xin Min Dong" userId="6647684b-86c4-4538-a0ea-723982d85692" providerId="ADAL" clId="{273A2E3A-68A0-4418-9B04-456AD733E653}" dt="2021-05-21T02:46:37.761" v="871" actId="1035"/>
          <ac:spMkLst>
            <pc:docMk/>
            <pc:sldMk cId="853088657" sldId="274"/>
            <ac:spMk id="32" creationId="{B851EF0C-5DA5-4F97-B915-D63B8AB00DC5}"/>
          </ac:spMkLst>
        </pc:spChg>
        <pc:spChg chg="del mod">
          <ac:chgData name="Simon Xin Min Dong" userId="6647684b-86c4-4538-a0ea-723982d85692" providerId="ADAL" clId="{273A2E3A-68A0-4418-9B04-456AD733E653}" dt="2021-05-21T02:33:18.833" v="684" actId="478"/>
          <ac:spMkLst>
            <pc:docMk/>
            <pc:sldMk cId="853088657" sldId="274"/>
            <ac:spMk id="33" creationId="{A5E67EE1-5FB1-4CA4-8D45-186DEDB9674F}"/>
          </ac:spMkLst>
        </pc:spChg>
        <pc:spChg chg="add mod">
          <ac:chgData name="Simon Xin Min Dong" userId="6647684b-86c4-4538-a0ea-723982d85692" providerId="ADAL" clId="{273A2E3A-68A0-4418-9B04-456AD733E653}" dt="2021-05-21T02:46:37.761" v="871" actId="1035"/>
          <ac:spMkLst>
            <pc:docMk/>
            <pc:sldMk cId="853088657" sldId="274"/>
            <ac:spMk id="34" creationId="{EBA3A32A-AD4F-4588-960E-A696F765BAF4}"/>
          </ac:spMkLst>
        </pc:spChg>
        <pc:grpChg chg="add mod">
          <ac:chgData name="Simon Xin Min Dong" userId="6647684b-86c4-4538-a0ea-723982d85692" providerId="ADAL" clId="{273A2E3A-68A0-4418-9B04-456AD733E653}" dt="2021-05-21T02:46:37.761" v="871" actId="1035"/>
          <ac:grpSpMkLst>
            <pc:docMk/>
            <pc:sldMk cId="853088657" sldId="274"/>
            <ac:grpSpMk id="2" creationId="{FD37F227-AADF-4898-BEC9-70B4E1FB4FCD}"/>
          </ac:grpSpMkLst>
        </pc:grpChg>
        <pc:grpChg chg="mod">
          <ac:chgData name="Simon Xin Min Dong" userId="6647684b-86c4-4538-a0ea-723982d85692" providerId="ADAL" clId="{273A2E3A-68A0-4418-9B04-456AD733E653}" dt="2021-05-21T02:46:37.761" v="871" actId="1035"/>
          <ac:grpSpMkLst>
            <pc:docMk/>
            <pc:sldMk cId="853088657" sldId="274"/>
            <ac:grpSpMk id="4" creationId="{192BEC6B-DCF4-421B-9ECB-A7928E71D6A0}"/>
          </ac:grpSpMkLst>
        </pc:grpChg>
        <pc:grpChg chg="mod">
          <ac:chgData name="Simon Xin Min Dong" userId="6647684b-86c4-4538-a0ea-723982d85692" providerId="ADAL" clId="{273A2E3A-68A0-4418-9B04-456AD733E653}" dt="2021-05-21T02:46:37.761" v="871" actId="1035"/>
          <ac:grpSpMkLst>
            <pc:docMk/>
            <pc:sldMk cId="853088657" sldId="274"/>
            <ac:grpSpMk id="16" creationId="{23F26196-9277-473E-9D32-C84F89019923}"/>
          </ac:grpSpMkLst>
        </pc:grpChg>
        <pc:grpChg chg="add del mod">
          <ac:chgData name="Simon Xin Min Dong" userId="6647684b-86c4-4538-a0ea-723982d85692" providerId="ADAL" clId="{273A2E3A-68A0-4418-9B04-456AD733E653}" dt="2021-05-21T02:34:00.485" v="706" actId="165"/>
          <ac:grpSpMkLst>
            <pc:docMk/>
            <pc:sldMk cId="853088657" sldId="274"/>
            <ac:grpSpMk id="24" creationId="{C0B0295C-2A4A-496F-8CC0-60A8B04F6D50}"/>
          </ac:grpSpMkLst>
        </pc:grpChg>
        <pc:picChg chg="mod">
          <ac:chgData name="Simon Xin Min Dong" userId="6647684b-86c4-4538-a0ea-723982d85692" providerId="ADAL" clId="{273A2E3A-68A0-4418-9B04-456AD733E653}" dt="2021-05-21T02:46:37.761" v="871" actId="1035"/>
          <ac:picMkLst>
            <pc:docMk/>
            <pc:sldMk cId="853088657" sldId="274"/>
            <ac:picMk id="5" creationId="{D712A5CA-4CFB-455C-A35A-DF8C2163B35E}"/>
          </ac:picMkLst>
        </pc:picChg>
      </pc:sldChg>
    </pc:docChg>
  </pc:docChgLst>
  <pc:docChgLst>
    <pc:chgData name="Simon Xin Min Dong" userId="6647684b-86c4-4538-a0ea-723982d85692" providerId="ADAL" clId="{5E4D38C0-DC1E-4697-A7CD-1F29D24D640D}"/>
    <pc:docChg chg="modSld">
      <pc:chgData name="Simon Xin Min Dong" userId="6647684b-86c4-4538-a0ea-723982d85692" providerId="ADAL" clId="{5E4D38C0-DC1E-4697-A7CD-1F29D24D640D}" dt="2021-05-21T14:56:35.898" v="111" actId="20577"/>
      <pc:docMkLst>
        <pc:docMk/>
      </pc:docMkLst>
      <pc:sldChg chg="modSp mod">
        <pc:chgData name="Simon Xin Min Dong" userId="6647684b-86c4-4538-a0ea-723982d85692" providerId="ADAL" clId="{5E4D38C0-DC1E-4697-A7CD-1F29D24D640D}" dt="2021-05-21T14:52:08.169" v="7" actId="20577"/>
        <pc:sldMkLst>
          <pc:docMk/>
          <pc:sldMk cId="427278201" sldId="256"/>
        </pc:sldMkLst>
        <pc:spChg chg="mod">
          <ac:chgData name="Simon Xin Min Dong" userId="6647684b-86c4-4538-a0ea-723982d85692" providerId="ADAL" clId="{5E4D38C0-DC1E-4697-A7CD-1F29D24D640D}" dt="2021-05-21T14:52:08.169" v="7" actId="20577"/>
          <ac:spMkLst>
            <pc:docMk/>
            <pc:sldMk cId="427278201" sldId="256"/>
            <ac:spMk id="40" creationId="{1D589266-3798-48D8-B221-3D5C44F70777}"/>
          </ac:spMkLst>
        </pc:spChg>
      </pc:sldChg>
      <pc:sldChg chg="modSp mod">
        <pc:chgData name="Simon Xin Min Dong" userId="6647684b-86c4-4538-a0ea-723982d85692" providerId="ADAL" clId="{5E4D38C0-DC1E-4697-A7CD-1F29D24D640D}" dt="2021-05-21T14:52:22.731" v="13" actId="20577"/>
        <pc:sldMkLst>
          <pc:docMk/>
          <pc:sldMk cId="1524448352" sldId="257"/>
        </pc:sldMkLst>
        <pc:spChg chg="mod">
          <ac:chgData name="Simon Xin Min Dong" userId="6647684b-86c4-4538-a0ea-723982d85692" providerId="ADAL" clId="{5E4D38C0-DC1E-4697-A7CD-1F29D24D640D}" dt="2021-05-21T14:52:22.731" v="13" actId="20577"/>
          <ac:spMkLst>
            <pc:docMk/>
            <pc:sldMk cId="1524448352" sldId="257"/>
            <ac:spMk id="28" creationId="{A941FE8C-4D15-47CF-A939-82D70870E0BA}"/>
          </ac:spMkLst>
        </pc:spChg>
      </pc:sldChg>
      <pc:sldChg chg="modSp mod">
        <pc:chgData name="Simon Xin Min Dong" userId="6647684b-86c4-4538-a0ea-723982d85692" providerId="ADAL" clId="{5E4D38C0-DC1E-4697-A7CD-1F29D24D640D}" dt="2021-05-21T14:52:36.343" v="21" actId="20577"/>
        <pc:sldMkLst>
          <pc:docMk/>
          <pc:sldMk cId="24903166" sldId="258"/>
        </pc:sldMkLst>
        <pc:spChg chg="mod">
          <ac:chgData name="Simon Xin Min Dong" userId="6647684b-86c4-4538-a0ea-723982d85692" providerId="ADAL" clId="{5E4D38C0-DC1E-4697-A7CD-1F29D24D640D}" dt="2021-05-21T14:52:36.343" v="21" actId="20577"/>
          <ac:spMkLst>
            <pc:docMk/>
            <pc:sldMk cId="24903166" sldId="258"/>
            <ac:spMk id="30" creationId="{D45E8919-BA32-40F3-AC04-BD68E173ECB6}"/>
          </ac:spMkLst>
        </pc:spChg>
      </pc:sldChg>
      <pc:sldChg chg="modSp mod">
        <pc:chgData name="Simon Xin Min Dong" userId="6647684b-86c4-4538-a0ea-723982d85692" providerId="ADAL" clId="{5E4D38C0-DC1E-4697-A7CD-1F29D24D640D}" dt="2021-05-21T14:52:47.608" v="25" actId="20577"/>
        <pc:sldMkLst>
          <pc:docMk/>
          <pc:sldMk cId="2173231402" sldId="259"/>
        </pc:sldMkLst>
        <pc:spChg chg="mod">
          <ac:chgData name="Simon Xin Min Dong" userId="6647684b-86c4-4538-a0ea-723982d85692" providerId="ADAL" clId="{5E4D38C0-DC1E-4697-A7CD-1F29D24D640D}" dt="2021-05-21T14:52:47.608" v="25" actId="20577"/>
          <ac:spMkLst>
            <pc:docMk/>
            <pc:sldMk cId="2173231402" sldId="259"/>
            <ac:spMk id="40" creationId="{7220B53F-4A71-4672-8807-23E68E6D2929}"/>
          </ac:spMkLst>
        </pc:spChg>
      </pc:sldChg>
      <pc:sldChg chg="modSp mod">
        <pc:chgData name="Simon Xin Min Dong" userId="6647684b-86c4-4538-a0ea-723982d85692" providerId="ADAL" clId="{5E4D38C0-DC1E-4697-A7CD-1F29D24D640D}" dt="2021-05-21T14:52:57.156" v="29" actId="20577"/>
        <pc:sldMkLst>
          <pc:docMk/>
          <pc:sldMk cId="1772152896" sldId="260"/>
        </pc:sldMkLst>
        <pc:spChg chg="mod">
          <ac:chgData name="Simon Xin Min Dong" userId="6647684b-86c4-4538-a0ea-723982d85692" providerId="ADAL" clId="{5E4D38C0-DC1E-4697-A7CD-1F29D24D640D}" dt="2021-05-21T14:52:57.156" v="29" actId="20577"/>
          <ac:spMkLst>
            <pc:docMk/>
            <pc:sldMk cId="1772152896" sldId="260"/>
            <ac:spMk id="3" creationId="{627943C9-6685-417A-981F-42B82F3F0DDF}"/>
          </ac:spMkLst>
        </pc:spChg>
      </pc:sldChg>
      <pc:sldChg chg="modSp mod">
        <pc:chgData name="Simon Xin Min Dong" userId="6647684b-86c4-4538-a0ea-723982d85692" providerId="ADAL" clId="{5E4D38C0-DC1E-4697-A7CD-1F29D24D640D}" dt="2021-05-21T14:53:12.034" v="37" actId="20577"/>
        <pc:sldMkLst>
          <pc:docMk/>
          <pc:sldMk cId="1821796093" sldId="261"/>
        </pc:sldMkLst>
        <pc:spChg chg="mod">
          <ac:chgData name="Simon Xin Min Dong" userId="6647684b-86c4-4538-a0ea-723982d85692" providerId="ADAL" clId="{5E4D38C0-DC1E-4697-A7CD-1F29D24D640D}" dt="2021-05-21T14:53:12.034" v="37" actId="20577"/>
          <ac:spMkLst>
            <pc:docMk/>
            <pc:sldMk cId="1821796093" sldId="261"/>
            <ac:spMk id="2" creationId="{7DDC36C8-E00F-46F7-9501-2DD2798B8DCA}"/>
          </ac:spMkLst>
        </pc:spChg>
      </pc:sldChg>
      <pc:sldChg chg="modSp mod">
        <pc:chgData name="Simon Xin Min Dong" userId="6647684b-86c4-4538-a0ea-723982d85692" providerId="ADAL" clId="{5E4D38C0-DC1E-4697-A7CD-1F29D24D640D}" dt="2021-05-21T14:53:23.805" v="43" actId="20577"/>
        <pc:sldMkLst>
          <pc:docMk/>
          <pc:sldMk cId="2054106518" sldId="262"/>
        </pc:sldMkLst>
        <pc:spChg chg="mod">
          <ac:chgData name="Simon Xin Min Dong" userId="6647684b-86c4-4538-a0ea-723982d85692" providerId="ADAL" clId="{5E4D38C0-DC1E-4697-A7CD-1F29D24D640D}" dt="2021-05-21T14:53:23.805" v="43" actId="20577"/>
          <ac:spMkLst>
            <pc:docMk/>
            <pc:sldMk cId="2054106518" sldId="262"/>
            <ac:spMk id="27" creationId="{EAA81835-A83F-4EF4-96D8-684DAEADB838}"/>
          </ac:spMkLst>
        </pc:spChg>
      </pc:sldChg>
      <pc:sldChg chg="modSp mod">
        <pc:chgData name="Simon Xin Min Dong" userId="6647684b-86c4-4538-a0ea-723982d85692" providerId="ADAL" clId="{5E4D38C0-DC1E-4697-A7CD-1F29D24D640D}" dt="2021-05-21T14:53:35.360" v="51" actId="6549"/>
        <pc:sldMkLst>
          <pc:docMk/>
          <pc:sldMk cId="1828249279" sldId="263"/>
        </pc:sldMkLst>
        <pc:spChg chg="mod">
          <ac:chgData name="Simon Xin Min Dong" userId="6647684b-86c4-4538-a0ea-723982d85692" providerId="ADAL" clId="{5E4D38C0-DC1E-4697-A7CD-1F29D24D640D}" dt="2021-05-21T14:53:35.360" v="51" actId="6549"/>
          <ac:spMkLst>
            <pc:docMk/>
            <pc:sldMk cId="1828249279" sldId="263"/>
            <ac:spMk id="2" creationId="{2638570E-A0FA-4776-821E-230831E07F8E}"/>
          </ac:spMkLst>
        </pc:spChg>
      </pc:sldChg>
      <pc:sldChg chg="modSp mod">
        <pc:chgData name="Simon Xin Min Dong" userId="6647684b-86c4-4538-a0ea-723982d85692" providerId="ADAL" clId="{5E4D38C0-DC1E-4697-A7CD-1F29D24D640D}" dt="2021-05-21T14:55:00.611" v="79" actId="20577"/>
        <pc:sldMkLst>
          <pc:docMk/>
          <pc:sldMk cId="1101007786" sldId="264"/>
        </pc:sldMkLst>
        <pc:spChg chg="mod">
          <ac:chgData name="Simon Xin Min Dong" userId="6647684b-86c4-4538-a0ea-723982d85692" providerId="ADAL" clId="{5E4D38C0-DC1E-4697-A7CD-1F29D24D640D}" dt="2021-05-21T14:55:00.611" v="79" actId="20577"/>
          <ac:spMkLst>
            <pc:docMk/>
            <pc:sldMk cId="1101007786" sldId="264"/>
            <ac:spMk id="8" creationId="{BA336ADC-DE94-41A0-8DFA-7FA91808680B}"/>
          </ac:spMkLst>
        </pc:spChg>
        <pc:spChg chg="mod">
          <ac:chgData name="Simon Xin Min Dong" userId="6647684b-86c4-4538-a0ea-723982d85692" providerId="ADAL" clId="{5E4D38C0-DC1E-4697-A7CD-1F29D24D640D}" dt="2021-05-21T14:54:34.096" v="71" actId="20577"/>
          <ac:spMkLst>
            <pc:docMk/>
            <pc:sldMk cId="1101007786" sldId="264"/>
            <ac:spMk id="38" creationId="{8126FD95-6997-480B-99D0-6A58BF6FF6A8}"/>
          </ac:spMkLst>
        </pc:spChg>
      </pc:sldChg>
      <pc:sldChg chg="modSp mod">
        <pc:chgData name="Simon Xin Min Dong" userId="6647684b-86c4-4538-a0ea-723982d85692" providerId="ADAL" clId="{5E4D38C0-DC1E-4697-A7CD-1F29D24D640D}" dt="2021-05-21T14:56:35.898" v="111" actId="20577"/>
        <pc:sldMkLst>
          <pc:docMk/>
          <pc:sldMk cId="2581434553" sldId="265"/>
        </pc:sldMkLst>
        <pc:spChg chg="mod">
          <ac:chgData name="Simon Xin Min Dong" userId="6647684b-86c4-4538-a0ea-723982d85692" providerId="ADAL" clId="{5E4D38C0-DC1E-4697-A7CD-1F29D24D640D}" dt="2021-05-21T14:56:35.898" v="111" actId="20577"/>
          <ac:spMkLst>
            <pc:docMk/>
            <pc:sldMk cId="2581434553" sldId="265"/>
            <ac:spMk id="27" creationId="{EB0A639F-0D24-484F-B27A-3EC7B6AC4E80}"/>
          </ac:spMkLst>
        </pc:spChg>
      </pc:sldChg>
      <pc:sldChg chg="modSp mod">
        <pc:chgData name="Simon Xin Min Dong" userId="6647684b-86c4-4538-a0ea-723982d85692" providerId="ADAL" clId="{5E4D38C0-DC1E-4697-A7CD-1F29D24D640D}" dt="2021-05-21T14:55:48.468" v="99" actId="20577"/>
        <pc:sldMkLst>
          <pc:docMk/>
          <pc:sldMk cId="2632378769" sldId="266"/>
        </pc:sldMkLst>
        <pc:spChg chg="mod">
          <ac:chgData name="Simon Xin Min Dong" userId="6647684b-86c4-4538-a0ea-723982d85692" providerId="ADAL" clId="{5E4D38C0-DC1E-4697-A7CD-1F29D24D640D}" dt="2021-05-21T14:55:48.468" v="99" actId="20577"/>
          <ac:spMkLst>
            <pc:docMk/>
            <pc:sldMk cId="2632378769" sldId="266"/>
            <ac:spMk id="5" creationId="{51F68246-C516-47F5-B674-42AD1DD8D780}"/>
          </ac:spMkLst>
        </pc:spChg>
      </pc:sldChg>
      <pc:sldChg chg="modSp mod">
        <pc:chgData name="Simon Xin Min Dong" userId="6647684b-86c4-4538-a0ea-723982d85692" providerId="ADAL" clId="{5E4D38C0-DC1E-4697-A7CD-1F29D24D640D}" dt="2021-05-21T14:53:49.353" v="59" actId="20577"/>
        <pc:sldMkLst>
          <pc:docMk/>
          <pc:sldMk cId="853088657" sldId="274"/>
        </pc:sldMkLst>
        <pc:spChg chg="mod">
          <ac:chgData name="Simon Xin Min Dong" userId="6647684b-86c4-4538-a0ea-723982d85692" providerId="ADAL" clId="{5E4D38C0-DC1E-4697-A7CD-1F29D24D640D}" dt="2021-05-21T14:53:49.353" v="59" actId="20577"/>
          <ac:spMkLst>
            <pc:docMk/>
            <pc:sldMk cId="853088657" sldId="274"/>
            <ac:spMk id="28" creationId="{A941FE8C-4D15-47CF-A939-82D70870E0BA}"/>
          </ac:spMkLst>
        </pc:spChg>
      </pc:sldChg>
    </pc:docChg>
  </pc:docChgLst>
  <pc:docChgLst>
    <pc:chgData name="Simon Xin Min Dong" userId="6647684b-86c4-4538-a0ea-723982d85692" providerId="ADAL" clId="{FE2D03A3-BD66-4431-98CA-07CC4142844A}"/>
    <pc:docChg chg="modSld">
      <pc:chgData name="Simon Xin Min Dong" userId="6647684b-86c4-4538-a0ea-723982d85692" providerId="ADAL" clId="{FE2D03A3-BD66-4431-98CA-07CC4142844A}" dt="2021-06-29T15:36:53.621" v="279" actId="20577"/>
      <pc:docMkLst>
        <pc:docMk/>
      </pc:docMkLst>
      <pc:sldChg chg="modSp mod">
        <pc:chgData name="Simon Xin Min Dong" userId="6647684b-86c4-4538-a0ea-723982d85692" providerId="ADAL" clId="{FE2D03A3-BD66-4431-98CA-07CC4142844A}" dt="2021-06-29T15:30:38.531" v="141" actId="20577"/>
        <pc:sldMkLst>
          <pc:docMk/>
          <pc:sldMk cId="427278201" sldId="256"/>
        </pc:sldMkLst>
        <pc:spChg chg="mod">
          <ac:chgData name="Simon Xin Min Dong" userId="6647684b-86c4-4538-a0ea-723982d85692" providerId="ADAL" clId="{FE2D03A3-BD66-4431-98CA-07CC4142844A}" dt="2021-06-29T15:21:58.648" v="33" actId="1038"/>
          <ac:spMkLst>
            <pc:docMk/>
            <pc:sldMk cId="427278201" sldId="256"/>
            <ac:spMk id="37" creationId="{F7113CE4-AF49-48A5-9DCC-49AB871CDE3F}"/>
          </ac:spMkLst>
        </pc:spChg>
        <pc:spChg chg="mod">
          <ac:chgData name="Simon Xin Min Dong" userId="6647684b-86c4-4538-a0ea-723982d85692" providerId="ADAL" clId="{FE2D03A3-BD66-4431-98CA-07CC4142844A}" dt="2021-06-29T15:22:06.161" v="41" actId="1035"/>
          <ac:spMkLst>
            <pc:docMk/>
            <pc:sldMk cId="427278201" sldId="256"/>
            <ac:spMk id="38" creationId="{AFBEC820-3626-4ED5-A868-2AF212FECD33}"/>
          </ac:spMkLst>
        </pc:spChg>
        <pc:spChg chg="mod">
          <ac:chgData name="Simon Xin Min Dong" userId="6647684b-86c4-4538-a0ea-723982d85692" providerId="ADAL" clId="{FE2D03A3-BD66-4431-98CA-07CC4142844A}" dt="2021-06-29T15:30:38.531" v="141" actId="20577"/>
          <ac:spMkLst>
            <pc:docMk/>
            <pc:sldMk cId="427278201" sldId="256"/>
            <ac:spMk id="40" creationId="{1D589266-3798-48D8-B221-3D5C44F70777}"/>
          </ac:spMkLst>
        </pc:spChg>
      </pc:sldChg>
      <pc:sldChg chg="modSp mod">
        <pc:chgData name="Simon Xin Min Dong" userId="6647684b-86c4-4538-a0ea-723982d85692" providerId="ADAL" clId="{FE2D03A3-BD66-4431-98CA-07CC4142844A}" dt="2021-06-29T15:31:02.316" v="147" actId="20577"/>
        <pc:sldMkLst>
          <pc:docMk/>
          <pc:sldMk cId="1524448352" sldId="257"/>
        </pc:sldMkLst>
        <pc:spChg chg="mod">
          <ac:chgData name="Simon Xin Min Dong" userId="6647684b-86c4-4538-a0ea-723982d85692" providerId="ADAL" clId="{FE2D03A3-BD66-4431-98CA-07CC4142844A}" dt="2021-06-29T15:22:37.143" v="52" actId="1036"/>
          <ac:spMkLst>
            <pc:docMk/>
            <pc:sldMk cId="1524448352" sldId="257"/>
            <ac:spMk id="12" creationId="{C9DB8B25-1E62-45C1-B916-C005359545CC}"/>
          </ac:spMkLst>
        </pc:spChg>
        <pc:spChg chg="mod">
          <ac:chgData name="Simon Xin Min Dong" userId="6647684b-86c4-4538-a0ea-723982d85692" providerId="ADAL" clId="{FE2D03A3-BD66-4431-98CA-07CC4142844A}" dt="2021-06-29T15:31:02.316" v="147" actId="20577"/>
          <ac:spMkLst>
            <pc:docMk/>
            <pc:sldMk cId="1524448352" sldId="257"/>
            <ac:spMk id="28" creationId="{A941FE8C-4D15-47CF-A939-82D70870E0BA}"/>
          </ac:spMkLst>
        </pc:spChg>
      </pc:sldChg>
      <pc:sldChg chg="modSp mod">
        <pc:chgData name="Simon Xin Min Dong" userId="6647684b-86c4-4538-a0ea-723982d85692" providerId="ADAL" clId="{FE2D03A3-BD66-4431-98CA-07CC4142844A}" dt="2021-06-29T15:31:28.399" v="163" actId="20577"/>
        <pc:sldMkLst>
          <pc:docMk/>
          <pc:sldMk cId="24903166" sldId="258"/>
        </pc:sldMkLst>
        <pc:spChg chg="mod">
          <ac:chgData name="Simon Xin Min Dong" userId="6647684b-86c4-4538-a0ea-723982d85692" providerId="ADAL" clId="{FE2D03A3-BD66-4431-98CA-07CC4142844A}" dt="2021-06-29T15:31:28.399" v="163" actId="20577"/>
          <ac:spMkLst>
            <pc:docMk/>
            <pc:sldMk cId="24903166" sldId="258"/>
            <ac:spMk id="30" creationId="{D45E8919-BA32-40F3-AC04-BD68E173ECB6}"/>
          </ac:spMkLst>
        </pc:spChg>
      </pc:sldChg>
      <pc:sldChg chg="modSp mod">
        <pc:chgData name="Simon Xin Min Dong" userId="6647684b-86c4-4538-a0ea-723982d85692" providerId="ADAL" clId="{FE2D03A3-BD66-4431-98CA-07CC4142844A}" dt="2021-06-29T15:31:49.137" v="171" actId="20577"/>
        <pc:sldMkLst>
          <pc:docMk/>
          <pc:sldMk cId="2173231402" sldId="259"/>
        </pc:sldMkLst>
        <pc:spChg chg="mod">
          <ac:chgData name="Simon Xin Min Dong" userId="6647684b-86c4-4538-a0ea-723982d85692" providerId="ADAL" clId="{FE2D03A3-BD66-4431-98CA-07CC4142844A}" dt="2021-06-29T15:31:49.137" v="171" actId="20577"/>
          <ac:spMkLst>
            <pc:docMk/>
            <pc:sldMk cId="2173231402" sldId="259"/>
            <ac:spMk id="40" creationId="{7220B53F-4A71-4672-8807-23E68E6D2929}"/>
          </ac:spMkLst>
        </pc:spChg>
      </pc:sldChg>
      <pc:sldChg chg="modSp mod">
        <pc:chgData name="Simon Xin Min Dong" userId="6647684b-86c4-4538-a0ea-723982d85692" providerId="ADAL" clId="{FE2D03A3-BD66-4431-98CA-07CC4142844A}" dt="2021-06-29T15:32:00.119" v="175" actId="20577"/>
        <pc:sldMkLst>
          <pc:docMk/>
          <pc:sldMk cId="1772152896" sldId="260"/>
        </pc:sldMkLst>
        <pc:spChg chg="mod">
          <ac:chgData name="Simon Xin Min Dong" userId="6647684b-86c4-4538-a0ea-723982d85692" providerId="ADAL" clId="{FE2D03A3-BD66-4431-98CA-07CC4142844A}" dt="2021-06-29T15:32:00.119" v="175" actId="20577"/>
          <ac:spMkLst>
            <pc:docMk/>
            <pc:sldMk cId="1772152896" sldId="260"/>
            <ac:spMk id="3" creationId="{627943C9-6685-417A-981F-42B82F3F0DDF}"/>
          </ac:spMkLst>
        </pc:spChg>
      </pc:sldChg>
      <pc:sldChg chg="modSp mod">
        <pc:chgData name="Simon Xin Min Dong" userId="6647684b-86c4-4538-a0ea-723982d85692" providerId="ADAL" clId="{FE2D03A3-BD66-4431-98CA-07CC4142844A}" dt="2021-06-29T15:32:15.943" v="183" actId="20577"/>
        <pc:sldMkLst>
          <pc:docMk/>
          <pc:sldMk cId="1821796093" sldId="261"/>
        </pc:sldMkLst>
        <pc:spChg chg="mod">
          <ac:chgData name="Simon Xin Min Dong" userId="6647684b-86c4-4538-a0ea-723982d85692" providerId="ADAL" clId="{FE2D03A3-BD66-4431-98CA-07CC4142844A}" dt="2021-06-29T15:32:15.943" v="183" actId="20577"/>
          <ac:spMkLst>
            <pc:docMk/>
            <pc:sldMk cId="1821796093" sldId="261"/>
            <ac:spMk id="2" creationId="{7DDC36C8-E00F-46F7-9501-2DD2798B8DCA}"/>
          </ac:spMkLst>
        </pc:spChg>
      </pc:sldChg>
      <pc:sldChg chg="modSp mod">
        <pc:chgData name="Simon Xin Min Dong" userId="6647684b-86c4-4538-a0ea-723982d85692" providerId="ADAL" clId="{FE2D03A3-BD66-4431-98CA-07CC4142844A}" dt="2021-06-29T15:32:37.390" v="195" actId="20577"/>
        <pc:sldMkLst>
          <pc:docMk/>
          <pc:sldMk cId="2054106518" sldId="262"/>
        </pc:sldMkLst>
        <pc:spChg chg="mod">
          <ac:chgData name="Simon Xin Min Dong" userId="6647684b-86c4-4538-a0ea-723982d85692" providerId="ADAL" clId="{FE2D03A3-BD66-4431-98CA-07CC4142844A}" dt="2021-06-29T15:32:37.390" v="195" actId="20577"/>
          <ac:spMkLst>
            <pc:docMk/>
            <pc:sldMk cId="2054106518" sldId="262"/>
            <ac:spMk id="27" creationId="{EAA81835-A83F-4EF4-96D8-684DAEADB838}"/>
          </ac:spMkLst>
        </pc:spChg>
      </pc:sldChg>
      <pc:sldChg chg="modSp mod">
        <pc:chgData name="Simon Xin Min Dong" userId="6647684b-86c4-4538-a0ea-723982d85692" providerId="ADAL" clId="{FE2D03A3-BD66-4431-98CA-07CC4142844A}" dt="2021-06-29T15:32:59.108" v="211" actId="6549"/>
        <pc:sldMkLst>
          <pc:docMk/>
          <pc:sldMk cId="1828249279" sldId="263"/>
        </pc:sldMkLst>
        <pc:spChg chg="mod">
          <ac:chgData name="Simon Xin Min Dong" userId="6647684b-86c4-4538-a0ea-723982d85692" providerId="ADAL" clId="{FE2D03A3-BD66-4431-98CA-07CC4142844A}" dt="2021-06-29T15:32:59.108" v="211" actId="6549"/>
          <ac:spMkLst>
            <pc:docMk/>
            <pc:sldMk cId="1828249279" sldId="263"/>
            <ac:spMk id="2" creationId="{2638570E-A0FA-4776-821E-230831E07F8E}"/>
          </ac:spMkLst>
        </pc:spChg>
      </pc:sldChg>
      <pc:sldChg chg="modSp mod">
        <pc:chgData name="Simon Xin Min Dong" userId="6647684b-86c4-4538-a0ea-723982d85692" providerId="ADAL" clId="{FE2D03A3-BD66-4431-98CA-07CC4142844A}" dt="2021-06-29T15:36:16.960" v="273" actId="20577"/>
        <pc:sldMkLst>
          <pc:docMk/>
          <pc:sldMk cId="1101007786" sldId="264"/>
        </pc:sldMkLst>
        <pc:spChg chg="mod">
          <ac:chgData name="Simon Xin Min Dong" userId="6647684b-86c4-4538-a0ea-723982d85692" providerId="ADAL" clId="{FE2D03A3-BD66-4431-98CA-07CC4142844A}" dt="2021-06-29T15:36:16.960" v="273" actId="20577"/>
          <ac:spMkLst>
            <pc:docMk/>
            <pc:sldMk cId="1101007786" sldId="264"/>
            <ac:spMk id="8" creationId="{BA336ADC-DE94-41A0-8DFA-7FA91808680B}"/>
          </ac:spMkLst>
        </pc:spChg>
      </pc:sldChg>
      <pc:sldChg chg="modSp mod">
        <pc:chgData name="Simon Xin Min Dong" userId="6647684b-86c4-4538-a0ea-723982d85692" providerId="ADAL" clId="{FE2D03A3-BD66-4431-98CA-07CC4142844A}" dt="2021-06-29T15:33:50.288" v="243" actId="20577"/>
        <pc:sldMkLst>
          <pc:docMk/>
          <pc:sldMk cId="2581434553" sldId="265"/>
        </pc:sldMkLst>
        <pc:spChg chg="mod">
          <ac:chgData name="Simon Xin Min Dong" userId="6647684b-86c4-4538-a0ea-723982d85692" providerId="ADAL" clId="{FE2D03A3-BD66-4431-98CA-07CC4142844A}" dt="2021-06-29T15:33:50.288" v="243" actId="20577"/>
          <ac:spMkLst>
            <pc:docMk/>
            <pc:sldMk cId="2581434553" sldId="265"/>
            <ac:spMk id="27" creationId="{EB0A639F-0D24-484F-B27A-3EC7B6AC4E80}"/>
          </ac:spMkLst>
        </pc:spChg>
      </pc:sldChg>
      <pc:sldChg chg="modSp mod">
        <pc:chgData name="Simon Xin Min Dong" userId="6647684b-86c4-4538-a0ea-723982d85692" providerId="ADAL" clId="{FE2D03A3-BD66-4431-98CA-07CC4142844A}" dt="2021-06-29T15:36:53.621" v="279" actId="20577"/>
        <pc:sldMkLst>
          <pc:docMk/>
          <pc:sldMk cId="2632378769" sldId="266"/>
        </pc:sldMkLst>
        <pc:spChg chg="mod">
          <ac:chgData name="Simon Xin Min Dong" userId="6647684b-86c4-4538-a0ea-723982d85692" providerId="ADAL" clId="{FE2D03A3-BD66-4431-98CA-07CC4142844A}" dt="2021-06-29T15:36:53.621" v="279" actId="20577"/>
          <ac:spMkLst>
            <pc:docMk/>
            <pc:sldMk cId="2632378769" sldId="266"/>
            <ac:spMk id="5" creationId="{51F68246-C516-47F5-B674-42AD1DD8D780}"/>
          </ac:spMkLst>
        </pc:spChg>
      </pc:sldChg>
      <pc:sldChg chg="modSp mod">
        <pc:chgData name="Simon Xin Min Dong" userId="6647684b-86c4-4538-a0ea-723982d85692" providerId="ADAL" clId="{FE2D03A3-BD66-4431-98CA-07CC4142844A}" dt="2021-06-29T15:21:32.176" v="31" actId="20577"/>
        <pc:sldMkLst>
          <pc:docMk/>
          <pc:sldMk cId="386154674" sldId="268"/>
        </pc:sldMkLst>
        <pc:spChg chg="mod">
          <ac:chgData name="Simon Xin Min Dong" userId="6647684b-86c4-4538-a0ea-723982d85692" providerId="ADAL" clId="{FE2D03A3-BD66-4431-98CA-07CC4142844A}" dt="2021-06-29T15:21:32.176" v="31" actId="20577"/>
          <ac:spMkLst>
            <pc:docMk/>
            <pc:sldMk cId="386154674" sldId="268"/>
            <ac:spMk id="22" creationId="{19085A89-6CBE-48D4-AF85-1BA8A1D762C5}"/>
          </ac:spMkLst>
        </pc:spChg>
      </pc:sldChg>
      <pc:sldChg chg="modSp mod">
        <pc:chgData name="Simon Xin Min Dong" userId="6647684b-86c4-4538-a0ea-723982d85692" providerId="ADAL" clId="{FE2D03A3-BD66-4431-98CA-07CC4142844A}" dt="2021-06-29T15:20:43.680" v="27" actId="20577"/>
        <pc:sldMkLst>
          <pc:docMk/>
          <pc:sldMk cId="1882904827" sldId="269"/>
        </pc:sldMkLst>
        <pc:spChg chg="mod">
          <ac:chgData name="Simon Xin Min Dong" userId="6647684b-86c4-4538-a0ea-723982d85692" providerId="ADAL" clId="{FE2D03A3-BD66-4431-98CA-07CC4142844A}" dt="2021-06-29T15:19:38.714" v="7" actId="20577"/>
          <ac:spMkLst>
            <pc:docMk/>
            <pc:sldMk cId="1882904827" sldId="269"/>
            <ac:spMk id="10" creationId="{B1A90298-2974-406C-82C6-0C9170438378}"/>
          </ac:spMkLst>
        </pc:spChg>
        <pc:spChg chg="mod">
          <ac:chgData name="Simon Xin Min Dong" userId="6647684b-86c4-4538-a0ea-723982d85692" providerId="ADAL" clId="{FE2D03A3-BD66-4431-98CA-07CC4142844A}" dt="2021-06-29T15:19:46.992" v="11" actId="20577"/>
          <ac:spMkLst>
            <pc:docMk/>
            <pc:sldMk cId="1882904827" sldId="269"/>
            <ac:spMk id="12" creationId="{F5208DC4-0F07-4850-A4C3-F69E6C827055}"/>
          </ac:spMkLst>
        </pc:spChg>
        <pc:spChg chg="mod">
          <ac:chgData name="Simon Xin Min Dong" userId="6647684b-86c4-4538-a0ea-723982d85692" providerId="ADAL" clId="{FE2D03A3-BD66-4431-98CA-07CC4142844A}" dt="2021-06-29T15:19:32.233" v="3" actId="20577"/>
          <ac:spMkLst>
            <pc:docMk/>
            <pc:sldMk cId="1882904827" sldId="269"/>
            <ac:spMk id="14" creationId="{9BA838F0-E02E-436F-82ED-CB1A16C32DB5}"/>
          </ac:spMkLst>
        </pc:spChg>
        <pc:spChg chg="mod">
          <ac:chgData name="Simon Xin Min Dong" userId="6647684b-86c4-4538-a0ea-723982d85692" providerId="ADAL" clId="{FE2D03A3-BD66-4431-98CA-07CC4142844A}" dt="2021-06-29T15:19:35.657" v="5" actId="20577"/>
          <ac:spMkLst>
            <pc:docMk/>
            <pc:sldMk cId="1882904827" sldId="269"/>
            <ac:spMk id="18" creationId="{8D1D08C7-961D-4D6E-A206-81AC64951A77}"/>
          </ac:spMkLst>
        </pc:spChg>
        <pc:spChg chg="mod">
          <ac:chgData name="Simon Xin Min Dong" userId="6647684b-86c4-4538-a0ea-723982d85692" providerId="ADAL" clId="{FE2D03A3-BD66-4431-98CA-07CC4142844A}" dt="2021-06-29T15:19:28.133" v="1" actId="20577"/>
          <ac:spMkLst>
            <pc:docMk/>
            <pc:sldMk cId="1882904827" sldId="269"/>
            <ac:spMk id="20" creationId="{E05626E9-C378-4A5F-BF30-13BA7762635F}"/>
          </ac:spMkLst>
        </pc:spChg>
        <pc:spChg chg="mod">
          <ac:chgData name="Simon Xin Min Dong" userId="6647684b-86c4-4538-a0ea-723982d85692" providerId="ADAL" clId="{FE2D03A3-BD66-4431-98CA-07CC4142844A}" dt="2021-06-29T15:19:43.742" v="9" actId="20577"/>
          <ac:spMkLst>
            <pc:docMk/>
            <pc:sldMk cId="1882904827" sldId="269"/>
            <ac:spMk id="22" creationId="{2D395956-5521-46AC-AA55-775A792002B5}"/>
          </ac:spMkLst>
        </pc:spChg>
        <pc:spChg chg="mod">
          <ac:chgData name="Simon Xin Min Dong" userId="6647684b-86c4-4538-a0ea-723982d85692" providerId="ADAL" clId="{FE2D03A3-BD66-4431-98CA-07CC4142844A}" dt="2021-06-29T15:20:43.680" v="27" actId="20577"/>
          <ac:spMkLst>
            <pc:docMk/>
            <pc:sldMk cId="1882904827" sldId="269"/>
            <ac:spMk id="25" creationId="{CD0137B2-2F2C-4EBC-A913-32CBC6D040D7}"/>
          </ac:spMkLst>
        </pc:spChg>
      </pc:sldChg>
      <pc:sldChg chg="modSp mod">
        <pc:chgData name="Simon Xin Min Dong" userId="6647684b-86c4-4538-a0ea-723982d85692" providerId="ADAL" clId="{FE2D03A3-BD66-4431-98CA-07CC4142844A}" dt="2021-06-29T15:33:22.243" v="225" actId="20577"/>
        <pc:sldMkLst>
          <pc:docMk/>
          <pc:sldMk cId="853088657" sldId="274"/>
        </pc:sldMkLst>
        <pc:spChg chg="mod">
          <ac:chgData name="Simon Xin Min Dong" userId="6647684b-86c4-4538-a0ea-723982d85692" providerId="ADAL" clId="{FE2D03A3-BD66-4431-98CA-07CC4142844A}" dt="2021-06-29T15:33:22.243" v="225" actId="20577"/>
          <ac:spMkLst>
            <pc:docMk/>
            <pc:sldMk cId="853088657" sldId="274"/>
            <ac:spMk id="28" creationId="{A941FE8C-4D15-47CF-A939-82D70870E0BA}"/>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DC335E4-896C-4363-86BC-1C25718C677D}" type="datetimeFigureOut">
              <a:rPr lang="en-CA" smtClean="0"/>
              <a:t>2021-06-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8331015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C335E4-896C-4363-86BC-1C25718C677D}" type="datetimeFigureOut">
              <a:rPr lang="en-CA" smtClean="0"/>
              <a:t>2021-06-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32566777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C335E4-896C-4363-86BC-1C25718C677D}" type="datetimeFigureOut">
              <a:rPr lang="en-CA" smtClean="0"/>
              <a:t>2021-06-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34033330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C335E4-896C-4363-86BC-1C25718C677D}" type="datetimeFigureOut">
              <a:rPr lang="en-CA" smtClean="0"/>
              <a:t>2021-06-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1406198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DC335E4-896C-4363-86BC-1C25718C677D}" type="datetimeFigureOut">
              <a:rPr lang="en-CA" smtClean="0"/>
              <a:t>2021-06-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4887713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DC335E4-896C-4363-86BC-1C25718C677D}" type="datetimeFigureOut">
              <a:rPr lang="en-CA" smtClean="0"/>
              <a:t>2021-06-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32763943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DC335E4-896C-4363-86BC-1C25718C677D}" type="datetimeFigureOut">
              <a:rPr lang="en-CA" smtClean="0"/>
              <a:t>2021-06-2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3334447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DC335E4-896C-4363-86BC-1C25718C677D}" type="datetimeFigureOut">
              <a:rPr lang="en-CA" smtClean="0"/>
              <a:t>2021-06-2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16940563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C335E4-896C-4363-86BC-1C25718C677D}" type="datetimeFigureOut">
              <a:rPr lang="en-CA" smtClean="0"/>
              <a:t>2021-06-2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2840768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EDC335E4-896C-4363-86BC-1C25718C677D}" type="datetimeFigureOut">
              <a:rPr lang="en-CA" smtClean="0"/>
              <a:t>2021-06-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20705491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EDC335E4-896C-4363-86BC-1C25718C677D}" type="datetimeFigureOut">
              <a:rPr lang="en-CA" smtClean="0"/>
              <a:t>2021-06-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A35C181-F421-48C8-A7E3-66CD07600973}" type="slidenum">
              <a:rPr lang="en-CA" smtClean="0"/>
              <a:t>‹#›</a:t>
            </a:fld>
            <a:endParaRPr lang="en-CA"/>
          </a:p>
        </p:txBody>
      </p:sp>
    </p:spTree>
    <p:extLst>
      <p:ext uri="{BB962C8B-B14F-4D97-AF65-F5344CB8AC3E}">
        <p14:creationId xmlns:p14="http://schemas.microsoft.com/office/powerpoint/2010/main" val="26173360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EDC335E4-896C-4363-86BC-1C25718C677D}" type="datetimeFigureOut">
              <a:rPr lang="en-CA" smtClean="0"/>
              <a:t>2021-06-29</a:t>
            </a:fld>
            <a:endParaRPr lang="en-CA"/>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6A35C181-F421-48C8-A7E3-66CD07600973}" type="slidenum">
              <a:rPr lang="en-CA" smtClean="0"/>
              <a:t>‹#›</a:t>
            </a:fld>
            <a:endParaRPr lang="en-CA"/>
          </a:p>
        </p:txBody>
      </p:sp>
    </p:spTree>
    <p:extLst>
      <p:ext uri="{BB962C8B-B14F-4D97-AF65-F5344CB8AC3E}">
        <p14:creationId xmlns:p14="http://schemas.microsoft.com/office/powerpoint/2010/main" val="18745501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3.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5.emf"/><Relationship Id="rId4" Type="http://schemas.openxmlformats.org/officeDocument/2006/relationships/image" Target="../media/image2.emf"/><Relationship Id="rId9" Type="http://schemas.openxmlformats.org/officeDocument/2006/relationships/oleObject" Target="../embeddings/oleObject4.bin"/><Relationship Id="rId14" Type="http://schemas.openxmlformats.org/officeDocument/2006/relationships/image" Target="../media/image7.emf"/></Relationships>
</file>

<file path=ppt/slides/_rels/slide10.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9.bin"/><Relationship Id="rId13" Type="http://schemas.microsoft.com/office/2007/relationships/hdphoto" Target="../media/hdphoto2.wdp"/><Relationship Id="rId3" Type="http://schemas.microsoft.com/office/2007/relationships/hdphoto" Target="../media/hdphoto1.wdp"/><Relationship Id="rId7" Type="http://schemas.openxmlformats.org/officeDocument/2006/relationships/image" Target="../media/image10.emf"/><Relationship Id="rId12" Type="http://schemas.openxmlformats.org/officeDocument/2006/relationships/image" Target="../media/image13.png"/><Relationship Id="rId17" Type="http://schemas.openxmlformats.org/officeDocument/2006/relationships/image" Target="../media/image15.emf"/><Relationship Id="rId2" Type="http://schemas.openxmlformats.org/officeDocument/2006/relationships/image" Target="../media/image8.png"/><Relationship Id="rId16" Type="http://schemas.openxmlformats.org/officeDocument/2006/relationships/oleObject" Target="../embeddings/oleObject12.bin"/><Relationship Id="rId1" Type="http://schemas.openxmlformats.org/officeDocument/2006/relationships/slideLayout" Target="../slideLayouts/slideLayout1.xml"/><Relationship Id="rId6" Type="http://schemas.openxmlformats.org/officeDocument/2006/relationships/oleObject" Target="../embeddings/oleObject8.bin"/><Relationship Id="rId11" Type="http://schemas.openxmlformats.org/officeDocument/2006/relationships/image" Target="../media/image12.emf"/><Relationship Id="rId5" Type="http://schemas.openxmlformats.org/officeDocument/2006/relationships/image" Target="../media/image9.emf"/><Relationship Id="rId15" Type="http://schemas.openxmlformats.org/officeDocument/2006/relationships/image" Target="../media/image14.emf"/><Relationship Id="rId10" Type="http://schemas.openxmlformats.org/officeDocument/2006/relationships/oleObject" Target="../embeddings/oleObject10.bin"/><Relationship Id="rId4" Type="http://schemas.openxmlformats.org/officeDocument/2006/relationships/oleObject" Target="../embeddings/oleObject7.bin"/><Relationship Id="rId9" Type="http://schemas.openxmlformats.org/officeDocument/2006/relationships/image" Target="../media/image11.emf"/><Relationship Id="rId14" Type="http://schemas.openxmlformats.org/officeDocument/2006/relationships/oleObject" Target="../embeddings/oleObject11.bin"/></Relationships>
</file>

<file path=ppt/slides/_rels/slide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E3217C8-2DBE-4930-A28B-46069AA75B10}"/>
              </a:ext>
            </a:extLst>
          </p:cNvPr>
          <p:cNvGrpSpPr/>
          <p:nvPr/>
        </p:nvGrpSpPr>
        <p:grpSpPr>
          <a:xfrm>
            <a:off x="522803" y="4322392"/>
            <a:ext cx="2470918" cy="1890518"/>
            <a:chOff x="5887875" y="720750"/>
            <a:chExt cx="2947296" cy="2671192"/>
          </a:xfrm>
        </p:grpSpPr>
        <p:sp>
          <p:nvSpPr>
            <p:cNvPr id="22" name="TextBox 21">
              <a:extLst>
                <a:ext uri="{FF2B5EF4-FFF2-40B4-BE49-F238E27FC236}">
                  <a16:creationId xmlns:a16="http://schemas.microsoft.com/office/drawing/2014/main" id="{2D395956-5521-46AC-AA55-775A792002B5}"/>
                </a:ext>
              </a:extLst>
            </p:cNvPr>
            <p:cNvSpPr txBox="1"/>
            <p:nvPr/>
          </p:nvSpPr>
          <p:spPr>
            <a:xfrm>
              <a:off x="5887875" y="720750"/>
              <a:ext cx="2787742" cy="348802"/>
            </a:xfrm>
            <a:prstGeom prst="rect">
              <a:avLst/>
            </a:prstGeom>
            <a:noFill/>
          </p:spPr>
          <p:txBody>
            <a:bodyPr wrap="square" rtlCol="0">
              <a:spAutoFit/>
            </a:bodyPr>
            <a:lstStyle>
              <a:defPPr>
                <a:defRPr lang="en-US"/>
              </a:defPPr>
              <a:lvl1pPr>
                <a:defRPr sz="1600"/>
              </a:lvl1pPr>
            </a:lstStyle>
            <a:p>
              <a:r>
                <a:rPr lang="en-CA" sz="1004" dirty="0"/>
                <a:t>E: THP-1 undifferentiated</a:t>
              </a:r>
            </a:p>
          </p:txBody>
        </p:sp>
        <p:pic>
          <p:nvPicPr>
            <p:cNvPr id="23" name="Picture 22">
              <a:extLst>
                <a:ext uri="{FF2B5EF4-FFF2-40B4-BE49-F238E27FC236}">
                  <a16:creationId xmlns:a16="http://schemas.microsoft.com/office/drawing/2014/main" id="{6E7E413B-4679-4AC9-9A88-73EC91F3483A}"/>
                </a:ext>
              </a:extLst>
            </p:cNvPr>
            <p:cNvPicPr>
              <a:picLocks noChangeAspect="1"/>
            </p:cNvPicPr>
            <p:nvPr/>
          </p:nvPicPr>
          <p:blipFill>
            <a:blip r:embed="rId2"/>
            <a:stretch>
              <a:fillRect/>
            </a:stretch>
          </p:blipFill>
          <p:spPr>
            <a:xfrm>
              <a:off x="5926085" y="1032776"/>
              <a:ext cx="2909086" cy="2359166"/>
            </a:xfrm>
            <a:prstGeom prst="rect">
              <a:avLst/>
            </a:prstGeom>
          </p:spPr>
        </p:pic>
      </p:grpSp>
      <p:grpSp>
        <p:nvGrpSpPr>
          <p:cNvPr id="4" name="Group 3">
            <a:extLst>
              <a:ext uri="{FF2B5EF4-FFF2-40B4-BE49-F238E27FC236}">
                <a16:creationId xmlns:a16="http://schemas.microsoft.com/office/drawing/2014/main" id="{43EF9634-FC4E-44D6-8389-159A6DACBF2F}"/>
              </a:ext>
            </a:extLst>
          </p:cNvPr>
          <p:cNvGrpSpPr/>
          <p:nvPr/>
        </p:nvGrpSpPr>
        <p:grpSpPr>
          <a:xfrm>
            <a:off x="541336" y="634402"/>
            <a:ext cx="2345658" cy="1845751"/>
            <a:chOff x="332929" y="790571"/>
            <a:chExt cx="2841142" cy="2622936"/>
          </a:xfrm>
        </p:grpSpPr>
        <p:sp>
          <p:nvSpPr>
            <p:cNvPr id="20" name="TextBox 19">
              <a:extLst>
                <a:ext uri="{FF2B5EF4-FFF2-40B4-BE49-F238E27FC236}">
                  <a16:creationId xmlns:a16="http://schemas.microsoft.com/office/drawing/2014/main" id="{E05626E9-C378-4A5F-BF30-13BA7762635F}"/>
                </a:ext>
              </a:extLst>
            </p:cNvPr>
            <p:cNvSpPr txBox="1"/>
            <p:nvPr/>
          </p:nvSpPr>
          <p:spPr>
            <a:xfrm>
              <a:off x="332929" y="790571"/>
              <a:ext cx="2411546" cy="350807"/>
            </a:xfrm>
            <a:prstGeom prst="rect">
              <a:avLst/>
            </a:prstGeom>
            <a:noFill/>
          </p:spPr>
          <p:txBody>
            <a:bodyPr wrap="square" rtlCol="0">
              <a:spAutoFit/>
            </a:bodyPr>
            <a:lstStyle/>
            <a:p>
              <a:r>
                <a:rPr lang="en-CA" sz="1004" dirty="0"/>
                <a:t>A: U937 undifferentiated</a:t>
              </a:r>
            </a:p>
          </p:txBody>
        </p:sp>
        <p:graphicFrame>
          <p:nvGraphicFramePr>
            <p:cNvPr id="21" name="Object 20">
              <a:extLst>
                <a:ext uri="{FF2B5EF4-FFF2-40B4-BE49-F238E27FC236}">
                  <a16:creationId xmlns:a16="http://schemas.microsoft.com/office/drawing/2014/main" id="{F0460C2C-A4AB-4CD3-B318-D1DA2DABCC24}"/>
                </a:ext>
              </a:extLst>
            </p:cNvPr>
            <p:cNvGraphicFramePr>
              <a:graphicFrameLocks noChangeAspect="1"/>
            </p:cNvGraphicFramePr>
            <p:nvPr>
              <p:extLst>
                <p:ext uri="{D42A27DB-BD31-4B8C-83A1-F6EECF244321}">
                  <p14:modId xmlns:p14="http://schemas.microsoft.com/office/powerpoint/2010/main" val="2466240237"/>
                </p:ext>
              </p:extLst>
            </p:nvPr>
          </p:nvGraphicFramePr>
          <p:xfrm>
            <a:off x="355997" y="1102124"/>
            <a:ext cx="2818074" cy="2311383"/>
          </p:xfrm>
          <a:graphic>
            <a:graphicData uri="http://schemas.openxmlformats.org/presentationml/2006/ole">
              <mc:AlternateContent xmlns:mc="http://schemas.openxmlformats.org/markup-compatibility/2006">
                <mc:Choice xmlns:v="urn:schemas-microsoft-com:vml" Requires="v">
                  <p:oleObj name="Prism 6" r:id="rId3" imgW="3482152" imgH="2841976" progId="Prism6.Document">
                    <p:embed/>
                  </p:oleObj>
                </mc:Choice>
                <mc:Fallback>
                  <p:oleObj name="Prism 6" r:id="rId3" imgW="3482152" imgH="2841976" progId="Prism6.Document">
                    <p:embed/>
                    <p:pic>
                      <p:nvPicPr>
                        <p:cNvPr id="21" name="Object 20">
                          <a:extLst>
                            <a:ext uri="{FF2B5EF4-FFF2-40B4-BE49-F238E27FC236}">
                              <a16:creationId xmlns:a16="http://schemas.microsoft.com/office/drawing/2014/main" id="{F0460C2C-A4AB-4CD3-B318-D1DA2DABCC24}"/>
                            </a:ext>
                          </a:extLst>
                        </p:cNvPr>
                        <p:cNvPicPr/>
                        <p:nvPr/>
                      </p:nvPicPr>
                      <p:blipFill>
                        <a:blip r:embed="rId4"/>
                        <a:stretch>
                          <a:fillRect/>
                        </a:stretch>
                      </p:blipFill>
                      <p:spPr>
                        <a:xfrm>
                          <a:off x="355997" y="1102124"/>
                          <a:ext cx="2818074" cy="2311383"/>
                        </a:xfrm>
                        <a:prstGeom prst="rect">
                          <a:avLst/>
                        </a:prstGeom>
                      </p:spPr>
                    </p:pic>
                  </p:oleObj>
                </mc:Fallback>
              </mc:AlternateContent>
            </a:graphicData>
          </a:graphic>
        </p:graphicFrame>
      </p:grpSp>
      <p:grpSp>
        <p:nvGrpSpPr>
          <p:cNvPr id="5" name="Group 4">
            <a:extLst>
              <a:ext uri="{FF2B5EF4-FFF2-40B4-BE49-F238E27FC236}">
                <a16:creationId xmlns:a16="http://schemas.microsoft.com/office/drawing/2014/main" id="{C99BD2B1-4FB5-4D6C-8F73-F8F0FBE69A21}"/>
              </a:ext>
            </a:extLst>
          </p:cNvPr>
          <p:cNvGrpSpPr/>
          <p:nvPr/>
        </p:nvGrpSpPr>
        <p:grpSpPr>
          <a:xfrm>
            <a:off x="522803" y="2413324"/>
            <a:ext cx="2395761" cy="1908154"/>
            <a:chOff x="3042326" y="760242"/>
            <a:chExt cx="3068807" cy="2458223"/>
          </a:xfrm>
        </p:grpSpPr>
        <p:sp>
          <p:nvSpPr>
            <p:cNvPr id="18" name="TextBox 17">
              <a:extLst>
                <a:ext uri="{FF2B5EF4-FFF2-40B4-BE49-F238E27FC236}">
                  <a16:creationId xmlns:a16="http://schemas.microsoft.com/office/drawing/2014/main" id="{8D1D08C7-961D-4D6E-A206-81AC64951A77}"/>
                </a:ext>
              </a:extLst>
            </p:cNvPr>
            <p:cNvSpPr txBox="1"/>
            <p:nvPr/>
          </p:nvSpPr>
          <p:spPr>
            <a:xfrm>
              <a:off x="3042326" y="760242"/>
              <a:ext cx="2727977" cy="517102"/>
            </a:xfrm>
            <a:prstGeom prst="rect">
              <a:avLst/>
            </a:prstGeom>
            <a:noFill/>
          </p:spPr>
          <p:txBody>
            <a:bodyPr wrap="square" rtlCol="0">
              <a:spAutoFit/>
            </a:bodyPr>
            <a:lstStyle>
              <a:defPPr>
                <a:defRPr lang="en-US"/>
              </a:defPPr>
              <a:lvl1pPr>
                <a:defRPr sz="1600"/>
              </a:lvl1pPr>
            </a:lstStyle>
            <a:p>
              <a:r>
                <a:rPr lang="en-CA" sz="1004" dirty="0"/>
                <a:t>C: U1 undifferentiated</a:t>
              </a:r>
            </a:p>
            <a:p>
              <a:r>
                <a:rPr lang="en-CA" sz="1004" dirty="0"/>
                <a:t>  </a:t>
              </a:r>
            </a:p>
          </p:txBody>
        </p:sp>
        <p:graphicFrame>
          <p:nvGraphicFramePr>
            <p:cNvPr id="19" name="Object 18">
              <a:extLst>
                <a:ext uri="{FF2B5EF4-FFF2-40B4-BE49-F238E27FC236}">
                  <a16:creationId xmlns:a16="http://schemas.microsoft.com/office/drawing/2014/main" id="{C2CB5818-0E94-4644-9C39-21C7C4E07FB5}"/>
                </a:ext>
              </a:extLst>
            </p:cNvPr>
            <p:cNvGraphicFramePr>
              <a:graphicFrameLocks noChangeAspect="1"/>
            </p:cNvGraphicFramePr>
            <p:nvPr>
              <p:extLst>
                <p:ext uri="{D42A27DB-BD31-4B8C-83A1-F6EECF244321}">
                  <p14:modId xmlns:p14="http://schemas.microsoft.com/office/powerpoint/2010/main" val="411357817"/>
                </p:ext>
              </p:extLst>
            </p:nvPr>
          </p:nvGraphicFramePr>
          <p:xfrm>
            <a:off x="3202047" y="1017736"/>
            <a:ext cx="2909086" cy="2200729"/>
          </p:xfrm>
          <a:graphic>
            <a:graphicData uri="http://schemas.openxmlformats.org/presentationml/2006/ole">
              <mc:AlternateContent xmlns:mc="http://schemas.openxmlformats.org/markup-compatibility/2006">
                <mc:Choice xmlns:v="urn:schemas-microsoft-com:vml" Requires="v">
                  <p:oleObj name="Prism 6" r:id="rId5" imgW="4399778" imgH="2790113" progId="Prism6.Document">
                    <p:embed/>
                  </p:oleObj>
                </mc:Choice>
                <mc:Fallback>
                  <p:oleObj name="Prism 6" r:id="rId5" imgW="4399778" imgH="2790113" progId="Prism6.Document">
                    <p:embed/>
                    <p:pic>
                      <p:nvPicPr>
                        <p:cNvPr id="19" name="Object 18">
                          <a:extLst>
                            <a:ext uri="{FF2B5EF4-FFF2-40B4-BE49-F238E27FC236}">
                              <a16:creationId xmlns:a16="http://schemas.microsoft.com/office/drawing/2014/main" id="{C2CB5818-0E94-4644-9C39-21C7C4E07FB5}"/>
                            </a:ext>
                          </a:extLst>
                        </p:cNvPr>
                        <p:cNvPicPr/>
                        <p:nvPr/>
                      </p:nvPicPr>
                      <p:blipFill>
                        <a:blip r:embed="rId6"/>
                        <a:stretch>
                          <a:fillRect/>
                        </a:stretch>
                      </p:blipFill>
                      <p:spPr>
                        <a:xfrm>
                          <a:off x="3202047" y="1017736"/>
                          <a:ext cx="2909086" cy="2200729"/>
                        </a:xfrm>
                        <a:prstGeom prst="rect">
                          <a:avLst/>
                        </a:prstGeom>
                      </p:spPr>
                    </p:pic>
                  </p:oleObj>
                </mc:Fallback>
              </mc:AlternateContent>
            </a:graphicData>
          </a:graphic>
        </p:graphicFrame>
      </p:grpSp>
      <p:grpSp>
        <p:nvGrpSpPr>
          <p:cNvPr id="6" name="Group 5">
            <a:extLst>
              <a:ext uri="{FF2B5EF4-FFF2-40B4-BE49-F238E27FC236}">
                <a16:creationId xmlns:a16="http://schemas.microsoft.com/office/drawing/2014/main" id="{8EF80B08-6188-43CB-89D9-3AFEE08B0750}"/>
              </a:ext>
            </a:extLst>
          </p:cNvPr>
          <p:cNvGrpSpPr/>
          <p:nvPr/>
        </p:nvGrpSpPr>
        <p:grpSpPr>
          <a:xfrm>
            <a:off x="2461481" y="6182813"/>
            <a:ext cx="2599035" cy="2021735"/>
            <a:chOff x="8869897" y="670168"/>
            <a:chExt cx="3035683" cy="2780167"/>
          </a:xfrm>
        </p:grpSpPr>
        <p:graphicFrame>
          <p:nvGraphicFramePr>
            <p:cNvPr id="16" name="Object 15">
              <a:extLst>
                <a:ext uri="{FF2B5EF4-FFF2-40B4-BE49-F238E27FC236}">
                  <a16:creationId xmlns:a16="http://schemas.microsoft.com/office/drawing/2014/main" id="{C8BC7DA1-BC73-47DC-912D-99E2C5A548D9}"/>
                </a:ext>
              </a:extLst>
            </p:cNvPr>
            <p:cNvGraphicFramePr>
              <a:graphicFrameLocks noChangeAspect="1"/>
            </p:cNvGraphicFramePr>
            <p:nvPr>
              <p:extLst>
                <p:ext uri="{D42A27DB-BD31-4B8C-83A1-F6EECF244321}">
                  <p14:modId xmlns:p14="http://schemas.microsoft.com/office/powerpoint/2010/main" val="429245653"/>
                </p:ext>
              </p:extLst>
            </p:nvPr>
          </p:nvGraphicFramePr>
          <p:xfrm>
            <a:off x="8869897" y="1028008"/>
            <a:ext cx="2815097" cy="2422327"/>
          </p:xfrm>
          <a:graphic>
            <a:graphicData uri="http://schemas.openxmlformats.org/presentationml/2006/ole">
              <mc:AlternateContent xmlns:mc="http://schemas.openxmlformats.org/markup-compatibility/2006">
                <mc:Choice xmlns:v="urn:schemas-microsoft-com:vml" Requires="v">
                  <p:oleObj name="Prism 6" r:id="rId7" imgW="3549137" imgH="2844857" progId="Prism6.Document">
                    <p:embed/>
                  </p:oleObj>
                </mc:Choice>
                <mc:Fallback>
                  <p:oleObj name="Prism 6" r:id="rId7" imgW="3549137" imgH="2844857" progId="Prism6.Document">
                    <p:embed/>
                    <p:pic>
                      <p:nvPicPr>
                        <p:cNvPr id="16" name="Object 15">
                          <a:extLst>
                            <a:ext uri="{FF2B5EF4-FFF2-40B4-BE49-F238E27FC236}">
                              <a16:creationId xmlns:a16="http://schemas.microsoft.com/office/drawing/2014/main" id="{C8BC7DA1-BC73-47DC-912D-99E2C5A548D9}"/>
                            </a:ext>
                          </a:extLst>
                        </p:cNvPr>
                        <p:cNvPicPr/>
                        <p:nvPr/>
                      </p:nvPicPr>
                      <p:blipFill>
                        <a:blip r:embed="rId8"/>
                        <a:stretch>
                          <a:fillRect/>
                        </a:stretch>
                      </p:blipFill>
                      <p:spPr>
                        <a:xfrm>
                          <a:off x="8869897" y="1028008"/>
                          <a:ext cx="2815097" cy="2422327"/>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82A674AC-4DB0-424A-9D1E-A7018E938901}"/>
                </a:ext>
              </a:extLst>
            </p:cNvPr>
            <p:cNvSpPr txBox="1"/>
            <p:nvPr/>
          </p:nvSpPr>
          <p:spPr>
            <a:xfrm>
              <a:off x="8955689" y="670168"/>
              <a:ext cx="2949891" cy="639695"/>
            </a:xfrm>
            <a:prstGeom prst="rect">
              <a:avLst/>
            </a:prstGeom>
            <a:noFill/>
          </p:spPr>
          <p:txBody>
            <a:bodyPr wrap="square" rtlCol="0">
              <a:spAutoFit/>
            </a:bodyPr>
            <a:lstStyle>
              <a:defPPr>
                <a:defRPr lang="en-US"/>
              </a:defPPr>
              <a:lvl1pPr>
                <a:defRPr sz="1600"/>
              </a:lvl1pPr>
            </a:lstStyle>
            <a:p>
              <a:r>
                <a:rPr lang="en-CA" sz="1004" dirty="0"/>
                <a:t>G: 16-day-old primary MDMs </a:t>
              </a:r>
            </a:p>
            <a:p>
              <a:endParaRPr lang="en-CA" sz="1004" dirty="0"/>
            </a:p>
          </p:txBody>
        </p:sp>
      </p:grpSp>
      <p:grpSp>
        <p:nvGrpSpPr>
          <p:cNvPr id="7" name="Group 6">
            <a:extLst>
              <a:ext uri="{FF2B5EF4-FFF2-40B4-BE49-F238E27FC236}">
                <a16:creationId xmlns:a16="http://schemas.microsoft.com/office/drawing/2014/main" id="{D549CB17-09BF-440E-B341-799227569F7A}"/>
              </a:ext>
            </a:extLst>
          </p:cNvPr>
          <p:cNvGrpSpPr/>
          <p:nvPr/>
        </p:nvGrpSpPr>
        <p:grpSpPr>
          <a:xfrm>
            <a:off x="3829870" y="605591"/>
            <a:ext cx="2395566" cy="1874562"/>
            <a:chOff x="347057" y="3637057"/>
            <a:chExt cx="2894938" cy="2621965"/>
          </a:xfrm>
        </p:grpSpPr>
        <p:sp>
          <p:nvSpPr>
            <p:cNvPr id="14" name="TextBox 13">
              <a:extLst>
                <a:ext uri="{FF2B5EF4-FFF2-40B4-BE49-F238E27FC236}">
                  <a16:creationId xmlns:a16="http://schemas.microsoft.com/office/drawing/2014/main" id="{9BA838F0-E02E-436F-82ED-CB1A16C32DB5}"/>
                </a:ext>
              </a:extLst>
            </p:cNvPr>
            <p:cNvSpPr txBox="1"/>
            <p:nvPr/>
          </p:nvSpPr>
          <p:spPr>
            <a:xfrm>
              <a:off x="385683" y="3637057"/>
              <a:ext cx="2784239" cy="345288"/>
            </a:xfrm>
            <a:prstGeom prst="rect">
              <a:avLst/>
            </a:prstGeom>
            <a:noFill/>
          </p:spPr>
          <p:txBody>
            <a:bodyPr wrap="square" rtlCol="0">
              <a:spAutoFit/>
            </a:bodyPr>
            <a:lstStyle>
              <a:defPPr>
                <a:defRPr lang="en-US"/>
              </a:defPPr>
              <a:lvl1pPr>
                <a:defRPr sz="1600"/>
              </a:lvl1pPr>
            </a:lstStyle>
            <a:p>
              <a:r>
                <a:rPr lang="en-CA" sz="1004" dirty="0"/>
                <a:t>B: U937 differentiated 7 days</a:t>
              </a:r>
            </a:p>
          </p:txBody>
        </p:sp>
        <p:graphicFrame>
          <p:nvGraphicFramePr>
            <p:cNvPr id="15" name="Object 14">
              <a:extLst>
                <a:ext uri="{FF2B5EF4-FFF2-40B4-BE49-F238E27FC236}">
                  <a16:creationId xmlns:a16="http://schemas.microsoft.com/office/drawing/2014/main" id="{B00D8952-9F1D-4322-9ED3-2C25CDC3C6CB}"/>
                </a:ext>
              </a:extLst>
            </p:cNvPr>
            <p:cNvGraphicFramePr>
              <a:graphicFrameLocks noChangeAspect="1"/>
            </p:cNvGraphicFramePr>
            <p:nvPr>
              <p:extLst>
                <p:ext uri="{D42A27DB-BD31-4B8C-83A1-F6EECF244321}">
                  <p14:modId xmlns:p14="http://schemas.microsoft.com/office/powerpoint/2010/main" val="2103460777"/>
                </p:ext>
              </p:extLst>
            </p:nvPr>
          </p:nvGraphicFramePr>
          <p:xfrm>
            <a:off x="347057" y="3876630"/>
            <a:ext cx="2894938" cy="2382392"/>
          </p:xfrm>
          <a:graphic>
            <a:graphicData uri="http://schemas.openxmlformats.org/presentationml/2006/ole">
              <mc:AlternateContent xmlns:mc="http://schemas.openxmlformats.org/markup-compatibility/2006">
                <mc:Choice xmlns:v="urn:schemas-microsoft-com:vml" Requires="v">
                  <p:oleObj name="Prism 6" r:id="rId9" imgW="3524648" imgH="2844857" progId="Prism6.Document">
                    <p:embed/>
                  </p:oleObj>
                </mc:Choice>
                <mc:Fallback>
                  <p:oleObj name="Prism 6" r:id="rId9" imgW="3524648" imgH="2844857" progId="Prism6.Document">
                    <p:embed/>
                    <p:pic>
                      <p:nvPicPr>
                        <p:cNvPr id="15" name="Object 14">
                          <a:extLst>
                            <a:ext uri="{FF2B5EF4-FFF2-40B4-BE49-F238E27FC236}">
                              <a16:creationId xmlns:a16="http://schemas.microsoft.com/office/drawing/2014/main" id="{B00D8952-9F1D-4322-9ED3-2C25CDC3C6CB}"/>
                            </a:ext>
                          </a:extLst>
                        </p:cNvPr>
                        <p:cNvPicPr/>
                        <p:nvPr/>
                      </p:nvPicPr>
                      <p:blipFill>
                        <a:blip r:embed="rId10"/>
                        <a:stretch>
                          <a:fillRect/>
                        </a:stretch>
                      </p:blipFill>
                      <p:spPr>
                        <a:xfrm>
                          <a:off x="347057" y="3876630"/>
                          <a:ext cx="2894938" cy="2382392"/>
                        </a:xfrm>
                        <a:prstGeom prst="rect">
                          <a:avLst/>
                        </a:prstGeom>
                      </p:spPr>
                    </p:pic>
                  </p:oleObj>
                </mc:Fallback>
              </mc:AlternateContent>
            </a:graphicData>
          </a:graphic>
        </p:graphicFrame>
      </p:grpSp>
      <p:grpSp>
        <p:nvGrpSpPr>
          <p:cNvPr id="8" name="Group 7">
            <a:extLst>
              <a:ext uri="{FF2B5EF4-FFF2-40B4-BE49-F238E27FC236}">
                <a16:creationId xmlns:a16="http://schemas.microsoft.com/office/drawing/2014/main" id="{B97CCEE2-F9C9-4AD2-9622-8822C86FFFDA}"/>
              </a:ext>
            </a:extLst>
          </p:cNvPr>
          <p:cNvGrpSpPr/>
          <p:nvPr/>
        </p:nvGrpSpPr>
        <p:grpSpPr>
          <a:xfrm>
            <a:off x="3763136" y="4362643"/>
            <a:ext cx="2471723" cy="1737531"/>
            <a:chOff x="5994397" y="3231997"/>
            <a:chExt cx="2848063" cy="2808058"/>
          </a:xfrm>
        </p:grpSpPr>
        <p:sp>
          <p:nvSpPr>
            <p:cNvPr id="12" name="TextBox 11">
              <a:extLst>
                <a:ext uri="{FF2B5EF4-FFF2-40B4-BE49-F238E27FC236}">
                  <a16:creationId xmlns:a16="http://schemas.microsoft.com/office/drawing/2014/main" id="{F5208DC4-0F07-4850-A4C3-F69E6C827055}"/>
                </a:ext>
              </a:extLst>
            </p:cNvPr>
            <p:cNvSpPr txBox="1"/>
            <p:nvPr/>
          </p:nvSpPr>
          <p:spPr>
            <a:xfrm>
              <a:off x="6013374" y="3231997"/>
              <a:ext cx="2829086" cy="398959"/>
            </a:xfrm>
            <a:prstGeom prst="rect">
              <a:avLst/>
            </a:prstGeom>
            <a:noFill/>
          </p:spPr>
          <p:txBody>
            <a:bodyPr wrap="square" rtlCol="0">
              <a:spAutoFit/>
            </a:bodyPr>
            <a:lstStyle>
              <a:defPPr>
                <a:defRPr lang="en-US"/>
              </a:defPPr>
              <a:lvl1pPr>
                <a:defRPr sz="1600"/>
              </a:lvl1pPr>
            </a:lstStyle>
            <a:p>
              <a:r>
                <a:rPr lang="en-CA" sz="1004" dirty="0"/>
                <a:t>F: THP-1 differentiated 4 days</a:t>
              </a:r>
            </a:p>
          </p:txBody>
        </p:sp>
        <p:graphicFrame>
          <p:nvGraphicFramePr>
            <p:cNvPr id="13" name="Object 12">
              <a:extLst>
                <a:ext uri="{FF2B5EF4-FFF2-40B4-BE49-F238E27FC236}">
                  <a16:creationId xmlns:a16="http://schemas.microsoft.com/office/drawing/2014/main" id="{D8B1A29A-A091-44BE-AA61-EA9804E268C8}"/>
                </a:ext>
              </a:extLst>
            </p:cNvPr>
            <p:cNvGraphicFramePr>
              <a:graphicFrameLocks noChangeAspect="1"/>
            </p:cNvGraphicFramePr>
            <p:nvPr>
              <p:extLst>
                <p:ext uri="{D42A27DB-BD31-4B8C-83A1-F6EECF244321}">
                  <p14:modId xmlns:p14="http://schemas.microsoft.com/office/powerpoint/2010/main" val="2186687613"/>
                </p:ext>
              </p:extLst>
            </p:nvPr>
          </p:nvGraphicFramePr>
          <p:xfrm>
            <a:off x="5994397" y="3657665"/>
            <a:ext cx="2808339" cy="2382390"/>
          </p:xfrm>
          <a:graphic>
            <a:graphicData uri="http://schemas.openxmlformats.org/presentationml/2006/ole">
              <mc:AlternateContent xmlns:mc="http://schemas.openxmlformats.org/markup-compatibility/2006">
                <mc:Choice xmlns:v="urn:schemas-microsoft-com:vml" Requires="v">
                  <p:oleObj name="Prism 6" r:id="rId11" imgW="3508082" imgH="2817485" progId="Prism6.Document">
                    <p:embed/>
                  </p:oleObj>
                </mc:Choice>
                <mc:Fallback>
                  <p:oleObj name="Prism 6" r:id="rId11" imgW="3508082" imgH="2817485" progId="Prism6.Document">
                    <p:embed/>
                    <p:pic>
                      <p:nvPicPr>
                        <p:cNvPr id="13" name="Object 12">
                          <a:extLst>
                            <a:ext uri="{FF2B5EF4-FFF2-40B4-BE49-F238E27FC236}">
                              <a16:creationId xmlns:a16="http://schemas.microsoft.com/office/drawing/2014/main" id="{D8B1A29A-A091-44BE-AA61-EA9804E268C8}"/>
                            </a:ext>
                          </a:extLst>
                        </p:cNvPr>
                        <p:cNvPicPr/>
                        <p:nvPr/>
                      </p:nvPicPr>
                      <p:blipFill>
                        <a:blip r:embed="rId12"/>
                        <a:stretch>
                          <a:fillRect/>
                        </a:stretch>
                      </p:blipFill>
                      <p:spPr>
                        <a:xfrm>
                          <a:off x="5994397" y="3657665"/>
                          <a:ext cx="2808339" cy="2382390"/>
                        </a:xfrm>
                        <a:prstGeom prst="rect">
                          <a:avLst/>
                        </a:prstGeom>
                      </p:spPr>
                    </p:pic>
                  </p:oleObj>
                </mc:Fallback>
              </mc:AlternateContent>
            </a:graphicData>
          </a:graphic>
        </p:graphicFrame>
      </p:grpSp>
      <p:grpSp>
        <p:nvGrpSpPr>
          <p:cNvPr id="9" name="Group 8">
            <a:extLst>
              <a:ext uri="{FF2B5EF4-FFF2-40B4-BE49-F238E27FC236}">
                <a16:creationId xmlns:a16="http://schemas.microsoft.com/office/drawing/2014/main" id="{E6083CA3-7516-42A1-AC04-FF38BE01E017}"/>
              </a:ext>
            </a:extLst>
          </p:cNvPr>
          <p:cNvGrpSpPr/>
          <p:nvPr/>
        </p:nvGrpSpPr>
        <p:grpSpPr>
          <a:xfrm>
            <a:off x="3823473" y="2462204"/>
            <a:ext cx="2665009" cy="1934430"/>
            <a:chOff x="3624576" y="3538022"/>
            <a:chExt cx="3102396" cy="2459306"/>
          </a:xfrm>
        </p:grpSpPr>
        <p:sp>
          <p:nvSpPr>
            <p:cNvPr id="10" name="TextBox 9">
              <a:extLst>
                <a:ext uri="{FF2B5EF4-FFF2-40B4-BE49-F238E27FC236}">
                  <a16:creationId xmlns:a16="http://schemas.microsoft.com/office/drawing/2014/main" id="{B1A90298-2974-406C-82C6-0C9170438378}"/>
                </a:ext>
              </a:extLst>
            </p:cNvPr>
            <p:cNvSpPr txBox="1"/>
            <p:nvPr/>
          </p:nvSpPr>
          <p:spPr>
            <a:xfrm>
              <a:off x="3624576" y="3538022"/>
              <a:ext cx="3102396" cy="313844"/>
            </a:xfrm>
            <a:prstGeom prst="rect">
              <a:avLst/>
            </a:prstGeom>
            <a:noFill/>
          </p:spPr>
          <p:txBody>
            <a:bodyPr wrap="square" rtlCol="0">
              <a:spAutoFit/>
            </a:bodyPr>
            <a:lstStyle>
              <a:defPPr>
                <a:defRPr lang="en-US"/>
              </a:defPPr>
              <a:lvl1pPr>
                <a:defRPr sz="1600"/>
              </a:lvl1pPr>
            </a:lstStyle>
            <a:p>
              <a:r>
                <a:rPr lang="en-CA" sz="1004" dirty="0"/>
                <a:t>D: U1 differentiated 7 days</a:t>
              </a:r>
            </a:p>
          </p:txBody>
        </p:sp>
        <p:graphicFrame>
          <p:nvGraphicFramePr>
            <p:cNvPr id="11" name="Object 10">
              <a:extLst>
                <a:ext uri="{FF2B5EF4-FFF2-40B4-BE49-F238E27FC236}">
                  <a16:creationId xmlns:a16="http://schemas.microsoft.com/office/drawing/2014/main" id="{20A9D28B-1D6F-42CE-8B6D-1EB670DF5114}"/>
                </a:ext>
              </a:extLst>
            </p:cNvPr>
            <p:cNvGraphicFramePr>
              <a:graphicFrameLocks noChangeAspect="1"/>
            </p:cNvGraphicFramePr>
            <p:nvPr>
              <p:extLst>
                <p:ext uri="{D42A27DB-BD31-4B8C-83A1-F6EECF244321}">
                  <p14:modId xmlns:p14="http://schemas.microsoft.com/office/powerpoint/2010/main" val="1617399072"/>
                </p:ext>
              </p:extLst>
            </p:nvPr>
          </p:nvGraphicFramePr>
          <p:xfrm>
            <a:off x="3694514" y="3796600"/>
            <a:ext cx="2726240" cy="2200728"/>
          </p:xfrm>
          <a:graphic>
            <a:graphicData uri="http://schemas.openxmlformats.org/presentationml/2006/ole">
              <mc:AlternateContent xmlns:mc="http://schemas.openxmlformats.org/markup-compatibility/2006">
                <mc:Choice xmlns:v="urn:schemas-microsoft-com:vml" Requires="v">
                  <p:oleObj name="Prism 6" r:id="rId13" imgW="4372408" imgH="2844857" progId="Prism6.Document">
                    <p:embed/>
                  </p:oleObj>
                </mc:Choice>
                <mc:Fallback>
                  <p:oleObj name="Prism 6" r:id="rId13" imgW="4372408" imgH="2844857" progId="Prism6.Document">
                    <p:embed/>
                    <p:pic>
                      <p:nvPicPr>
                        <p:cNvPr id="11" name="Object 10">
                          <a:extLst>
                            <a:ext uri="{FF2B5EF4-FFF2-40B4-BE49-F238E27FC236}">
                              <a16:creationId xmlns:a16="http://schemas.microsoft.com/office/drawing/2014/main" id="{20A9D28B-1D6F-42CE-8B6D-1EB670DF5114}"/>
                            </a:ext>
                          </a:extLst>
                        </p:cNvPr>
                        <p:cNvPicPr/>
                        <p:nvPr/>
                      </p:nvPicPr>
                      <p:blipFill>
                        <a:blip r:embed="rId14"/>
                        <a:stretch>
                          <a:fillRect/>
                        </a:stretch>
                      </p:blipFill>
                      <p:spPr>
                        <a:xfrm>
                          <a:off x="3694514" y="3796600"/>
                          <a:ext cx="2726240" cy="2200728"/>
                        </a:xfrm>
                        <a:prstGeom prst="rect">
                          <a:avLst/>
                        </a:prstGeom>
                      </p:spPr>
                    </p:pic>
                  </p:oleObj>
                </mc:Fallback>
              </mc:AlternateContent>
            </a:graphicData>
          </a:graphic>
        </p:graphicFrame>
      </p:grpSp>
      <p:sp>
        <p:nvSpPr>
          <p:cNvPr id="25" name="TextBox 24">
            <a:extLst>
              <a:ext uri="{FF2B5EF4-FFF2-40B4-BE49-F238E27FC236}">
                <a16:creationId xmlns:a16="http://schemas.microsoft.com/office/drawing/2014/main" id="{CD0137B2-2F2C-4EBC-A913-32CBC6D040D7}"/>
              </a:ext>
            </a:extLst>
          </p:cNvPr>
          <p:cNvSpPr txBox="1"/>
          <p:nvPr/>
        </p:nvSpPr>
        <p:spPr>
          <a:xfrm>
            <a:off x="638828" y="8231485"/>
            <a:ext cx="6187857" cy="1384995"/>
          </a:xfrm>
          <a:prstGeom prst="rect">
            <a:avLst/>
          </a:prstGeom>
          <a:noFill/>
        </p:spPr>
        <p:txBody>
          <a:bodyPr wrap="square">
            <a:spAutoFit/>
          </a:bodyPr>
          <a:lstStyle/>
          <a:p>
            <a:pPr marL="0" marR="0" algn="just">
              <a:spcBef>
                <a:spcPts val="0"/>
              </a:spcBef>
              <a:spcAft>
                <a:spcPts val="0"/>
              </a:spcAft>
            </a:pPr>
            <a:r>
              <a:rPr lang="en-CA" sz="1200" b="1" kern="1200" dirty="0">
                <a:effectLst/>
                <a:latin typeface="Times New Roman" panose="02020603050405020304" pitchFamily="18" charset="0"/>
                <a:ea typeface="+mn-ea"/>
              </a:rPr>
              <a:t>Supplementary Figure 1 - Puromycin sensitivity of undifferentiated and differentiated U937, U1, THP-1 and primary MDMs. </a:t>
            </a:r>
            <a:r>
              <a:rPr lang="en-US" sz="1200" kern="1200" dirty="0">
                <a:effectLst/>
                <a:latin typeface="Times New Roman" panose="02020603050405020304" pitchFamily="18" charset="0"/>
                <a:ea typeface="+mn-ea"/>
              </a:rPr>
              <a:t>Undifferentiated and differentiated cells were treated with various doses of puromycin for 48 </a:t>
            </a:r>
            <a:r>
              <a:rPr lang="en-US" sz="1200" kern="1200" dirty="0" err="1">
                <a:effectLst/>
                <a:latin typeface="Times New Roman" panose="02020603050405020304" pitchFamily="18" charset="0"/>
                <a:ea typeface="+mn-ea"/>
              </a:rPr>
              <a:t>hr</a:t>
            </a:r>
            <a:r>
              <a:rPr lang="en-US" sz="1200" kern="1200" dirty="0">
                <a:effectLst/>
                <a:latin typeface="Times New Roman" panose="02020603050405020304" pitchFamily="18" charset="0"/>
                <a:ea typeface="+mn-ea"/>
              </a:rPr>
              <a:t>, harvested and PI staining were applied to track dead cells. The percentage of dead cells were detected by flow cytometry at PI channel. The mean value and standard deviation were based on three independent experiments (n=3). </a:t>
            </a:r>
            <a:r>
              <a:rPr lang="en-US" sz="1200" b="1" kern="1200" dirty="0">
                <a:effectLst/>
                <a:latin typeface="Times New Roman" panose="02020603050405020304" pitchFamily="18" charset="0"/>
                <a:ea typeface="+mn-ea"/>
              </a:rPr>
              <a:t>A</a:t>
            </a:r>
            <a:r>
              <a:rPr lang="en-US" sz="1200" kern="1200" dirty="0">
                <a:effectLst/>
                <a:latin typeface="Times New Roman" panose="02020603050405020304" pitchFamily="18" charset="0"/>
                <a:ea typeface="+mn-ea"/>
              </a:rPr>
              <a:t>: </a:t>
            </a:r>
            <a:r>
              <a:rPr lang="en-CA" sz="1200" kern="1200" dirty="0">
                <a:effectLst/>
                <a:latin typeface="Times New Roman" panose="02020603050405020304" pitchFamily="18" charset="0"/>
                <a:ea typeface="+mn-ea"/>
              </a:rPr>
              <a:t>U937 undifferentiated; </a:t>
            </a:r>
            <a:r>
              <a:rPr lang="en-CA" sz="1200" b="1" kern="1200" dirty="0">
                <a:effectLst/>
                <a:latin typeface="Times New Roman" panose="02020603050405020304" pitchFamily="18" charset="0"/>
                <a:ea typeface="+mn-ea"/>
              </a:rPr>
              <a:t>B</a:t>
            </a:r>
            <a:r>
              <a:rPr lang="en-CA" sz="1200" kern="1200" dirty="0">
                <a:effectLst/>
                <a:latin typeface="Times New Roman" panose="02020603050405020304" pitchFamily="18" charset="0"/>
                <a:ea typeface="+mn-ea"/>
              </a:rPr>
              <a:t>: U937 differentiated 7 days; </a:t>
            </a:r>
            <a:r>
              <a:rPr lang="en-CA" sz="1200" b="1" kern="1200" dirty="0">
                <a:effectLst/>
                <a:latin typeface="Times New Roman" panose="02020603050405020304" pitchFamily="18" charset="0"/>
                <a:ea typeface="+mn-ea"/>
              </a:rPr>
              <a:t>C</a:t>
            </a:r>
            <a:r>
              <a:rPr lang="en-CA" sz="1200" kern="1200" dirty="0">
                <a:effectLst/>
                <a:latin typeface="Times New Roman" panose="02020603050405020304" pitchFamily="18" charset="0"/>
                <a:ea typeface="+mn-ea"/>
              </a:rPr>
              <a:t>: U1 undifferentiated; </a:t>
            </a:r>
            <a:r>
              <a:rPr lang="en-US" sz="1200" b="1" kern="1200" dirty="0">
                <a:effectLst/>
                <a:latin typeface="Times New Roman" panose="02020603050405020304" pitchFamily="18" charset="0"/>
                <a:ea typeface="+mn-ea"/>
              </a:rPr>
              <a:t>D</a:t>
            </a:r>
            <a:r>
              <a:rPr lang="en-US" sz="1200" kern="1200" dirty="0">
                <a:effectLst/>
                <a:latin typeface="Times New Roman" panose="02020603050405020304" pitchFamily="18" charset="0"/>
                <a:ea typeface="+mn-ea"/>
              </a:rPr>
              <a:t>: U1 differentiated 7 days; </a:t>
            </a:r>
            <a:r>
              <a:rPr lang="en-US" sz="1200" b="1" kern="1200" dirty="0">
                <a:effectLst/>
                <a:latin typeface="Times New Roman" panose="02020603050405020304" pitchFamily="18" charset="0"/>
                <a:ea typeface="+mn-ea"/>
              </a:rPr>
              <a:t>E</a:t>
            </a:r>
            <a:r>
              <a:rPr lang="en-US" sz="1200" kern="1200" dirty="0">
                <a:effectLst/>
                <a:latin typeface="Times New Roman" panose="02020603050405020304" pitchFamily="18" charset="0"/>
                <a:ea typeface="+mn-ea"/>
              </a:rPr>
              <a:t>: THP-1 undifferentiated; </a:t>
            </a:r>
            <a:r>
              <a:rPr lang="en-US" sz="1200" b="1" kern="1200" dirty="0">
                <a:effectLst/>
                <a:latin typeface="Times New Roman" panose="02020603050405020304" pitchFamily="18" charset="0"/>
                <a:ea typeface="+mn-ea"/>
              </a:rPr>
              <a:t>F</a:t>
            </a:r>
            <a:r>
              <a:rPr lang="en-US" sz="1200" kern="1200" dirty="0">
                <a:effectLst/>
                <a:latin typeface="Times New Roman" panose="02020603050405020304" pitchFamily="18" charset="0"/>
                <a:ea typeface="+mn-ea"/>
              </a:rPr>
              <a:t>: THP-1 differentiated 4 days; </a:t>
            </a:r>
            <a:r>
              <a:rPr lang="en-US" sz="1200" b="1" kern="1200" dirty="0">
                <a:effectLst/>
                <a:latin typeface="Times New Roman" panose="02020603050405020304" pitchFamily="18" charset="0"/>
                <a:ea typeface="+mn-ea"/>
              </a:rPr>
              <a:t>G</a:t>
            </a:r>
            <a:r>
              <a:rPr lang="en-US" sz="1200" kern="1200" dirty="0">
                <a:effectLst/>
                <a:latin typeface="Times New Roman" panose="02020603050405020304" pitchFamily="18" charset="0"/>
                <a:ea typeface="+mn-ea"/>
              </a:rPr>
              <a:t>: 16-day-old primary MDMs.</a:t>
            </a:r>
            <a:endParaRPr lang="en-CA"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8829048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638570E-A0FA-4776-821E-230831E07F8E}"/>
              </a:ext>
            </a:extLst>
          </p:cNvPr>
          <p:cNvSpPr txBox="1"/>
          <p:nvPr/>
        </p:nvSpPr>
        <p:spPr>
          <a:xfrm>
            <a:off x="713983" y="7794596"/>
            <a:ext cx="623796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10 - Full blots corresponding to Figure 6B </a:t>
            </a:r>
            <a:r>
              <a:rPr lang="en-CA" sz="1200" b="1" kern="1200" dirty="0" err="1">
                <a:effectLst/>
                <a:latin typeface="Times New Roman" panose="02020603050405020304" pitchFamily="18" charset="0"/>
                <a:cs typeface="Times New Roman" panose="02020603050405020304" pitchFamily="18" charset="0"/>
              </a:rPr>
              <a:t>Uqcrq</a:t>
            </a:r>
            <a:r>
              <a:rPr lang="en-CA" sz="1200" b="1" kern="1200" dirty="0">
                <a:effectLst/>
                <a:latin typeface="Times New Roman" panose="02020603050405020304" pitchFamily="18" charset="0"/>
                <a:cs typeface="Times New Roman" panose="02020603050405020304" pitchFamily="18" charset="0"/>
              </a:rPr>
              <a:t>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Anti-UQCRQ polyclonal antibody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 6B</a:t>
            </a:r>
            <a:r>
              <a:rPr lang="en-US" sz="1200" dirty="0">
                <a:latin typeface="Times New Roman" panose="02020603050405020304" pitchFamily="18" charset="0"/>
                <a:cs typeface="Times New Roman" panose="02020603050405020304" pitchFamily="18" charset="0"/>
              </a:rPr>
              <a:t>.</a:t>
            </a:r>
            <a:endParaRPr lang="en-US" sz="1200" kern="1200" dirty="0">
              <a:effectLst/>
              <a:latin typeface="Times New Roman" panose="02020603050405020304" pitchFamily="18" charset="0"/>
              <a:cs typeface="Times New Roman" panose="02020603050405020304" pitchFamily="18" charset="0"/>
            </a:endParaRPr>
          </a:p>
        </p:txBody>
      </p:sp>
      <p:pic>
        <p:nvPicPr>
          <p:cNvPr id="6" name="Picture 5" descr="A close-up of a piece of paper&#10;&#10;Description automatically generated with medium confidence">
            <a:extLst>
              <a:ext uri="{FF2B5EF4-FFF2-40B4-BE49-F238E27FC236}">
                <a16:creationId xmlns:a16="http://schemas.microsoft.com/office/drawing/2014/main" id="{5696E89B-9918-4493-8600-BF8DF36FE2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19901" y="2041738"/>
            <a:ext cx="4831003" cy="5583887"/>
          </a:xfrm>
          <a:prstGeom prst="rect">
            <a:avLst/>
          </a:prstGeom>
        </p:spPr>
      </p:pic>
      <p:sp>
        <p:nvSpPr>
          <p:cNvPr id="7" name="TextBox 14">
            <a:extLst>
              <a:ext uri="{FF2B5EF4-FFF2-40B4-BE49-F238E27FC236}">
                <a16:creationId xmlns:a16="http://schemas.microsoft.com/office/drawing/2014/main" id="{EE2FE8EA-0EB6-4CBC-A902-357FAA5FA0E9}"/>
              </a:ext>
            </a:extLst>
          </p:cNvPr>
          <p:cNvSpPr txBox="1">
            <a:spLocks noChangeArrowheads="1"/>
          </p:cNvSpPr>
          <p:nvPr/>
        </p:nvSpPr>
        <p:spPr bwMode="auto">
          <a:xfrm>
            <a:off x="5336940" y="4942553"/>
            <a:ext cx="1082649"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Uqcrq</a:t>
            </a:r>
            <a:endParaRPr lang="en-US" altLang="en-US" sz="1299" dirty="0">
              <a:solidFill>
                <a:srgbClr val="000000"/>
              </a:solidFill>
            </a:endParaRPr>
          </a:p>
          <a:p>
            <a:pPr eaLnBrk="0" fontAlgn="base" hangingPunct="0">
              <a:spcBef>
                <a:spcPct val="0"/>
              </a:spcBef>
              <a:spcAft>
                <a:spcPct val="0"/>
              </a:spcAft>
              <a:buNone/>
            </a:pPr>
            <a:r>
              <a:rPr lang="en-US" altLang="en-US" sz="1299" dirty="0">
                <a:solidFill>
                  <a:srgbClr val="000000"/>
                </a:solidFill>
              </a:rPr>
              <a:t>12.7kDa</a:t>
            </a:r>
          </a:p>
        </p:txBody>
      </p:sp>
      <p:sp>
        <p:nvSpPr>
          <p:cNvPr id="9" name="TextBox 13">
            <a:extLst>
              <a:ext uri="{FF2B5EF4-FFF2-40B4-BE49-F238E27FC236}">
                <a16:creationId xmlns:a16="http://schemas.microsoft.com/office/drawing/2014/main" id="{83D6EAA8-71CF-4F9C-9A8E-B32DC93CE91E}"/>
              </a:ext>
            </a:extLst>
          </p:cNvPr>
          <p:cNvSpPr txBox="1">
            <a:spLocks noChangeArrowheads="1"/>
          </p:cNvSpPr>
          <p:nvPr/>
        </p:nvSpPr>
        <p:spPr bwMode="auto">
          <a:xfrm>
            <a:off x="5336411" y="3095298"/>
            <a:ext cx="758893"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t>β</a:t>
            </a:r>
            <a:r>
              <a:rPr lang="en-US" altLang="en-US" sz="1299" dirty="0"/>
              <a:t>-actin</a:t>
            </a:r>
          </a:p>
          <a:p>
            <a:pPr eaLnBrk="0" fontAlgn="base" hangingPunct="0">
              <a:spcBef>
                <a:spcPct val="0"/>
              </a:spcBef>
              <a:spcAft>
                <a:spcPct val="0"/>
              </a:spcAft>
              <a:buNone/>
            </a:pPr>
            <a:r>
              <a:rPr lang="en-US" altLang="en-US" sz="1299" dirty="0"/>
              <a:t>42kDa</a:t>
            </a:r>
          </a:p>
        </p:txBody>
      </p:sp>
      <p:grpSp>
        <p:nvGrpSpPr>
          <p:cNvPr id="11" name="Group 10">
            <a:extLst>
              <a:ext uri="{FF2B5EF4-FFF2-40B4-BE49-F238E27FC236}">
                <a16:creationId xmlns:a16="http://schemas.microsoft.com/office/drawing/2014/main" id="{CE9E04BA-4A87-4CD0-A26C-73F2A86AD92E}"/>
              </a:ext>
            </a:extLst>
          </p:cNvPr>
          <p:cNvGrpSpPr/>
          <p:nvPr/>
        </p:nvGrpSpPr>
        <p:grpSpPr>
          <a:xfrm>
            <a:off x="1891432" y="1778785"/>
            <a:ext cx="839014" cy="3940091"/>
            <a:chOff x="1377864" y="1803837"/>
            <a:chExt cx="839014" cy="3940091"/>
          </a:xfrm>
        </p:grpSpPr>
        <p:sp>
          <p:nvSpPr>
            <p:cNvPr id="12" name="TextBox 11">
              <a:extLst>
                <a:ext uri="{FF2B5EF4-FFF2-40B4-BE49-F238E27FC236}">
                  <a16:creationId xmlns:a16="http://schemas.microsoft.com/office/drawing/2014/main" id="{BFDCA857-1E36-4ED0-B2B4-49B408B23550}"/>
                </a:ext>
              </a:extLst>
            </p:cNvPr>
            <p:cNvSpPr txBox="1">
              <a:spLocks noChangeArrowheads="1"/>
            </p:cNvSpPr>
            <p:nvPr/>
          </p:nvSpPr>
          <p:spPr bwMode="auto">
            <a:xfrm>
              <a:off x="1478072" y="311892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50</a:t>
              </a:r>
            </a:p>
          </p:txBody>
        </p:sp>
        <p:sp>
          <p:nvSpPr>
            <p:cNvPr id="13" name="TextBox 12">
              <a:extLst>
                <a:ext uri="{FF2B5EF4-FFF2-40B4-BE49-F238E27FC236}">
                  <a16:creationId xmlns:a16="http://schemas.microsoft.com/office/drawing/2014/main" id="{D77CB056-9C66-4C8C-8D26-013D20F42106}"/>
                </a:ext>
              </a:extLst>
            </p:cNvPr>
            <p:cNvSpPr txBox="1">
              <a:spLocks noChangeArrowheads="1"/>
            </p:cNvSpPr>
            <p:nvPr/>
          </p:nvSpPr>
          <p:spPr bwMode="auto">
            <a:xfrm>
              <a:off x="1478071" y="3412790"/>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37</a:t>
              </a:r>
            </a:p>
          </p:txBody>
        </p:sp>
        <p:sp>
          <p:nvSpPr>
            <p:cNvPr id="14" name="TextBox 7">
              <a:extLst>
                <a:ext uri="{FF2B5EF4-FFF2-40B4-BE49-F238E27FC236}">
                  <a16:creationId xmlns:a16="http://schemas.microsoft.com/office/drawing/2014/main" id="{A7001076-2BC7-484B-B0C1-0C477CDC3282}"/>
                </a:ext>
              </a:extLst>
            </p:cNvPr>
            <p:cNvSpPr txBox="1">
              <a:spLocks noChangeArrowheads="1"/>
            </p:cNvSpPr>
            <p:nvPr/>
          </p:nvSpPr>
          <p:spPr bwMode="auto">
            <a:xfrm>
              <a:off x="1478072" y="391931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5</a:t>
              </a:r>
            </a:p>
          </p:txBody>
        </p:sp>
        <p:sp>
          <p:nvSpPr>
            <p:cNvPr id="15" name="TextBox 4">
              <a:extLst>
                <a:ext uri="{FF2B5EF4-FFF2-40B4-BE49-F238E27FC236}">
                  <a16:creationId xmlns:a16="http://schemas.microsoft.com/office/drawing/2014/main" id="{9EAC1014-DC37-41F4-8096-9BA55EA453DE}"/>
                </a:ext>
              </a:extLst>
            </p:cNvPr>
            <p:cNvSpPr txBox="1">
              <a:spLocks noChangeArrowheads="1"/>
            </p:cNvSpPr>
            <p:nvPr/>
          </p:nvSpPr>
          <p:spPr bwMode="auto">
            <a:xfrm>
              <a:off x="1465547" y="2791303"/>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75</a:t>
              </a:r>
            </a:p>
          </p:txBody>
        </p:sp>
        <p:sp>
          <p:nvSpPr>
            <p:cNvPr id="16" name="TextBox 4">
              <a:extLst>
                <a:ext uri="{FF2B5EF4-FFF2-40B4-BE49-F238E27FC236}">
                  <a16:creationId xmlns:a16="http://schemas.microsoft.com/office/drawing/2014/main" id="{40DDBAC3-4287-42A6-B6CF-27BA860A8F94}"/>
                </a:ext>
              </a:extLst>
            </p:cNvPr>
            <p:cNvSpPr txBox="1">
              <a:spLocks noChangeArrowheads="1"/>
            </p:cNvSpPr>
            <p:nvPr/>
          </p:nvSpPr>
          <p:spPr bwMode="auto">
            <a:xfrm>
              <a:off x="1377864" y="243013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0</a:t>
              </a:r>
            </a:p>
          </p:txBody>
        </p:sp>
        <p:sp>
          <p:nvSpPr>
            <p:cNvPr id="17" name="TextBox 4">
              <a:extLst>
                <a:ext uri="{FF2B5EF4-FFF2-40B4-BE49-F238E27FC236}">
                  <a16:creationId xmlns:a16="http://schemas.microsoft.com/office/drawing/2014/main" id="{15D4D507-CFDF-4506-A0B7-B954A64DE253}"/>
                </a:ext>
              </a:extLst>
            </p:cNvPr>
            <p:cNvSpPr txBox="1">
              <a:spLocks noChangeArrowheads="1"/>
            </p:cNvSpPr>
            <p:nvPr/>
          </p:nvSpPr>
          <p:spPr bwMode="auto">
            <a:xfrm>
              <a:off x="1377864" y="2607590"/>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0</a:t>
              </a:r>
            </a:p>
          </p:txBody>
        </p:sp>
        <p:sp>
          <p:nvSpPr>
            <p:cNvPr id="18" name="TextBox 4">
              <a:extLst>
                <a:ext uri="{FF2B5EF4-FFF2-40B4-BE49-F238E27FC236}">
                  <a16:creationId xmlns:a16="http://schemas.microsoft.com/office/drawing/2014/main" id="{408436DB-41FA-4D24-B6CB-FCAF3DB6F897}"/>
                </a:ext>
              </a:extLst>
            </p:cNvPr>
            <p:cNvSpPr txBox="1">
              <a:spLocks noChangeArrowheads="1"/>
            </p:cNvSpPr>
            <p:nvPr/>
          </p:nvSpPr>
          <p:spPr bwMode="auto">
            <a:xfrm>
              <a:off x="1392478" y="1803837"/>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t>kDa</a:t>
              </a:r>
              <a:endParaRPr lang="en-US" altLang="en-US" sz="1299" dirty="0"/>
            </a:p>
          </p:txBody>
        </p:sp>
        <p:sp>
          <p:nvSpPr>
            <p:cNvPr id="19" name="TextBox 7">
              <a:extLst>
                <a:ext uri="{FF2B5EF4-FFF2-40B4-BE49-F238E27FC236}">
                  <a16:creationId xmlns:a16="http://schemas.microsoft.com/office/drawing/2014/main" id="{8A2A3178-20ED-4DE0-AA5C-8D5223073F06}"/>
                </a:ext>
              </a:extLst>
            </p:cNvPr>
            <p:cNvSpPr txBox="1">
              <a:spLocks noChangeArrowheads="1"/>
            </p:cNvSpPr>
            <p:nvPr/>
          </p:nvSpPr>
          <p:spPr bwMode="auto">
            <a:xfrm>
              <a:off x="1455107" y="4785703"/>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a:t>
              </a:r>
            </a:p>
          </p:txBody>
        </p:sp>
        <p:sp>
          <p:nvSpPr>
            <p:cNvPr id="20" name="TextBox 7">
              <a:extLst>
                <a:ext uri="{FF2B5EF4-FFF2-40B4-BE49-F238E27FC236}">
                  <a16:creationId xmlns:a16="http://schemas.microsoft.com/office/drawing/2014/main" id="{FACAE207-8365-4C51-BD80-97583BBA09A5}"/>
                </a:ext>
              </a:extLst>
            </p:cNvPr>
            <p:cNvSpPr txBox="1">
              <a:spLocks noChangeArrowheads="1"/>
            </p:cNvSpPr>
            <p:nvPr/>
          </p:nvSpPr>
          <p:spPr bwMode="auto">
            <a:xfrm>
              <a:off x="1480159" y="429718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0</a:t>
              </a:r>
            </a:p>
          </p:txBody>
        </p:sp>
        <p:sp>
          <p:nvSpPr>
            <p:cNvPr id="21" name="TextBox 7">
              <a:extLst>
                <a:ext uri="{FF2B5EF4-FFF2-40B4-BE49-F238E27FC236}">
                  <a16:creationId xmlns:a16="http://schemas.microsoft.com/office/drawing/2014/main" id="{C99F4AB0-A2B2-462E-AA0C-6531968F1DAA}"/>
                </a:ext>
              </a:extLst>
            </p:cNvPr>
            <p:cNvSpPr txBox="1">
              <a:spLocks noChangeArrowheads="1"/>
            </p:cNvSpPr>
            <p:nvPr/>
          </p:nvSpPr>
          <p:spPr bwMode="auto">
            <a:xfrm>
              <a:off x="1494774" y="545166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a:t>
              </a:r>
            </a:p>
          </p:txBody>
        </p:sp>
      </p:grpSp>
      <p:grpSp>
        <p:nvGrpSpPr>
          <p:cNvPr id="22" name="Group 21">
            <a:extLst>
              <a:ext uri="{FF2B5EF4-FFF2-40B4-BE49-F238E27FC236}">
                <a16:creationId xmlns:a16="http://schemas.microsoft.com/office/drawing/2014/main" id="{274F8303-FEDB-465C-A251-5DA0EF6A7C46}"/>
              </a:ext>
            </a:extLst>
          </p:cNvPr>
          <p:cNvGrpSpPr/>
          <p:nvPr/>
        </p:nvGrpSpPr>
        <p:grpSpPr>
          <a:xfrm>
            <a:off x="3155845" y="37577"/>
            <a:ext cx="2440594" cy="2155960"/>
            <a:chOff x="3018059" y="37579"/>
            <a:chExt cx="2440594" cy="2155960"/>
          </a:xfrm>
        </p:grpSpPr>
        <p:sp>
          <p:nvSpPr>
            <p:cNvPr id="23" name="TextBox 22">
              <a:extLst>
                <a:ext uri="{FF2B5EF4-FFF2-40B4-BE49-F238E27FC236}">
                  <a16:creationId xmlns:a16="http://schemas.microsoft.com/office/drawing/2014/main" id="{100086DB-4408-4279-9192-FFBB086AC3F7}"/>
                </a:ext>
              </a:extLst>
            </p:cNvPr>
            <p:cNvSpPr txBox="1"/>
            <p:nvPr/>
          </p:nvSpPr>
          <p:spPr>
            <a:xfrm rot="18305062">
              <a:off x="2204581" y="1082670"/>
              <a:ext cx="1903956" cy="276999"/>
            </a:xfrm>
            <a:prstGeom prst="rect">
              <a:avLst/>
            </a:prstGeom>
            <a:noFill/>
          </p:spPr>
          <p:txBody>
            <a:bodyPr wrap="square" rtlCol="0">
              <a:spAutoFit/>
            </a:bodyPr>
            <a:lstStyle/>
            <a:p>
              <a:r>
                <a:rPr lang="en-US" sz="1200" dirty="0"/>
                <a:t>Protein Standard</a:t>
              </a:r>
              <a:endParaRPr lang="en-CA" sz="1200" dirty="0"/>
            </a:p>
          </p:txBody>
        </p:sp>
        <p:sp>
          <p:nvSpPr>
            <p:cNvPr id="24" name="TextBox 23">
              <a:extLst>
                <a:ext uri="{FF2B5EF4-FFF2-40B4-BE49-F238E27FC236}">
                  <a16:creationId xmlns:a16="http://schemas.microsoft.com/office/drawing/2014/main" id="{6EBD361A-26E2-4BF8-8392-94E1915E96FE}"/>
                </a:ext>
              </a:extLst>
            </p:cNvPr>
            <p:cNvSpPr txBox="1"/>
            <p:nvPr/>
          </p:nvSpPr>
          <p:spPr>
            <a:xfrm rot="18305062">
              <a:off x="2644737" y="1002319"/>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25" name="TextBox 24">
              <a:extLst>
                <a:ext uri="{FF2B5EF4-FFF2-40B4-BE49-F238E27FC236}">
                  <a16:creationId xmlns:a16="http://schemas.microsoft.com/office/drawing/2014/main" id="{1A2F7B42-B00F-4BFD-843E-B0C72D671E1A}"/>
                </a:ext>
              </a:extLst>
            </p:cNvPr>
            <p:cNvSpPr txBox="1"/>
            <p:nvPr/>
          </p:nvSpPr>
          <p:spPr>
            <a:xfrm rot="18305062">
              <a:off x="3185636" y="974767"/>
              <a:ext cx="2105441" cy="276999"/>
            </a:xfrm>
            <a:prstGeom prst="rect">
              <a:avLst/>
            </a:prstGeom>
            <a:noFill/>
          </p:spPr>
          <p:txBody>
            <a:bodyPr wrap="square" rtlCol="0">
              <a:spAutoFit/>
            </a:bodyPr>
            <a:lstStyle/>
            <a:p>
              <a:r>
                <a:rPr lang="en-US" sz="1200" dirty="0"/>
                <a:t>Donor-1 + UQCRQ siRNA</a:t>
              </a:r>
              <a:endParaRPr lang="en-CA" sz="1200" dirty="0"/>
            </a:p>
          </p:txBody>
        </p:sp>
        <p:sp>
          <p:nvSpPr>
            <p:cNvPr id="26" name="TextBox 25">
              <a:extLst>
                <a:ext uri="{FF2B5EF4-FFF2-40B4-BE49-F238E27FC236}">
                  <a16:creationId xmlns:a16="http://schemas.microsoft.com/office/drawing/2014/main" id="{6A482138-FA0E-447C-8A0E-BFCC50715B7F}"/>
                </a:ext>
              </a:extLst>
            </p:cNvPr>
            <p:cNvSpPr txBox="1"/>
            <p:nvPr/>
          </p:nvSpPr>
          <p:spPr>
            <a:xfrm rot="18305062">
              <a:off x="3726535" y="979355"/>
              <a:ext cx="2105441" cy="276999"/>
            </a:xfrm>
            <a:prstGeom prst="rect">
              <a:avLst/>
            </a:prstGeom>
            <a:noFill/>
          </p:spPr>
          <p:txBody>
            <a:bodyPr wrap="square" rtlCol="0">
              <a:spAutoFit/>
            </a:bodyPr>
            <a:lstStyle/>
            <a:p>
              <a:r>
                <a:rPr lang="en-US" sz="1200" dirty="0"/>
                <a:t>Donor-2 + Non-target siRNA</a:t>
              </a:r>
              <a:endParaRPr lang="en-CA" sz="1200" dirty="0"/>
            </a:p>
          </p:txBody>
        </p:sp>
        <p:sp>
          <p:nvSpPr>
            <p:cNvPr id="27" name="TextBox 26">
              <a:extLst>
                <a:ext uri="{FF2B5EF4-FFF2-40B4-BE49-F238E27FC236}">
                  <a16:creationId xmlns:a16="http://schemas.microsoft.com/office/drawing/2014/main" id="{31FAA2E1-896A-4881-99EF-A3837D4A76A0}"/>
                </a:ext>
              </a:extLst>
            </p:cNvPr>
            <p:cNvSpPr txBox="1"/>
            <p:nvPr/>
          </p:nvSpPr>
          <p:spPr>
            <a:xfrm rot="18305062">
              <a:off x="4267433" y="951800"/>
              <a:ext cx="2105441" cy="276999"/>
            </a:xfrm>
            <a:prstGeom prst="rect">
              <a:avLst/>
            </a:prstGeom>
            <a:noFill/>
          </p:spPr>
          <p:txBody>
            <a:bodyPr wrap="square" rtlCol="0">
              <a:spAutoFit/>
            </a:bodyPr>
            <a:lstStyle/>
            <a:p>
              <a:r>
                <a:rPr lang="en-US" sz="1200" dirty="0"/>
                <a:t>Donor-2 + UQCRQ siRNA</a:t>
              </a:r>
              <a:endParaRPr lang="en-CA" sz="1200" dirty="0"/>
            </a:p>
          </p:txBody>
        </p:sp>
      </p:grpSp>
      <p:sp>
        <p:nvSpPr>
          <p:cNvPr id="28" name="Rectangle 27">
            <a:extLst>
              <a:ext uri="{FF2B5EF4-FFF2-40B4-BE49-F238E27FC236}">
                <a16:creationId xmlns:a16="http://schemas.microsoft.com/office/drawing/2014/main" id="{5423DBAF-69B2-44B1-808B-F19F249DCA06}"/>
              </a:ext>
            </a:extLst>
          </p:cNvPr>
          <p:cNvSpPr/>
          <p:nvPr/>
        </p:nvSpPr>
        <p:spPr>
          <a:xfrm>
            <a:off x="2993721" y="5047980"/>
            <a:ext cx="1215024" cy="33821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9" name="Rectangle 28">
            <a:extLst>
              <a:ext uri="{FF2B5EF4-FFF2-40B4-BE49-F238E27FC236}">
                <a16:creationId xmlns:a16="http://schemas.microsoft.com/office/drawing/2014/main" id="{48373F1A-F0C9-4BFC-A8DC-42F23EECF823}"/>
              </a:ext>
            </a:extLst>
          </p:cNvPr>
          <p:cNvSpPr/>
          <p:nvPr/>
        </p:nvSpPr>
        <p:spPr>
          <a:xfrm>
            <a:off x="3018773" y="3206657"/>
            <a:ext cx="1114816" cy="31523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18282492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white&#10;&#10;Description automatically generated">
            <a:extLst>
              <a:ext uri="{FF2B5EF4-FFF2-40B4-BE49-F238E27FC236}">
                <a16:creationId xmlns:a16="http://schemas.microsoft.com/office/drawing/2014/main" id="{D712A5CA-4CFB-455C-A35A-DF8C2163B35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5799" y="3382025"/>
            <a:ext cx="6304813" cy="4878269"/>
          </a:xfrm>
          <a:prstGeom prst="rect">
            <a:avLst/>
          </a:prstGeom>
        </p:spPr>
      </p:pic>
      <p:grpSp>
        <p:nvGrpSpPr>
          <p:cNvPr id="4" name="Group 3">
            <a:extLst>
              <a:ext uri="{FF2B5EF4-FFF2-40B4-BE49-F238E27FC236}">
                <a16:creationId xmlns:a16="http://schemas.microsoft.com/office/drawing/2014/main" id="{192BEC6B-DCF4-421B-9ECB-A7928E71D6A0}"/>
              </a:ext>
            </a:extLst>
          </p:cNvPr>
          <p:cNvGrpSpPr/>
          <p:nvPr/>
        </p:nvGrpSpPr>
        <p:grpSpPr>
          <a:xfrm>
            <a:off x="4596337" y="1456172"/>
            <a:ext cx="2520698" cy="2130908"/>
            <a:chOff x="3193421" y="191046"/>
            <a:chExt cx="2520698" cy="2130908"/>
          </a:xfrm>
        </p:grpSpPr>
        <p:sp>
          <p:nvSpPr>
            <p:cNvPr id="6" name="TextBox 5">
              <a:extLst>
                <a:ext uri="{FF2B5EF4-FFF2-40B4-BE49-F238E27FC236}">
                  <a16:creationId xmlns:a16="http://schemas.microsoft.com/office/drawing/2014/main" id="{CABC1B9C-DD10-4F45-819E-FEC0D7283BFC}"/>
                </a:ext>
              </a:extLst>
            </p:cNvPr>
            <p:cNvSpPr txBox="1"/>
            <p:nvPr/>
          </p:nvSpPr>
          <p:spPr>
            <a:xfrm rot="18305062">
              <a:off x="2379943" y="1211085"/>
              <a:ext cx="1903956"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Protein Standard</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6807DF18-A250-4879-9569-D52FE1625640}"/>
                </a:ext>
              </a:extLst>
            </p:cNvPr>
            <p:cNvSpPr txBox="1"/>
            <p:nvPr/>
          </p:nvSpPr>
          <p:spPr>
            <a:xfrm rot="18305062">
              <a:off x="2840125" y="1130734"/>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Mock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35527F7D-DFEF-48C9-AAFE-7F0AD97EF9EB}"/>
                </a:ext>
              </a:extLst>
            </p:cNvPr>
            <p:cNvSpPr txBox="1"/>
            <p:nvPr/>
          </p:nvSpPr>
          <p:spPr>
            <a:xfrm rot="18305062">
              <a:off x="3401050" y="1128232"/>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HIV-HSA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9" name="TextBox 8">
              <a:extLst>
                <a:ext uri="{FF2B5EF4-FFF2-40B4-BE49-F238E27FC236}">
                  <a16:creationId xmlns:a16="http://schemas.microsoft.com/office/drawing/2014/main" id="{0F3C7DDE-40BC-4499-842E-3BA15400B0B8}"/>
                </a:ext>
              </a:extLst>
            </p:cNvPr>
            <p:cNvSpPr txBox="1"/>
            <p:nvPr/>
          </p:nvSpPr>
          <p:spPr>
            <a:xfrm rot="18305062">
              <a:off x="3961975" y="1128231"/>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HIV-HSA +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0" name="TextBox 9">
              <a:extLst>
                <a:ext uri="{FF2B5EF4-FFF2-40B4-BE49-F238E27FC236}">
                  <a16:creationId xmlns:a16="http://schemas.microsoft.com/office/drawing/2014/main" id="{17DF6728-775F-4E62-8761-2B2510B2EAAC}"/>
                </a:ext>
              </a:extLst>
            </p:cNvPr>
            <p:cNvSpPr txBox="1"/>
            <p:nvPr/>
          </p:nvSpPr>
          <p:spPr>
            <a:xfrm rot="18305062">
              <a:off x="4522899" y="1105267"/>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HIV-HSA +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sp>
        <p:nvSpPr>
          <p:cNvPr id="12" name="TextBox 13">
            <a:extLst>
              <a:ext uri="{FF2B5EF4-FFF2-40B4-BE49-F238E27FC236}">
                <a16:creationId xmlns:a16="http://schemas.microsoft.com/office/drawing/2014/main" id="{C9DB8B25-1E62-45C1-B916-C005359545CC}"/>
              </a:ext>
            </a:extLst>
          </p:cNvPr>
          <p:cNvSpPr txBox="1">
            <a:spLocks noChangeArrowheads="1"/>
          </p:cNvSpPr>
          <p:nvPr/>
        </p:nvSpPr>
        <p:spPr bwMode="auto">
          <a:xfrm>
            <a:off x="3884886" y="5146310"/>
            <a:ext cx="705903"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l-GR"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β</a:t>
            </a: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actin</a:t>
            </a:r>
          </a:p>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42kDa</a:t>
            </a:r>
          </a:p>
        </p:txBody>
      </p:sp>
      <p:sp>
        <p:nvSpPr>
          <p:cNvPr id="13" name="TextBox 14">
            <a:extLst>
              <a:ext uri="{FF2B5EF4-FFF2-40B4-BE49-F238E27FC236}">
                <a16:creationId xmlns:a16="http://schemas.microsoft.com/office/drawing/2014/main" id="{0517B030-B3E9-4210-B6ED-CA64BD5B1C72}"/>
              </a:ext>
            </a:extLst>
          </p:cNvPr>
          <p:cNvSpPr txBox="1">
            <a:spLocks noChangeArrowheads="1"/>
          </p:cNvSpPr>
          <p:nvPr/>
        </p:nvSpPr>
        <p:spPr bwMode="auto">
          <a:xfrm>
            <a:off x="3844501" y="6371921"/>
            <a:ext cx="852761"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Cox7a2</a:t>
            </a:r>
          </a:p>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11kDa</a:t>
            </a:r>
          </a:p>
        </p:txBody>
      </p:sp>
      <p:grpSp>
        <p:nvGrpSpPr>
          <p:cNvPr id="16" name="Group 15">
            <a:extLst>
              <a:ext uri="{FF2B5EF4-FFF2-40B4-BE49-F238E27FC236}">
                <a16:creationId xmlns:a16="http://schemas.microsoft.com/office/drawing/2014/main" id="{23F26196-9277-473E-9D32-C84F89019923}"/>
              </a:ext>
            </a:extLst>
          </p:cNvPr>
          <p:cNvGrpSpPr/>
          <p:nvPr/>
        </p:nvGrpSpPr>
        <p:grpSpPr>
          <a:xfrm>
            <a:off x="617856" y="4559568"/>
            <a:ext cx="857802" cy="2334679"/>
            <a:chOff x="1043742" y="3219284"/>
            <a:chExt cx="857802" cy="2334679"/>
          </a:xfrm>
        </p:grpSpPr>
        <p:sp>
          <p:nvSpPr>
            <p:cNvPr id="17" name="TextBox 4">
              <a:extLst>
                <a:ext uri="{FF2B5EF4-FFF2-40B4-BE49-F238E27FC236}">
                  <a16:creationId xmlns:a16="http://schemas.microsoft.com/office/drawing/2014/main" id="{32A11330-A07D-47CD-8D93-46E5D25C6E89}"/>
                </a:ext>
              </a:extLst>
            </p:cNvPr>
            <p:cNvSpPr txBox="1">
              <a:spLocks noChangeArrowheads="1"/>
            </p:cNvSpPr>
            <p:nvPr/>
          </p:nvSpPr>
          <p:spPr bwMode="auto">
            <a:xfrm>
              <a:off x="1141863" y="368260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50</a:t>
              </a:r>
            </a:p>
          </p:txBody>
        </p:sp>
        <p:sp>
          <p:nvSpPr>
            <p:cNvPr id="18" name="TextBox 5">
              <a:extLst>
                <a:ext uri="{FF2B5EF4-FFF2-40B4-BE49-F238E27FC236}">
                  <a16:creationId xmlns:a16="http://schemas.microsoft.com/office/drawing/2014/main" id="{F24FF78C-B5CD-4A18-A661-F331B5B73F5F}"/>
                </a:ext>
              </a:extLst>
            </p:cNvPr>
            <p:cNvSpPr txBox="1">
              <a:spLocks noChangeArrowheads="1"/>
            </p:cNvSpPr>
            <p:nvPr/>
          </p:nvSpPr>
          <p:spPr bwMode="auto">
            <a:xfrm>
              <a:off x="1141863" y="4176886"/>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37</a:t>
              </a:r>
            </a:p>
          </p:txBody>
        </p:sp>
        <p:sp>
          <p:nvSpPr>
            <p:cNvPr id="19" name="TextBox 7">
              <a:extLst>
                <a:ext uri="{FF2B5EF4-FFF2-40B4-BE49-F238E27FC236}">
                  <a16:creationId xmlns:a16="http://schemas.microsoft.com/office/drawing/2014/main" id="{A006D2C8-D66E-423C-BD79-7B205244F392}"/>
                </a:ext>
              </a:extLst>
            </p:cNvPr>
            <p:cNvSpPr txBox="1">
              <a:spLocks noChangeArrowheads="1"/>
            </p:cNvSpPr>
            <p:nvPr/>
          </p:nvSpPr>
          <p:spPr bwMode="auto">
            <a:xfrm>
              <a:off x="1154389" y="458320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25</a:t>
              </a:r>
            </a:p>
          </p:txBody>
        </p:sp>
        <p:sp>
          <p:nvSpPr>
            <p:cNvPr id="20" name="TextBox 11">
              <a:extLst>
                <a:ext uri="{FF2B5EF4-FFF2-40B4-BE49-F238E27FC236}">
                  <a16:creationId xmlns:a16="http://schemas.microsoft.com/office/drawing/2014/main" id="{149380CE-5226-4D19-A4FB-F2C4BECEF37E}"/>
                </a:ext>
              </a:extLst>
            </p:cNvPr>
            <p:cNvSpPr txBox="1">
              <a:spLocks noChangeArrowheads="1"/>
            </p:cNvSpPr>
            <p:nvPr/>
          </p:nvSpPr>
          <p:spPr bwMode="auto">
            <a:xfrm>
              <a:off x="1129337" y="526170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10</a:t>
              </a:r>
            </a:p>
          </p:txBody>
        </p:sp>
        <p:sp>
          <p:nvSpPr>
            <p:cNvPr id="21" name="TextBox 20">
              <a:extLst>
                <a:ext uri="{FF2B5EF4-FFF2-40B4-BE49-F238E27FC236}">
                  <a16:creationId xmlns:a16="http://schemas.microsoft.com/office/drawing/2014/main" id="{28DEC9F9-4EAE-4C7D-8D72-34A7CD26F7B5}"/>
                </a:ext>
              </a:extLst>
            </p:cNvPr>
            <p:cNvSpPr txBox="1">
              <a:spLocks noChangeArrowheads="1"/>
            </p:cNvSpPr>
            <p:nvPr/>
          </p:nvSpPr>
          <p:spPr bwMode="auto">
            <a:xfrm>
              <a:off x="1141863" y="5077165"/>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15</a:t>
              </a:r>
            </a:p>
          </p:txBody>
        </p:sp>
        <p:sp>
          <p:nvSpPr>
            <p:cNvPr id="22" name="TextBox 4">
              <a:extLst>
                <a:ext uri="{FF2B5EF4-FFF2-40B4-BE49-F238E27FC236}">
                  <a16:creationId xmlns:a16="http://schemas.microsoft.com/office/drawing/2014/main" id="{03EAC110-9A8F-47F0-8933-589A38FA3B8F}"/>
                </a:ext>
              </a:extLst>
            </p:cNvPr>
            <p:cNvSpPr txBox="1">
              <a:spLocks noChangeArrowheads="1"/>
            </p:cNvSpPr>
            <p:nvPr/>
          </p:nvSpPr>
          <p:spPr bwMode="auto">
            <a:xfrm>
              <a:off x="1141863" y="353034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75</a:t>
              </a:r>
            </a:p>
          </p:txBody>
        </p:sp>
        <p:sp>
          <p:nvSpPr>
            <p:cNvPr id="23" name="TextBox 7">
              <a:extLst>
                <a:ext uri="{FF2B5EF4-FFF2-40B4-BE49-F238E27FC236}">
                  <a16:creationId xmlns:a16="http://schemas.microsoft.com/office/drawing/2014/main" id="{C58C6F21-786C-4A1C-9208-4BDBA5E5D7C0}"/>
                </a:ext>
              </a:extLst>
            </p:cNvPr>
            <p:cNvSpPr txBox="1">
              <a:spLocks noChangeArrowheads="1"/>
            </p:cNvSpPr>
            <p:nvPr/>
          </p:nvSpPr>
          <p:spPr bwMode="auto">
            <a:xfrm>
              <a:off x="1179441" y="4767718"/>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rPr>
                <a:t>20</a:t>
              </a:r>
            </a:p>
          </p:txBody>
        </p:sp>
        <p:sp>
          <p:nvSpPr>
            <p:cNvPr id="26" name="TextBox 4">
              <a:extLst>
                <a:ext uri="{FF2B5EF4-FFF2-40B4-BE49-F238E27FC236}">
                  <a16:creationId xmlns:a16="http://schemas.microsoft.com/office/drawing/2014/main" id="{96698DE4-13C8-4F6D-ACA0-E594FFA6A3AB}"/>
                </a:ext>
              </a:extLst>
            </p:cNvPr>
            <p:cNvSpPr txBox="1">
              <a:spLocks noChangeArrowheads="1"/>
            </p:cNvSpPr>
            <p:nvPr/>
          </p:nvSpPr>
          <p:spPr bwMode="auto">
            <a:xfrm>
              <a:off x="1043742" y="3219284"/>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en-US" sz="1299" b="0" i="0" u="none" strike="noStrike" kern="1200" cap="none" spc="0" normalizeH="0" baseline="0" noProof="0" dirty="0" err="1">
                  <a:ln>
                    <a:noFill/>
                  </a:ln>
                  <a:solidFill>
                    <a:srgbClr val="000000"/>
                  </a:solidFill>
                  <a:effectLst/>
                  <a:uLnTx/>
                  <a:uFillTx/>
                  <a:latin typeface="Arial" panose="020B0604020202020204" pitchFamily="34" charset="0"/>
                  <a:ea typeface="+mn-ea"/>
                  <a:cs typeface="+mn-cs"/>
                </a:rPr>
                <a:t>kDa</a:t>
              </a:r>
              <a:endParaRPr kumimoji="0" lang="en-US" altLang="en-US" sz="1299" b="0" i="0" u="none" strike="noStrike" kern="1200" cap="none" spc="0" normalizeH="0" baseline="0" noProof="0" dirty="0">
                <a:ln>
                  <a:noFill/>
                </a:ln>
                <a:solidFill>
                  <a:srgbClr val="000000"/>
                </a:solidFill>
                <a:effectLst/>
                <a:uLnTx/>
                <a:uFillTx/>
                <a:latin typeface="Arial" panose="020B0604020202020204" pitchFamily="34" charset="0"/>
                <a:ea typeface="+mn-ea"/>
                <a:cs typeface="+mn-cs"/>
              </a:endParaRPr>
            </a:p>
          </p:txBody>
        </p:sp>
      </p:grpSp>
      <p:sp>
        <p:nvSpPr>
          <p:cNvPr id="28" name="TextBox 27">
            <a:extLst>
              <a:ext uri="{FF2B5EF4-FFF2-40B4-BE49-F238E27FC236}">
                <a16:creationId xmlns:a16="http://schemas.microsoft.com/office/drawing/2014/main" id="{A941FE8C-4D15-47CF-A939-82D70870E0BA}"/>
              </a:ext>
            </a:extLst>
          </p:cNvPr>
          <p:cNvSpPr txBox="1"/>
          <p:nvPr/>
        </p:nvSpPr>
        <p:spPr>
          <a:xfrm>
            <a:off x="588723" y="8383321"/>
            <a:ext cx="6413326" cy="830997"/>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CA"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11 - Full blots corresponding to Figure 6B Cox7a2 siRNA silencing.  </a:t>
            </a:r>
            <a:r>
              <a:rPr kumimoji="0" lang="en-CA"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VDF membranes was blotted with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mn-cs"/>
              </a:rPr>
              <a:t>rabbit anti-COX7A2 polyclonal antibody C-terminal end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nd rabbit anti-β-actin (13E5) monoclonal antibody simultaneously. The rectangles depict the approximative area used in the manuscript Fig. 6B.</a:t>
            </a:r>
          </a:p>
        </p:txBody>
      </p:sp>
      <p:sp>
        <p:nvSpPr>
          <p:cNvPr id="29" name="Rectangle 28">
            <a:extLst>
              <a:ext uri="{FF2B5EF4-FFF2-40B4-BE49-F238E27FC236}">
                <a16:creationId xmlns:a16="http://schemas.microsoft.com/office/drawing/2014/main" id="{C6B48D1E-B713-46E3-A3AD-963C7A304D37}"/>
              </a:ext>
            </a:extLst>
          </p:cNvPr>
          <p:cNvSpPr/>
          <p:nvPr/>
        </p:nvSpPr>
        <p:spPr>
          <a:xfrm>
            <a:off x="2192056" y="6413324"/>
            <a:ext cx="1164919" cy="35073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C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0" name="Rectangle 29">
            <a:extLst>
              <a:ext uri="{FF2B5EF4-FFF2-40B4-BE49-F238E27FC236}">
                <a16:creationId xmlns:a16="http://schemas.microsoft.com/office/drawing/2014/main" id="{FC1A4AB8-9A9D-410B-A80D-A5CADABE8804}"/>
              </a:ext>
            </a:extLst>
          </p:cNvPr>
          <p:cNvSpPr/>
          <p:nvPr/>
        </p:nvSpPr>
        <p:spPr>
          <a:xfrm>
            <a:off x="2217107" y="5212912"/>
            <a:ext cx="1127342" cy="3507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C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nvGrpSpPr>
          <p:cNvPr id="2" name="Group 1">
            <a:extLst>
              <a:ext uri="{FF2B5EF4-FFF2-40B4-BE49-F238E27FC236}">
                <a16:creationId xmlns:a16="http://schemas.microsoft.com/office/drawing/2014/main" id="{FD37F227-AADF-4898-BEC9-70B4E1FB4FCD}"/>
              </a:ext>
            </a:extLst>
          </p:cNvPr>
          <p:cNvGrpSpPr/>
          <p:nvPr/>
        </p:nvGrpSpPr>
        <p:grpSpPr>
          <a:xfrm>
            <a:off x="1742491" y="996792"/>
            <a:ext cx="2676012" cy="2620955"/>
            <a:chOff x="1629757" y="445648"/>
            <a:chExt cx="2676012" cy="2620955"/>
          </a:xfrm>
        </p:grpSpPr>
        <p:sp>
          <p:nvSpPr>
            <p:cNvPr id="25" name="TextBox 24">
              <a:extLst>
                <a:ext uri="{FF2B5EF4-FFF2-40B4-BE49-F238E27FC236}">
                  <a16:creationId xmlns:a16="http://schemas.microsoft.com/office/drawing/2014/main" id="{C54DF889-EFD6-4A90-8C0E-D72AC786D35F}"/>
                </a:ext>
              </a:extLst>
            </p:cNvPr>
            <p:cNvSpPr txBox="1"/>
            <p:nvPr/>
          </p:nvSpPr>
          <p:spPr>
            <a:xfrm rot="18305062">
              <a:off x="816279" y="1914629"/>
              <a:ext cx="1903956"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Protein Standard</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7" name="TextBox 26">
              <a:extLst>
                <a:ext uri="{FF2B5EF4-FFF2-40B4-BE49-F238E27FC236}">
                  <a16:creationId xmlns:a16="http://schemas.microsoft.com/office/drawing/2014/main" id="{9213A078-6C66-4F64-BE54-70868DBC960D}"/>
                </a:ext>
              </a:extLst>
            </p:cNvPr>
            <p:cNvSpPr txBox="1"/>
            <p:nvPr/>
          </p:nvSpPr>
          <p:spPr>
            <a:xfrm rot="18305062">
              <a:off x="1276461" y="1834278"/>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7-days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1" name="TextBox 30">
              <a:extLst>
                <a:ext uri="{FF2B5EF4-FFF2-40B4-BE49-F238E27FC236}">
                  <a16:creationId xmlns:a16="http://schemas.microsoft.com/office/drawing/2014/main" id="{E71A23E9-5282-4EB8-8162-6A7DBCA8DBD2}"/>
                </a:ext>
              </a:extLst>
            </p:cNvPr>
            <p:cNvSpPr txBox="1"/>
            <p:nvPr/>
          </p:nvSpPr>
          <p:spPr>
            <a:xfrm rot="18305062">
              <a:off x="1837386" y="1831776"/>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2" name="TextBox 31">
              <a:extLst>
                <a:ext uri="{FF2B5EF4-FFF2-40B4-BE49-F238E27FC236}">
                  <a16:creationId xmlns:a16="http://schemas.microsoft.com/office/drawing/2014/main" id="{B851EF0C-5DA5-4F97-B915-D63B8AB00DC5}"/>
                </a:ext>
              </a:extLst>
            </p:cNvPr>
            <p:cNvSpPr txBox="1"/>
            <p:nvPr/>
          </p:nvSpPr>
          <p:spPr>
            <a:xfrm rot="18305062">
              <a:off x="2296253" y="1635371"/>
              <a:ext cx="2585465"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Accell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4" name="TextBox 33">
              <a:extLst>
                <a:ext uri="{FF2B5EF4-FFF2-40B4-BE49-F238E27FC236}">
                  <a16:creationId xmlns:a16="http://schemas.microsoft.com/office/drawing/2014/main" id="{EBA3A32A-AD4F-4588-960E-A696F765BAF4}"/>
                </a:ext>
              </a:extLst>
            </p:cNvPr>
            <p:cNvSpPr txBox="1"/>
            <p:nvPr/>
          </p:nvSpPr>
          <p:spPr>
            <a:xfrm rot="18305062">
              <a:off x="2874537" y="1599881"/>
              <a:ext cx="2585465"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a:t>
              </a:r>
              <a:r>
                <a:rPr kumimoji="0" lang="en-US" sz="1200" b="0" i="0" u="none" strike="noStrike" kern="1200" cap="none" spc="0" normalizeH="0" baseline="0" noProof="0" dirty="0" err="1">
                  <a:ln>
                    <a:noFill/>
                  </a:ln>
                  <a:solidFill>
                    <a:prstClr val="black"/>
                  </a:solidFill>
                  <a:effectLst/>
                  <a:uLnTx/>
                  <a:uFillTx/>
                  <a:latin typeface="Calibri" panose="020F0502020204030204"/>
                  <a:ea typeface="+mn-ea"/>
                  <a:cs typeface="+mn-cs"/>
                </a:rPr>
                <a:t>Ontarget</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Plus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spTree>
    <p:extLst>
      <p:ext uri="{BB962C8B-B14F-4D97-AF65-F5344CB8AC3E}">
        <p14:creationId xmlns:p14="http://schemas.microsoft.com/office/powerpoint/2010/main" val="8530886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picture containing text, white&#10;&#10;Description automatically generated">
            <a:extLst>
              <a:ext uri="{FF2B5EF4-FFF2-40B4-BE49-F238E27FC236}">
                <a16:creationId xmlns:a16="http://schemas.microsoft.com/office/drawing/2014/main" id="{8811492D-41AD-4985-9F75-D5C1B9AE1E5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7361" y="2974661"/>
            <a:ext cx="5606694" cy="5071307"/>
          </a:xfrm>
          <a:prstGeom prst="rect">
            <a:avLst/>
          </a:prstGeom>
        </p:spPr>
      </p:pic>
      <p:grpSp>
        <p:nvGrpSpPr>
          <p:cNvPr id="8" name="Group 7">
            <a:extLst>
              <a:ext uri="{FF2B5EF4-FFF2-40B4-BE49-F238E27FC236}">
                <a16:creationId xmlns:a16="http://schemas.microsoft.com/office/drawing/2014/main" id="{B16E2B2E-E8A1-4414-973F-43911322E89D}"/>
              </a:ext>
            </a:extLst>
          </p:cNvPr>
          <p:cNvGrpSpPr/>
          <p:nvPr/>
        </p:nvGrpSpPr>
        <p:grpSpPr>
          <a:xfrm>
            <a:off x="1252605" y="2718234"/>
            <a:ext cx="859890" cy="4428606"/>
            <a:chOff x="1365338" y="1803837"/>
            <a:chExt cx="859890" cy="4428606"/>
          </a:xfrm>
        </p:grpSpPr>
        <p:sp>
          <p:nvSpPr>
            <p:cNvPr id="9" name="TextBox 8">
              <a:extLst>
                <a:ext uri="{FF2B5EF4-FFF2-40B4-BE49-F238E27FC236}">
                  <a16:creationId xmlns:a16="http://schemas.microsoft.com/office/drawing/2014/main" id="{5ACEFFEF-BD31-4312-A024-2F3D21A8D52C}"/>
                </a:ext>
              </a:extLst>
            </p:cNvPr>
            <p:cNvSpPr txBox="1">
              <a:spLocks noChangeArrowheads="1"/>
            </p:cNvSpPr>
            <p:nvPr/>
          </p:nvSpPr>
          <p:spPr bwMode="auto">
            <a:xfrm>
              <a:off x="1503124" y="364501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50</a:t>
              </a:r>
            </a:p>
          </p:txBody>
        </p:sp>
        <p:sp>
          <p:nvSpPr>
            <p:cNvPr id="10" name="TextBox 9">
              <a:extLst>
                <a:ext uri="{FF2B5EF4-FFF2-40B4-BE49-F238E27FC236}">
                  <a16:creationId xmlns:a16="http://schemas.microsoft.com/office/drawing/2014/main" id="{B5DC7838-50A8-4B57-BDBC-C0E51DEE882F}"/>
                </a:ext>
              </a:extLst>
            </p:cNvPr>
            <p:cNvSpPr txBox="1">
              <a:spLocks noChangeArrowheads="1"/>
            </p:cNvSpPr>
            <p:nvPr/>
          </p:nvSpPr>
          <p:spPr bwMode="auto">
            <a:xfrm>
              <a:off x="1503123" y="409772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37</a:t>
              </a:r>
            </a:p>
          </p:txBody>
        </p:sp>
        <p:sp>
          <p:nvSpPr>
            <p:cNvPr id="11" name="TextBox 7">
              <a:extLst>
                <a:ext uri="{FF2B5EF4-FFF2-40B4-BE49-F238E27FC236}">
                  <a16:creationId xmlns:a16="http://schemas.microsoft.com/office/drawing/2014/main" id="{1E5A8AE9-A264-4A17-8C0F-AF41A628FE56}"/>
                </a:ext>
              </a:extLst>
            </p:cNvPr>
            <p:cNvSpPr txBox="1">
              <a:spLocks noChangeArrowheads="1"/>
            </p:cNvSpPr>
            <p:nvPr/>
          </p:nvSpPr>
          <p:spPr bwMode="auto">
            <a:xfrm>
              <a:off x="1490598" y="474603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5</a:t>
              </a:r>
            </a:p>
          </p:txBody>
        </p:sp>
        <p:sp>
          <p:nvSpPr>
            <p:cNvPr id="12" name="TextBox 4">
              <a:extLst>
                <a:ext uri="{FF2B5EF4-FFF2-40B4-BE49-F238E27FC236}">
                  <a16:creationId xmlns:a16="http://schemas.microsoft.com/office/drawing/2014/main" id="{C53782EA-A1DC-4EF4-9050-480B859B8A50}"/>
                </a:ext>
              </a:extLst>
            </p:cNvPr>
            <p:cNvSpPr txBox="1">
              <a:spLocks noChangeArrowheads="1"/>
            </p:cNvSpPr>
            <p:nvPr/>
          </p:nvSpPr>
          <p:spPr bwMode="auto">
            <a:xfrm>
              <a:off x="1453021" y="3229713"/>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75</a:t>
              </a:r>
            </a:p>
          </p:txBody>
        </p:sp>
        <p:sp>
          <p:nvSpPr>
            <p:cNvPr id="13" name="TextBox 4">
              <a:extLst>
                <a:ext uri="{FF2B5EF4-FFF2-40B4-BE49-F238E27FC236}">
                  <a16:creationId xmlns:a16="http://schemas.microsoft.com/office/drawing/2014/main" id="{CB08EDDB-EEF9-487D-9C9E-8EBCD5D52105}"/>
                </a:ext>
              </a:extLst>
            </p:cNvPr>
            <p:cNvSpPr txBox="1">
              <a:spLocks noChangeArrowheads="1"/>
            </p:cNvSpPr>
            <p:nvPr/>
          </p:nvSpPr>
          <p:spPr bwMode="auto">
            <a:xfrm>
              <a:off x="1365338" y="2780865"/>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0</a:t>
              </a:r>
            </a:p>
          </p:txBody>
        </p:sp>
        <p:sp>
          <p:nvSpPr>
            <p:cNvPr id="14" name="TextBox 4">
              <a:extLst>
                <a:ext uri="{FF2B5EF4-FFF2-40B4-BE49-F238E27FC236}">
                  <a16:creationId xmlns:a16="http://schemas.microsoft.com/office/drawing/2014/main" id="{2FE9CFEE-6A66-4F33-B7EA-EE2E504A2FBA}"/>
                </a:ext>
              </a:extLst>
            </p:cNvPr>
            <p:cNvSpPr txBox="1">
              <a:spLocks noChangeArrowheads="1"/>
            </p:cNvSpPr>
            <p:nvPr/>
          </p:nvSpPr>
          <p:spPr bwMode="auto">
            <a:xfrm>
              <a:off x="1365338" y="299589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0</a:t>
              </a:r>
            </a:p>
          </p:txBody>
        </p:sp>
        <p:sp>
          <p:nvSpPr>
            <p:cNvPr id="15" name="TextBox 4">
              <a:extLst>
                <a:ext uri="{FF2B5EF4-FFF2-40B4-BE49-F238E27FC236}">
                  <a16:creationId xmlns:a16="http://schemas.microsoft.com/office/drawing/2014/main" id="{ABE995F5-2112-4956-AE3B-5B7311D5ECCE}"/>
                </a:ext>
              </a:extLst>
            </p:cNvPr>
            <p:cNvSpPr txBox="1">
              <a:spLocks noChangeArrowheads="1"/>
            </p:cNvSpPr>
            <p:nvPr/>
          </p:nvSpPr>
          <p:spPr bwMode="auto">
            <a:xfrm>
              <a:off x="1392478" y="1803837"/>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t>kDa</a:t>
              </a:r>
              <a:endParaRPr lang="en-US" altLang="en-US" sz="1299" dirty="0"/>
            </a:p>
          </p:txBody>
        </p:sp>
        <p:sp>
          <p:nvSpPr>
            <p:cNvPr id="16" name="TextBox 7">
              <a:extLst>
                <a:ext uri="{FF2B5EF4-FFF2-40B4-BE49-F238E27FC236}">
                  <a16:creationId xmlns:a16="http://schemas.microsoft.com/office/drawing/2014/main" id="{7B15D83A-7D56-4DAA-91C4-F8A2C4BAEFC9}"/>
                </a:ext>
              </a:extLst>
            </p:cNvPr>
            <p:cNvSpPr txBox="1">
              <a:spLocks noChangeArrowheads="1"/>
            </p:cNvSpPr>
            <p:nvPr/>
          </p:nvSpPr>
          <p:spPr bwMode="auto">
            <a:xfrm>
              <a:off x="1480159" y="566252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a:t>
              </a:r>
            </a:p>
          </p:txBody>
        </p:sp>
        <p:sp>
          <p:nvSpPr>
            <p:cNvPr id="17" name="TextBox 7">
              <a:extLst>
                <a:ext uri="{FF2B5EF4-FFF2-40B4-BE49-F238E27FC236}">
                  <a16:creationId xmlns:a16="http://schemas.microsoft.com/office/drawing/2014/main" id="{C7DC72A4-799C-49C1-8924-AE21D50DB250}"/>
                </a:ext>
              </a:extLst>
            </p:cNvPr>
            <p:cNvSpPr txBox="1">
              <a:spLocks noChangeArrowheads="1"/>
            </p:cNvSpPr>
            <p:nvPr/>
          </p:nvSpPr>
          <p:spPr bwMode="auto">
            <a:xfrm>
              <a:off x="1480159" y="511137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0</a:t>
              </a:r>
            </a:p>
          </p:txBody>
        </p:sp>
        <p:sp>
          <p:nvSpPr>
            <p:cNvPr id="18" name="TextBox 7">
              <a:extLst>
                <a:ext uri="{FF2B5EF4-FFF2-40B4-BE49-F238E27FC236}">
                  <a16:creationId xmlns:a16="http://schemas.microsoft.com/office/drawing/2014/main" id="{B65ABE72-0D67-479D-B62B-BB17DD5D699B}"/>
                </a:ext>
              </a:extLst>
            </p:cNvPr>
            <p:cNvSpPr txBox="1">
              <a:spLocks noChangeArrowheads="1"/>
            </p:cNvSpPr>
            <p:nvPr/>
          </p:nvSpPr>
          <p:spPr bwMode="auto">
            <a:xfrm>
              <a:off x="1482248" y="594018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a:t>
              </a:r>
            </a:p>
          </p:txBody>
        </p:sp>
      </p:grpSp>
      <p:sp>
        <p:nvSpPr>
          <p:cNvPr id="19" name="TextBox 13">
            <a:extLst>
              <a:ext uri="{FF2B5EF4-FFF2-40B4-BE49-F238E27FC236}">
                <a16:creationId xmlns:a16="http://schemas.microsoft.com/office/drawing/2014/main" id="{158287E1-32D8-40E9-AA2B-ED5F05525607}"/>
              </a:ext>
            </a:extLst>
          </p:cNvPr>
          <p:cNvSpPr txBox="1">
            <a:spLocks noChangeArrowheads="1"/>
          </p:cNvSpPr>
          <p:nvPr/>
        </p:nvSpPr>
        <p:spPr bwMode="auto">
          <a:xfrm>
            <a:off x="5147821" y="4776581"/>
            <a:ext cx="1290557"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l-GR" altLang="en-US" sz="1299" dirty="0">
                <a:solidFill>
                  <a:srgbClr val="000000"/>
                </a:solidFill>
              </a:rPr>
              <a:t>β</a:t>
            </a:r>
            <a:r>
              <a:rPr lang="en-US" altLang="en-US" sz="1299" dirty="0">
                <a:solidFill>
                  <a:srgbClr val="000000"/>
                </a:solidFill>
              </a:rPr>
              <a:t>-actin 42kDa</a:t>
            </a:r>
          </a:p>
        </p:txBody>
      </p:sp>
      <p:sp>
        <p:nvSpPr>
          <p:cNvPr id="20" name="TextBox 14">
            <a:extLst>
              <a:ext uri="{FF2B5EF4-FFF2-40B4-BE49-F238E27FC236}">
                <a16:creationId xmlns:a16="http://schemas.microsoft.com/office/drawing/2014/main" id="{FD159075-4E2C-4DEE-B383-4934598C92F4}"/>
              </a:ext>
            </a:extLst>
          </p:cNvPr>
          <p:cNvSpPr txBox="1">
            <a:spLocks noChangeArrowheads="1"/>
          </p:cNvSpPr>
          <p:nvPr/>
        </p:nvSpPr>
        <p:spPr bwMode="auto">
          <a:xfrm>
            <a:off x="5165765" y="4482032"/>
            <a:ext cx="1322717" cy="2903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n-US" altLang="en-US" sz="1299" dirty="0">
                <a:solidFill>
                  <a:srgbClr val="000000"/>
                </a:solidFill>
              </a:rPr>
              <a:t>Atp5a1 55kDa</a:t>
            </a:r>
          </a:p>
        </p:txBody>
      </p:sp>
      <p:grpSp>
        <p:nvGrpSpPr>
          <p:cNvPr id="21" name="Group 20">
            <a:extLst>
              <a:ext uri="{FF2B5EF4-FFF2-40B4-BE49-F238E27FC236}">
                <a16:creationId xmlns:a16="http://schemas.microsoft.com/office/drawing/2014/main" id="{31F01EBC-B456-4C25-AA4E-91596421D963}"/>
              </a:ext>
            </a:extLst>
          </p:cNvPr>
          <p:cNvGrpSpPr/>
          <p:nvPr/>
        </p:nvGrpSpPr>
        <p:grpSpPr>
          <a:xfrm>
            <a:off x="2542070" y="1064709"/>
            <a:ext cx="2966688" cy="2132996"/>
            <a:chOff x="3018059" y="75157"/>
            <a:chExt cx="2966688" cy="2132996"/>
          </a:xfrm>
        </p:grpSpPr>
        <p:sp>
          <p:nvSpPr>
            <p:cNvPr id="22" name="TextBox 21">
              <a:extLst>
                <a:ext uri="{FF2B5EF4-FFF2-40B4-BE49-F238E27FC236}">
                  <a16:creationId xmlns:a16="http://schemas.microsoft.com/office/drawing/2014/main" id="{D3FB8F25-D97C-4DD5-B3AF-84043943BB91}"/>
                </a:ext>
              </a:extLst>
            </p:cNvPr>
            <p:cNvSpPr txBox="1"/>
            <p:nvPr/>
          </p:nvSpPr>
          <p:spPr>
            <a:xfrm rot="18305062">
              <a:off x="2204581" y="1095196"/>
              <a:ext cx="1903956" cy="276999"/>
            </a:xfrm>
            <a:prstGeom prst="rect">
              <a:avLst/>
            </a:prstGeom>
            <a:noFill/>
          </p:spPr>
          <p:txBody>
            <a:bodyPr wrap="square" rtlCol="0">
              <a:spAutoFit/>
            </a:bodyPr>
            <a:lstStyle/>
            <a:p>
              <a:r>
                <a:rPr lang="en-US" sz="1200" dirty="0"/>
                <a:t>Protein Standard</a:t>
              </a:r>
              <a:endParaRPr lang="en-CA" sz="1200" dirty="0"/>
            </a:p>
          </p:txBody>
        </p:sp>
        <p:sp>
          <p:nvSpPr>
            <p:cNvPr id="23" name="TextBox 22">
              <a:extLst>
                <a:ext uri="{FF2B5EF4-FFF2-40B4-BE49-F238E27FC236}">
                  <a16:creationId xmlns:a16="http://schemas.microsoft.com/office/drawing/2014/main" id="{2D8BBF3B-382D-48AE-AC28-06ED4FDA7BD4}"/>
                </a:ext>
              </a:extLst>
            </p:cNvPr>
            <p:cNvSpPr txBox="1"/>
            <p:nvPr/>
          </p:nvSpPr>
          <p:spPr>
            <a:xfrm rot="18305062">
              <a:off x="2776260" y="1014845"/>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24" name="TextBox 23">
              <a:extLst>
                <a:ext uri="{FF2B5EF4-FFF2-40B4-BE49-F238E27FC236}">
                  <a16:creationId xmlns:a16="http://schemas.microsoft.com/office/drawing/2014/main" id="{ECD64F72-706F-4822-91AD-6BD23F88D524}"/>
                </a:ext>
              </a:extLst>
            </p:cNvPr>
            <p:cNvSpPr txBox="1"/>
            <p:nvPr/>
          </p:nvSpPr>
          <p:spPr>
            <a:xfrm rot="18305062">
              <a:off x="3448682" y="1012345"/>
              <a:ext cx="2105441" cy="276999"/>
            </a:xfrm>
            <a:prstGeom prst="rect">
              <a:avLst/>
            </a:prstGeom>
            <a:noFill/>
          </p:spPr>
          <p:txBody>
            <a:bodyPr wrap="square" rtlCol="0">
              <a:spAutoFit/>
            </a:bodyPr>
            <a:lstStyle/>
            <a:p>
              <a:r>
                <a:rPr lang="en-US" sz="1200" dirty="0"/>
                <a:t>Donor-1 + UQCRQ siRNA</a:t>
              </a:r>
              <a:endParaRPr lang="en-CA" sz="1200" dirty="0"/>
            </a:p>
          </p:txBody>
        </p:sp>
        <p:sp>
          <p:nvSpPr>
            <p:cNvPr id="25" name="TextBox 24">
              <a:extLst>
                <a:ext uri="{FF2B5EF4-FFF2-40B4-BE49-F238E27FC236}">
                  <a16:creationId xmlns:a16="http://schemas.microsoft.com/office/drawing/2014/main" id="{2983058E-FC1F-4DFD-A428-50273C1DFE99}"/>
                </a:ext>
              </a:extLst>
            </p:cNvPr>
            <p:cNvSpPr txBox="1"/>
            <p:nvPr/>
          </p:nvSpPr>
          <p:spPr>
            <a:xfrm rot="18305062">
              <a:off x="4121104" y="1016933"/>
              <a:ext cx="2105441" cy="276999"/>
            </a:xfrm>
            <a:prstGeom prst="rect">
              <a:avLst/>
            </a:prstGeom>
            <a:noFill/>
          </p:spPr>
          <p:txBody>
            <a:bodyPr wrap="square" rtlCol="0">
              <a:spAutoFit/>
            </a:bodyPr>
            <a:lstStyle/>
            <a:p>
              <a:r>
                <a:rPr lang="en-US" sz="1200" dirty="0"/>
                <a:t>Donor-2 + Non-target siRNA</a:t>
              </a:r>
              <a:endParaRPr lang="en-CA" sz="1200" dirty="0"/>
            </a:p>
          </p:txBody>
        </p:sp>
        <p:sp>
          <p:nvSpPr>
            <p:cNvPr id="26" name="TextBox 25">
              <a:extLst>
                <a:ext uri="{FF2B5EF4-FFF2-40B4-BE49-F238E27FC236}">
                  <a16:creationId xmlns:a16="http://schemas.microsoft.com/office/drawing/2014/main" id="{52374572-C219-4248-B0F4-C2E3FA75AD71}"/>
                </a:ext>
              </a:extLst>
            </p:cNvPr>
            <p:cNvSpPr txBox="1"/>
            <p:nvPr/>
          </p:nvSpPr>
          <p:spPr>
            <a:xfrm rot="18305062">
              <a:off x="4793527" y="989378"/>
              <a:ext cx="2105441" cy="276999"/>
            </a:xfrm>
            <a:prstGeom prst="rect">
              <a:avLst/>
            </a:prstGeom>
            <a:noFill/>
          </p:spPr>
          <p:txBody>
            <a:bodyPr wrap="square" rtlCol="0">
              <a:spAutoFit/>
            </a:bodyPr>
            <a:lstStyle/>
            <a:p>
              <a:r>
                <a:rPr lang="en-US" sz="1200" dirty="0"/>
                <a:t>Donor-2 + UQCRQ siRNA</a:t>
              </a:r>
              <a:endParaRPr lang="en-CA" sz="1200" dirty="0"/>
            </a:p>
          </p:txBody>
        </p:sp>
      </p:grpSp>
      <p:sp>
        <p:nvSpPr>
          <p:cNvPr id="27" name="TextBox 26">
            <a:extLst>
              <a:ext uri="{FF2B5EF4-FFF2-40B4-BE49-F238E27FC236}">
                <a16:creationId xmlns:a16="http://schemas.microsoft.com/office/drawing/2014/main" id="{EB0A639F-0D24-484F-B27A-3EC7B6AC4E80}"/>
              </a:ext>
            </a:extLst>
          </p:cNvPr>
          <p:cNvSpPr txBox="1"/>
          <p:nvPr/>
        </p:nvSpPr>
        <p:spPr>
          <a:xfrm>
            <a:off x="851769" y="8170379"/>
            <a:ext cx="6413326" cy="1015663"/>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CA"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12A - Full blots corresponding to Figure 6B Atp5a1 siRNA silencing.  </a:t>
            </a:r>
            <a:r>
              <a:rPr kumimoji="0" lang="en-CA"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VDF membranes was blotted with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mn-cs"/>
              </a:rPr>
              <a:t>anti-ATP5A1 polyclonal antibody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nd rabbit anti-β-actin (13E5) monoclonal antibody simultaneously. Since ATP5A1 bands were too bright compared to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bands, we exposed the membranes containing these bands separately for different durations to make them clear and visible as shown in Supplementary Figure 12B and Supplementary Figure 12C. </a:t>
            </a:r>
          </a:p>
        </p:txBody>
      </p:sp>
    </p:spTree>
    <p:extLst>
      <p:ext uri="{BB962C8B-B14F-4D97-AF65-F5344CB8AC3E}">
        <p14:creationId xmlns:p14="http://schemas.microsoft.com/office/powerpoint/2010/main" val="25814345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shape&#10;&#10;Description automatically generated">
            <a:extLst>
              <a:ext uri="{FF2B5EF4-FFF2-40B4-BE49-F238E27FC236}">
                <a16:creationId xmlns:a16="http://schemas.microsoft.com/office/drawing/2014/main" id="{DCB8BB63-5F3E-4A3A-ABDC-8B3E9454A1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41935" y="2188426"/>
            <a:ext cx="5634646" cy="5153822"/>
          </a:xfrm>
          <a:prstGeom prst="rect">
            <a:avLst/>
          </a:prstGeom>
        </p:spPr>
      </p:pic>
      <p:sp>
        <p:nvSpPr>
          <p:cNvPr id="5" name="TextBox 4">
            <a:extLst>
              <a:ext uri="{FF2B5EF4-FFF2-40B4-BE49-F238E27FC236}">
                <a16:creationId xmlns:a16="http://schemas.microsoft.com/office/drawing/2014/main" id="{51F68246-C516-47F5-B674-42AD1DD8D780}"/>
              </a:ext>
            </a:extLst>
          </p:cNvPr>
          <p:cNvSpPr txBox="1"/>
          <p:nvPr/>
        </p:nvSpPr>
        <p:spPr>
          <a:xfrm>
            <a:off x="826716" y="7644286"/>
            <a:ext cx="6563639" cy="1015663"/>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CA"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12B - Full blots corresponding to Figure 6B Atp5a1 siRNA silencing.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ince ATP5A1 bands were too bright compared to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we exposed for shorter duration to make the ATP5A1 bands clear and visible, but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bands became invisible. Short </a:t>
            </a:r>
            <a:r>
              <a:rPr lang="en-US" sz="1200" dirty="0">
                <a:solidFill>
                  <a:prstClr val="black"/>
                </a:solidFill>
                <a:latin typeface="Times New Roman" panose="02020603050405020304" pitchFamily="18" charset="0"/>
                <a:cs typeface="Times New Roman" panose="02020603050405020304" pitchFamily="18" charset="0"/>
              </a:rPr>
              <a:t>explosion also made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both the protein standard and background invisible. The rectangle depicts the approximative area used in the manuscript Fig. 6B for ATP5A1 bands.</a:t>
            </a:r>
          </a:p>
        </p:txBody>
      </p:sp>
      <p:sp>
        <p:nvSpPr>
          <p:cNvPr id="7" name="Rectangle 6">
            <a:extLst>
              <a:ext uri="{FF2B5EF4-FFF2-40B4-BE49-F238E27FC236}">
                <a16:creationId xmlns:a16="http://schemas.microsoft.com/office/drawing/2014/main" id="{0EDB539A-11AC-4A02-8DE6-71610AACB6B4}"/>
              </a:ext>
            </a:extLst>
          </p:cNvPr>
          <p:cNvSpPr/>
          <p:nvPr/>
        </p:nvSpPr>
        <p:spPr>
          <a:xfrm>
            <a:off x="3607495" y="3684737"/>
            <a:ext cx="1352811" cy="3507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C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nvGrpSpPr>
          <p:cNvPr id="8" name="Group 7">
            <a:extLst>
              <a:ext uri="{FF2B5EF4-FFF2-40B4-BE49-F238E27FC236}">
                <a16:creationId xmlns:a16="http://schemas.microsoft.com/office/drawing/2014/main" id="{DD8B3C93-AB03-4A53-A0E3-6E5872478A00}"/>
              </a:ext>
            </a:extLst>
          </p:cNvPr>
          <p:cNvGrpSpPr/>
          <p:nvPr/>
        </p:nvGrpSpPr>
        <p:grpSpPr>
          <a:xfrm>
            <a:off x="1127345" y="1916568"/>
            <a:ext cx="859890" cy="4428606"/>
            <a:chOff x="1365338" y="1803837"/>
            <a:chExt cx="859890" cy="4428606"/>
          </a:xfrm>
        </p:grpSpPr>
        <p:sp>
          <p:nvSpPr>
            <p:cNvPr id="9" name="TextBox 8">
              <a:extLst>
                <a:ext uri="{FF2B5EF4-FFF2-40B4-BE49-F238E27FC236}">
                  <a16:creationId xmlns:a16="http://schemas.microsoft.com/office/drawing/2014/main" id="{09FFAA76-1A56-4C65-81E2-0FC7F7FF227A}"/>
                </a:ext>
              </a:extLst>
            </p:cNvPr>
            <p:cNvSpPr txBox="1">
              <a:spLocks noChangeArrowheads="1"/>
            </p:cNvSpPr>
            <p:nvPr/>
          </p:nvSpPr>
          <p:spPr bwMode="auto">
            <a:xfrm>
              <a:off x="1503124" y="366806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50</a:t>
              </a:r>
            </a:p>
          </p:txBody>
        </p:sp>
        <p:sp>
          <p:nvSpPr>
            <p:cNvPr id="10" name="TextBox 9">
              <a:extLst>
                <a:ext uri="{FF2B5EF4-FFF2-40B4-BE49-F238E27FC236}">
                  <a16:creationId xmlns:a16="http://schemas.microsoft.com/office/drawing/2014/main" id="{7DF4302B-12F4-4B43-8537-2A9436D779C0}"/>
                </a:ext>
              </a:extLst>
            </p:cNvPr>
            <p:cNvSpPr txBox="1">
              <a:spLocks noChangeArrowheads="1"/>
            </p:cNvSpPr>
            <p:nvPr/>
          </p:nvSpPr>
          <p:spPr bwMode="auto">
            <a:xfrm>
              <a:off x="1503123" y="407466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37</a:t>
              </a:r>
            </a:p>
          </p:txBody>
        </p:sp>
        <p:sp>
          <p:nvSpPr>
            <p:cNvPr id="11" name="TextBox 7">
              <a:extLst>
                <a:ext uri="{FF2B5EF4-FFF2-40B4-BE49-F238E27FC236}">
                  <a16:creationId xmlns:a16="http://schemas.microsoft.com/office/drawing/2014/main" id="{E350659E-4B99-47FE-872C-2C32701834D6}"/>
                </a:ext>
              </a:extLst>
            </p:cNvPr>
            <p:cNvSpPr txBox="1">
              <a:spLocks noChangeArrowheads="1"/>
            </p:cNvSpPr>
            <p:nvPr/>
          </p:nvSpPr>
          <p:spPr bwMode="auto">
            <a:xfrm>
              <a:off x="1490598" y="474603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25</a:t>
              </a:r>
            </a:p>
          </p:txBody>
        </p:sp>
        <p:sp>
          <p:nvSpPr>
            <p:cNvPr id="12" name="TextBox 4">
              <a:extLst>
                <a:ext uri="{FF2B5EF4-FFF2-40B4-BE49-F238E27FC236}">
                  <a16:creationId xmlns:a16="http://schemas.microsoft.com/office/drawing/2014/main" id="{56EDF024-E04C-4A9F-A1CE-0D52D7CF63D6}"/>
                </a:ext>
              </a:extLst>
            </p:cNvPr>
            <p:cNvSpPr txBox="1">
              <a:spLocks noChangeArrowheads="1"/>
            </p:cNvSpPr>
            <p:nvPr/>
          </p:nvSpPr>
          <p:spPr bwMode="auto">
            <a:xfrm>
              <a:off x="1453021" y="3229713"/>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75</a:t>
              </a:r>
            </a:p>
          </p:txBody>
        </p:sp>
        <p:sp>
          <p:nvSpPr>
            <p:cNvPr id="13" name="TextBox 4">
              <a:extLst>
                <a:ext uri="{FF2B5EF4-FFF2-40B4-BE49-F238E27FC236}">
                  <a16:creationId xmlns:a16="http://schemas.microsoft.com/office/drawing/2014/main" id="{B409C642-BCC4-4D73-B8FF-332965D5055A}"/>
                </a:ext>
              </a:extLst>
            </p:cNvPr>
            <p:cNvSpPr txBox="1">
              <a:spLocks noChangeArrowheads="1"/>
            </p:cNvSpPr>
            <p:nvPr/>
          </p:nvSpPr>
          <p:spPr bwMode="auto">
            <a:xfrm>
              <a:off x="1365338" y="2780865"/>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150</a:t>
              </a:r>
            </a:p>
          </p:txBody>
        </p:sp>
        <p:sp>
          <p:nvSpPr>
            <p:cNvPr id="14" name="TextBox 4">
              <a:extLst>
                <a:ext uri="{FF2B5EF4-FFF2-40B4-BE49-F238E27FC236}">
                  <a16:creationId xmlns:a16="http://schemas.microsoft.com/office/drawing/2014/main" id="{1606C358-A850-49B6-9B3A-AAED2E3B8ADF}"/>
                </a:ext>
              </a:extLst>
            </p:cNvPr>
            <p:cNvSpPr txBox="1">
              <a:spLocks noChangeArrowheads="1"/>
            </p:cNvSpPr>
            <p:nvPr/>
          </p:nvSpPr>
          <p:spPr bwMode="auto">
            <a:xfrm>
              <a:off x="1365338" y="299589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100</a:t>
              </a:r>
            </a:p>
          </p:txBody>
        </p:sp>
        <p:sp>
          <p:nvSpPr>
            <p:cNvPr id="15" name="TextBox 4">
              <a:extLst>
                <a:ext uri="{FF2B5EF4-FFF2-40B4-BE49-F238E27FC236}">
                  <a16:creationId xmlns:a16="http://schemas.microsoft.com/office/drawing/2014/main" id="{65B994BD-C10B-40E2-BD9E-B06EE820C515}"/>
                </a:ext>
              </a:extLst>
            </p:cNvPr>
            <p:cNvSpPr txBox="1">
              <a:spLocks noChangeArrowheads="1"/>
            </p:cNvSpPr>
            <p:nvPr/>
          </p:nvSpPr>
          <p:spPr bwMode="auto">
            <a:xfrm>
              <a:off x="1392478" y="1803837"/>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t>kDa</a:t>
              </a:r>
              <a:endParaRPr lang="en-US" altLang="en-US" sz="1299" dirty="0"/>
            </a:p>
          </p:txBody>
        </p:sp>
        <p:sp>
          <p:nvSpPr>
            <p:cNvPr id="16" name="TextBox 7">
              <a:extLst>
                <a:ext uri="{FF2B5EF4-FFF2-40B4-BE49-F238E27FC236}">
                  <a16:creationId xmlns:a16="http://schemas.microsoft.com/office/drawing/2014/main" id="{936C2E64-2053-4B21-BC38-FFCB5ADB5EF3}"/>
                </a:ext>
              </a:extLst>
            </p:cNvPr>
            <p:cNvSpPr txBox="1">
              <a:spLocks noChangeArrowheads="1"/>
            </p:cNvSpPr>
            <p:nvPr/>
          </p:nvSpPr>
          <p:spPr bwMode="auto">
            <a:xfrm>
              <a:off x="1480159" y="566252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15</a:t>
              </a:r>
            </a:p>
          </p:txBody>
        </p:sp>
        <p:sp>
          <p:nvSpPr>
            <p:cNvPr id="17" name="TextBox 7">
              <a:extLst>
                <a:ext uri="{FF2B5EF4-FFF2-40B4-BE49-F238E27FC236}">
                  <a16:creationId xmlns:a16="http://schemas.microsoft.com/office/drawing/2014/main" id="{8A49C004-CDFD-481D-917A-FBCEBB4DFA7A}"/>
                </a:ext>
              </a:extLst>
            </p:cNvPr>
            <p:cNvSpPr txBox="1">
              <a:spLocks noChangeArrowheads="1"/>
            </p:cNvSpPr>
            <p:nvPr/>
          </p:nvSpPr>
          <p:spPr bwMode="auto">
            <a:xfrm>
              <a:off x="1480159" y="511137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20</a:t>
              </a:r>
            </a:p>
          </p:txBody>
        </p:sp>
        <p:sp>
          <p:nvSpPr>
            <p:cNvPr id="18" name="TextBox 7">
              <a:extLst>
                <a:ext uri="{FF2B5EF4-FFF2-40B4-BE49-F238E27FC236}">
                  <a16:creationId xmlns:a16="http://schemas.microsoft.com/office/drawing/2014/main" id="{D316CA78-A921-447B-A3A5-BE8068AFEB28}"/>
                </a:ext>
              </a:extLst>
            </p:cNvPr>
            <p:cNvSpPr txBox="1">
              <a:spLocks noChangeArrowheads="1"/>
            </p:cNvSpPr>
            <p:nvPr/>
          </p:nvSpPr>
          <p:spPr bwMode="auto">
            <a:xfrm>
              <a:off x="1482248" y="594018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t>10</a:t>
              </a:r>
            </a:p>
          </p:txBody>
        </p:sp>
      </p:grpSp>
      <p:sp>
        <p:nvSpPr>
          <p:cNvPr id="19" name="TextBox 13">
            <a:extLst>
              <a:ext uri="{FF2B5EF4-FFF2-40B4-BE49-F238E27FC236}">
                <a16:creationId xmlns:a16="http://schemas.microsoft.com/office/drawing/2014/main" id="{98D566AF-EBCA-49F4-AF8A-728CB46E1A08}"/>
              </a:ext>
            </a:extLst>
          </p:cNvPr>
          <p:cNvSpPr txBox="1">
            <a:spLocks noChangeArrowheads="1"/>
          </p:cNvSpPr>
          <p:nvPr/>
        </p:nvSpPr>
        <p:spPr bwMode="auto">
          <a:xfrm>
            <a:off x="4934879" y="4050071"/>
            <a:ext cx="1290557"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l-GR" altLang="en-US" sz="1299" dirty="0">
                <a:solidFill>
                  <a:srgbClr val="000000"/>
                </a:solidFill>
              </a:rPr>
              <a:t>β</a:t>
            </a:r>
            <a:r>
              <a:rPr lang="en-US" altLang="en-US" sz="1299" dirty="0">
                <a:solidFill>
                  <a:srgbClr val="000000"/>
                </a:solidFill>
              </a:rPr>
              <a:t>-actin 42kDa</a:t>
            </a:r>
          </a:p>
        </p:txBody>
      </p:sp>
      <p:sp>
        <p:nvSpPr>
          <p:cNvPr id="20" name="TextBox 14">
            <a:extLst>
              <a:ext uri="{FF2B5EF4-FFF2-40B4-BE49-F238E27FC236}">
                <a16:creationId xmlns:a16="http://schemas.microsoft.com/office/drawing/2014/main" id="{F22B9B40-E3F5-411A-933B-BB38CB8368FB}"/>
              </a:ext>
            </a:extLst>
          </p:cNvPr>
          <p:cNvSpPr txBox="1">
            <a:spLocks noChangeArrowheads="1"/>
          </p:cNvSpPr>
          <p:nvPr/>
        </p:nvSpPr>
        <p:spPr bwMode="auto">
          <a:xfrm>
            <a:off x="4952823" y="3730470"/>
            <a:ext cx="1322717" cy="2903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n-US" altLang="en-US" sz="1299" dirty="0">
                <a:solidFill>
                  <a:srgbClr val="000000"/>
                </a:solidFill>
              </a:rPr>
              <a:t>Atp5a1 55kDa</a:t>
            </a:r>
          </a:p>
        </p:txBody>
      </p:sp>
      <p:grpSp>
        <p:nvGrpSpPr>
          <p:cNvPr id="21" name="Group 20">
            <a:extLst>
              <a:ext uri="{FF2B5EF4-FFF2-40B4-BE49-F238E27FC236}">
                <a16:creationId xmlns:a16="http://schemas.microsoft.com/office/drawing/2014/main" id="{DA679B68-CA27-459A-BB05-12C681EDEBBF}"/>
              </a:ext>
            </a:extLst>
          </p:cNvPr>
          <p:cNvGrpSpPr/>
          <p:nvPr/>
        </p:nvGrpSpPr>
        <p:grpSpPr>
          <a:xfrm>
            <a:off x="2291550" y="237991"/>
            <a:ext cx="2966688" cy="2132996"/>
            <a:chOff x="3018059" y="75157"/>
            <a:chExt cx="2966688" cy="2132996"/>
          </a:xfrm>
        </p:grpSpPr>
        <p:sp>
          <p:nvSpPr>
            <p:cNvPr id="22" name="TextBox 21">
              <a:extLst>
                <a:ext uri="{FF2B5EF4-FFF2-40B4-BE49-F238E27FC236}">
                  <a16:creationId xmlns:a16="http://schemas.microsoft.com/office/drawing/2014/main" id="{1424F1D2-EF15-4F00-A0E7-5D8B4B9BB905}"/>
                </a:ext>
              </a:extLst>
            </p:cNvPr>
            <p:cNvSpPr txBox="1"/>
            <p:nvPr/>
          </p:nvSpPr>
          <p:spPr>
            <a:xfrm rot="18305062">
              <a:off x="2204581" y="1095196"/>
              <a:ext cx="1903956" cy="276999"/>
            </a:xfrm>
            <a:prstGeom prst="rect">
              <a:avLst/>
            </a:prstGeom>
            <a:noFill/>
          </p:spPr>
          <p:txBody>
            <a:bodyPr wrap="square" rtlCol="0">
              <a:spAutoFit/>
            </a:bodyPr>
            <a:lstStyle/>
            <a:p>
              <a:r>
                <a:rPr lang="en-US" sz="1200" dirty="0"/>
                <a:t>Protein Standard</a:t>
              </a:r>
              <a:endParaRPr lang="en-CA" sz="1200" dirty="0"/>
            </a:p>
          </p:txBody>
        </p:sp>
        <p:sp>
          <p:nvSpPr>
            <p:cNvPr id="23" name="TextBox 22">
              <a:extLst>
                <a:ext uri="{FF2B5EF4-FFF2-40B4-BE49-F238E27FC236}">
                  <a16:creationId xmlns:a16="http://schemas.microsoft.com/office/drawing/2014/main" id="{F8E1435E-A1CF-4C19-8220-D083730DDB1E}"/>
                </a:ext>
              </a:extLst>
            </p:cNvPr>
            <p:cNvSpPr txBox="1"/>
            <p:nvPr/>
          </p:nvSpPr>
          <p:spPr>
            <a:xfrm rot="18305062">
              <a:off x="2776260" y="1014845"/>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24" name="TextBox 23">
              <a:extLst>
                <a:ext uri="{FF2B5EF4-FFF2-40B4-BE49-F238E27FC236}">
                  <a16:creationId xmlns:a16="http://schemas.microsoft.com/office/drawing/2014/main" id="{54A8F275-C135-4E75-AEA6-420CBDBD5A43}"/>
                </a:ext>
              </a:extLst>
            </p:cNvPr>
            <p:cNvSpPr txBox="1"/>
            <p:nvPr/>
          </p:nvSpPr>
          <p:spPr>
            <a:xfrm rot="18305062">
              <a:off x="3448682" y="1012345"/>
              <a:ext cx="2105441" cy="276999"/>
            </a:xfrm>
            <a:prstGeom prst="rect">
              <a:avLst/>
            </a:prstGeom>
            <a:noFill/>
          </p:spPr>
          <p:txBody>
            <a:bodyPr wrap="square" rtlCol="0">
              <a:spAutoFit/>
            </a:bodyPr>
            <a:lstStyle/>
            <a:p>
              <a:r>
                <a:rPr lang="en-US" sz="1200" dirty="0"/>
                <a:t>Donor-1 + UQCRQ siRNA</a:t>
              </a:r>
              <a:endParaRPr lang="en-CA" sz="1200" dirty="0"/>
            </a:p>
          </p:txBody>
        </p:sp>
        <p:sp>
          <p:nvSpPr>
            <p:cNvPr id="25" name="TextBox 24">
              <a:extLst>
                <a:ext uri="{FF2B5EF4-FFF2-40B4-BE49-F238E27FC236}">
                  <a16:creationId xmlns:a16="http://schemas.microsoft.com/office/drawing/2014/main" id="{111E9012-7102-4E95-BB47-6245817020AA}"/>
                </a:ext>
              </a:extLst>
            </p:cNvPr>
            <p:cNvSpPr txBox="1"/>
            <p:nvPr/>
          </p:nvSpPr>
          <p:spPr>
            <a:xfrm rot="18305062">
              <a:off x="4121104" y="1016933"/>
              <a:ext cx="2105441" cy="276999"/>
            </a:xfrm>
            <a:prstGeom prst="rect">
              <a:avLst/>
            </a:prstGeom>
            <a:noFill/>
          </p:spPr>
          <p:txBody>
            <a:bodyPr wrap="square" rtlCol="0">
              <a:spAutoFit/>
            </a:bodyPr>
            <a:lstStyle/>
            <a:p>
              <a:r>
                <a:rPr lang="en-US" sz="1200" dirty="0"/>
                <a:t>Donor-2 + Non-target siRNA</a:t>
              </a:r>
              <a:endParaRPr lang="en-CA" sz="1200" dirty="0"/>
            </a:p>
          </p:txBody>
        </p:sp>
        <p:sp>
          <p:nvSpPr>
            <p:cNvPr id="26" name="TextBox 25">
              <a:extLst>
                <a:ext uri="{FF2B5EF4-FFF2-40B4-BE49-F238E27FC236}">
                  <a16:creationId xmlns:a16="http://schemas.microsoft.com/office/drawing/2014/main" id="{AA4E7DD3-FF76-42E3-915F-3FA116EEE8D5}"/>
                </a:ext>
              </a:extLst>
            </p:cNvPr>
            <p:cNvSpPr txBox="1"/>
            <p:nvPr/>
          </p:nvSpPr>
          <p:spPr>
            <a:xfrm rot="18305062">
              <a:off x="4793527" y="989378"/>
              <a:ext cx="2105441" cy="276999"/>
            </a:xfrm>
            <a:prstGeom prst="rect">
              <a:avLst/>
            </a:prstGeom>
            <a:noFill/>
          </p:spPr>
          <p:txBody>
            <a:bodyPr wrap="square" rtlCol="0">
              <a:spAutoFit/>
            </a:bodyPr>
            <a:lstStyle/>
            <a:p>
              <a:r>
                <a:rPr lang="en-US" sz="1200" dirty="0"/>
                <a:t>Donor-2 + UQCRQ siRNA</a:t>
              </a:r>
              <a:endParaRPr lang="en-CA" sz="1200" dirty="0"/>
            </a:p>
          </p:txBody>
        </p:sp>
      </p:grpSp>
    </p:spTree>
    <p:extLst>
      <p:ext uri="{BB962C8B-B14F-4D97-AF65-F5344CB8AC3E}">
        <p14:creationId xmlns:p14="http://schemas.microsoft.com/office/powerpoint/2010/main" val="263237876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computer screen&#10;&#10;Description automatically generated with low confidence">
            <a:extLst>
              <a:ext uri="{FF2B5EF4-FFF2-40B4-BE49-F238E27FC236}">
                <a16:creationId xmlns:a16="http://schemas.microsoft.com/office/drawing/2014/main" id="{C4EB1C16-740E-4252-AF31-500F3366A6A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16882" y="2688477"/>
            <a:ext cx="5647172" cy="5089984"/>
          </a:xfrm>
          <a:prstGeom prst="rect">
            <a:avLst/>
          </a:prstGeom>
        </p:spPr>
      </p:pic>
      <p:sp>
        <p:nvSpPr>
          <p:cNvPr id="8" name="TextBox 7">
            <a:extLst>
              <a:ext uri="{FF2B5EF4-FFF2-40B4-BE49-F238E27FC236}">
                <a16:creationId xmlns:a16="http://schemas.microsoft.com/office/drawing/2014/main" id="{BA336ADC-DE94-41A0-8DFA-7FA91808680B}"/>
              </a:ext>
            </a:extLst>
          </p:cNvPr>
          <p:cNvSpPr txBox="1"/>
          <p:nvPr/>
        </p:nvSpPr>
        <p:spPr>
          <a:xfrm>
            <a:off x="826717" y="7957436"/>
            <a:ext cx="6413326" cy="830997"/>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CA"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12C - Full blots corresponding to Figure 6B Atp5a1 siRNA silencing.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ince ATP5A1 bands were too bright compared to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we exposed longer duration to make the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bands clear and visible. The rectangle depicts the approximative area used in the manuscript Fig. 6B for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n bands.</a:t>
            </a:r>
          </a:p>
        </p:txBody>
      </p:sp>
      <p:sp>
        <p:nvSpPr>
          <p:cNvPr id="9" name="Rectangle 8">
            <a:extLst>
              <a:ext uri="{FF2B5EF4-FFF2-40B4-BE49-F238E27FC236}">
                <a16:creationId xmlns:a16="http://schemas.microsoft.com/office/drawing/2014/main" id="{677E2BB0-F612-4BF5-8715-65763F6C04AB}"/>
              </a:ext>
            </a:extLst>
          </p:cNvPr>
          <p:cNvSpPr/>
          <p:nvPr/>
        </p:nvSpPr>
        <p:spPr>
          <a:xfrm>
            <a:off x="3858016" y="4473877"/>
            <a:ext cx="1352811" cy="3507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C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nvGrpSpPr>
          <p:cNvPr id="10" name="Group 9">
            <a:extLst>
              <a:ext uri="{FF2B5EF4-FFF2-40B4-BE49-F238E27FC236}">
                <a16:creationId xmlns:a16="http://schemas.microsoft.com/office/drawing/2014/main" id="{BB4E658C-59FF-4331-A44A-E2E4C846B615}"/>
              </a:ext>
            </a:extLst>
          </p:cNvPr>
          <p:cNvGrpSpPr/>
          <p:nvPr/>
        </p:nvGrpSpPr>
        <p:grpSpPr>
          <a:xfrm>
            <a:off x="2517018" y="739032"/>
            <a:ext cx="2966688" cy="2132996"/>
            <a:chOff x="3018059" y="75157"/>
            <a:chExt cx="2966688" cy="2132996"/>
          </a:xfrm>
        </p:grpSpPr>
        <p:sp>
          <p:nvSpPr>
            <p:cNvPr id="11" name="TextBox 10">
              <a:extLst>
                <a:ext uri="{FF2B5EF4-FFF2-40B4-BE49-F238E27FC236}">
                  <a16:creationId xmlns:a16="http://schemas.microsoft.com/office/drawing/2014/main" id="{7E286101-6712-4B3B-9E95-F9913F7984A1}"/>
                </a:ext>
              </a:extLst>
            </p:cNvPr>
            <p:cNvSpPr txBox="1"/>
            <p:nvPr/>
          </p:nvSpPr>
          <p:spPr>
            <a:xfrm rot="18305062">
              <a:off x="2204581" y="1095196"/>
              <a:ext cx="1903956" cy="276999"/>
            </a:xfrm>
            <a:prstGeom prst="rect">
              <a:avLst/>
            </a:prstGeom>
            <a:noFill/>
          </p:spPr>
          <p:txBody>
            <a:bodyPr wrap="square" rtlCol="0">
              <a:spAutoFit/>
            </a:bodyPr>
            <a:lstStyle/>
            <a:p>
              <a:r>
                <a:rPr lang="en-US" sz="1200" dirty="0"/>
                <a:t>Protein Standard</a:t>
              </a:r>
              <a:endParaRPr lang="en-CA" sz="1200" dirty="0"/>
            </a:p>
          </p:txBody>
        </p:sp>
        <p:sp>
          <p:nvSpPr>
            <p:cNvPr id="12" name="TextBox 11">
              <a:extLst>
                <a:ext uri="{FF2B5EF4-FFF2-40B4-BE49-F238E27FC236}">
                  <a16:creationId xmlns:a16="http://schemas.microsoft.com/office/drawing/2014/main" id="{91842274-16ED-4FF2-86DC-2F56EF39AB7D}"/>
                </a:ext>
              </a:extLst>
            </p:cNvPr>
            <p:cNvSpPr txBox="1"/>
            <p:nvPr/>
          </p:nvSpPr>
          <p:spPr>
            <a:xfrm rot="18305062">
              <a:off x="2776260" y="1014845"/>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13" name="TextBox 12">
              <a:extLst>
                <a:ext uri="{FF2B5EF4-FFF2-40B4-BE49-F238E27FC236}">
                  <a16:creationId xmlns:a16="http://schemas.microsoft.com/office/drawing/2014/main" id="{CB05D86C-513B-4DC7-B1C3-A28E719DEBB4}"/>
                </a:ext>
              </a:extLst>
            </p:cNvPr>
            <p:cNvSpPr txBox="1"/>
            <p:nvPr/>
          </p:nvSpPr>
          <p:spPr>
            <a:xfrm rot="18305062">
              <a:off x="3448682" y="1012345"/>
              <a:ext cx="2105441" cy="276999"/>
            </a:xfrm>
            <a:prstGeom prst="rect">
              <a:avLst/>
            </a:prstGeom>
            <a:noFill/>
          </p:spPr>
          <p:txBody>
            <a:bodyPr wrap="square" rtlCol="0">
              <a:spAutoFit/>
            </a:bodyPr>
            <a:lstStyle/>
            <a:p>
              <a:r>
                <a:rPr lang="en-US" sz="1200" dirty="0"/>
                <a:t>Donor-1 + UQCRQ siRNA</a:t>
              </a:r>
              <a:endParaRPr lang="en-CA" sz="1200" dirty="0"/>
            </a:p>
          </p:txBody>
        </p:sp>
        <p:sp>
          <p:nvSpPr>
            <p:cNvPr id="14" name="TextBox 13">
              <a:extLst>
                <a:ext uri="{FF2B5EF4-FFF2-40B4-BE49-F238E27FC236}">
                  <a16:creationId xmlns:a16="http://schemas.microsoft.com/office/drawing/2014/main" id="{2EB4F3EB-1245-461F-B84D-C8C6D0EA7FA9}"/>
                </a:ext>
              </a:extLst>
            </p:cNvPr>
            <p:cNvSpPr txBox="1"/>
            <p:nvPr/>
          </p:nvSpPr>
          <p:spPr>
            <a:xfrm rot="18305062">
              <a:off x="4121104" y="1016933"/>
              <a:ext cx="2105441" cy="276999"/>
            </a:xfrm>
            <a:prstGeom prst="rect">
              <a:avLst/>
            </a:prstGeom>
            <a:noFill/>
          </p:spPr>
          <p:txBody>
            <a:bodyPr wrap="square" rtlCol="0">
              <a:spAutoFit/>
            </a:bodyPr>
            <a:lstStyle/>
            <a:p>
              <a:r>
                <a:rPr lang="en-US" sz="1200" dirty="0"/>
                <a:t>Donor-2 + Non-target siRNA</a:t>
              </a:r>
              <a:endParaRPr lang="en-CA" sz="1200" dirty="0"/>
            </a:p>
          </p:txBody>
        </p:sp>
        <p:sp>
          <p:nvSpPr>
            <p:cNvPr id="15" name="TextBox 14">
              <a:extLst>
                <a:ext uri="{FF2B5EF4-FFF2-40B4-BE49-F238E27FC236}">
                  <a16:creationId xmlns:a16="http://schemas.microsoft.com/office/drawing/2014/main" id="{5D473B39-7795-447E-AA24-F0BB3BECAB2B}"/>
                </a:ext>
              </a:extLst>
            </p:cNvPr>
            <p:cNvSpPr txBox="1"/>
            <p:nvPr/>
          </p:nvSpPr>
          <p:spPr>
            <a:xfrm rot="18305062">
              <a:off x="4793527" y="989378"/>
              <a:ext cx="2105441" cy="276999"/>
            </a:xfrm>
            <a:prstGeom prst="rect">
              <a:avLst/>
            </a:prstGeom>
            <a:noFill/>
          </p:spPr>
          <p:txBody>
            <a:bodyPr wrap="square" rtlCol="0">
              <a:spAutoFit/>
            </a:bodyPr>
            <a:lstStyle/>
            <a:p>
              <a:r>
                <a:rPr lang="en-US" sz="1200" dirty="0"/>
                <a:t>Donor-2 + UQCRQ siRNA</a:t>
              </a:r>
              <a:endParaRPr lang="en-CA" sz="1200" dirty="0"/>
            </a:p>
          </p:txBody>
        </p:sp>
      </p:grpSp>
      <p:grpSp>
        <p:nvGrpSpPr>
          <p:cNvPr id="16" name="Group 15">
            <a:extLst>
              <a:ext uri="{FF2B5EF4-FFF2-40B4-BE49-F238E27FC236}">
                <a16:creationId xmlns:a16="http://schemas.microsoft.com/office/drawing/2014/main" id="{73AC21B2-E25B-45D0-B7E2-66E95EE6E54D}"/>
              </a:ext>
            </a:extLst>
          </p:cNvPr>
          <p:cNvGrpSpPr/>
          <p:nvPr/>
        </p:nvGrpSpPr>
        <p:grpSpPr>
          <a:xfrm>
            <a:off x="1164923" y="2442661"/>
            <a:ext cx="859890" cy="4428606"/>
            <a:chOff x="1365338" y="1803837"/>
            <a:chExt cx="859890" cy="4428606"/>
          </a:xfrm>
        </p:grpSpPr>
        <p:sp>
          <p:nvSpPr>
            <p:cNvPr id="17" name="TextBox 16">
              <a:extLst>
                <a:ext uri="{FF2B5EF4-FFF2-40B4-BE49-F238E27FC236}">
                  <a16:creationId xmlns:a16="http://schemas.microsoft.com/office/drawing/2014/main" id="{09D7BC16-064E-4200-B88D-BA88E8389E96}"/>
                </a:ext>
              </a:extLst>
            </p:cNvPr>
            <p:cNvSpPr txBox="1">
              <a:spLocks noChangeArrowheads="1"/>
            </p:cNvSpPr>
            <p:nvPr/>
          </p:nvSpPr>
          <p:spPr bwMode="auto">
            <a:xfrm>
              <a:off x="1503124" y="364501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50</a:t>
              </a:r>
            </a:p>
          </p:txBody>
        </p:sp>
        <p:sp>
          <p:nvSpPr>
            <p:cNvPr id="18" name="TextBox 17">
              <a:extLst>
                <a:ext uri="{FF2B5EF4-FFF2-40B4-BE49-F238E27FC236}">
                  <a16:creationId xmlns:a16="http://schemas.microsoft.com/office/drawing/2014/main" id="{1DFBF0DC-60E5-4EA0-8873-84C563DA9715}"/>
                </a:ext>
              </a:extLst>
            </p:cNvPr>
            <p:cNvSpPr txBox="1">
              <a:spLocks noChangeArrowheads="1"/>
            </p:cNvSpPr>
            <p:nvPr/>
          </p:nvSpPr>
          <p:spPr bwMode="auto">
            <a:xfrm>
              <a:off x="1503123" y="405161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37</a:t>
              </a:r>
            </a:p>
          </p:txBody>
        </p:sp>
        <p:sp>
          <p:nvSpPr>
            <p:cNvPr id="19" name="TextBox 7">
              <a:extLst>
                <a:ext uri="{FF2B5EF4-FFF2-40B4-BE49-F238E27FC236}">
                  <a16:creationId xmlns:a16="http://schemas.microsoft.com/office/drawing/2014/main" id="{7DC21CF7-99D5-461E-A429-C703D7365CB7}"/>
                </a:ext>
              </a:extLst>
            </p:cNvPr>
            <p:cNvSpPr txBox="1">
              <a:spLocks noChangeArrowheads="1"/>
            </p:cNvSpPr>
            <p:nvPr/>
          </p:nvSpPr>
          <p:spPr bwMode="auto">
            <a:xfrm>
              <a:off x="1490598" y="474603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5</a:t>
              </a:r>
            </a:p>
          </p:txBody>
        </p:sp>
        <p:sp>
          <p:nvSpPr>
            <p:cNvPr id="20" name="TextBox 4">
              <a:extLst>
                <a:ext uri="{FF2B5EF4-FFF2-40B4-BE49-F238E27FC236}">
                  <a16:creationId xmlns:a16="http://schemas.microsoft.com/office/drawing/2014/main" id="{D0C03511-42EA-4F23-9511-9ABC2C0D2648}"/>
                </a:ext>
              </a:extLst>
            </p:cNvPr>
            <p:cNvSpPr txBox="1">
              <a:spLocks noChangeArrowheads="1"/>
            </p:cNvSpPr>
            <p:nvPr/>
          </p:nvSpPr>
          <p:spPr bwMode="auto">
            <a:xfrm>
              <a:off x="1453021" y="3229713"/>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75</a:t>
              </a:r>
            </a:p>
          </p:txBody>
        </p:sp>
        <p:sp>
          <p:nvSpPr>
            <p:cNvPr id="21" name="TextBox 4">
              <a:extLst>
                <a:ext uri="{FF2B5EF4-FFF2-40B4-BE49-F238E27FC236}">
                  <a16:creationId xmlns:a16="http://schemas.microsoft.com/office/drawing/2014/main" id="{8625F5CC-5E5A-419A-8D23-8BB5BA26DA77}"/>
                </a:ext>
              </a:extLst>
            </p:cNvPr>
            <p:cNvSpPr txBox="1">
              <a:spLocks noChangeArrowheads="1"/>
            </p:cNvSpPr>
            <p:nvPr/>
          </p:nvSpPr>
          <p:spPr bwMode="auto">
            <a:xfrm>
              <a:off x="1365338" y="2780865"/>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0</a:t>
              </a:r>
            </a:p>
          </p:txBody>
        </p:sp>
        <p:sp>
          <p:nvSpPr>
            <p:cNvPr id="22" name="TextBox 4">
              <a:extLst>
                <a:ext uri="{FF2B5EF4-FFF2-40B4-BE49-F238E27FC236}">
                  <a16:creationId xmlns:a16="http://schemas.microsoft.com/office/drawing/2014/main" id="{98E99B90-967A-44E4-9F4B-5449BCB07299}"/>
                </a:ext>
              </a:extLst>
            </p:cNvPr>
            <p:cNvSpPr txBox="1">
              <a:spLocks noChangeArrowheads="1"/>
            </p:cNvSpPr>
            <p:nvPr/>
          </p:nvSpPr>
          <p:spPr bwMode="auto">
            <a:xfrm>
              <a:off x="1365338" y="299589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0</a:t>
              </a:r>
            </a:p>
          </p:txBody>
        </p:sp>
        <p:sp>
          <p:nvSpPr>
            <p:cNvPr id="23" name="TextBox 4">
              <a:extLst>
                <a:ext uri="{FF2B5EF4-FFF2-40B4-BE49-F238E27FC236}">
                  <a16:creationId xmlns:a16="http://schemas.microsoft.com/office/drawing/2014/main" id="{773289DC-A496-44B7-8110-79EC7634F485}"/>
                </a:ext>
              </a:extLst>
            </p:cNvPr>
            <p:cNvSpPr txBox="1">
              <a:spLocks noChangeArrowheads="1"/>
            </p:cNvSpPr>
            <p:nvPr/>
          </p:nvSpPr>
          <p:spPr bwMode="auto">
            <a:xfrm>
              <a:off x="1392478" y="1803837"/>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t>kDa</a:t>
              </a:r>
              <a:endParaRPr lang="en-US" altLang="en-US" sz="1299" dirty="0"/>
            </a:p>
          </p:txBody>
        </p:sp>
        <p:sp>
          <p:nvSpPr>
            <p:cNvPr id="24" name="TextBox 7">
              <a:extLst>
                <a:ext uri="{FF2B5EF4-FFF2-40B4-BE49-F238E27FC236}">
                  <a16:creationId xmlns:a16="http://schemas.microsoft.com/office/drawing/2014/main" id="{4DCF7213-8B7B-4E23-B796-510AE03C5B80}"/>
                </a:ext>
              </a:extLst>
            </p:cNvPr>
            <p:cNvSpPr txBox="1">
              <a:spLocks noChangeArrowheads="1"/>
            </p:cNvSpPr>
            <p:nvPr/>
          </p:nvSpPr>
          <p:spPr bwMode="auto">
            <a:xfrm>
              <a:off x="1480159" y="566252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a:t>
              </a:r>
            </a:p>
          </p:txBody>
        </p:sp>
        <p:sp>
          <p:nvSpPr>
            <p:cNvPr id="25" name="TextBox 7">
              <a:extLst>
                <a:ext uri="{FF2B5EF4-FFF2-40B4-BE49-F238E27FC236}">
                  <a16:creationId xmlns:a16="http://schemas.microsoft.com/office/drawing/2014/main" id="{80301F91-93F3-423C-8AE3-E2AA859628AC}"/>
                </a:ext>
              </a:extLst>
            </p:cNvPr>
            <p:cNvSpPr txBox="1">
              <a:spLocks noChangeArrowheads="1"/>
            </p:cNvSpPr>
            <p:nvPr/>
          </p:nvSpPr>
          <p:spPr bwMode="auto">
            <a:xfrm>
              <a:off x="1480159" y="511137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0</a:t>
              </a:r>
            </a:p>
          </p:txBody>
        </p:sp>
        <p:sp>
          <p:nvSpPr>
            <p:cNvPr id="26" name="TextBox 7">
              <a:extLst>
                <a:ext uri="{FF2B5EF4-FFF2-40B4-BE49-F238E27FC236}">
                  <a16:creationId xmlns:a16="http://schemas.microsoft.com/office/drawing/2014/main" id="{6EFE6E0B-5C49-49BE-8BE0-BE6169EEF14C}"/>
                </a:ext>
              </a:extLst>
            </p:cNvPr>
            <p:cNvSpPr txBox="1">
              <a:spLocks noChangeArrowheads="1"/>
            </p:cNvSpPr>
            <p:nvPr/>
          </p:nvSpPr>
          <p:spPr bwMode="auto">
            <a:xfrm>
              <a:off x="1482248" y="594018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a:t>
              </a:r>
            </a:p>
          </p:txBody>
        </p:sp>
      </p:grpSp>
      <p:sp>
        <p:nvSpPr>
          <p:cNvPr id="38" name="TextBox 13">
            <a:extLst>
              <a:ext uri="{FF2B5EF4-FFF2-40B4-BE49-F238E27FC236}">
                <a16:creationId xmlns:a16="http://schemas.microsoft.com/office/drawing/2014/main" id="{8126FD95-6997-480B-99D0-6A58BF6FF6A8}"/>
              </a:ext>
            </a:extLst>
          </p:cNvPr>
          <p:cNvSpPr txBox="1">
            <a:spLocks noChangeArrowheads="1"/>
          </p:cNvSpPr>
          <p:nvPr/>
        </p:nvSpPr>
        <p:spPr bwMode="auto">
          <a:xfrm>
            <a:off x="5172874" y="4438378"/>
            <a:ext cx="1290557"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l-GR" altLang="en-US" sz="1299" dirty="0">
                <a:solidFill>
                  <a:srgbClr val="000000"/>
                </a:solidFill>
              </a:rPr>
              <a:t>β</a:t>
            </a:r>
            <a:r>
              <a:rPr lang="en-US" altLang="en-US" sz="1299" dirty="0">
                <a:solidFill>
                  <a:srgbClr val="000000"/>
                </a:solidFill>
              </a:rPr>
              <a:t>-actin 42kDa</a:t>
            </a:r>
          </a:p>
        </p:txBody>
      </p:sp>
      <p:sp>
        <p:nvSpPr>
          <p:cNvPr id="39" name="TextBox 14">
            <a:extLst>
              <a:ext uri="{FF2B5EF4-FFF2-40B4-BE49-F238E27FC236}">
                <a16:creationId xmlns:a16="http://schemas.microsoft.com/office/drawing/2014/main" id="{777174FE-448F-4964-9FFC-4A4AD4211BFA}"/>
              </a:ext>
            </a:extLst>
          </p:cNvPr>
          <p:cNvSpPr txBox="1">
            <a:spLocks noChangeArrowheads="1"/>
          </p:cNvSpPr>
          <p:nvPr/>
        </p:nvSpPr>
        <p:spPr bwMode="auto">
          <a:xfrm>
            <a:off x="5190818" y="4143829"/>
            <a:ext cx="1322717" cy="2903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n-US" altLang="en-US" sz="1299" dirty="0">
                <a:solidFill>
                  <a:srgbClr val="000000"/>
                </a:solidFill>
              </a:rPr>
              <a:t>Atp5a1 55kDa</a:t>
            </a:r>
          </a:p>
        </p:txBody>
      </p:sp>
    </p:spTree>
    <p:extLst>
      <p:ext uri="{BB962C8B-B14F-4D97-AF65-F5344CB8AC3E}">
        <p14:creationId xmlns:p14="http://schemas.microsoft.com/office/powerpoint/2010/main" val="11010077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2C562D5E-B0FC-4D01-A994-C15D4610522B}"/>
              </a:ext>
            </a:extLst>
          </p:cNvPr>
          <p:cNvPicPr/>
          <p:nvPr/>
        </p:nvPicPr>
        <p:blipFill>
          <a:blip r:embed="rId2" cstate="print">
            <a:extLst>
              <a:ext uri="{BEBA8EAE-BF5A-486C-A8C5-ECC9F3942E4B}">
                <a14:imgProps xmlns:a14="http://schemas.microsoft.com/office/drawing/2010/main">
                  <a14:imgLayer r:embed="rId3">
                    <a14:imgEffect>
                      <a14:brightnessContrast bright="14000"/>
                    </a14:imgEffect>
                  </a14:imgLayer>
                </a14:imgProps>
              </a:ext>
              <a:ext uri="{28A0092B-C50C-407E-A947-70E740481C1C}">
                <a14:useLocalDpi xmlns:a14="http://schemas.microsoft.com/office/drawing/2010/main" val="0"/>
              </a:ext>
            </a:extLst>
          </a:blip>
          <a:srcRect/>
          <a:stretch>
            <a:fillRect/>
          </a:stretch>
        </p:blipFill>
        <p:spPr bwMode="auto">
          <a:xfrm>
            <a:off x="899349" y="6489851"/>
            <a:ext cx="1793747" cy="1551857"/>
          </a:xfrm>
          <a:prstGeom prst="rect">
            <a:avLst/>
          </a:prstGeom>
          <a:noFill/>
          <a:ln>
            <a:noFill/>
          </a:ln>
        </p:spPr>
      </p:pic>
      <p:sp>
        <p:nvSpPr>
          <p:cNvPr id="14" name="TextBox 13">
            <a:extLst>
              <a:ext uri="{FF2B5EF4-FFF2-40B4-BE49-F238E27FC236}">
                <a16:creationId xmlns:a16="http://schemas.microsoft.com/office/drawing/2014/main" id="{7B8E200B-3FC0-4B67-AE9D-1C600380E74D}"/>
              </a:ext>
            </a:extLst>
          </p:cNvPr>
          <p:cNvSpPr txBox="1"/>
          <p:nvPr/>
        </p:nvSpPr>
        <p:spPr>
          <a:xfrm>
            <a:off x="641350" y="2707597"/>
            <a:ext cx="3255258" cy="397511"/>
          </a:xfrm>
          <a:prstGeom prst="rect">
            <a:avLst/>
          </a:prstGeom>
          <a:noFill/>
        </p:spPr>
        <p:txBody>
          <a:bodyPr wrap="square" rtlCol="0">
            <a:spAutoFit/>
          </a:bodyPr>
          <a:lstStyle>
            <a:defPPr>
              <a:defRPr lang="en-US"/>
            </a:defPPr>
            <a:lvl1pPr>
              <a:defRPr sz="1600"/>
            </a:lvl1pPr>
          </a:lstStyle>
          <a:p>
            <a:r>
              <a:rPr lang="en-CA" sz="879" dirty="0"/>
              <a:t>C: U1 undifferentiated</a:t>
            </a:r>
          </a:p>
        </p:txBody>
      </p:sp>
      <p:sp>
        <p:nvSpPr>
          <p:cNvPr id="15" name="TextBox 14">
            <a:extLst>
              <a:ext uri="{FF2B5EF4-FFF2-40B4-BE49-F238E27FC236}">
                <a16:creationId xmlns:a16="http://schemas.microsoft.com/office/drawing/2014/main" id="{6E77F925-7E79-476D-9A02-5702EC256B89}"/>
              </a:ext>
            </a:extLst>
          </p:cNvPr>
          <p:cNvSpPr txBox="1"/>
          <p:nvPr/>
        </p:nvSpPr>
        <p:spPr>
          <a:xfrm>
            <a:off x="641350" y="778522"/>
            <a:ext cx="2415237" cy="397511"/>
          </a:xfrm>
          <a:prstGeom prst="rect">
            <a:avLst/>
          </a:prstGeom>
          <a:noFill/>
        </p:spPr>
        <p:txBody>
          <a:bodyPr wrap="square" rtlCol="0">
            <a:spAutoFit/>
          </a:bodyPr>
          <a:lstStyle>
            <a:defPPr>
              <a:defRPr lang="en-US"/>
            </a:defPPr>
            <a:lvl1pPr>
              <a:defRPr sz="1600" b="0"/>
            </a:lvl1pPr>
          </a:lstStyle>
          <a:p>
            <a:r>
              <a:rPr lang="en-CA" sz="879" dirty="0"/>
              <a:t>A: U937 undifferentiated</a:t>
            </a:r>
          </a:p>
        </p:txBody>
      </p:sp>
      <p:sp>
        <p:nvSpPr>
          <p:cNvPr id="16" name="TextBox 15">
            <a:extLst>
              <a:ext uri="{FF2B5EF4-FFF2-40B4-BE49-F238E27FC236}">
                <a16:creationId xmlns:a16="http://schemas.microsoft.com/office/drawing/2014/main" id="{E593EF28-03AC-4586-BD5E-4DB4496A0682}"/>
              </a:ext>
            </a:extLst>
          </p:cNvPr>
          <p:cNvSpPr txBox="1"/>
          <p:nvPr/>
        </p:nvSpPr>
        <p:spPr>
          <a:xfrm>
            <a:off x="641350" y="6215497"/>
            <a:ext cx="2402475" cy="227626"/>
          </a:xfrm>
          <a:prstGeom prst="rect">
            <a:avLst/>
          </a:prstGeom>
          <a:noFill/>
        </p:spPr>
        <p:txBody>
          <a:bodyPr wrap="square" rtlCol="0">
            <a:spAutoFit/>
          </a:bodyPr>
          <a:lstStyle/>
          <a:p>
            <a:r>
              <a:rPr lang="en-CA" sz="879" dirty="0"/>
              <a:t>G: 14-day-old primary MDMs without treatment</a:t>
            </a:r>
            <a:endParaRPr lang="en-CA" sz="1255" b="1" dirty="0"/>
          </a:p>
        </p:txBody>
      </p:sp>
      <p:graphicFrame>
        <p:nvGraphicFramePr>
          <p:cNvPr id="17" name="Object 16">
            <a:extLst>
              <a:ext uri="{FF2B5EF4-FFF2-40B4-BE49-F238E27FC236}">
                <a16:creationId xmlns:a16="http://schemas.microsoft.com/office/drawing/2014/main" id="{F0ED5E9D-420E-45BB-9B29-8A8D2C3B2D93}"/>
              </a:ext>
            </a:extLst>
          </p:cNvPr>
          <p:cNvGraphicFramePr>
            <a:graphicFrameLocks noChangeAspect="1"/>
          </p:cNvGraphicFramePr>
          <p:nvPr>
            <p:extLst>
              <p:ext uri="{D42A27DB-BD31-4B8C-83A1-F6EECF244321}">
                <p14:modId xmlns:p14="http://schemas.microsoft.com/office/powerpoint/2010/main" val="2145299464"/>
              </p:ext>
            </p:extLst>
          </p:nvPr>
        </p:nvGraphicFramePr>
        <p:xfrm>
          <a:off x="692181" y="973208"/>
          <a:ext cx="2151227" cy="1694719"/>
        </p:xfrm>
        <a:graphic>
          <a:graphicData uri="http://schemas.openxmlformats.org/presentationml/2006/ole">
            <mc:AlternateContent xmlns:mc="http://schemas.openxmlformats.org/markup-compatibility/2006">
              <mc:Choice xmlns:v="urn:schemas-microsoft-com:vml" Requires="v">
                <p:oleObj name="Prism 6" r:id="rId4" imgW="3942406" imgH="2712320" progId="Prism6.Document">
                  <p:embed/>
                </p:oleObj>
              </mc:Choice>
              <mc:Fallback>
                <p:oleObj name="Prism 6" r:id="rId4" imgW="3942406" imgH="2712320" progId="Prism6.Document">
                  <p:embed/>
                  <p:pic>
                    <p:nvPicPr>
                      <p:cNvPr id="17" name="Object 16">
                        <a:extLst>
                          <a:ext uri="{FF2B5EF4-FFF2-40B4-BE49-F238E27FC236}">
                            <a16:creationId xmlns:a16="http://schemas.microsoft.com/office/drawing/2014/main" id="{F0ED5E9D-420E-45BB-9B29-8A8D2C3B2D93}"/>
                          </a:ext>
                        </a:extLst>
                      </p:cNvPr>
                      <p:cNvPicPr/>
                      <p:nvPr/>
                    </p:nvPicPr>
                    <p:blipFill>
                      <a:blip r:embed="rId5"/>
                      <a:stretch>
                        <a:fillRect/>
                      </a:stretch>
                    </p:blipFill>
                    <p:spPr>
                      <a:xfrm>
                        <a:off x="692181" y="973208"/>
                        <a:ext cx="2151227" cy="1694719"/>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12190B15-DAA8-4C48-80C6-B562DDCDCED8}"/>
              </a:ext>
            </a:extLst>
          </p:cNvPr>
          <p:cNvGraphicFramePr>
            <a:graphicFrameLocks noChangeAspect="1"/>
          </p:cNvGraphicFramePr>
          <p:nvPr>
            <p:extLst>
              <p:ext uri="{D42A27DB-BD31-4B8C-83A1-F6EECF244321}">
                <p14:modId xmlns:p14="http://schemas.microsoft.com/office/powerpoint/2010/main" val="1757672008"/>
              </p:ext>
            </p:extLst>
          </p:nvPr>
        </p:nvGraphicFramePr>
        <p:xfrm>
          <a:off x="558217" y="4525885"/>
          <a:ext cx="2235087" cy="1782689"/>
        </p:xfrm>
        <a:graphic>
          <a:graphicData uri="http://schemas.openxmlformats.org/presentationml/2006/ole">
            <mc:AlternateContent xmlns:mc="http://schemas.openxmlformats.org/markup-compatibility/2006">
              <mc:Choice xmlns:v="urn:schemas-microsoft-com:vml" Requires="v">
                <p:oleObj name="Prism 6" r:id="rId6" imgW="3860295" imgH="2781109" progId="Prism6.Document">
                  <p:embed/>
                </p:oleObj>
              </mc:Choice>
              <mc:Fallback>
                <p:oleObj name="Prism 6" r:id="rId6" imgW="3860295" imgH="2781109" progId="Prism6.Document">
                  <p:embed/>
                  <p:pic>
                    <p:nvPicPr>
                      <p:cNvPr id="18" name="Object 17">
                        <a:extLst>
                          <a:ext uri="{FF2B5EF4-FFF2-40B4-BE49-F238E27FC236}">
                            <a16:creationId xmlns:a16="http://schemas.microsoft.com/office/drawing/2014/main" id="{12190B15-DAA8-4C48-80C6-B562DDCDCED8}"/>
                          </a:ext>
                        </a:extLst>
                      </p:cNvPr>
                      <p:cNvPicPr/>
                      <p:nvPr/>
                    </p:nvPicPr>
                    <p:blipFill>
                      <a:blip r:embed="rId7"/>
                      <a:stretch>
                        <a:fillRect/>
                      </a:stretch>
                    </p:blipFill>
                    <p:spPr>
                      <a:xfrm>
                        <a:off x="558217" y="4525885"/>
                        <a:ext cx="2235087" cy="1782689"/>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F669824A-1A86-4AAF-8A5C-DF100EA378D7}"/>
              </a:ext>
            </a:extLst>
          </p:cNvPr>
          <p:cNvGraphicFramePr>
            <a:graphicFrameLocks noChangeAspect="1"/>
          </p:cNvGraphicFramePr>
          <p:nvPr>
            <p:extLst>
              <p:ext uri="{D42A27DB-BD31-4B8C-83A1-F6EECF244321}">
                <p14:modId xmlns:p14="http://schemas.microsoft.com/office/powerpoint/2010/main" val="594729625"/>
              </p:ext>
            </p:extLst>
          </p:nvPr>
        </p:nvGraphicFramePr>
        <p:xfrm>
          <a:off x="556333" y="2881970"/>
          <a:ext cx="2249497" cy="1551649"/>
        </p:xfrm>
        <a:graphic>
          <a:graphicData uri="http://schemas.openxmlformats.org/presentationml/2006/ole">
            <mc:AlternateContent xmlns:mc="http://schemas.openxmlformats.org/markup-compatibility/2006">
              <mc:Choice xmlns:v="urn:schemas-microsoft-com:vml" Requires="v">
                <p:oleObj name="Prism 6" r:id="rId8" imgW="3184680" imgH="2215308" progId="Prism6.Document">
                  <p:embed/>
                </p:oleObj>
              </mc:Choice>
              <mc:Fallback>
                <p:oleObj name="Prism 6" r:id="rId8" imgW="3184680" imgH="2215308" progId="Prism6.Document">
                  <p:embed/>
                  <p:pic>
                    <p:nvPicPr>
                      <p:cNvPr id="19" name="Object 18">
                        <a:extLst>
                          <a:ext uri="{FF2B5EF4-FFF2-40B4-BE49-F238E27FC236}">
                            <a16:creationId xmlns:a16="http://schemas.microsoft.com/office/drawing/2014/main" id="{F669824A-1A86-4AAF-8A5C-DF100EA378D7}"/>
                          </a:ext>
                        </a:extLst>
                      </p:cNvPr>
                      <p:cNvPicPr/>
                      <p:nvPr/>
                    </p:nvPicPr>
                    <p:blipFill>
                      <a:blip r:embed="rId9"/>
                      <a:stretch>
                        <a:fillRect/>
                      </a:stretch>
                    </p:blipFill>
                    <p:spPr>
                      <a:xfrm>
                        <a:off x="556333" y="2881970"/>
                        <a:ext cx="2249497" cy="1551649"/>
                      </a:xfrm>
                      <a:prstGeom prst="rect">
                        <a:avLst/>
                      </a:prstGeom>
                    </p:spPr>
                  </p:pic>
                </p:oleObj>
              </mc:Fallback>
            </mc:AlternateContent>
          </a:graphicData>
        </a:graphic>
      </p:graphicFrame>
      <p:sp>
        <p:nvSpPr>
          <p:cNvPr id="20" name="TextBox 19">
            <a:extLst>
              <a:ext uri="{FF2B5EF4-FFF2-40B4-BE49-F238E27FC236}">
                <a16:creationId xmlns:a16="http://schemas.microsoft.com/office/drawing/2014/main" id="{6F7BAB0E-50A6-497C-848C-24B56DFCD149}"/>
              </a:ext>
            </a:extLst>
          </p:cNvPr>
          <p:cNvSpPr txBox="1"/>
          <p:nvPr/>
        </p:nvSpPr>
        <p:spPr>
          <a:xfrm>
            <a:off x="641350" y="4403586"/>
            <a:ext cx="2702171" cy="397511"/>
          </a:xfrm>
          <a:prstGeom prst="rect">
            <a:avLst/>
          </a:prstGeom>
          <a:noFill/>
        </p:spPr>
        <p:txBody>
          <a:bodyPr wrap="square" rtlCol="0">
            <a:spAutoFit/>
          </a:bodyPr>
          <a:lstStyle>
            <a:defPPr>
              <a:defRPr lang="en-US"/>
            </a:defPPr>
            <a:lvl1pPr>
              <a:defRPr sz="1600"/>
            </a:lvl1pPr>
          </a:lstStyle>
          <a:p>
            <a:r>
              <a:rPr lang="en-CA" sz="879" dirty="0"/>
              <a:t>E: THP-1 undifferentiated</a:t>
            </a:r>
          </a:p>
        </p:txBody>
      </p:sp>
      <p:graphicFrame>
        <p:nvGraphicFramePr>
          <p:cNvPr id="5" name="Object 4">
            <a:extLst>
              <a:ext uri="{FF2B5EF4-FFF2-40B4-BE49-F238E27FC236}">
                <a16:creationId xmlns:a16="http://schemas.microsoft.com/office/drawing/2014/main" id="{9C9CCE01-E603-4CD5-B011-3C5897506CAC}"/>
              </a:ext>
            </a:extLst>
          </p:cNvPr>
          <p:cNvGraphicFramePr>
            <a:graphicFrameLocks noChangeAspect="1"/>
          </p:cNvGraphicFramePr>
          <p:nvPr>
            <p:extLst>
              <p:ext uri="{D42A27DB-BD31-4B8C-83A1-F6EECF244321}">
                <p14:modId xmlns:p14="http://schemas.microsoft.com/office/powerpoint/2010/main" val="244518257"/>
              </p:ext>
            </p:extLst>
          </p:nvPr>
        </p:nvGraphicFramePr>
        <p:xfrm>
          <a:off x="4429958" y="4634035"/>
          <a:ext cx="2020946" cy="1570664"/>
        </p:xfrm>
        <a:graphic>
          <a:graphicData uri="http://schemas.openxmlformats.org/presentationml/2006/ole">
            <mc:AlternateContent xmlns:mc="http://schemas.openxmlformats.org/markup-compatibility/2006">
              <mc:Choice xmlns:v="urn:schemas-microsoft-com:vml" Requires="v">
                <p:oleObj name="Prism 6" r:id="rId10" imgW="3787187" imgH="2762742" progId="Prism6.Document">
                  <p:embed/>
                </p:oleObj>
              </mc:Choice>
              <mc:Fallback>
                <p:oleObj name="Prism 6" r:id="rId10" imgW="3787187" imgH="2762742" progId="Prism6.Document">
                  <p:embed/>
                  <p:pic>
                    <p:nvPicPr>
                      <p:cNvPr id="5" name="Object 4">
                        <a:extLst>
                          <a:ext uri="{FF2B5EF4-FFF2-40B4-BE49-F238E27FC236}">
                            <a16:creationId xmlns:a16="http://schemas.microsoft.com/office/drawing/2014/main" id="{9C9CCE01-E603-4CD5-B011-3C5897506CAC}"/>
                          </a:ext>
                        </a:extLst>
                      </p:cNvPr>
                      <p:cNvPicPr/>
                      <p:nvPr/>
                    </p:nvPicPr>
                    <p:blipFill>
                      <a:blip r:embed="rId11"/>
                      <a:stretch>
                        <a:fillRect/>
                      </a:stretch>
                    </p:blipFill>
                    <p:spPr>
                      <a:xfrm>
                        <a:off x="4429958" y="4634035"/>
                        <a:ext cx="2020946" cy="1570664"/>
                      </a:xfrm>
                      <a:prstGeom prst="rect">
                        <a:avLst/>
                      </a:prstGeom>
                    </p:spPr>
                  </p:pic>
                </p:oleObj>
              </mc:Fallback>
            </mc:AlternateContent>
          </a:graphicData>
        </a:graphic>
      </p:graphicFrame>
      <p:pic>
        <p:nvPicPr>
          <p:cNvPr id="6" name="Picture 5">
            <a:extLst>
              <a:ext uri="{FF2B5EF4-FFF2-40B4-BE49-F238E27FC236}">
                <a16:creationId xmlns:a16="http://schemas.microsoft.com/office/drawing/2014/main" id="{C4746B79-A64E-4617-AFFB-F5D294291C9A}"/>
              </a:ext>
            </a:extLst>
          </p:cNvPr>
          <p:cNvPicPr/>
          <p:nvPr/>
        </p:nvPicPr>
        <p:blipFill>
          <a:blip r:embed="rId12" cstate="print">
            <a:extLst>
              <a:ext uri="{BEBA8EAE-BF5A-486C-A8C5-ECC9F3942E4B}">
                <a14:imgProps xmlns:a14="http://schemas.microsoft.com/office/drawing/2010/main">
                  <a14:imgLayer r:embed="rId13">
                    <a14:imgEffect>
                      <a14:brightnessContrast bright="16000"/>
                    </a14:imgEffect>
                  </a14:imgLayer>
                </a14:imgProps>
              </a:ext>
              <a:ext uri="{28A0092B-C50C-407E-A947-70E740481C1C}">
                <a14:useLocalDpi xmlns:a14="http://schemas.microsoft.com/office/drawing/2010/main" val="0"/>
              </a:ext>
            </a:extLst>
          </a:blip>
          <a:srcRect/>
          <a:stretch>
            <a:fillRect/>
          </a:stretch>
        </p:blipFill>
        <p:spPr bwMode="auto">
          <a:xfrm>
            <a:off x="4629256" y="6422498"/>
            <a:ext cx="1884279" cy="1581633"/>
          </a:xfrm>
          <a:prstGeom prst="rect">
            <a:avLst/>
          </a:prstGeom>
          <a:noFill/>
          <a:ln>
            <a:noFill/>
          </a:ln>
        </p:spPr>
      </p:pic>
      <p:sp>
        <p:nvSpPr>
          <p:cNvPr id="7" name="TextBox 6">
            <a:extLst>
              <a:ext uri="{FF2B5EF4-FFF2-40B4-BE49-F238E27FC236}">
                <a16:creationId xmlns:a16="http://schemas.microsoft.com/office/drawing/2014/main" id="{BF51C8F7-0F82-4D6C-8DB5-D5F51244EDBF}"/>
              </a:ext>
            </a:extLst>
          </p:cNvPr>
          <p:cNvSpPr txBox="1"/>
          <p:nvPr/>
        </p:nvSpPr>
        <p:spPr>
          <a:xfrm>
            <a:off x="4324150" y="781728"/>
            <a:ext cx="2657554" cy="397510"/>
          </a:xfrm>
          <a:prstGeom prst="rect">
            <a:avLst/>
          </a:prstGeom>
          <a:noFill/>
        </p:spPr>
        <p:txBody>
          <a:bodyPr wrap="square" rtlCol="0">
            <a:spAutoFit/>
          </a:bodyPr>
          <a:lstStyle>
            <a:defPPr>
              <a:defRPr lang="en-US"/>
            </a:defPPr>
            <a:lvl1pPr>
              <a:defRPr sz="1600" b="1"/>
            </a:lvl1pPr>
          </a:lstStyle>
          <a:p>
            <a:r>
              <a:rPr lang="en-CA" sz="879" b="0" dirty="0"/>
              <a:t>B: U937 differentiated 5 days</a:t>
            </a:r>
          </a:p>
        </p:txBody>
      </p:sp>
      <p:sp>
        <p:nvSpPr>
          <p:cNvPr id="8" name="TextBox 7">
            <a:extLst>
              <a:ext uri="{FF2B5EF4-FFF2-40B4-BE49-F238E27FC236}">
                <a16:creationId xmlns:a16="http://schemas.microsoft.com/office/drawing/2014/main" id="{A4F5D02A-DDC1-4942-9F31-82328107ABC2}"/>
              </a:ext>
            </a:extLst>
          </p:cNvPr>
          <p:cNvSpPr txBox="1"/>
          <p:nvPr/>
        </p:nvSpPr>
        <p:spPr>
          <a:xfrm>
            <a:off x="4324150" y="4517595"/>
            <a:ext cx="2754411" cy="397510"/>
          </a:xfrm>
          <a:prstGeom prst="rect">
            <a:avLst/>
          </a:prstGeom>
          <a:noFill/>
        </p:spPr>
        <p:txBody>
          <a:bodyPr wrap="square" rtlCol="0">
            <a:spAutoFit/>
          </a:bodyPr>
          <a:lstStyle>
            <a:defPPr>
              <a:defRPr lang="en-US"/>
            </a:defPPr>
            <a:lvl1pPr>
              <a:defRPr sz="1600" b="0"/>
            </a:lvl1pPr>
          </a:lstStyle>
          <a:p>
            <a:r>
              <a:rPr lang="en-CA" sz="879" dirty="0"/>
              <a:t>F: THP-1 differentiated 2 days</a:t>
            </a:r>
          </a:p>
        </p:txBody>
      </p:sp>
      <p:sp>
        <p:nvSpPr>
          <p:cNvPr id="9" name="TextBox 8">
            <a:extLst>
              <a:ext uri="{FF2B5EF4-FFF2-40B4-BE49-F238E27FC236}">
                <a16:creationId xmlns:a16="http://schemas.microsoft.com/office/drawing/2014/main" id="{1E635D08-765D-4290-80AE-78637EC41617}"/>
              </a:ext>
            </a:extLst>
          </p:cNvPr>
          <p:cNvSpPr txBox="1"/>
          <p:nvPr/>
        </p:nvSpPr>
        <p:spPr>
          <a:xfrm>
            <a:off x="4324150" y="2684847"/>
            <a:ext cx="2509887" cy="397510"/>
          </a:xfrm>
          <a:prstGeom prst="rect">
            <a:avLst/>
          </a:prstGeom>
          <a:noFill/>
        </p:spPr>
        <p:txBody>
          <a:bodyPr wrap="square" rtlCol="0">
            <a:spAutoFit/>
          </a:bodyPr>
          <a:lstStyle>
            <a:defPPr>
              <a:defRPr lang="en-US"/>
            </a:defPPr>
            <a:lvl1pPr>
              <a:defRPr sz="1600" b="0"/>
            </a:lvl1pPr>
          </a:lstStyle>
          <a:p>
            <a:r>
              <a:rPr lang="en-CA" sz="879" dirty="0"/>
              <a:t>D: U1 differentiated 5 days</a:t>
            </a:r>
          </a:p>
        </p:txBody>
      </p:sp>
      <p:graphicFrame>
        <p:nvGraphicFramePr>
          <p:cNvPr id="10" name="Object 9">
            <a:extLst>
              <a:ext uri="{FF2B5EF4-FFF2-40B4-BE49-F238E27FC236}">
                <a16:creationId xmlns:a16="http://schemas.microsoft.com/office/drawing/2014/main" id="{712473BE-B3F0-48BD-8681-C3DDC0697BED}"/>
              </a:ext>
            </a:extLst>
          </p:cNvPr>
          <p:cNvGraphicFramePr>
            <a:graphicFrameLocks noChangeAspect="1"/>
          </p:cNvGraphicFramePr>
          <p:nvPr>
            <p:extLst>
              <p:ext uri="{D42A27DB-BD31-4B8C-83A1-F6EECF244321}">
                <p14:modId xmlns:p14="http://schemas.microsoft.com/office/powerpoint/2010/main" val="1451398767"/>
              </p:ext>
            </p:extLst>
          </p:nvPr>
        </p:nvGraphicFramePr>
        <p:xfrm>
          <a:off x="4371489" y="938082"/>
          <a:ext cx="2116993" cy="1729033"/>
        </p:xfrm>
        <a:graphic>
          <a:graphicData uri="http://schemas.openxmlformats.org/presentationml/2006/ole">
            <mc:AlternateContent xmlns:mc="http://schemas.openxmlformats.org/markup-compatibility/2006">
              <mc:Choice xmlns:v="urn:schemas-microsoft-com:vml" Requires="v">
                <p:oleObj name="Prism 6" r:id="rId14" imgW="4148403" imgH="2790113" progId="Prism6.Document">
                  <p:embed/>
                </p:oleObj>
              </mc:Choice>
              <mc:Fallback>
                <p:oleObj name="Prism 6" r:id="rId14" imgW="4148403" imgH="2790113" progId="Prism6.Document">
                  <p:embed/>
                  <p:pic>
                    <p:nvPicPr>
                      <p:cNvPr id="10" name="Object 9">
                        <a:extLst>
                          <a:ext uri="{FF2B5EF4-FFF2-40B4-BE49-F238E27FC236}">
                            <a16:creationId xmlns:a16="http://schemas.microsoft.com/office/drawing/2014/main" id="{712473BE-B3F0-48BD-8681-C3DDC0697BED}"/>
                          </a:ext>
                        </a:extLst>
                      </p:cNvPr>
                      <p:cNvPicPr/>
                      <p:nvPr/>
                    </p:nvPicPr>
                    <p:blipFill>
                      <a:blip r:embed="rId15"/>
                      <a:stretch>
                        <a:fillRect/>
                      </a:stretch>
                    </p:blipFill>
                    <p:spPr>
                      <a:xfrm>
                        <a:off x="4371489" y="938082"/>
                        <a:ext cx="2116993" cy="1729033"/>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42208BB2-589F-47E0-B2E4-C7976CDF08B0}"/>
              </a:ext>
            </a:extLst>
          </p:cNvPr>
          <p:cNvSpPr txBox="1"/>
          <p:nvPr/>
        </p:nvSpPr>
        <p:spPr>
          <a:xfrm>
            <a:off x="4324150" y="6203016"/>
            <a:ext cx="2803159" cy="235359"/>
          </a:xfrm>
          <a:prstGeom prst="rect">
            <a:avLst/>
          </a:prstGeom>
          <a:noFill/>
        </p:spPr>
        <p:txBody>
          <a:bodyPr wrap="square" rtlCol="0">
            <a:spAutoFit/>
          </a:bodyPr>
          <a:lstStyle>
            <a:defPPr>
              <a:defRPr lang="en-US"/>
            </a:defPPr>
            <a:lvl1pPr>
              <a:defRPr sz="1600" b="1"/>
            </a:lvl1pPr>
          </a:lstStyle>
          <a:p>
            <a:r>
              <a:rPr lang="en-CA" sz="879" b="0" dirty="0"/>
              <a:t>H: 14-day-old primary MDMs 5µg/ml polybrene treated</a:t>
            </a:r>
          </a:p>
        </p:txBody>
      </p:sp>
      <p:graphicFrame>
        <p:nvGraphicFramePr>
          <p:cNvPr id="12" name="Object 11">
            <a:extLst>
              <a:ext uri="{FF2B5EF4-FFF2-40B4-BE49-F238E27FC236}">
                <a16:creationId xmlns:a16="http://schemas.microsoft.com/office/drawing/2014/main" id="{47CA1F48-7A48-470B-B2CC-FC21FCDB55CE}"/>
              </a:ext>
            </a:extLst>
          </p:cNvPr>
          <p:cNvGraphicFramePr>
            <a:graphicFrameLocks noChangeAspect="1"/>
          </p:cNvGraphicFramePr>
          <p:nvPr>
            <p:extLst>
              <p:ext uri="{D42A27DB-BD31-4B8C-83A1-F6EECF244321}">
                <p14:modId xmlns:p14="http://schemas.microsoft.com/office/powerpoint/2010/main" val="1847101292"/>
              </p:ext>
            </p:extLst>
          </p:nvPr>
        </p:nvGraphicFramePr>
        <p:xfrm>
          <a:off x="4351484" y="2863066"/>
          <a:ext cx="2149524" cy="1663786"/>
        </p:xfrm>
        <a:graphic>
          <a:graphicData uri="http://schemas.openxmlformats.org/presentationml/2006/ole">
            <mc:AlternateContent xmlns:mc="http://schemas.openxmlformats.org/markup-compatibility/2006">
              <mc:Choice xmlns:v="urn:schemas-microsoft-com:vml" Requires="v">
                <p:oleObj name="Prism 6" r:id="rId16" imgW="3181799" imgH="2273292" progId="Prism6.Document">
                  <p:embed/>
                </p:oleObj>
              </mc:Choice>
              <mc:Fallback>
                <p:oleObj name="Prism 6" r:id="rId16" imgW="3181799" imgH="2273292" progId="Prism6.Document">
                  <p:embed/>
                  <p:pic>
                    <p:nvPicPr>
                      <p:cNvPr id="12" name="Object 11">
                        <a:extLst>
                          <a:ext uri="{FF2B5EF4-FFF2-40B4-BE49-F238E27FC236}">
                            <a16:creationId xmlns:a16="http://schemas.microsoft.com/office/drawing/2014/main" id="{47CA1F48-7A48-470B-B2CC-FC21FCDB55CE}"/>
                          </a:ext>
                        </a:extLst>
                      </p:cNvPr>
                      <p:cNvPicPr/>
                      <p:nvPr/>
                    </p:nvPicPr>
                    <p:blipFill>
                      <a:blip r:embed="rId17"/>
                      <a:stretch>
                        <a:fillRect/>
                      </a:stretch>
                    </p:blipFill>
                    <p:spPr>
                      <a:xfrm>
                        <a:off x="4351484" y="2863066"/>
                        <a:ext cx="2149524" cy="1663786"/>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19085A89-6CBE-48D4-AF85-1BA8A1D762C5}"/>
              </a:ext>
            </a:extLst>
          </p:cNvPr>
          <p:cNvSpPr txBox="1"/>
          <p:nvPr/>
        </p:nvSpPr>
        <p:spPr>
          <a:xfrm>
            <a:off x="739036" y="8281590"/>
            <a:ext cx="6350696" cy="1384995"/>
          </a:xfrm>
          <a:prstGeom prst="rect">
            <a:avLst/>
          </a:prstGeom>
          <a:noFill/>
        </p:spPr>
        <p:txBody>
          <a:bodyPr wrap="square">
            <a:spAutoFit/>
          </a:bodyPr>
          <a:lstStyle/>
          <a:p>
            <a:pPr marL="0" marR="0" algn="just">
              <a:spcBef>
                <a:spcPts val="0"/>
              </a:spcBef>
              <a:spcAft>
                <a:spcPts val="0"/>
              </a:spcAft>
            </a:pPr>
            <a:r>
              <a:rPr lang="en-CA" sz="1200" b="1" kern="1200" dirty="0">
                <a:effectLst/>
                <a:latin typeface="Times New Roman" panose="02020603050405020304" pitchFamily="18" charset="0"/>
                <a:ea typeface="+mn-ea"/>
              </a:rPr>
              <a:t>Supplementary Figure 2 - Polybrene tolerance of U937, U1, THP-1 and primary MDMs. </a:t>
            </a:r>
            <a:r>
              <a:rPr lang="en-CA" sz="1200" kern="1200" dirty="0">
                <a:effectLst/>
                <a:latin typeface="Times New Roman" panose="02020603050405020304" pitchFamily="18" charset="0"/>
                <a:ea typeface="+mn-ea"/>
              </a:rPr>
              <a:t>Myeloid lineage cells were treated with various doses of polybrene for 48 hr. Cells were harvested and PI staining were applied to track dead cells. The percentage dead cells were detected by flow </a:t>
            </a:r>
            <a:r>
              <a:rPr lang="en-CA" sz="1200" dirty="0">
                <a:latin typeface="Times New Roman" panose="02020603050405020304" pitchFamily="18" charset="0"/>
              </a:rPr>
              <a:t>c</a:t>
            </a:r>
            <a:r>
              <a:rPr lang="en-CA" sz="1200" kern="1200" dirty="0">
                <a:effectLst/>
                <a:latin typeface="Times New Roman" panose="02020603050405020304" pitchFamily="18" charset="0"/>
                <a:ea typeface="+mn-ea"/>
              </a:rPr>
              <a:t>ytometry at PI channel. </a:t>
            </a:r>
            <a:r>
              <a:rPr lang="en-US" sz="1200" kern="1200" dirty="0">
                <a:effectLst/>
                <a:latin typeface="Times New Roman" panose="02020603050405020304" pitchFamily="18" charset="0"/>
                <a:ea typeface="+mn-ea"/>
              </a:rPr>
              <a:t>The mean value and standard deviation were based on three independent experiments (n=3). </a:t>
            </a:r>
            <a:r>
              <a:rPr lang="en-US" sz="1200" b="1" kern="1200" dirty="0">
                <a:effectLst/>
                <a:latin typeface="Times New Roman" panose="02020603050405020304" pitchFamily="18" charset="0"/>
                <a:ea typeface="+mn-ea"/>
              </a:rPr>
              <a:t>A</a:t>
            </a:r>
            <a:r>
              <a:rPr lang="en-US" sz="1200" kern="1200" dirty="0">
                <a:effectLst/>
                <a:latin typeface="Times New Roman" panose="02020603050405020304" pitchFamily="18" charset="0"/>
                <a:ea typeface="+mn-ea"/>
              </a:rPr>
              <a:t>: U937 undifferentiated; </a:t>
            </a:r>
            <a:r>
              <a:rPr lang="en-CA" sz="1200" b="1" kern="1200" dirty="0">
                <a:effectLst/>
                <a:latin typeface="Times New Roman" panose="02020603050405020304" pitchFamily="18" charset="0"/>
                <a:ea typeface="+mn-ea"/>
              </a:rPr>
              <a:t>B</a:t>
            </a:r>
            <a:r>
              <a:rPr lang="en-CA" sz="1200" kern="1200" dirty="0">
                <a:effectLst/>
                <a:latin typeface="Times New Roman" panose="02020603050405020304" pitchFamily="18" charset="0"/>
                <a:ea typeface="+mn-ea"/>
              </a:rPr>
              <a:t>: U937 differentiated 5 days; </a:t>
            </a:r>
            <a:r>
              <a:rPr lang="en-CA" sz="1200" b="1" kern="1200" dirty="0">
                <a:effectLst/>
                <a:latin typeface="Times New Roman" panose="02020603050405020304" pitchFamily="18" charset="0"/>
                <a:ea typeface="+mn-ea"/>
              </a:rPr>
              <a:t>C</a:t>
            </a:r>
            <a:r>
              <a:rPr lang="en-CA" sz="1200" kern="1200" dirty="0">
                <a:effectLst/>
                <a:latin typeface="Times New Roman" panose="02020603050405020304" pitchFamily="18" charset="0"/>
                <a:ea typeface="+mn-ea"/>
              </a:rPr>
              <a:t>: U1 undifferentiated; </a:t>
            </a:r>
            <a:r>
              <a:rPr lang="en-US" sz="1200" b="1" kern="1200" dirty="0">
                <a:effectLst/>
                <a:latin typeface="Times New Roman" panose="02020603050405020304" pitchFamily="18" charset="0"/>
                <a:ea typeface="+mn-ea"/>
              </a:rPr>
              <a:t>D</a:t>
            </a:r>
            <a:r>
              <a:rPr lang="en-US" sz="1200" kern="1200" dirty="0">
                <a:effectLst/>
                <a:latin typeface="Times New Roman" panose="02020603050405020304" pitchFamily="18" charset="0"/>
                <a:ea typeface="+mn-ea"/>
              </a:rPr>
              <a:t>: U1 differentiated 5 days; </a:t>
            </a:r>
            <a:r>
              <a:rPr lang="en-US" sz="1200" b="1" kern="1200" dirty="0">
                <a:effectLst/>
                <a:latin typeface="Times New Roman" panose="02020603050405020304" pitchFamily="18" charset="0"/>
                <a:ea typeface="+mn-ea"/>
              </a:rPr>
              <a:t>E</a:t>
            </a:r>
            <a:r>
              <a:rPr lang="en-US" sz="1200" kern="1200" dirty="0">
                <a:effectLst/>
                <a:latin typeface="Times New Roman" panose="02020603050405020304" pitchFamily="18" charset="0"/>
                <a:ea typeface="+mn-ea"/>
              </a:rPr>
              <a:t>: THP-1 undifferentiated; </a:t>
            </a:r>
            <a:r>
              <a:rPr lang="en-US" sz="1200" b="1" kern="1200" dirty="0">
                <a:effectLst/>
                <a:latin typeface="Times New Roman" panose="02020603050405020304" pitchFamily="18" charset="0"/>
                <a:ea typeface="+mn-ea"/>
              </a:rPr>
              <a:t>F</a:t>
            </a:r>
            <a:r>
              <a:rPr lang="en-US" sz="1200" kern="1200" dirty="0">
                <a:effectLst/>
                <a:latin typeface="Times New Roman" panose="02020603050405020304" pitchFamily="18" charset="0"/>
                <a:ea typeface="+mn-ea"/>
              </a:rPr>
              <a:t>: THP-1 differentiated 2 days; </a:t>
            </a:r>
            <a:r>
              <a:rPr lang="en-US" sz="1200" b="1" kern="1200" dirty="0">
                <a:effectLst/>
                <a:latin typeface="Times New Roman" panose="02020603050405020304" pitchFamily="18" charset="0"/>
                <a:ea typeface="+mn-ea"/>
              </a:rPr>
              <a:t>G</a:t>
            </a:r>
            <a:r>
              <a:rPr lang="en-US" sz="1200" kern="1200" dirty="0">
                <a:effectLst/>
                <a:latin typeface="Times New Roman" panose="02020603050405020304" pitchFamily="18" charset="0"/>
                <a:ea typeface="+mn-ea"/>
              </a:rPr>
              <a:t>: 14-day-old primary MDMs without treatment; </a:t>
            </a:r>
            <a:r>
              <a:rPr lang="en-US" sz="1200" b="1" kern="1200" dirty="0">
                <a:effectLst/>
                <a:latin typeface="Times New Roman" panose="02020603050405020304" pitchFamily="18" charset="0"/>
                <a:ea typeface="+mn-ea"/>
              </a:rPr>
              <a:t>H</a:t>
            </a:r>
            <a:r>
              <a:rPr lang="en-US" sz="1200" kern="1200" dirty="0">
                <a:effectLst/>
                <a:latin typeface="Times New Roman" panose="02020603050405020304" pitchFamily="18" charset="0"/>
                <a:ea typeface="+mn-ea"/>
              </a:rPr>
              <a:t>: 14-day-old primary MDMs 5µg/ml polybrene treated.</a:t>
            </a:r>
            <a:endParaRPr lang="en-CA"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861546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piece of paper&#10;&#10;Description automatically generated with medium confidence">
            <a:extLst>
              <a:ext uri="{FF2B5EF4-FFF2-40B4-BE49-F238E27FC236}">
                <a16:creationId xmlns:a16="http://schemas.microsoft.com/office/drawing/2014/main" id="{167F4265-139F-47C5-A6CA-184D0C4D05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90595" y="2254685"/>
            <a:ext cx="4398059" cy="5098093"/>
          </a:xfrm>
          <a:prstGeom prst="rect">
            <a:avLst/>
          </a:prstGeom>
        </p:spPr>
      </p:pic>
      <p:grpSp>
        <p:nvGrpSpPr>
          <p:cNvPr id="46" name="Group 45">
            <a:extLst>
              <a:ext uri="{FF2B5EF4-FFF2-40B4-BE49-F238E27FC236}">
                <a16:creationId xmlns:a16="http://schemas.microsoft.com/office/drawing/2014/main" id="{571FE299-DC4C-456D-B453-6D3612CA6C4A}"/>
              </a:ext>
            </a:extLst>
          </p:cNvPr>
          <p:cNvGrpSpPr/>
          <p:nvPr/>
        </p:nvGrpSpPr>
        <p:grpSpPr>
          <a:xfrm>
            <a:off x="1104285" y="1741213"/>
            <a:ext cx="722104" cy="4501682"/>
            <a:chOff x="1104285" y="1741213"/>
            <a:chExt cx="722104" cy="4501682"/>
          </a:xfrm>
        </p:grpSpPr>
        <p:sp>
          <p:nvSpPr>
            <p:cNvPr id="11" name="TextBox 4">
              <a:extLst>
                <a:ext uri="{FF2B5EF4-FFF2-40B4-BE49-F238E27FC236}">
                  <a16:creationId xmlns:a16="http://schemas.microsoft.com/office/drawing/2014/main" id="{F2E0F8EB-6A17-4519-8941-9C026C8D5343}"/>
                </a:ext>
              </a:extLst>
            </p:cNvPr>
            <p:cNvSpPr txBox="1">
              <a:spLocks noChangeArrowheads="1"/>
            </p:cNvSpPr>
            <p:nvPr/>
          </p:nvSpPr>
          <p:spPr bwMode="auto">
            <a:xfrm>
              <a:off x="1104285" y="3269242"/>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50</a:t>
              </a:r>
            </a:p>
          </p:txBody>
        </p:sp>
        <p:sp>
          <p:nvSpPr>
            <p:cNvPr id="12" name="TextBox 5">
              <a:extLst>
                <a:ext uri="{FF2B5EF4-FFF2-40B4-BE49-F238E27FC236}">
                  <a16:creationId xmlns:a16="http://schemas.microsoft.com/office/drawing/2014/main" id="{B73E3516-8B03-49DF-A088-F9FAB84270AF}"/>
                </a:ext>
              </a:extLst>
            </p:cNvPr>
            <p:cNvSpPr txBox="1">
              <a:spLocks noChangeArrowheads="1"/>
            </p:cNvSpPr>
            <p:nvPr/>
          </p:nvSpPr>
          <p:spPr bwMode="auto">
            <a:xfrm>
              <a:off x="1104285" y="362574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37</a:t>
              </a:r>
            </a:p>
          </p:txBody>
        </p:sp>
        <p:sp>
          <p:nvSpPr>
            <p:cNvPr id="13" name="TextBox 7">
              <a:extLst>
                <a:ext uri="{FF2B5EF4-FFF2-40B4-BE49-F238E27FC236}">
                  <a16:creationId xmlns:a16="http://schemas.microsoft.com/office/drawing/2014/main" id="{C577332C-9E0C-4780-BE5A-157286FE0972}"/>
                </a:ext>
              </a:extLst>
            </p:cNvPr>
            <p:cNvSpPr txBox="1">
              <a:spLocks noChangeArrowheads="1"/>
            </p:cNvSpPr>
            <p:nvPr/>
          </p:nvSpPr>
          <p:spPr bwMode="auto">
            <a:xfrm>
              <a:off x="1104285" y="4194898"/>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5</a:t>
              </a:r>
            </a:p>
          </p:txBody>
        </p:sp>
        <p:sp>
          <p:nvSpPr>
            <p:cNvPr id="14" name="TextBox 11">
              <a:extLst>
                <a:ext uri="{FF2B5EF4-FFF2-40B4-BE49-F238E27FC236}">
                  <a16:creationId xmlns:a16="http://schemas.microsoft.com/office/drawing/2014/main" id="{64F90F78-CC53-4B4F-BEF9-29B76499379B}"/>
                </a:ext>
              </a:extLst>
            </p:cNvPr>
            <p:cNvSpPr txBox="1">
              <a:spLocks noChangeArrowheads="1"/>
            </p:cNvSpPr>
            <p:nvPr/>
          </p:nvSpPr>
          <p:spPr bwMode="auto">
            <a:xfrm>
              <a:off x="1104285" y="5950636"/>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a:t>
              </a:r>
            </a:p>
          </p:txBody>
        </p:sp>
        <p:sp>
          <p:nvSpPr>
            <p:cNvPr id="8" name="TextBox 7">
              <a:extLst>
                <a:ext uri="{FF2B5EF4-FFF2-40B4-BE49-F238E27FC236}">
                  <a16:creationId xmlns:a16="http://schemas.microsoft.com/office/drawing/2014/main" id="{FC904090-D9CA-4391-97BA-82CF8E2B292E}"/>
                </a:ext>
              </a:extLst>
            </p:cNvPr>
            <p:cNvSpPr txBox="1">
              <a:spLocks noChangeArrowheads="1"/>
            </p:cNvSpPr>
            <p:nvPr/>
          </p:nvSpPr>
          <p:spPr bwMode="auto">
            <a:xfrm>
              <a:off x="1104285" y="5265055"/>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a:t>
              </a:r>
            </a:p>
          </p:txBody>
        </p:sp>
        <p:sp>
          <p:nvSpPr>
            <p:cNvPr id="9" name="TextBox 4">
              <a:extLst>
                <a:ext uri="{FF2B5EF4-FFF2-40B4-BE49-F238E27FC236}">
                  <a16:creationId xmlns:a16="http://schemas.microsoft.com/office/drawing/2014/main" id="{A0586275-C5FD-4818-BFA4-0AF2D2746097}"/>
                </a:ext>
              </a:extLst>
            </p:cNvPr>
            <p:cNvSpPr txBox="1">
              <a:spLocks noChangeArrowheads="1"/>
            </p:cNvSpPr>
            <p:nvPr/>
          </p:nvSpPr>
          <p:spPr bwMode="auto">
            <a:xfrm>
              <a:off x="1104285" y="286646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75</a:t>
              </a:r>
            </a:p>
          </p:txBody>
        </p:sp>
        <p:sp>
          <p:nvSpPr>
            <p:cNvPr id="10" name="TextBox 7">
              <a:extLst>
                <a:ext uri="{FF2B5EF4-FFF2-40B4-BE49-F238E27FC236}">
                  <a16:creationId xmlns:a16="http://schemas.microsoft.com/office/drawing/2014/main" id="{DD60A8EC-DDF5-438E-8D7B-B8E72FBDB0A5}"/>
                </a:ext>
              </a:extLst>
            </p:cNvPr>
            <p:cNvSpPr txBox="1">
              <a:spLocks noChangeArrowheads="1"/>
            </p:cNvSpPr>
            <p:nvPr/>
          </p:nvSpPr>
          <p:spPr bwMode="auto">
            <a:xfrm>
              <a:off x="1104285" y="4692562"/>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0</a:t>
              </a:r>
            </a:p>
          </p:txBody>
        </p:sp>
        <p:sp>
          <p:nvSpPr>
            <p:cNvPr id="24" name="TextBox 4">
              <a:extLst>
                <a:ext uri="{FF2B5EF4-FFF2-40B4-BE49-F238E27FC236}">
                  <a16:creationId xmlns:a16="http://schemas.microsoft.com/office/drawing/2014/main" id="{235B5DA0-7FF9-4F0D-BA4F-A4A26F352F5D}"/>
                </a:ext>
              </a:extLst>
            </p:cNvPr>
            <p:cNvSpPr txBox="1">
              <a:spLocks noChangeArrowheads="1"/>
            </p:cNvSpPr>
            <p:nvPr/>
          </p:nvSpPr>
          <p:spPr bwMode="auto">
            <a:xfrm>
              <a:off x="1104285" y="2480248"/>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0</a:t>
              </a:r>
            </a:p>
          </p:txBody>
        </p:sp>
        <p:sp>
          <p:nvSpPr>
            <p:cNvPr id="25" name="TextBox 4">
              <a:extLst>
                <a:ext uri="{FF2B5EF4-FFF2-40B4-BE49-F238E27FC236}">
                  <a16:creationId xmlns:a16="http://schemas.microsoft.com/office/drawing/2014/main" id="{AEB09E58-9AAD-480D-AA94-CA026F0F648B}"/>
                </a:ext>
              </a:extLst>
            </p:cNvPr>
            <p:cNvSpPr txBox="1">
              <a:spLocks noChangeArrowheads="1"/>
            </p:cNvSpPr>
            <p:nvPr/>
          </p:nvSpPr>
          <p:spPr bwMode="auto">
            <a:xfrm>
              <a:off x="1104285" y="2645174"/>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0</a:t>
              </a:r>
            </a:p>
          </p:txBody>
        </p:sp>
        <p:sp>
          <p:nvSpPr>
            <p:cNvPr id="15" name="TextBox 4">
              <a:extLst>
                <a:ext uri="{FF2B5EF4-FFF2-40B4-BE49-F238E27FC236}">
                  <a16:creationId xmlns:a16="http://schemas.microsoft.com/office/drawing/2014/main" id="{B2C16086-67C3-48C0-964B-B7A424F2A592}"/>
                </a:ext>
              </a:extLst>
            </p:cNvPr>
            <p:cNvSpPr txBox="1">
              <a:spLocks noChangeArrowheads="1"/>
            </p:cNvSpPr>
            <p:nvPr/>
          </p:nvSpPr>
          <p:spPr bwMode="auto">
            <a:xfrm>
              <a:off x="1131425" y="1741213"/>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kDa</a:t>
              </a:r>
              <a:endParaRPr lang="en-US" altLang="en-US" sz="1299" dirty="0">
                <a:solidFill>
                  <a:srgbClr val="000000"/>
                </a:solidFill>
              </a:endParaRPr>
            </a:p>
          </p:txBody>
        </p:sp>
      </p:grpSp>
      <p:sp>
        <p:nvSpPr>
          <p:cNvPr id="26" name="TextBox 25">
            <a:extLst>
              <a:ext uri="{FF2B5EF4-FFF2-40B4-BE49-F238E27FC236}">
                <a16:creationId xmlns:a16="http://schemas.microsoft.com/office/drawing/2014/main" id="{D21808DA-9386-4258-80D4-B1478E87A2E1}"/>
              </a:ext>
            </a:extLst>
          </p:cNvPr>
          <p:cNvSpPr txBox="1"/>
          <p:nvPr/>
        </p:nvSpPr>
        <p:spPr>
          <a:xfrm rot="18305062">
            <a:off x="1402915" y="1211085"/>
            <a:ext cx="1903956" cy="276999"/>
          </a:xfrm>
          <a:prstGeom prst="rect">
            <a:avLst/>
          </a:prstGeom>
          <a:noFill/>
        </p:spPr>
        <p:txBody>
          <a:bodyPr wrap="square" rtlCol="0">
            <a:spAutoFit/>
          </a:bodyPr>
          <a:lstStyle/>
          <a:p>
            <a:r>
              <a:rPr lang="en-US" sz="1200" dirty="0"/>
              <a:t>Protein Standard</a:t>
            </a:r>
            <a:endParaRPr lang="en-CA" sz="1200" dirty="0"/>
          </a:p>
        </p:txBody>
      </p:sp>
      <p:sp>
        <p:nvSpPr>
          <p:cNvPr id="27" name="TextBox 26">
            <a:extLst>
              <a:ext uri="{FF2B5EF4-FFF2-40B4-BE49-F238E27FC236}">
                <a16:creationId xmlns:a16="http://schemas.microsoft.com/office/drawing/2014/main" id="{E69F42EE-E907-422B-9FAF-1F6964254626}"/>
              </a:ext>
            </a:extLst>
          </p:cNvPr>
          <p:cNvSpPr txBox="1"/>
          <p:nvPr/>
        </p:nvSpPr>
        <p:spPr>
          <a:xfrm rot="18305062">
            <a:off x="2082302" y="1130734"/>
            <a:ext cx="2105441" cy="276999"/>
          </a:xfrm>
          <a:prstGeom prst="rect">
            <a:avLst/>
          </a:prstGeom>
          <a:noFill/>
        </p:spPr>
        <p:txBody>
          <a:bodyPr wrap="square" rtlCol="0">
            <a:spAutoFit/>
          </a:bodyPr>
          <a:lstStyle/>
          <a:p>
            <a:r>
              <a:rPr lang="en-US" sz="1200" dirty="0"/>
              <a:t>Mock + Non-target siRNA</a:t>
            </a:r>
            <a:endParaRPr lang="en-CA" sz="1200" dirty="0"/>
          </a:p>
        </p:txBody>
      </p:sp>
      <p:sp>
        <p:nvSpPr>
          <p:cNvPr id="29" name="TextBox 28">
            <a:extLst>
              <a:ext uri="{FF2B5EF4-FFF2-40B4-BE49-F238E27FC236}">
                <a16:creationId xmlns:a16="http://schemas.microsoft.com/office/drawing/2014/main" id="{BC22E28F-B9B8-4BA3-AAE1-EBF8A49B3882}"/>
              </a:ext>
            </a:extLst>
          </p:cNvPr>
          <p:cNvSpPr txBox="1"/>
          <p:nvPr/>
        </p:nvSpPr>
        <p:spPr>
          <a:xfrm rot="18305062">
            <a:off x="2862432" y="1128232"/>
            <a:ext cx="2105441" cy="276999"/>
          </a:xfrm>
          <a:prstGeom prst="rect">
            <a:avLst/>
          </a:prstGeom>
          <a:noFill/>
        </p:spPr>
        <p:txBody>
          <a:bodyPr wrap="square" rtlCol="0">
            <a:spAutoFit/>
          </a:bodyPr>
          <a:lstStyle/>
          <a:p>
            <a:r>
              <a:rPr lang="en-US" sz="1200" dirty="0"/>
              <a:t>Mock + CDK siRNA</a:t>
            </a:r>
            <a:endParaRPr lang="en-CA" sz="1200" dirty="0"/>
          </a:p>
        </p:txBody>
      </p:sp>
      <p:sp>
        <p:nvSpPr>
          <p:cNvPr id="30" name="TextBox 29">
            <a:extLst>
              <a:ext uri="{FF2B5EF4-FFF2-40B4-BE49-F238E27FC236}">
                <a16:creationId xmlns:a16="http://schemas.microsoft.com/office/drawing/2014/main" id="{09C26701-8E1E-422A-A692-947C2FD6B0D0}"/>
              </a:ext>
            </a:extLst>
          </p:cNvPr>
          <p:cNvSpPr txBox="1"/>
          <p:nvPr/>
        </p:nvSpPr>
        <p:spPr>
          <a:xfrm rot="18305062">
            <a:off x="3642562" y="1078127"/>
            <a:ext cx="2105441" cy="276999"/>
          </a:xfrm>
          <a:prstGeom prst="rect">
            <a:avLst/>
          </a:prstGeom>
          <a:noFill/>
        </p:spPr>
        <p:txBody>
          <a:bodyPr wrap="square" rtlCol="0">
            <a:spAutoFit/>
          </a:bodyPr>
          <a:lstStyle/>
          <a:p>
            <a:r>
              <a:rPr lang="en-US" sz="1200" dirty="0"/>
              <a:t>HIV-HSA + Non-target siRNA</a:t>
            </a:r>
            <a:endParaRPr lang="en-CA" sz="1200" dirty="0"/>
          </a:p>
        </p:txBody>
      </p:sp>
      <p:sp>
        <p:nvSpPr>
          <p:cNvPr id="31" name="TextBox 30">
            <a:extLst>
              <a:ext uri="{FF2B5EF4-FFF2-40B4-BE49-F238E27FC236}">
                <a16:creationId xmlns:a16="http://schemas.microsoft.com/office/drawing/2014/main" id="{7CD576D9-30F3-4854-ADC6-5584381CBA7B}"/>
              </a:ext>
            </a:extLst>
          </p:cNvPr>
          <p:cNvSpPr txBox="1"/>
          <p:nvPr/>
        </p:nvSpPr>
        <p:spPr>
          <a:xfrm rot="18305062">
            <a:off x="4422691" y="1105267"/>
            <a:ext cx="2105441" cy="276999"/>
          </a:xfrm>
          <a:prstGeom prst="rect">
            <a:avLst/>
          </a:prstGeom>
          <a:noFill/>
        </p:spPr>
        <p:txBody>
          <a:bodyPr wrap="square" rtlCol="0">
            <a:spAutoFit/>
          </a:bodyPr>
          <a:lstStyle/>
          <a:p>
            <a:r>
              <a:rPr lang="en-US" sz="1200" dirty="0"/>
              <a:t>HIV-HSA + CDK siRNA</a:t>
            </a:r>
            <a:endParaRPr lang="en-CA" sz="1200" dirty="0"/>
          </a:p>
        </p:txBody>
      </p:sp>
      <p:sp>
        <p:nvSpPr>
          <p:cNvPr id="37" name="TextBox 13">
            <a:extLst>
              <a:ext uri="{FF2B5EF4-FFF2-40B4-BE49-F238E27FC236}">
                <a16:creationId xmlns:a16="http://schemas.microsoft.com/office/drawing/2014/main" id="{F7113CE4-AF49-48A5-9DCC-49AB871CDE3F}"/>
              </a:ext>
            </a:extLst>
          </p:cNvPr>
          <p:cNvSpPr txBox="1">
            <a:spLocks noChangeArrowheads="1"/>
          </p:cNvSpPr>
          <p:nvPr/>
        </p:nvSpPr>
        <p:spPr bwMode="auto">
          <a:xfrm>
            <a:off x="5821406" y="3418817"/>
            <a:ext cx="1343397" cy="2922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solidFill>
                  <a:srgbClr val="000000"/>
                </a:solidFill>
              </a:rPr>
              <a:t>β</a:t>
            </a:r>
            <a:r>
              <a:rPr lang="en-US" altLang="en-US" sz="1299" dirty="0">
                <a:solidFill>
                  <a:srgbClr val="000000"/>
                </a:solidFill>
              </a:rPr>
              <a:t>-actin: 42kDa</a:t>
            </a:r>
          </a:p>
        </p:txBody>
      </p:sp>
      <p:sp>
        <p:nvSpPr>
          <p:cNvPr id="38" name="TextBox 14">
            <a:extLst>
              <a:ext uri="{FF2B5EF4-FFF2-40B4-BE49-F238E27FC236}">
                <a16:creationId xmlns:a16="http://schemas.microsoft.com/office/drawing/2014/main" id="{AFBEC820-3626-4ED5-A868-2AF212FECD33}"/>
              </a:ext>
            </a:extLst>
          </p:cNvPr>
          <p:cNvSpPr txBox="1">
            <a:spLocks noChangeArrowheads="1"/>
          </p:cNvSpPr>
          <p:nvPr/>
        </p:nvSpPr>
        <p:spPr bwMode="auto">
          <a:xfrm>
            <a:off x="5825389" y="3884639"/>
            <a:ext cx="1658741" cy="2922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Cdk2: 33kDa</a:t>
            </a:r>
          </a:p>
        </p:txBody>
      </p:sp>
      <p:sp>
        <p:nvSpPr>
          <p:cNvPr id="40" name="TextBox 39">
            <a:extLst>
              <a:ext uri="{FF2B5EF4-FFF2-40B4-BE49-F238E27FC236}">
                <a16:creationId xmlns:a16="http://schemas.microsoft.com/office/drawing/2014/main" id="{1D589266-3798-48D8-B221-3D5C44F70777}"/>
              </a:ext>
            </a:extLst>
          </p:cNvPr>
          <p:cNvSpPr txBox="1"/>
          <p:nvPr/>
        </p:nvSpPr>
        <p:spPr>
          <a:xfrm>
            <a:off x="964503" y="7556604"/>
            <a:ext cx="5987442"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3 - Full blots corresponding to Figure 3E Cdk2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CA" sz="1200" dirty="0">
                <a:latin typeface="Times New Roman" panose="02020603050405020304" pitchFamily="18" charset="0"/>
                <a:cs typeface="Times New Roman" panose="02020603050405020304" pitchFamily="18" charset="0"/>
              </a:rPr>
              <a:t>r</a:t>
            </a:r>
            <a:r>
              <a:rPr lang="en-CA" sz="1200" kern="1200" dirty="0">
                <a:effectLst/>
                <a:latin typeface="Times New Roman" panose="02020603050405020304" pitchFamily="18" charset="0"/>
                <a:cs typeface="Times New Roman" panose="02020603050405020304" pitchFamily="18" charset="0"/>
              </a:rPr>
              <a:t>abbit anti-CDK2 monoclonal antibody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3E.</a:t>
            </a:r>
            <a:endParaRPr lang="en-US" sz="1200" kern="1200" dirty="0">
              <a:effectLst/>
              <a:latin typeface="Times New Roman" panose="02020603050405020304" pitchFamily="18" charset="0"/>
              <a:cs typeface="Times New Roman" panose="02020603050405020304" pitchFamily="18" charset="0"/>
            </a:endParaRPr>
          </a:p>
        </p:txBody>
      </p:sp>
      <p:sp>
        <p:nvSpPr>
          <p:cNvPr id="41" name="Rectangle 40">
            <a:extLst>
              <a:ext uri="{FF2B5EF4-FFF2-40B4-BE49-F238E27FC236}">
                <a16:creationId xmlns:a16="http://schemas.microsoft.com/office/drawing/2014/main" id="{0578DAEC-B93C-4C0C-BEB2-3BA1F99190BC}"/>
              </a:ext>
            </a:extLst>
          </p:cNvPr>
          <p:cNvSpPr/>
          <p:nvPr/>
        </p:nvSpPr>
        <p:spPr>
          <a:xfrm>
            <a:off x="2287421" y="3883068"/>
            <a:ext cx="3118981" cy="30062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42" name="Rectangle 41">
            <a:extLst>
              <a:ext uri="{FF2B5EF4-FFF2-40B4-BE49-F238E27FC236}">
                <a16:creationId xmlns:a16="http://schemas.microsoft.com/office/drawing/2014/main" id="{BC6D38F1-7409-4BA8-8A03-FB34DFB949B6}"/>
              </a:ext>
            </a:extLst>
          </p:cNvPr>
          <p:cNvSpPr/>
          <p:nvPr/>
        </p:nvSpPr>
        <p:spPr>
          <a:xfrm>
            <a:off x="2294351" y="3457184"/>
            <a:ext cx="3118981" cy="29018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4272782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white&#10;&#10;Description automatically generated">
            <a:extLst>
              <a:ext uri="{FF2B5EF4-FFF2-40B4-BE49-F238E27FC236}">
                <a16:creationId xmlns:a16="http://schemas.microsoft.com/office/drawing/2014/main" id="{D712A5CA-4CFB-455C-A35A-DF8C2163B35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3065" y="3519811"/>
            <a:ext cx="6304813" cy="4878269"/>
          </a:xfrm>
          <a:prstGeom prst="rect">
            <a:avLst/>
          </a:prstGeom>
        </p:spPr>
      </p:pic>
      <p:grpSp>
        <p:nvGrpSpPr>
          <p:cNvPr id="4" name="Group 3">
            <a:extLst>
              <a:ext uri="{FF2B5EF4-FFF2-40B4-BE49-F238E27FC236}">
                <a16:creationId xmlns:a16="http://schemas.microsoft.com/office/drawing/2014/main" id="{192BEC6B-DCF4-421B-9ECB-A7928E71D6A0}"/>
              </a:ext>
            </a:extLst>
          </p:cNvPr>
          <p:cNvGrpSpPr/>
          <p:nvPr/>
        </p:nvGrpSpPr>
        <p:grpSpPr>
          <a:xfrm>
            <a:off x="4483603" y="1593958"/>
            <a:ext cx="2520698" cy="2130908"/>
            <a:chOff x="3193421" y="191046"/>
            <a:chExt cx="2520698" cy="2130908"/>
          </a:xfrm>
        </p:grpSpPr>
        <p:sp>
          <p:nvSpPr>
            <p:cNvPr id="6" name="TextBox 5">
              <a:extLst>
                <a:ext uri="{FF2B5EF4-FFF2-40B4-BE49-F238E27FC236}">
                  <a16:creationId xmlns:a16="http://schemas.microsoft.com/office/drawing/2014/main" id="{CABC1B9C-DD10-4F45-819E-FEC0D7283BFC}"/>
                </a:ext>
              </a:extLst>
            </p:cNvPr>
            <p:cNvSpPr txBox="1"/>
            <p:nvPr/>
          </p:nvSpPr>
          <p:spPr>
            <a:xfrm rot="18305062">
              <a:off x="2379943" y="1211085"/>
              <a:ext cx="1903956" cy="276999"/>
            </a:xfrm>
            <a:prstGeom prst="rect">
              <a:avLst/>
            </a:prstGeom>
            <a:noFill/>
          </p:spPr>
          <p:txBody>
            <a:bodyPr wrap="square" rtlCol="0">
              <a:spAutoFit/>
            </a:bodyPr>
            <a:lstStyle/>
            <a:p>
              <a:r>
                <a:rPr lang="en-US" sz="1200" dirty="0"/>
                <a:t>Protein Standard</a:t>
              </a:r>
              <a:endParaRPr lang="en-CA" sz="1200" dirty="0"/>
            </a:p>
          </p:txBody>
        </p:sp>
        <p:sp>
          <p:nvSpPr>
            <p:cNvPr id="7" name="TextBox 6">
              <a:extLst>
                <a:ext uri="{FF2B5EF4-FFF2-40B4-BE49-F238E27FC236}">
                  <a16:creationId xmlns:a16="http://schemas.microsoft.com/office/drawing/2014/main" id="{6807DF18-A250-4879-9569-D52FE1625640}"/>
                </a:ext>
              </a:extLst>
            </p:cNvPr>
            <p:cNvSpPr txBox="1"/>
            <p:nvPr/>
          </p:nvSpPr>
          <p:spPr>
            <a:xfrm rot="18305062">
              <a:off x="2840125" y="1130734"/>
              <a:ext cx="2105441" cy="276999"/>
            </a:xfrm>
            <a:prstGeom prst="rect">
              <a:avLst/>
            </a:prstGeom>
            <a:noFill/>
          </p:spPr>
          <p:txBody>
            <a:bodyPr wrap="square" rtlCol="0">
              <a:spAutoFit/>
            </a:bodyPr>
            <a:lstStyle/>
            <a:p>
              <a:r>
                <a:rPr lang="en-US" sz="1200" dirty="0"/>
                <a:t>Mock + Non-target siRNA</a:t>
              </a:r>
              <a:endParaRPr lang="en-CA" sz="1200" dirty="0"/>
            </a:p>
          </p:txBody>
        </p:sp>
        <p:sp>
          <p:nvSpPr>
            <p:cNvPr id="8" name="TextBox 7">
              <a:extLst>
                <a:ext uri="{FF2B5EF4-FFF2-40B4-BE49-F238E27FC236}">
                  <a16:creationId xmlns:a16="http://schemas.microsoft.com/office/drawing/2014/main" id="{35527F7D-DFEF-48C9-AAFE-7F0AD97EF9EB}"/>
                </a:ext>
              </a:extLst>
            </p:cNvPr>
            <p:cNvSpPr txBox="1"/>
            <p:nvPr/>
          </p:nvSpPr>
          <p:spPr>
            <a:xfrm rot="18305062">
              <a:off x="3401050" y="1128232"/>
              <a:ext cx="2105441" cy="276999"/>
            </a:xfrm>
            <a:prstGeom prst="rect">
              <a:avLst/>
            </a:prstGeom>
            <a:noFill/>
          </p:spPr>
          <p:txBody>
            <a:bodyPr wrap="square" rtlCol="0">
              <a:spAutoFit/>
            </a:bodyPr>
            <a:lstStyle/>
            <a:p>
              <a:r>
                <a:rPr lang="en-US" sz="1200" dirty="0"/>
                <a:t>HIV-HSA + Non-target siRNA</a:t>
              </a:r>
              <a:endParaRPr lang="en-CA" sz="1200" dirty="0"/>
            </a:p>
          </p:txBody>
        </p:sp>
        <p:sp>
          <p:nvSpPr>
            <p:cNvPr id="9" name="TextBox 8">
              <a:extLst>
                <a:ext uri="{FF2B5EF4-FFF2-40B4-BE49-F238E27FC236}">
                  <a16:creationId xmlns:a16="http://schemas.microsoft.com/office/drawing/2014/main" id="{0F3C7DDE-40BC-4499-842E-3BA15400B0B8}"/>
                </a:ext>
              </a:extLst>
            </p:cNvPr>
            <p:cNvSpPr txBox="1"/>
            <p:nvPr/>
          </p:nvSpPr>
          <p:spPr>
            <a:xfrm rot="18305062">
              <a:off x="3961975" y="1128231"/>
              <a:ext cx="2105441" cy="276999"/>
            </a:xfrm>
            <a:prstGeom prst="rect">
              <a:avLst/>
            </a:prstGeom>
            <a:noFill/>
          </p:spPr>
          <p:txBody>
            <a:bodyPr wrap="square" rtlCol="0">
              <a:spAutoFit/>
            </a:bodyPr>
            <a:lstStyle/>
            <a:p>
              <a:r>
                <a:rPr lang="en-US" sz="1200" dirty="0"/>
                <a:t>HIV-HSA + COX7A2 siRNA</a:t>
              </a:r>
              <a:endParaRPr lang="en-CA" sz="1200" dirty="0"/>
            </a:p>
          </p:txBody>
        </p:sp>
        <p:sp>
          <p:nvSpPr>
            <p:cNvPr id="10" name="TextBox 9">
              <a:extLst>
                <a:ext uri="{FF2B5EF4-FFF2-40B4-BE49-F238E27FC236}">
                  <a16:creationId xmlns:a16="http://schemas.microsoft.com/office/drawing/2014/main" id="{17DF6728-775F-4E62-8761-2B2510B2EAAC}"/>
                </a:ext>
              </a:extLst>
            </p:cNvPr>
            <p:cNvSpPr txBox="1"/>
            <p:nvPr/>
          </p:nvSpPr>
          <p:spPr>
            <a:xfrm rot="18305062">
              <a:off x="4522899" y="1105267"/>
              <a:ext cx="2105441" cy="276999"/>
            </a:xfrm>
            <a:prstGeom prst="rect">
              <a:avLst/>
            </a:prstGeom>
            <a:noFill/>
          </p:spPr>
          <p:txBody>
            <a:bodyPr wrap="square" rtlCol="0">
              <a:spAutoFit/>
            </a:bodyPr>
            <a:lstStyle/>
            <a:p>
              <a:r>
                <a:rPr lang="en-US" sz="1200" dirty="0"/>
                <a:t>HIV-HSA + COX7A2 siRNA</a:t>
              </a:r>
              <a:endParaRPr lang="en-CA" sz="1200" dirty="0"/>
            </a:p>
          </p:txBody>
        </p:sp>
      </p:grpSp>
      <p:sp>
        <p:nvSpPr>
          <p:cNvPr id="12" name="TextBox 13">
            <a:extLst>
              <a:ext uri="{FF2B5EF4-FFF2-40B4-BE49-F238E27FC236}">
                <a16:creationId xmlns:a16="http://schemas.microsoft.com/office/drawing/2014/main" id="{C9DB8B25-1E62-45C1-B916-C005359545CC}"/>
              </a:ext>
            </a:extLst>
          </p:cNvPr>
          <p:cNvSpPr txBox="1">
            <a:spLocks noChangeArrowheads="1"/>
          </p:cNvSpPr>
          <p:nvPr/>
        </p:nvSpPr>
        <p:spPr bwMode="auto">
          <a:xfrm>
            <a:off x="6653139" y="5277360"/>
            <a:ext cx="705903"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solidFill>
                  <a:srgbClr val="000000"/>
                </a:solidFill>
              </a:rPr>
              <a:t>β</a:t>
            </a:r>
            <a:r>
              <a:rPr lang="en-US" altLang="en-US" sz="1299" dirty="0">
                <a:solidFill>
                  <a:srgbClr val="000000"/>
                </a:solidFill>
              </a:rPr>
              <a:t>-actin</a:t>
            </a:r>
          </a:p>
          <a:p>
            <a:pPr eaLnBrk="0" fontAlgn="base" hangingPunct="0">
              <a:spcBef>
                <a:spcPct val="0"/>
              </a:spcBef>
              <a:spcAft>
                <a:spcPct val="0"/>
              </a:spcAft>
              <a:buNone/>
            </a:pPr>
            <a:r>
              <a:rPr lang="en-US" altLang="en-US" sz="1299" dirty="0">
                <a:solidFill>
                  <a:srgbClr val="000000"/>
                </a:solidFill>
              </a:rPr>
              <a:t>42kDa</a:t>
            </a:r>
          </a:p>
        </p:txBody>
      </p:sp>
      <p:sp>
        <p:nvSpPr>
          <p:cNvPr id="13" name="TextBox 14">
            <a:extLst>
              <a:ext uri="{FF2B5EF4-FFF2-40B4-BE49-F238E27FC236}">
                <a16:creationId xmlns:a16="http://schemas.microsoft.com/office/drawing/2014/main" id="{0517B030-B3E9-4210-B6ED-CA64BD5B1C72}"/>
              </a:ext>
            </a:extLst>
          </p:cNvPr>
          <p:cNvSpPr txBox="1">
            <a:spLocks noChangeArrowheads="1"/>
          </p:cNvSpPr>
          <p:nvPr/>
        </p:nvSpPr>
        <p:spPr bwMode="auto">
          <a:xfrm>
            <a:off x="6662857" y="6509707"/>
            <a:ext cx="852761"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Cox7a2</a:t>
            </a:r>
          </a:p>
          <a:p>
            <a:pPr eaLnBrk="0" fontAlgn="base" hangingPunct="0">
              <a:spcBef>
                <a:spcPct val="0"/>
              </a:spcBef>
              <a:spcAft>
                <a:spcPct val="0"/>
              </a:spcAft>
              <a:buNone/>
            </a:pPr>
            <a:r>
              <a:rPr lang="en-US" altLang="en-US" sz="1299" dirty="0">
                <a:solidFill>
                  <a:srgbClr val="000000"/>
                </a:solidFill>
              </a:rPr>
              <a:t>11kDa</a:t>
            </a:r>
          </a:p>
        </p:txBody>
      </p:sp>
      <p:grpSp>
        <p:nvGrpSpPr>
          <p:cNvPr id="16" name="Group 15">
            <a:extLst>
              <a:ext uri="{FF2B5EF4-FFF2-40B4-BE49-F238E27FC236}">
                <a16:creationId xmlns:a16="http://schemas.microsoft.com/office/drawing/2014/main" id="{23F26196-9277-473E-9D32-C84F89019923}"/>
              </a:ext>
            </a:extLst>
          </p:cNvPr>
          <p:cNvGrpSpPr/>
          <p:nvPr/>
        </p:nvGrpSpPr>
        <p:grpSpPr>
          <a:xfrm>
            <a:off x="3511369" y="4722406"/>
            <a:ext cx="857802" cy="2334679"/>
            <a:chOff x="1043742" y="3219284"/>
            <a:chExt cx="857802" cy="2334679"/>
          </a:xfrm>
        </p:grpSpPr>
        <p:sp>
          <p:nvSpPr>
            <p:cNvPr id="17" name="TextBox 4">
              <a:extLst>
                <a:ext uri="{FF2B5EF4-FFF2-40B4-BE49-F238E27FC236}">
                  <a16:creationId xmlns:a16="http://schemas.microsoft.com/office/drawing/2014/main" id="{32A11330-A07D-47CD-8D93-46E5D25C6E89}"/>
                </a:ext>
              </a:extLst>
            </p:cNvPr>
            <p:cNvSpPr txBox="1">
              <a:spLocks noChangeArrowheads="1"/>
            </p:cNvSpPr>
            <p:nvPr/>
          </p:nvSpPr>
          <p:spPr bwMode="auto">
            <a:xfrm>
              <a:off x="1141863" y="368260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50</a:t>
              </a:r>
            </a:p>
          </p:txBody>
        </p:sp>
        <p:sp>
          <p:nvSpPr>
            <p:cNvPr id="18" name="TextBox 5">
              <a:extLst>
                <a:ext uri="{FF2B5EF4-FFF2-40B4-BE49-F238E27FC236}">
                  <a16:creationId xmlns:a16="http://schemas.microsoft.com/office/drawing/2014/main" id="{F24FF78C-B5CD-4A18-A661-F331B5B73F5F}"/>
                </a:ext>
              </a:extLst>
            </p:cNvPr>
            <p:cNvSpPr txBox="1">
              <a:spLocks noChangeArrowheads="1"/>
            </p:cNvSpPr>
            <p:nvPr/>
          </p:nvSpPr>
          <p:spPr bwMode="auto">
            <a:xfrm>
              <a:off x="1141863" y="4176886"/>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37</a:t>
              </a:r>
            </a:p>
          </p:txBody>
        </p:sp>
        <p:sp>
          <p:nvSpPr>
            <p:cNvPr id="19" name="TextBox 7">
              <a:extLst>
                <a:ext uri="{FF2B5EF4-FFF2-40B4-BE49-F238E27FC236}">
                  <a16:creationId xmlns:a16="http://schemas.microsoft.com/office/drawing/2014/main" id="{A006D2C8-D66E-423C-BD79-7B205244F392}"/>
                </a:ext>
              </a:extLst>
            </p:cNvPr>
            <p:cNvSpPr txBox="1">
              <a:spLocks noChangeArrowheads="1"/>
            </p:cNvSpPr>
            <p:nvPr/>
          </p:nvSpPr>
          <p:spPr bwMode="auto">
            <a:xfrm>
              <a:off x="1154389" y="458320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5</a:t>
              </a:r>
            </a:p>
          </p:txBody>
        </p:sp>
        <p:sp>
          <p:nvSpPr>
            <p:cNvPr id="20" name="TextBox 11">
              <a:extLst>
                <a:ext uri="{FF2B5EF4-FFF2-40B4-BE49-F238E27FC236}">
                  <a16:creationId xmlns:a16="http://schemas.microsoft.com/office/drawing/2014/main" id="{149380CE-5226-4D19-A4FB-F2C4BECEF37E}"/>
                </a:ext>
              </a:extLst>
            </p:cNvPr>
            <p:cNvSpPr txBox="1">
              <a:spLocks noChangeArrowheads="1"/>
            </p:cNvSpPr>
            <p:nvPr/>
          </p:nvSpPr>
          <p:spPr bwMode="auto">
            <a:xfrm>
              <a:off x="1129337" y="526170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a:t>
              </a:r>
            </a:p>
          </p:txBody>
        </p:sp>
        <p:sp>
          <p:nvSpPr>
            <p:cNvPr id="21" name="TextBox 20">
              <a:extLst>
                <a:ext uri="{FF2B5EF4-FFF2-40B4-BE49-F238E27FC236}">
                  <a16:creationId xmlns:a16="http://schemas.microsoft.com/office/drawing/2014/main" id="{28DEC9F9-4EAE-4C7D-8D72-34A7CD26F7B5}"/>
                </a:ext>
              </a:extLst>
            </p:cNvPr>
            <p:cNvSpPr txBox="1">
              <a:spLocks noChangeArrowheads="1"/>
            </p:cNvSpPr>
            <p:nvPr/>
          </p:nvSpPr>
          <p:spPr bwMode="auto">
            <a:xfrm>
              <a:off x="1141863" y="5077165"/>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a:t>
              </a:r>
            </a:p>
          </p:txBody>
        </p:sp>
        <p:sp>
          <p:nvSpPr>
            <p:cNvPr id="22" name="TextBox 4">
              <a:extLst>
                <a:ext uri="{FF2B5EF4-FFF2-40B4-BE49-F238E27FC236}">
                  <a16:creationId xmlns:a16="http://schemas.microsoft.com/office/drawing/2014/main" id="{03EAC110-9A8F-47F0-8933-589A38FA3B8F}"/>
                </a:ext>
              </a:extLst>
            </p:cNvPr>
            <p:cNvSpPr txBox="1">
              <a:spLocks noChangeArrowheads="1"/>
            </p:cNvSpPr>
            <p:nvPr/>
          </p:nvSpPr>
          <p:spPr bwMode="auto">
            <a:xfrm>
              <a:off x="1141863" y="353034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75</a:t>
              </a:r>
            </a:p>
          </p:txBody>
        </p:sp>
        <p:sp>
          <p:nvSpPr>
            <p:cNvPr id="23" name="TextBox 7">
              <a:extLst>
                <a:ext uri="{FF2B5EF4-FFF2-40B4-BE49-F238E27FC236}">
                  <a16:creationId xmlns:a16="http://schemas.microsoft.com/office/drawing/2014/main" id="{C58C6F21-786C-4A1C-9208-4BDBA5E5D7C0}"/>
                </a:ext>
              </a:extLst>
            </p:cNvPr>
            <p:cNvSpPr txBox="1">
              <a:spLocks noChangeArrowheads="1"/>
            </p:cNvSpPr>
            <p:nvPr/>
          </p:nvSpPr>
          <p:spPr bwMode="auto">
            <a:xfrm>
              <a:off x="1179441" y="4767718"/>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0</a:t>
              </a:r>
            </a:p>
          </p:txBody>
        </p:sp>
        <p:sp>
          <p:nvSpPr>
            <p:cNvPr id="26" name="TextBox 4">
              <a:extLst>
                <a:ext uri="{FF2B5EF4-FFF2-40B4-BE49-F238E27FC236}">
                  <a16:creationId xmlns:a16="http://schemas.microsoft.com/office/drawing/2014/main" id="{96698DE4-13C8-4F6D-ACA0-E594FFA6A3AB}"/>
                </a:ext>
              </a:extLst>
            </p:cNvPr>
            <p:cNvSpPr txBox="1">
              <a:spLocks noChangeArrowheads="1"/>
            </p:cNvSpPr>
            <p:nvPr/>
          </p:nvSpPr>
          <p:spPr bwMode="auto">
            <a:xfrm>
              <a:off x="1043742" y="3219284"/>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kDa</a:t>
              </a:r>
              <a:endParaRPr lang="en-US" altLang="en-US" sz="1299" dirty="0">
                <a:solidFill>
                  <a:srgbClr val="000000"/>
                </a:solidFill>
              </a:endParaRPr>
            </a:p>
          </p:txBody>
        </p:sp>
      </p:grpSp>
      <p:sp>
        <p:nvSpPr>
          <p:cNvPr id="28" name="TextBox 27">
            <a:extLst>
              <a:ext uri="{FF2B5EF4-FFF2-40B4-BE49-F238E27FC236}">
                <a16:creationId xmlns:a16="http://schemas.microsoft.com/office/drawing/2014/main" id="{A941FE8C-4D15-47CF-A939-82D70870E0BA}"/>
              </a:ext>
            </a:extLst>
          </p:cNvPr>
          <p:cNvSpPr txBox="1"/>
          <p:nvPr/>
        </p:nvSpPr>
        <p:spPr>
          <a:xfrm>
            <a:off x="713983" y="8496055"/>
            <a:ext cx="613775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4 - Full blots corresponding to Figure 3E Cox7a2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rabbit anti-COX7A2 polyclonal antibody C-terminal end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3E.</a:t>
            </a:r>
            <a:endParaRPr lang="en-US" sz="1200" kern="1200" dirty="0">
              <a:effectLst/>
              <a:latin typeface="Times New Roman" panose="02020603050405020304" pitchFamily="18" charset="0"/>
              <a:cs typeface="Times New Roman" panose="02020603050405020304" pitchFamily="18" charset="0"/>
            </a:endParaRPr>
          </a:p>
        </p:txBody>
      </p:sp>
      <p:sp>
        <p:nvSpPr>
          <p:cNvPr id="29" name="Rectangle 28">
            <a:extLst>
              <a:ext uri="{FF2B5EF4-FFF2-40B4-BE49-F238E27FC236}">
                <a16:creationId xmlns:a16="http://schemas.microsoft.com/office/drawing/2014/main" id="{C6B48D1E-B713-46E3-A3AD-963C7A304D37}"/>
              </a:ext>
            </a:extLst>
          </p:cNvPr>
          <p:cNvSpPr/>
          <p:nvPr/>
        </p:nvSpPr>
        <p:spPr>
          <a:xfrm>
            <a:off x="4308954" y="6601214"/>
            <a:ext cx="2342367" cy="35073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30" name="Rectangle 29">
            <a:extLst>
              <a:ext uri="{FF2B5EF4-FFF2-40B4-BE49-F238E27FC236}">
                <a16:creationId xmlns:a16="http://schemas.microsoft.com/office/drawing/2014/main" id="{FC1A4AB8-9A9D-410B-A80D-A5CADABE8804}"/>
              </a:ext>
            </a:extLst>
          </p:cNvPr>
          <p:cNvSpPr/>
          <p:nvPr/>
        </p:nvSpPr>
        <p:spPr>
          <a:xfrm>
            <a:off x="4346532" y="5350698"/>
            <a:ext cx="2317316" cy="3507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grpSp>
        <p:nvGrpSpPr>
          <p:cNvPr id="24" name="Group 23">
            <a:extLst>
              <a:ext uri="{FF2B5EF4-FFF2-40B4-BE49-F238E27FC236}">
                <a16:creationId xmlns:a16="http://schemas.microsoft.com/office/drawing/2014/main" id="{BDA0A74B-5B13-4A2A-9CB4-BA5BEABFA8A6}"/>
              </a:ext>
            </a:extLst>
          </p:cNvPr>
          <p:cNvGrpSpPr/>
          <p:nvPr/>
        </p:nvGrpSpPr>
        <p:grpSpPr>
          <a:xfrm>
            <a:off x="1629757" y="1172156"/>
            <a:ext cx="2676012" cy="2620955"/>
            <a:chOff x="1629757" y="445648"/>
            <a:chExt cx="2676012" cy="2620955"/>
          </a:xfrm>
        </p:grpSpPr>
        <p:sp>
          <p:nvSpPr>
            <p:cNvPr id="25" name="TextBox 24">
              <a:extLst>
                <a:ext uri="{FF2B5EF4-FFF2-40B4-BE49-F238E27FC236}">
                  <a16:creationId xmlns:a16="http://schemas.microsoft.com/office/drawing/2014/main" id="{5CD08A4A-1306-4A74-88FD-0A5E5053BDB1}"/>
                </a:ext>
              </a:extLst>
            </p:cNvPr>
            <p:cNvSpPr txBox="1"/>
            <p:nvPr/>
          </p:nvSpPr>
          <p:spPr>
            <a:xfrm rot="18305062">
              <a:off x="816279" y="1914629"/>
              <a:ext cx="1903956"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Protein Standard</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7" name="TextBox 26">
              <a:extLst>
                <a:ext uri="{FF2B5EF4-FFF2-40B4-BE49-F238E27FC236}">
                  <a16:creationId xmlns:a16="http://schemas.microsoft.com/office/drawing/2014/main" id="{9A1E90CB-CBB9-457B-84B6-2AD12D49801A}"/>
                </a:ext>
              </a:extLst>
            </p:cNvPr>
            <p:cNvSpPr txBox="1"/>
            <p:nvPr/>
          </p:nvSpPr>
          <p:spPr>
            <a:xfrm rot="18305062">
              <a:off x="1276461" y="1834278"/>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7-days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1" name="TextBox 30">
              <a:extLst>
                <a:ext uri="{FF2B5EF4-FFF2-40B4-BE49-F238E27FC236}">
                  <a16:creationId xmlns:a16="http://schemas.microsoft.com/office/drawing/2014/main" id="{57FB2952-ABCE-4815-9426-0070102EFB6A}"/>
                </a:ext>
              </a:extLst>
            </p:cNvPr>
            <p:cNvSpPr txBox="1"/>
            <p:nvPr/>
          </p:nvSpPr>
          <p:spPr>
            <a:xfrm rot="18305062">
              <a:off x="1837386" y="1831776"/>
              <a:ext cx="2105441"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Non-target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2" name="TextBox 31">
              <a:extLst>
                <a:ext uri="{FF2B5EF4-FFF2-40B4-BE49-F238E27FC236}">
                  <a16:creationId xmlns:a16="http://schemas.microsoft.com/office/drawing/2014/main" id="{3139F859-386D-4AAE-8FEE-54B4A042242A}"/>
                </a:ext>
              </a:extLst>
            </p:cNvPr>
            <p:cNvSpPr txBox="1"/>
            <p:nvPr/>
          </p:nvSpPr>
          <p:spPr>
            <a:xfrm rot="18305062">
              <a:off x="2296253" y="1635371"/>
              <a:ext cx="2585465"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Accell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3" name="TextBox 32">
              <a:extLst>
                <a:ext uri="{FF2B5EF4-FFF2-40B4-BE49-F238E27FC236}">
                  <a16:creationId xmlns:a16="http://schemas.microsoft.com/office/drawing/2014/main" id="{CC80B6DD-ECB1-4A4F-91D5-45E4266D459B}"/>
                </a:ext>
              </a:extLst>
            </p:cNvPr>
            <p:cNvSpPr txBox="1"/>
            <p:nvPr/>
          </p:nvSpPr>
          <p:spPr>
            <a:xfrm rot="18305062">
              <a:off x="2874537" y="1599881"/>
              <a:ext cx="2585465"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days + </a:t>
              </a:r>
              <a:r>
                <a:rPr kumimoji="0" lang="en-US" sz="1200" b="0" i="0" u="none" strike="noStrike" kern="1200" cap="none" spc="0" normalizeH="0" baseline="0" noProof="0" dirty="0" err="1">
                  <a:ln>
                    <a:noFill/>
                  </a:ln>
                  <a:solidFill>
                    <a:prstClr val="black"/>
                  </a:solidFill>
                  <a:effectLst/>
                  <a:uLnTx/>
                  <a:uFillTx/>
                  <a:latin typeface="Calibri" panose="020F0502020204030204"/>
                  <a:ea typeface="+mn-ea"/>
                  <a:cs typeface="+mn-cs"/>
                </a:rPr>
                <a:t>Ontarget</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Plus COX7A2 siRNA</a:t>
              </a:r>
              <a:endParaRPr kumimoji="0" lang="en-C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spTree>
    <p:extLst>
      <p:ext uri="{BB962C8B-B14F-4D97-AF65-F5344CB8AC3E}">
        <p14:creationId xmlns:p14="http://schemas.microsoft.com/office/powerpoint/2010/main" val="15244483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lose-up of a piece of paper&#10;&#10;Description automatically generated with low confidence">
            <a:extLst>
              <a:ext uri="{FF2B5EF4-FFF2-40B4-BE49-F238E27FC236}">
                <a16:creationId xmlns:a16="http://schemas.microsoft.com/office/drawing/2014/main" id="{346975D3-1D78-4F3F-ACE8-1142FFB6354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15739" y="2755565"/>
            <a:ext cx="4296337" cy="5438103"/>
          </a:xfrm>
          <a:prstGeom prst="rect">
            <a:avLst/>
          </a:prstGeom>
        </p:spPr>
      </p:pic>
      <p:grpSp>
        <p:nvGrpSpPr>
          <p:cNvPr id="8" name="Group 7">
            <a:extLst>
              <a:ext uri="{FF2B5EF4-FFF2-40B4-BE49-F238E27FC236}">
                <a16:creationId xmlns:a16="http://schemas.microsoft.com/office/drawing/2014/main" id="{1330D5C4-F491-461E-9A88-17C8BF6B2F04}"/>
              </a:ext>
            </a:extLst>
          </p:cNvPr>
          <p:cNvGrpSpPr/>
          <p:nvPr/>
        </p:nvGrpSpPr>
        <p:grpSpPr>
          <a:xfrm>
            <a:off x="2253972" y="764086"/>
            <a:ext cx="3209628" cy="2168487"/>
            <a:chOff x="2128711" y="153467"/>
            <a:chExt cx="3209628" cy="2168487"/>
          </a:xfrm>
        </p:grpSpPr>
        <p:sp>
          <p:nvSpPr>
            <p:cNvPr id="9" name="TextBox 8">
              <a:extLst>
                <a:ext uri="{FF2B5EF4-FFF2-40B4-BE49-F238E27FC236}">
                  <a16:creationId xmlns:a16="http://schemas.microsoft.com/office/drawing/2014/main" id="{BC54CE21-2343-4D89-9B65-62D8A1F02028}"/>
                </a:ext>
              </a:extLst>
            </p:cNvPr>
            <p:cNvSpPr txBox="1"/>
            <p:nvPr/>
          </p:nvSpPr>
          <p:spPr>
            <a:xfrm rot="18305062">
              <a:off x="1315233" y="1211085"/>
              <a:ext cx="1903956" cy="276999"/>
            </a:xfrm>
            <a:prstGeom prst="rect">
              <a:avLst/>
            </a:prstGeom>
            <a:noFill/>
          </p:spPr>
          <p:txBody>
            <a:bodyPr wrap="square" rtlCol="0">
              <a:spAutoFit/>
            </a:bodyPr>
            <a:lstStyle/>
            <a:p>
              <a:r>
                <a:rPr lang="en-US" sz="1200" dirty="0"/>
                <a:t>Protein Standard</a:t>
              </a:r>
              <a:endParaRPr lang="en-CA" sz="1200" dirty="0"/>
            </a:p>
          </p:txBody>
        </p:sp>
        <p:sp>
          <p:nvSpPr>
            <p:cNvPr id="10" name="TextBox 9">
              <a:extLst>
                <a:ext uri="{FF2B5EF4-FFF2-40B4-BE49-F238E27FC236}">
                  <a16:creationId xmlns:a16="http://schemas.microsoft.com/office/drawing/2014/main" id="{76EC011B-F837-4122-A461-72C365A3292E}"/>
                </a:ext>
              </a:extLst>
            </p:cNvPr>
            <p:cNvSpPr txBox="1"/>
            <p:nvPr/>
          </p:nvSpPr>
          <p:spPr>
            <a:xfrm rot="18305062">
              <a:off x="1947647" y="1130734"/>
              <a:ext cx="2105441" cy="276999"/>
            </a:xfrm>
            <a:prstGeom prst="rect">
              <a:avLst/>
            </a:prstGeom>
            <a:noFill/>
          </p:spPr>
          <p:txBody>
            <a:bodyPr wrap="square" rtlCol="0">
              <a:spAutoFit/>
            </a:bodyPr>
            <a:lstStyle/>
            <a:p>
              <a:r>
                <a:rPr lang="en-US" sz="1200" dirty="0"/>
                <a:t>Mock + Non-target siRNA</a:t>
              </a:r>
              <a:endParaRPr lang="en-CA" sz="1200" dirty="0"/>
            </a:p>
          </p:txBody>
        </p:sp>
        <p:sp>
          <p:nvSpPr>
            <p:cNvPr id="11" name="TextBox 10">
              <a:extLst>
                <a:ext uri="{FF2B5EF4-FFF2-40B4-BE49-F238E27FC236}">
                  <a16:creationId xmlns:a16="http://schemas.microsoft.com/office/drawing/2014/main" id="{3416C2B4-AED9-4174-981F-F39E54845FD5}"/>
                </a:ext>
              </a:extLst>
            </p:cNvPr>
            <p:cNvSpPr txBox="1"/>
            <p:nvPr/>
          </p:nvSpPr>
          <p:spPr>
            <a:xfrm rot="18305062">
              <a:off x="2680804" y="1128232"/>
              <a:ext cx="2105441" cy="276999"/>
            </a:xfrm>
            <a:prstGeom prst="rect">
              <a:avLst/>
            </a:prstGeom>
            <a:noFill/>
          </p:spPr>
          <p:txBody>
            <a:bodyPr wrap="square" rtlCol="0">
              <a:spAutoFit/>
            </a:bodyPr>
            <a:lstStyle/>
            <a:p>
              <a:r>
                <a:rPr lang="en-US" sz="1200" dirty="0"/>
                <a:t>HIV-HSA + CSTF2T siRNA</a:t>
              </a:r>
              <a:endParaRPr lang="en-CA" sz="1200" dirty="0"/>
            </a:p>
          </p:txBody>
        </p:sp>
        <p:sp>
          <p:nvSpPr>
            <p:cNvPr id="12" name="TextBox 11">
              <a:extLst>
                <a:ext uri="{FF2B5EF4-FFF2-40B4-BE49-F238E27FC236}">
                  <a16:creationId xmlns:a16="http://schemas.microsoft.com/office/drawing/2014/main" id="{8E00BDF3-B2D3-49B7-8079-B6F49C956344}"/>
                </a:ext>
              </a:extLst>
            </p:cNvPr>
            <p:cNvSpPr txBox="1"/>
            <p:nvPr/>
          </p:nvSpPr>
          <p:spPr>
            <a:xfrm rot="18305062">
              <a:off x="3413961" y="1078127"/>
              <a:ext cx="2105441" cy="276999"/>
            </a:xfrm>
            <a:prstGeom prst="rect">
              <a:avLst/>
            </a:prstGeom>
            <a:noFill/>
          </p:spPr>
          <p:txBody>
            <a:bodyPr wrap="square" rtlCol="0">
              <a:spAutoFit/>
            </a:bodyPr>
            <a:lstStyle/>
            <a:p>
              <a:r>
                <a:rPr lang="en-US" sz="1200" dirty="0"/>
                <a:t>HIV-HSA + Non-target siRNA</a:t>
              </a:r>
              <a:endParaRPr lang="en-CA" sz="1200" dirty="0"/>
            </a:p>
          </p:txBody>
        </p:sp>
        <p:sp>
          <p:nvSpPr>
            <p:cNvPr id="13" name="TextBox 12">
              <a:extLst>
                <a:ext uri="{FF2B5EF4-FFF2-40B4-BE49-F238E27FC236}">
                  <a16:creationId xmlns:a16="http://schemas.microsoft.com/office/drawing/2014/main" id="{3727B104-C384-4412-9933-666D6BCF690D}"/>
                </a:ext>
              </a:extLst>
            </p:cNvPr>
            <p:cNvSpPr txBox="1"/>
            <p:nvPr/>
          </p:nvSpPr>
          <p:spPr>
            <a:xfrm rot="18305062">
              <a:off x="4147119" y="1067688"/>
              <a:ext cx="2105441" cy="276999"/>
            </a:xfrm>
            <a:prstGeom prst="rect">
              <a:avLst/>
            </a:prstGeom>
            <a:noFill/>
          </p:spPr>
          <p:txBody>
            <a:bodyPr wrap="square" rtlCol="0">
              <a:spAutoFit/>
            </a:bodyPr>
            <a:lstStyle/>
            <a:p>
              <a:r>
                <a:rPr lang="en-US" sz="1200" dirty="0"/>
                <a:t>HIV-HSA + CSTF2T siRNA</a:t>
              </a:r>
              <a:endParaRPr lang="en-CA" sz="1200" dirty="0"/>
            </a:p>
          </p:txBody>
        </p:sp>
      </p:grpSp>
      <p:grpSp>
        <p:nvGrpSpPr>
          <p:cNvPr id="14" name="Group 13">
            <a:extLst>
              <a:ext uri="{FF2B5EF4-FFF2-40B4-BE49-F238E27FC236}">
                <a16:creationId xmlns:a16="http://schemas.microsoft.com/office/drawing/2014/main" id="{52FF0975-ECE9-4689-B5B6-4B2E9D199DB2}"/>
              </a:ext>
            </a:extLst>
          </p:cNvPr>
          <p:cNvGrpSpPr/>
          <p:nvPr/>
        </p:nvGrpSpPr>
        <p:grpSpPr>
          <a:xfrm>
            <a:off x="1014609" y="2918657"/>
            <a:ext cx="807698" cy="4163479"/>
            <a:chOff x="1056269" y="2217202"/>
            <a:chExt cx="807698" cy="4163479"/>
          </a:xfrm>
        </p:grpSpPr>
        <p:sp>
          <p:nvSpPr>
            <p:cNvPr id="15" name="TextBox 4">
              <a:extLst>
                <a:ext uri="{FF2B5EF4-FFF2-40B4-BE49-F238E27FC236}">
                  <a16:creationId xmlns:a16="http://schemas.microsoft.com/office/drawing/2014/main" id="{C6C64BB5-69B0-4368-92BC-F999F4B7B2C4}"/>
                </a:ext>
              </a:extLst>
            </p:cNvPr>
            <p:cNvSpPr txBox="1">
              <a:spLocks noChangeArrowheads="1"/>
            </p:cNvSpPr>
            <p:nvPr/>
          </p:nvSpPr>
          <p:spPr bwMode="auto">
            <a:xfrm>
              <a:off x="1104285" y="3269242"/>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50</a:t>
              </a:r>
            </a:p>
          </p:txBody>
        </p:sp>
        <p:sp>
          <p:nvSpPr>
            <p:cNvPr id="16" name="TextBox 5">
              <a:extLst>
                <a:ext uri="{FF2B5EF4-FFF2-40B4-BE49-F238E27FC236}">
                  <a16:creationId xmlns:a16="http://schemas.microsoft.com/office/drawing/2014/main" id="{F8F198F4-A560-4DB9-99E9-15EF052D26D2}"/>
                </a:ext>
              </a:extLst>
            </p:cNvPr>
            <p:cNvSpPr txBox="1">
              <a:spLocks noChangeArrowheads="1"/>
            </p:cNvSpPr>
            <p:nvPr/>
          </p:nvSpPr>
          <p:spPr bwMode="auto">
            <a:xfrm>
              <a:off x="1104285" y="362574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37</a:t>
              </a:r>
            </a:p>
          </p:txBody>
        </p:sp>
        <p:sp>
          <p:nvSpPr>
            <p:cNvPr id="17" name="TextBox 7">
              <a:extLst>
                <a:ext uri="{FF2B5EF4-FFF2-40B4-BE49-F238E27FC236}">
                  <a16:creationId xmlns:a16="http://schemas.microsoft.com/office/drawing/2014/main" id="{5160FB62-B5DA-4D95-B50A-5B9A5DF65C74}"/>
                </a:ext>
              </a:extLst>
            </p:cNvPr>
            <p:cNvSpPr txBox="1">
              <a:spLocks noChangeArrowheads="1"/>
            </p:cNvSpPr>
            <p:nvPr/>
          </p:nvSpPr>
          <p:spPr bwMode="auto">
            <a:xfrm>
              <a:off x="1104285" y="4194898"/>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5</a:t>
              </a:r>
            </a:p>
          </p:txBody>
        </p:sp>
        <p:sp>
          <p:nvSpPr>
            <p:cNvPr id="18" name="TextBox 11">
              <a:extLst>
                <a:ext uri="{FF2B5EF4-FFF2-40B4-BE49-F238E27FC236}">
                  <a16:creationId xmlns:a16="http://schemas.microsoft.com/office/drawing/2014/main" id="{376A89F4-0CED-44FC-980C-F847F554699A}"/>
                </a:ext>
              </a:extLst>
            </p:cNvPr>
            <p:cNvSpPr txBox="1">
              <a:spLocks noChangeArrowheads="1"/>
            </p:cNvSpPr>
            <p:nvPr/>
          </p:nvSpPr>
          <p:spPr bwMode="auto">
            <a:xfrm>
              <a:off x="1141863" y="6088422"/>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a:t>
              </a:r>
            </a:p>
          </p:txBody>
        </p:sp>
        <p:sp>
          <p:nvSpPr>
            <p:cNvPr id="19" name="TextBox 18">
              <a:extLst>
                <a:ext uri="{FF2B5EF4-FFF2-40B4-BE49-F238E27FC236}">
                  <a16:creationId xmlns:a16="http://schemas.microsoft.com/office/drawing/2014/main" id="{014E83B0-209B-4413-A4AC-A22C49009050}"/>
                </a:ext>
              </a:extLst>
            </p:cNvPr>
            <p:cNvSpPr txBox="1">
              <a:spLocks noChangeArrowheads="1"/>
            </p:cNvSpPr>
            <p:nvPr/>
          </p:nvSpPr>
          <p:spPr bwMode="auto">
            <a:xfrm>
              <a:off x="1104285" y="5189899"/>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a:t>
              </a:r>
            </a:p>
          </p:txBody>
        </p:sp>
        <p:sp>
          <p:nvSpPr>
            <p:cNvPr id="20" name="TextBox 4">
              <a:extLst>
                <a:ext uri="{FF2B5EF4-FFF2-40B4-BE49-F238E27FC236}">
                  <a16:creationId xmlns:a16="http://schemas.microsoft.com/office/drawing/2014/main" id="{C1269DFE-4D5D-4A76-89EA-7485FD36A53D}"/>
                </a:ext>
              </a:extLst>
            </p:cNvPr>
            <p:cNvSpPr txBox="1">
              <a:spLocks noChangeArrowheads="1"/>
            </p:cNvSpPr>
            <p:nvPr/>
          </p:nvSpPr>
          <p:spPr bwMode="auto">
            <a:xfrm>
              <a:off x="1116811" y="2966675"/>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75</a:t>
              </a:r>
            </a:p>
          </p:txBody>
        </p:sp>
        <p:sp>
          <p:nvSpPr>
            <p:cNvPr id="21" name="TextBox 7">
              <a:extLst>
                <a:ext uri="{FF2B5EF4-FFF2-40B4-BE49-F238E27FC236}">
                  <a16:creationId xmlns:a16="http://schemas.microsoft.com/office/drawing/2014/main" id="{4E60D663-1967-4319-8E35-E99E3DBAA729}"/>
                </a:ext>
              </a:extLst>
            </p:cNvPr>
            <p:cNvSpPr txBox="1">
              <a:spLocks noChangeArrowheads="1"/>
            </p:cNvSpPr>
            <p:nvPr/>
          </p:nvSpPr>
          <p:spPr bwMode="auto">
            <a:xfrm>
              <a:off x="1104285" y="4592354"/>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0</a:t>
              </a:r>
            </a:p>
          </p:txBody>
        </p:sp>
        <p:sp>
          <p:nvSpPr>
            <p:cNvPr id="22" name="TextBox 4">
              <a:extLst>
                <a:ext uri="{FF2B5EF4-FFF2-40B4-BE49-F238E27FC236}">
                  <a16:creationId xmlns:a16="http://schemas.microsoft.com/office/drawing/2014/main" id="{872D9243-86C9-48B2-8897-91B8E5E9821E}"/>
                </a:ext>
              </a:extLst>
            </p:cNvPr>
            <p:cNvSpPr txBox="1">
              <a:spLocks noChangeArrowheads="1"/>
            </p:cNvSpPr>
            <p:nvPr/>
          </p:nvSpPr>
          <p:spPr bwMode="auto">
            <a:xfrm>
              <a:off x="1104285" y="2567930"/>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0</a:t>
              </a:r>
            </a:p>
          </p:txBody>
        </p:sp>
        <p:sp>
          <p:nvSpPr>
            <p:cNvPr id="23" name="TextBox 4">
              <a:extLst>
                <a:ext uri="{FF2B5EF4-FFF2-40B4-BE49-F238E27FC236}">
                  <a16:creationId xmlns:a16="http://schemas.microsoft.com/office/drawing/2014/main" id="{BC7FDF84-2C85-4814-912C-708A739A85DB}"/>
                </a:ext>
              </a:extLst>
            </p:cNvPr>
            <p:cNvSpPr txBox="1">
              <a:spLocks noChangeArrowheads="1"/>
            </p:cNvSpPr>
            <p:nvPr/>
          </p:nvSpPr>
          <p:spPr bwMode="auto">
            <a:xfrm>
              <a:off x="1104285" y="2745382"/>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0</a:t>
              </a:r>
            </a:p>
          </p:txBody>
        </p:sp>
        <p:sp>
          <p:nvSpPr>
            <p:cNvPr id="24" name="TextBox 4">
              <a:extLst>
                <a:ext uri="{FF2B5EF4-FFF2-40B4-BE49-F238E27FC236}">
                  <a16:creationId xmlns:a16="http://schemas.microsoft.com/office/drawing/2014/main" id="{48DF8348-E3D2-4078-8582-39BDE87C0E74}"/>
                </a:ext>
              </a:extLst>
            </p:cNvPr>
            <p:cNvSpPr txBox="1">
              <a:spLocks noChangeArrowheads="1"/>
            </p:cNvSpPr>
            <p:nvPr/>
          </p:nvSpPr>
          <p:spPr bwMode="auto">
            <a:xfrm>
              <a:off x="1056269" y="2217202"/>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kDa</a:t>
              </a:r>
              <a:endParaRPr lang="en-US" altLang="en-US" sz="1299" dirty="0">
                <a:solidFill>
                  <a:srgbClr val="000000"/>
                </a:solidFill>
              </a:endParaRPr>
            </a:p>
          </p:txBody>
        </p:sp>
      </p:grpSp>
      <p:grpSp>
        <p:nvGrpSpPr>
          <p:cNvPr id="25" name="Group 24">
            <a:extLst>
              <a:ext uri="{FF2B5EF4-FFF2-40B4-BE49-F238E27FC236}">
                <a16:creationId xmlns:a16="http://schemas.microsoft.com/office/drawing/2014/main" id="{85AC889D-BA63-4E5F-8269-5481D62255AB}"/>
              </a:ext>
            </a:extLst>
          </p:cNvPr>
          <p:cNvGrpSpPr/>
          <p:nvPr/>
        </p:nvGrpSpPr>
        <p:grpSpPr>
          <a:xfrm>
            <a:off x="5734540" y="3596952"/>
            <a:ext cx="1630764" cy="749583"/>
            <a:chOff x="3720927" y="2225720"/>
            <a:chExt cx="824421" cy="692338"/>
          </a:xfrm>
        </p:grpSpPr>
        <p:sp>
          <p:nvSpPr>
            <p:cNvPr id="26" name="TextBox 14">
              <a:extLst>
                <a:ext uri="{FF2B5EF4-FFF2-40B4-BE49-F238E27FC236}">
                  <a16:creationId xmlns:a16="http://schemas.microsoft.com/office/drawing/2014/main" id="{74E60019-D739-49D2-9ADF-959D1ED6C208}"/>
                </a:ext>
              </a:extLst>
            </p:cNvPr>
            <p:cNvSpPr txBox="1">
              <a:spLocks noChangeArrowheads="1"/>
            </p:cNvSpPr>
            <p:nvPr/>
          </p:nvSpPr>
          <p:spPr bwMode="auto">
            <a:xfrm>
              <a:off x="3722544" y="2225720"/>
              <a:ext cx="822804" cy="2699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Cstf2t 64kDa</a:t>
              </a:r>
            </a:p>
          </p:txBody>
        </p:sp>
        <p:sp>
          <p:nvSpPr>
            <p:cNvPr id="28" name="TextBox 13">
              <a:extLst>
                <a:ext uri="{FF2B5EF4-FFF2-40B4-BE49-F238E27FC236}">
                  <a16:creationId xmlns:a16="http://schemas.microsoft.com/office/drawing/2014/main" id="{88AF072C-AB15-48CB-AC5E-BC4E1F8F1ED7}"/>
                </a:ext>
              </a:extLst>
            </p:cNvPr>
            <p:cNvSpPr txBox="1">
              <a:spLocks noChangeArrowheads="1"/>
            </p:cNvSpPr>
            <p:nvPr/>
          </p:nvSpPr>
          <p:spPr bwMode="auto">
            <a:xfrm>
              <a:off x="3720927" y="2648911"/>
              <a:ext cx="700939" cy="269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t>β</a:t>
              </a:r>
              <a:r>
                <a:rPr lang="en-US" altLang="en-US" sz="1299" dirty="0"/>
                <a:t>-actin 42kDa</a:t>
              </a:r>
            </a:p>
          </p:txBody>
        </p:sp>
      </p:grpSp>
      <p:sp>
        <p:nvSpPr>
          <p:cNvPr id="30" name="TextBox 29">
            <a:extLst>
              <a:ext uri="{FF2B5EF4-FFF2-40B4-BE49-F238E27FC236}">
                <a16:creationId xmlns:a16="http://schemas.microsoft.com/office/drawing/2014/main" id="{D45E8919-BA32-40F3-AC04-BD68E173ECB6}"/>
              </a:ext>
            </a:extLst>
          </p:cNvPr>
          <p:cNvSpPr txBox="1"/>
          <p:nvPr/>
        </p:nvSpPr>
        <p:spPr>
          <a:xfrm>
            <a:off x="939451" y="8458477"/>
            <a:ext cx="613775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5 - Full blots corresponding to Figure 3E Cstf2t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rabbit anti-CSTF2T monoclonal antibody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3E.</a:t>
            </a:r>
            <a:endParaRPr lang="en-US" sz="1200" kern="1200" dirty="0">
              <a:effectLst/>
              <a:latin typeface="Times New Roman" panose="02020603050405020304" pitchFamily="18" charset="0"/>
              <a:cs typeface="Times New Roman" panose="02020603050405020304" pitchFamily="18" charset="0"/>
            </a:endParaRPr>
          </a:p>
        </p:txBody>
      </p:sp>
      <p:sp>
        <p:nvSpPr>
          <p:cNvPr id="31" name="Rectangle 30">
            <a:extLst>
              <a:ext uri="{FF2B5EF4-FFF2-40B4-BE49-F238E27FC236}">
                <a16:creationId xmlns:a16="http://schemas.microsoft.com/office/drawing/2014/main" id="{6A96258D-A092-4BA8-A632-B7CFB4ED94CC}"/>
              </a:ext>
            </a:extLst>
          </p:cNvPr>
          <p:cNvSpPr/>
          <p:nvPr/>
        </p:nvSpPr>
        <p:spPr>
          <a:xfrm>
            <a:off x="2304790" y="4096008"/>
            <a:ext cx="2906037" cy="31315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32" name="Rectangle 31">
            <a:extLst>
              <a:ext uri="{FF2B5EF4-FFF2-40B4-BE49-F238E27FC236}">
                <a16:creationId xmlns:a16="http://schemas.microsoft.com/office/drawing/2014/main" id="{4F02C9A2-15F8-4A0A-AC33-3C197476F876}"/>
              </a:ext>
            </a:extLst>
          </p:cNvPr>
          <p:cNvSpPr/>
          <p:nvPr/>
        </p:nvSpPr>
        <p:spPr>
          <a:xfrm>
            <a:off x="2317316" y="3607494"/>
            <a:ext cx="2893511" cy="30271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249031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10;&#10;Description automatically generated">
            <a:extLst>
              <a:ext uri="{FF2B5EF4-FFF2-40B4-BE49-F238E27FC236}">
                <a16:creationId xmlns:a16="http://schemas.microsoft.com/office/drawing/2014/main" id="{A8BB2EE5-4756-4492-B239-1488EF601A9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3174" y="3029160"/>
            <a:ext cx="5544385" cy="4350802"/>
          </a:xfrm>
          <a:prstGeom prst="rect">
            <a:avLst/>
          </a:prstGeom>
        </p:spPr>
      </p:pic>
      <p:grpSp>
        <p:nvGrpSpPr>
          <p:cNvPr id="4" name="Group 3">
            <a:extLst>
              <a:ext uri="{FF2B5EF4-FFF2-40B4-BE49-F238E27FC236}">
                <a16:creationId xmlns:a16="http://schemas.microsoft.com/office/drawing/2014/main" id="{A0482A0C-84B9-41FC-B5A3-DF1C6042ADB2}"/>
              </a:ext>
            </a:extLst>
          </p:cNvPr>
          <p:cNvGrpSpPr/>
          <p:nvPr/>
        </p:nvGrpSpPr>
        <p:grpSpPr>
          <a:xfrm>
            <a:off x="200417" y="2856025"/>
            <a:ext cx="809786" cy="4374327"/>
            <a:chOff x="1104285" y="1741213"/>
            <a:chExt cx="809786" cy="4374327"/>
          </a:xfrm>
        </p:grpSpPr>
        <p:sp>
          <p:nvSpPr>
            <p:cNvPr id="5" name="TextBox 4">
              <a:extLst>
                <a:ext uri="{FF2B5EF4-FFF2-40B4-BE49-F238E27FC236}">
                  <a16:creationId xmlns:a16="http://schemas.microsoft.com/office/drawing/2014/main" id="{1AF6F294-6C1B-4057-A4C6-56FA929DC5BA}"/>
                </a:ext>
              </a:extLst>
            </p:cNvPr>
            <p:cNvSpPr txBox="1">
              <a:spLocks noChangeArrowheads="1"/>
            </p:cNvSpPr>
            <p:nvPr/>
          </p:nvSpPr>
          <p:spPr bwMode="auto">
            <a:xfrm>
              <a:off x="1166915" y="380786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50</a:t>
              </a:r>
            </a:p>
          </p:txBody>
        </p:sp>
        <p:sp>
          <p:nvSpPr>
            <p:cNvPr id="6" name="TextBox 5">
              <a:extLst>
                <a:ext uri="{FF2B5EF4-FFF2-40B4-BE49-F238E27FC236}">
                  <a16:creationId xmlns:a16="http://schemas.microsoft.com/office/drawing/2014/main" id="{1D4AFCD0-D909-4392-9364-BF28288CC7A1}"/>
                </a:ext>
              </a:extLst>
            </p:cNvPr>
            <p:cNvSpPr txBox="1">
              <a:spLocks noChangeArrowheads="1"/>
            </p:cNvSpPr>
            <p:nvPr/>
          </p:nvSpPr>
          <p:spPr bwMode="auto">
            <a:xfrm>
              <a:off x="1191967" y="465287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37</a:t>
              </a:r>
            </a:p>
          </p:txBody>
        </p:sp>
        <p:sp>
          <p:nvSpPr>
            <p:cNvPr id="7" name="TextBox 7">
              <a:extLst>
                <a:ext uri="{FF2B5EF4-FFF2-40B4-BE49-F238E27FC236}">
                  <a16:creationId xmlns:a16="http://schemas.microsoft.com/office/drawing/2014/main" id="{59CEB8EA-BE04-4C39-BE1A-4327E85F0315}"/>
                </a:ext>
              </a:extLst>
            </p:cNvPr>
            <p:cNvSpPr txBox="1">
              <a:spLocks noChangeArrowheads="1"/>
            </p:cNvSpPr>
            <p:nvPr/>
          </p:nvSpPr>
          <p:spPr bwMode="auto">
            <a:xfrm>
              <a:off x="1166915" y="582328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5</a:t>
              </a:r>
            </a:p>
          </p:txBody>
        </p:sp>
        <p:sp>
          <p:nvSpPr>
            <p:cNvPr id="10" name="TextBox 4">
              <a:extLst>
                <a:ext uri="{FF2B5EF4-FFF2-40B4-BE49-F238E27FC236}">
                  <a16:creationId xmlns:a16="http://schemas.microsoft.com/office/drawing/2014/main" id="{3C3466D3-38C9-48B7-9524-007621BB828F}"/>
                </a:ext>
              </a:extLst>
            </p:cNvPr>
            <p:cNvSpPr txBox="1">
              <a:spLocks noChangeArrowheads="1"/>
            </p:cNvSpPr>
            <p:nvPr/>
          </p:nvSpPr>
          <p:spPr bwMode="auto">
            <a:xfrm>
              <a:off x="1141863" y="3016779"/>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75</a:t>
              </a:r>
            </a:p>
          </p:txBody>
        </p:sp>
        <p:sp>
          <p:nvSpPr>
            <p:cNvPr id="12" name="TextBox 4">
              <a:extLst>
                <a:ext uri="{FF2B5EF4-FFF2-40B4-BE49-F238E27FC236}">
                  <a16:creationId xmlns:a16="http://schemas.microsoft.com/office/drawing/2014/main" id="{664302CB-A117-4FA2-B658-495BAFE4A506}"/>
                </a:ext>
              </a:extLst>
            </p:cNvPr>
            <p:cNvSpPr txBox="1">
              <a:spLocks noChangeArrowheads="1"/>
            </p:cNvSpPr>
            <p:nvPr/>
          </p:nvSpPr>
          <p:spPr bwMode="auto">
            <a:xfrm>
              <a:off x="1104285" y="2304884"/>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0</a:t>
              </a:r>
            </a:p>
          </p:txBody>
        </p:sp>
        <p:sp>
          <p:nvSpPr>
            <p:cNvPr id="13" name="TextBox 4">
              <a:extLst>
                <a:ext uri="{FF2B5EF4-FFF2-40B4-BE49-F238E27FC236}">
                  <a16:creationId xmlns:a16="http://schemas.microsoft.com/office/drawing/2014/main" id="{05C18B95-2218-4A32-B0D6-392E2CCEDEC5}"/>
                </a:ext>
              </a:extLst>
            </p:cNvPr>
            <p:cNvSpPr txBox="1">
              <a:spLocks noChangeArrowheads="1"/>
            </p:cNvSpPr>
            <p:nvPr/>
          </p:nvSpPr>
          <p:spPr bwMode="auto">
            <a:xfrm>
              <a:off x="1104285" y="2645174"/>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00</a:t>
              </a:r>
            </a:p>
          </p:txBody>
        </p:sp>
        <p:sp>
          <p:nvSpPr>
            <p:cNvPr id="14" name="TextBox 4">
              <a:extLst>
                <a:ext uri="{FF2B5EF4-FFF2-40B4-BE49-F238E27FC236}">
                  <a16:creationId xmlns:a16="http://schemas.microsoft.com/office/drawing/2014/main" id="{E8EFA767-CD91-412A-A79C-38661298F3D6}"/>
                </a:ext>
              </a:extLst>
            </p:cNvPr>
            <p:cNvSpPr txBox="1">
              <a:spLocks noChangeArrowheads="1"/>
            </p:cNvSpPr>
            <p:nvPr/>
          </p:nvSpPr>
          <p:spPr bwMode="auto">
            <a:xfrm>
              <a:off x="1131425" y="1741213"/>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kDa</a:t>
              </a:r>
              <a:endParaRPr lang="en-US" altLang="en-US" sz="1299" dirty="0">
                <a:solidFill>
                  <a:srgbClr val="000000"/>
                </a:solidFill>
              </a:endParaRPr>
            </a:p>
          </p:txBody>
        </p:sp>
      </p:grpSp>
      <p:sp>
        <p:nvSpPr>
          <p:cNvPr id="16" name="TextBox 15">
            <a:extLst>
              <a:ext uri="{FF2B5EF4-FFF2-40B4-BE49-F238E27FC236}">
                <a16:creationId xmlns:a16="http://schemas.microsoft.com/office/drawing/2014/main" id="{69B608CF-9AAC-412E-A678-0CE34896CD62}"/>
              </a:ext>
            </a:extLst>
          </p:cNvPr>
          <p:cNvSpPr txBox="1"/>
          <p:nvPr/>
        </p:nvSpPr>
        <p:spPr>
          <a:xfrm rot="18305062">
            <a:off x="951980" y="2147379"/>
            <a:ext cx="1903956" cy="276999"/>
          </a:xfrm>
          <a:prstGeom prst="rect">
            <a:avLst/>
          </a:prstGeom>
          <a:noFill/>
        </p:spPr>
        <p:txBody>
          <a:bodyPr wrap="square" rtlCol="0">
            <a:spAutoFit/>
          </a:bodyPr>
          <a:lstStyle/>
          <a:p>
            <a:r>
              <a:rPr lang="en-US" sz="1200" dirty="0"/>
              <a:t>Protein Standard</a:t>
            </a:r>
            <a:endParaRPr lang="en-CA" sz="1200" dirty="0"/>
          </a:p>
        </p:txBody>
      </p:sp>
      <p:sp>
        <p:nvSpPr>
          <p:cNvPr id="17" name="TextBox 16">
            <a:extLst>
              <a:ext uri="{FF2B5EF4-FFF2-40B4-BE49-F238E27FC236}">
                <a16:creationId xmlns:a16="http://schemas.microsoft.com/office/drawing/2014/main" id="{61735AC7-8F98-44D8-864B-95B99E0B4307}"/>
              </a:ext>
            </a:extLst>
          </p:cNvPr>
          <p:cNvSpPr txBox="1"/>
          <p:nvPr/>
        </p:nvSpPr>
        <p:spPr>
          <a:xfrm rot="18305062">
            <a:off x="1442456" y="2067028"/>
            <a:ext cx="2105441" cy="276999"/>
          </a:xfrm>
          <a:prstGeom prst="rect">
            <a:avLst/>
          </a:prstGeom>
          <a:noFill/>
        </p:spPr>
        <p:txBody>
          <a:bodyPr wrap="square" rtlCol="0">
            <a:spAutoFit/>
          </a:bodyPr>
          <a:lstStyle/>
          <a:p>
            <a:r>
              <a:rPr lang="en-US" sz="1200" dirty="0"/>
              <a:t>Donor-1 Non-target siRNA</a:t>
            </a:r>
            <a:endParaRPr lang="en-CA" sz="1200" dirty="0"/>
          </a:p>
        </p:txBody>
      </p:sp>
      <p:sp>
        <p:nvSpPr>
          <p:cNvPr id="18" name="TextBox 17">
            <a:extLst>
              <a:ext uri="{FF2B5EF4-FFF2-40B4-BE49-F238E27FC236}">
                <a16:creationId xmlns:a16="http://schemas.microsoft.com/office/drawing/2014/main" id="{11D7F7FE-A51E-4FB2-96E9-449887321516}"/>
              </a:ext>
            </a:extLst>
          </p:cNvPr>
          <p:cNvSpPr txBox="1"/>
          <p:nvPr/>
        </p:nvSpPr>
        <p:spPr>
          <a:xfrm rot="18305062">
            <a:off x="2033675" y="2067680"/>
            <a:ext cx="2105441" cy="276999"/>
          </a:xfrm>
          <a:prstGeom prst="rect">
            <a:avLst/>
          </a:prstGeom>
          <a:noFill/>
        </p:spPr>
        <p:txBody>
          <a:bodyPr wrap="square" rtlCol="0">
            <a:spAutoFit/>
          </a:bodyPr>
          <a:lstStyle/>
          <a:p>
            <a:r>
              <a:rPr lang="en-US" sz="1200" dirty="0"/>
              <a:t>Donor-1 + ZNF484 siRNA</a:t>
            </a:r>
            <a:endParaRPr lang="en-CA" sz="1200" dirty="0"/>
          </a:p>
        </p:txBody>
      </p:sp>
      <p:sp>
        <p:nvSpPr>
          <p:cNvPr id="29" name="TextBox 28">
            <a:extLst>
              <a:ext uri="{FF2B5EF4-FFF2-40B4-BE49-F238E27FC236}">
                <a16:creationId xmlns:a16="http://schemas.microsoft.com/office/drawing/2014/main" id="{B18C1E08-0A08-4CF7-85C1-537521AEFC2B}"/>
              </a:ext>
            </a:extLst>
          </p:cNvPr>
          <p:cNvSpPr txBox="1"/>
          <p:nvPr/>
        </p:nvSpPr>
        <p:spPr>
          <a:xfrm rot="18305062">
            <a:off x="2624894" y="2067680"/>
            <a:ext cx="2105441" cy="276999"/>
          </a:xfrm>
          <a:prstGeom prst="rect">
            <a:avLst/>
          </a:prstGeom>
          <a:noFill/>
        </p:spPr>
        <p:txBody>
          <a:bodyPr wrap="square" rtlCol="0">
            <a:spAutoFit/>
          </a:bodyPr>
          <a:lstStyle/>
          <a:p>
            <a:r>
              <a:rPr lang="en-US" sz="1200" dirty="0"/>
              <a:t>Donor-2 Non-target siRNA</a:t>
            </a:r>
            <a:endParaRPr lang="en-CA" sz="1200" dirty="0"/>
          </a:p>
        </p:txBody>
      </p:sp>
      <p:sp>
        <p:nvSpPr>
          <p:cNvPr id="30" name="TextBox 29">
            <a:extLst>
              <a:ext uri="{FF2B5EF4-FFF2-40B4-BE49-F238E27FC236}">
                <a16:creationId xmlns:a16="http://schemas.microsoft.com/office/drawing/2014/main" id="{72DCE368-4FBB-4373-AF5C-6E2651607BF8}"/>
              </a:ext>
            </a:extLst>
          </p:cNvPr>
          <p:cNvSpPr txBox="1"/>
          <p:nvPr/>
        </p:nvSpPr>
        <p:spPr>
          <a:xfrm rot="18305062">
            <a:off x="3216113" y="2068332"/>
            <a:ext cx="2105441" cy="276999"/>
          </a:xfrm>
          <a:prstGeom prst="rect">
            <a:avLst/>
          </a:prstGeom>
          <a:noFill/>
        </p:spPr>
        <p:txBody>
          <a:bodyPr wrap="square" rtlCol="0">
            <a:spAutoFit/>
          </a:bodyPr>
          <a:lstStyle/>
          <a:p>
            <a:r>
              <a:rPr lang="en-US" sz="1200" dirty="0"/>
              <a:t>Donor-2 + ZNF484 siRNA</a:t>
            </a:r>
            <a:endParaRPr lang="en-CA" sz="1200" dirty="0"/>
          </a:p>
        </p:txBody>
      </p:sp>
      <p:sp>
        <p:nvSpPr>
          <p:cNvPr id="33" name="TextBox 32">
            <a:extLst>
              <a:ext uri="{FF2B5EF4-FFF2-40B4-BE49-F238E27FC236}">
                <a16:creationId xmlns:a16="http://schemas.microsoft.com/office/drawing/2014/main" id="{B47D4765-1B17-484A-9FFD-DE4B616B23CE}"/>
              </a:ext>
            </a:extLst>
          </p:cNvPr>
          <p:cNvSpPr txBox="1"/>
          <p:nvPr/>
        </p:nvSpPr>
        <p:spPr>
          <a:xfrm rot="18305062">
            <a:off x="3807332" y="2065960"/>
            <a:ext cx="2105441" cy="276999"/>
          </a:xfrm>
          <a:prstGeom prst="rect">
            <a:avLst/>
          </a:prstGeom>
          <a:noFill/>
        </p:spPr>
        <p:txBody>
          <a:bodyPr wrap="square" rtlCol="0">
            <a:spAutoFit/>
          </a:bodyPr>
          <a:lstStyle/>
          <a:p>
            <a:r>
              <a:rPr lang="en-US" sz="1200" dirty="0"/>
              <a:t>Donor-3 Non-target siRNA</a:t>
            </a:r>
            <a:endParaRPr lang="en-CA" sz="1200" dirty="0"/>
          </a:p>
        </p:txBody>
      </p:sp>
      <p:sp>
        <p:nvSpPr>
          <p:cNvPr id="34" name="TextBox 33">
            <a:extLst>
              <a:ext uri="{FF2B5EF4-FFF2-40B4-BE49-F238E27FC236}">
                <a16:creationId xmlns:a16="http://schemas.microsoft.com/office/drawing/2014/main" id="{FBC5777A-F4AC-451B-A00F-225C3910D434}"/>
              </a:ext>
            </a:extLst>
          </p:cNvPr>
          <p:cNvSpPr txBox="1"/>
          <p:nvPr/>
        </p:nvSpPr>
        <p:spPr>
          <a:xfrm rot="18305062">
            <a:off x="4398551" y="2066612"/>
            <a:ext cx="2105441" cy="276999"/>
          </a:xfrm>
          <a:prstGeom prst="rect">
            <a:avLst/>
          </a:prstGeom>
          <a:noFill/>
        </p:spPr>
        <p:txBody>
          <a:bodyPr wrap="square" rtlCol="0">
            <a:spAutoFit/>
          </a:bodyPr>
          <a:lstStyle/>
          <a:p>
            <a:r>
              <a:rPr lang="en-US" sz="1200" dirty="0"/>
              <a:t>Donor-3 + ZNF484 siRNA</a:t>
            </a:r>
            <a:endParaRPr lang="en-CA" sz="1200" dirty="0"/>
          </a:p>
        </p:txBody>
      </p:sp>
      <p:sp>
        <p:nvSpPr>
          <p:cNvPr id="35" name="TextBox 34">
            <a:extLst>
              <a:ext uri="{FF2B5EF4-FFF2-40B4-BE49-F238E27FC236}">
                <a16:creationId xmlns:a16="http://schemas.microsoft.com/office/drawing/2014/main" id="{FF2994C6-668A-45A2-BB4A-48D67BC194F1}"/>
              </a:ext>
            </a:extLst>
          </p:cNvPr>
          <p:cNvSpPr txBox="1"/>
          <p:nvPr/>
        </p:nvSpPr>
        <p:spPr>
          <a:xfrm rot="18305062">
            <a:off x="4989770" y="2056174"/>
            <a:ext cx="2105441" cy="276999"/>
          </a:xfrm>
          <a:prstGeom prst="rect">
            <a:avLst/>
          </a:prstGeom>
          <a:noFill/>
        </p:spPr>
        <p:txBody>
          <a:bodyPr wrap="square" rtlCol="0">
            <a:spAutoFit/>
          </a:bodyPr>
          <a:lstStyle/>
          <a:p>
            <a:r>
              <a:rPr lang="en-US" sz="1200" dirty="0"/>
              <a:t>Donor-4 + ZNF484 siRNA</a:t>
            </a:r>
            <a:endParaRPr lang="en-CA" sz="1200" dirty="0"/>
          </a:p>
        </p:txBody>
      </p:sp>
      <p:sp>
        <p:nvSpPr>
          <p:cNvPr id="38" name="TextBox 13">
            <a:extLst>
              <a:ext uri="{FF2B5EF4-FFF2-40B4-BE49-F238E27FC236}">
                <a16:creationId xmlns:a16="http://schemas.microsoft.com/office/drawing/2014/main" id="{BEFB24DB-990F-43D3-9FA4-490A456877BD}"/>
              </a:ext>
            </a:extLst>
          </p:cNvPr>
          <p:cNvSpPr txBox="1">
            <a:spLocks noChangeArrowheads="1"/>
          </p:cNvSpPr>
          <p:nvPr/>
        </p:nvSpPr>
        <p:spPr bwMode="auto">
          <a:xfrm>
            <a:off x="6203060" y="5365028"/>
            <a:ext cx="1281242"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t>β</a:t>
            </a:r>
            <a:r>
              <a:rPr lang="en-US" altLang="en-US" sz="1299" dirty="0"/>
              <a:t>-actin 42kDa</a:t>
            </a:r>
          </a:p>
        </p:txBody>
      </p:sp>
      <p:sp>
        <p:nvSpPr>
          <p:cNvPr id="39" name="TextBox 14">
            <a:extLst>
              <a:ext uri="{FF2B5EF4-FFF2-40B4-BE49-F238E27FC236}">
                <a16:creationId xmlns:a16="http://schemas.microsoft.com/office/drawing/2014/main" id="{72FF14CE-31C7-4BF6-A3AE-874E2826A9F2}"/>
              </a:ext>
            </a:extLst>
          </p:cNvPr>
          <p:cNvSpPr txBox="1">
            <a:spLocks noChangeArrowheads="1"/>
          </p:cNvSpPr>
          <p:nvPr/>
        </p:nvSpPr>
        <p:spPr bwMode="auto">
          <a:xfrm>
            <a:off x="6100176" y="4055211"/>
            <a:ext cx="1465546"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n-US" altLang="en-US" sz="1299" dirty="0">
                <a:solidFill>
                  <a:srgbClr val="000000"/>
                </a:solidFill>
              </a:rPr>
              <a:t>Znf484 98kDa</a:t>
            </a:r>
          </a:p>
        </p:txBody>
      </p:sp>
      <p:sp>
        <p:nvSpPr>
          <p:cNvPr id="40" name="TextBox 39">
            <a:extLst>
              <a:ext uri="{FF2B5EF4-FFF2-40B4-BE49-F238E27FC236}">
                <a16:creationId xmlns:a16="http://schemas.microsoft.com/office/drawing/2014/main" id="{7220B53F-4A71-4672-8807-23E68E6D2929}"/>
              </a:ext>
            </a:extLst>
          </p:cNvPr>
          <p:cNvSpPr txBox="1"/>
          <p:nvPr/>
        </p:nvSpPr>
        <p:spPr>
          <a:xfrm>
            <a:off x="425884" y="7594179"/>
            <a:ext cx="613775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6 - Full blots corresponding to Figure 3E Znf484 siRNA silencing without HIV infection.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anti-ZNF484 polyclonal antibody N-terminal end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3E.</a:t>
            </a:r>
            <a:endParaRPr lang="en-US" sz="1200" kern="1200" dirty="0">
              <a:effectLst/>
              <a:latin typeface="Times New Roman" panose="02020603050405020304" pitchFamily="18" charset="0"/>
              <a:cs typeface="Times New Roman" panose="02020603050405020304" pitchFamily="18" charset="0"/>
            </a:endParaRPr>
          </a:p>
        </p:txBody>
      </p:sp>
      <p:sp>
        <p:nvSpPr>
          <p:cNvPr id="41" name="Rectangle 40">
            <a:extLst>
              <a:ext uri="{FF2B5EF4-FFF2-40B4-BE49-F238E27FC236}">
                <a16:creationId xmlns:a16="http://schemas.microsoft.com/office/drawing/2014/main" id="{038BD4C1-37C5-441D-98D2-51FAAE5646B6}"/>
              </a:ext>
            </a:extLst>
          </p:cNvPr>
          <p:cNvSpPr/>
          <p:nvPr/>
        </p:nvSpPr>
        <p:spPr>
          <a:xfrm>
            <a:off x="1653436" y="5223349"/>
            <a:ext cx="1227551" cy="40083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42" name="Rectangle 41">
            <a:extLst>
              <a:ext uri="{FF2B5EF4-FFF2-40B4-BE49-F238E27FC236}">
                <a16:creationId xmlns:a16="http://schemas.microsoft.com/office/drawing/2014/main" id="{BF805D95-E515-4A59-ADD3-4F7C334CD83E}"/>
              </a:ext>
            </a:extLst>
          </p:cNvPr>
          <p:cNvSpPr/>
          <p:nvPr/>
        </p:nvSpPr>
        <p:spPr>
          <a:xfrm>
            <a:off x="1691014" y="4010411"/>
            <a:ext cx="1215025" cy="3507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21732314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5">
            <a:extLst>
              <a:ext uri="{FF2B5EF4-FFF2-40B4-BE49-F238E27FC236}">
                <a16:creationId xmlns:a16="http://schemas.microsoft.com/office/drawing/2014/main" id="{A571CEE4-C521-4D63-B611-984D56631D9D}"/>
              </a:ext>
            </a:extLst>
          </p:cNvPr>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bright="18000" contrast="35000"/>
                    </a14:imgEffect>
                  </a14:imgLayer>
                </a14:imgProps>
              </a:ext>
              <a:ext uri="{28A0092B-C50C-407E-A947-70E740481C1C}">
                <a14:useLocalDpi xmlns:a14="http://schemas.microsoft.com/office/drawing/2010/main" val="0"/>
              </a:ext>
            </a:extLst>
          </a:blip>
          <a:srcRect l="20688" t="26513" r="15607" b="15716"/>
          <a:stretch/>
        </p:blipFill>
        <p:spPr bwMode="auto">
          <a:xfrm>
            <a:off x="1207181" y="3071449"/>
            <a:ext cx="5221480" cy="503347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a:extLst>
              <a:ext uri="{FF2B5EF4-FFF2-40B4-BE49-F238E27FC236}">
                <a16:creationId xmlns:a16="http://schemas.microsoft.com/office/drawing/2014/main" id="{627943C9-6685-417A-981F-42B82F3F0DDF}"/>
              </a:ext>
            </a:extLst>
          </p:cNvPr>
          <p:cNvSpPr txBox="1"/>
          <p:nvPr/>
        </p:nvSpPr>
        <p:spPr>
          <a:xfrm>
            <a:off x="977028" y="8220485"/>
            <a:ext cx="613775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a:t>
            </a:r>
            <a:r>
              <a:rPr lang="en-CA" sz="1200" b="1" dirty="0">
                <a:latin typeface="Times New Roman" panose="02020603050405020304" pitchFamily="18" charset="0"/>
                <a:cs typeface="Times New Roman" panose="02020603050405020304" pitchFamily="18" charset="0"/>
              </a:rPr>
              <a:t>7</a:t>
            </a:r>
            <a:r>
              <a:rPr lang="en-CA" sz="1200" b="1" kern="1200" dirty="0">
                <a:effectLst/>
                <a:latin typeface="Times New Roman" panose="02020603050405020304" pitchFamily="18" charset="0"/>
                <a:cs typeface="Times New Roman" panose="02020603050405020304" pitchFamily="18" charset="0"/>
              </a:rPr>
              <a:t> - Full blots corresponding to Figure 3E Znf484 siRNA silencing with HIV-HSA infection.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anti-ZNF484 polyclonal antibody N-terminal end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3E.</a:t>
            </a:r>
            <a:endParaRPr lang="en-US" sz="1200" kern="1200" dirty="0">
              <a:effectLst/>
              <a:latin typeface="Times New Roman" panose="02020603050405020304" pitchFamily="18" charset="0"/>
              <a:cs typeface="Times New Roman" panose="02020603050405020304" pitchFamily="18" charset="0"/>
            </a:endParaRPr>
          </a:p>
        </p:txBody>
      </p:sp>
      <p:grpSp>
        <p:nvGrpSpPr>
          <p:cNvPr id="4" name="Group 3">
            <a:extLst>
              <a:ext uri="{FF2B5EF4-FFF2-40B4-BE49-F238E27FC236}">
                <a16:creationId xmlns:a16="http://schemas.microsoft.com/office/drawing/2014/main" id="{526B1F39-C014-4593-BBD1-0777D95D36F7}"/>
              </a:ext>
            </a:extLst>
          </p:cNvPr>
          <p:cNvGrpSpPr/>
          <p:nvPr/>
        </p:nvGrpSpPr>
        <p:grpSpPr>
          <a:xfrm>
            <a:off x="3256054" y="1175358"/>
            <a:ext cx="2094810" cy="2108595"/>
            <a:chOff x="2128711" y="214011"/>
            <a:chExt cx="2094810" cy="2108595"/>
          </a:xfrm>
        </p:grpSpPr>
        <p:sp>
          <p:nvSpPr>
            <p:cNvPr id="5" name="TextBox 4">
              <a:extLst>
                <a:ext uri="{FF2B5EF4-FFF2-40B4-BE49-F238E27FC236}">
                  <a16:creationId xmlns:a16="http://schemas.microsoft.com/office/drawing/2014/main" id="{450CBF0A-B779-4D3E-BFC5-500FD4AC8428}"/>
                </a:ext>
              </a:extLst>
            </p:cNvPr>
            <p:cNvSpPr txBox="1"/>
            <p:nvPr/>
          </p:nvSpPr>
          <p:spPr>
            <a:xfrm rot="18305062">
              <a:off x="1315233" y="1211085"/>
              <a:ext cx="1903956" cy="276999"/>
            </a:xfrm>
            <a:prstGeom prst="rect">
              <a:avLst/>
            </a:prstGeom>
            <a:noFill/>
          </p:spPr>
          <p:txBody>
            <a:bodyPr wrap="square" rtlCol="0">
              <a:spAutoFit/>
            </a:bodyPr>
            <a:lstStyle/>
            <a:p>
              <a:r>
                <a:rPr lang="en-US" sz="1200" dirty="0"/>
                <a:t>Protein Standard</a:t>
              </a:r>
              <a:endParaRPr lang="en-CA" sz="1200" dirty="0"/>
            </a:p>
          </p:txBody>
        </p:sp>
        <p:sp>
          <p:nvSpPr>
            <p:cNvPr id="6" name="TextBox 5">
              <a:extLst>
                <a:ext uri="{FF2B5EF4-FFF2-40B4-BE49-F238E27FC236}">
                  <a16:creationId xmlns:a16="http://schemas.microsoft.com/office/drawing/2014/main" id="{7C051762-4FEC-4577-AFF3-91C5DEB88EFA}"/>
                </a:ext>
              </a:extLst>
            </p:cNvPr>
            <p:cNvSpPr txBox="1"/>
            <p:nvPr/>
          </p:nvSpPr>
          <p:spPr>
            <a:xfrm rot="18305062">
              <a:off x="1820427" y="1130734"/>
              <a:ext cx="2105441" cy="276999"/>
            </a:xfrm>
            <a:prstGeom prst="rect">
              <a:avLst/>
            </a:prstGeom>
            <a:noFill/>
          </p:spPr>
          <p:txBody>
            <a:bodyPr wrap="square" rtlCol="0">
              <a:spAutoFit/>
            </a:bodyPr>
            <a:lstStyle/>
            <a:p>
              <a:r>
                <a:rPr lang="en-US" sz="1200" dirty="0"/>
                <a:t>Mock + Non-target siRNA</a:t>
              </a:r>
              <a:endParaRPr lang="en-CA" sz="1200" dirty="0"/>
            </a:p>
          </p:txBody>
        </p:sp>
        <p:sp>
          <p:nvSpPr>
            <p:cNvPr id="7" name="TextBox 6">
              <a:extLst>
                <a:ext uri="{FF2B5EF4-FFF2-40B4-BE49-F238E27FC236}">
                  <a16:creationId xmlns:a16="http://schemas.microsoft.com/office/drawing/2014/main" id="{E7B3EBDC-77BC-41F7-849F-5D89E38D87E9}"/>
                </a:ext>
              </a:extLst>
            </p:cNvPr>
            <p:cNvSpPr txBox="1"/>
            <p:nvPr/>
          </p:nvSpPr>
          <p:spPr>
            <a:xfrm rot="18305062">
              <a:off x="2426364" y="1128232"/>
              <a:ext cx="2105441" cy="276999"/>
            </a:xfrm>
            <a:prstGeom prst="rect">
              <a:avLst/>
            </a:prstGeom>
            <a:noFill/>
          </p:spPr>
          <p:txBody>
            <a:bodyPr wrap="square" rtlCol="0">
              <a:spAutoFit/>
            </a:bodyPr>
            <a:lstStyle/>
            <a:p>
              <a:r>
                <a:rPr lang="en-US" sz="1200" dirty="0"/>
                <a:t>HIV-HSA + Non-target siRNA</a:t>
              </a:r>
              <a:endParaRPr lang="en-CA" sz="1200" dirty="0"/>
            </a:p>
          </p:txBody>
        </p:sp>
        <p:sp>
          <p:nvSpPr>
            <p:cNvPr id="9" name="TextBox 8">
              <a:extLst>
                <a:ext uri="{FF2B5EF4-FFF2-40B4-BE49-F238E27FC236}">
                  <a16:creationId xmlns:a16="http://schemas.microsoft.com/office/drawing/2014/main" id="{A8F6CDD4-05CB-4B05-AB15-5B15A7D9C2C0}"/>
                </a:ext>
              </a:extLst>
            </p:cNvPr>
            <p:cNvSpPr txBox="1"/>
            <p:nvPr/>
          </p:nvSpPr>
          <p:spPr>
            <a:xfrm rot="18305062">
              <a:off x="3032301" y="1131386"/>
              <a:ext cx="2105441" cy="276999"/>
            </a:xfrm>
            <a:prstGeom prst="rect">
              <a:avLst/>
            </a:prstGeom>
            <a:noFill/>
          </p:spPr>
          <p:txBody>
            <a:bodyPr wrap="square" rtlCol="0">
              <a:spAutoFit/>
            </a:bodyPr>
            <a:lstStyle/>
            <a:p>
              <a:r>
                <a:rPr lang="en-US" sz="1200" dirty="0"/>
                <a:t>HIV-HSA + ZNF484 siRNA</a:t>
              </a:r>
              <a:endParaRPr lang="en-CA" sz="1200" dirty="0"/>
            </a:p>
          </p:txBody>
        </p:sp>
      </p:grpSp>
      <p:grpSp>
        <p:nvGrpSpPr>
          <p:cNvPr id="8" name="Group 7">
            <a:extLst>
              <a:ext uri="{FF2B5EF4-FFF2-40B4-BE49-F238E27FC236}">
                <a16:creationId xmlns:a16="http://schemas.microsoft.com/office/drawing/2014/main" id="{FA59C845-2D73-4E03-B2A8-7D609C19BA75}"/>
              </a:ext>
            </a:extLst>
          </p:cNvPr>
          <p:cNvGrpSpPr/>
          <p:nvPr/>
        </p:nvGrpSpPr>
        <p:grpSpPr>
          <a:xfrm>
            <a:off x="4910202" y="3541645"/>
            <a:ext cx="1465546" cy="750306"/>
            <a:chOff x="5148197" y="2251467"/>
            <a:chExt cx="1465546" cy="750306"/>
          </a:xfrm>
        </p:grpSpPr>
        <p:sp>
          <p:nvSpPr>
            <p:cNvPr id="10" name="TextBox 13">
              <a:extLst>
                <a:ext uri="{FF2B5EF4-FFF2-40B4-BE49-F238E27FC236}">
                  <a16:creationId xmlns:a16="http://schemas.microsoft.com/office/drawing/2014/main" id="{A606A06C-6A6F-4D76-8A94-A960154EE0EA}"/>
                </a:ext>
              </a:extLst>
            </p:cNvPr>
            <p:cNvSpPr txBox="1">
              <a:spLocks noChangeArrowheads="1"/>
            </p:cNvSpPr>
            <p:nvPr/>
          </p:nvSpPr>
          <p:spPr bwMode="auto">
            <a:xfrm>
              <a:off x="5238555" y="2709514"/>
              <a:ext cx="1281242"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solidFill>
                    <a:schemeClr val="bg1"/>
                  </a:solidFill>
                </a:rPr>
                <a:t>β</a:t>
              </a:r>
              <a:r>
                <a:rPr lang="en-US" altLang="en-US" sz="1299" dirty="0">
                  <a:solidFill>
                    <a:schemeClr val="bg1"/>
                  </a:solidFill>
                </a:rPr>
                <a:t>-actin 42kDa</a:t>
              </a:r>
            </a:p>
          </p:txBody>
        </p:sp>
        <p:sp>
          <p:nvSpPr>
            <p:cNvPr id="11" name="TextBox 14">
              <a:extLst>
                <a:ext uri="{FF2B5EF4-FFF2-40B4-BE49-F238E27FC236}">
                  <a16:creationId xmlns:a16="http://schemas.microsoft.com/office/drawing/2014/main" id="{35EFFB0D-A4CD-4E37-B402-278BAEE97E60}"/>
                </a:ext>
              </a:extLst>
            </p:cNvPr>
            <p:cNvSpPr txBox="1">
              <a:spLocks noChangeArrowheads="1"/>
            </p:cNvSpPr>
            <p:nvPr/>
          </p:nvSpPr>
          <p:spPr bwMode="auto">
            <a:xfrm>
              <a:off x="5148197" y="2251467"/>
              <a:ext cx="1465546"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0" fontAlgn="base" hangingPunct="0">
                <a:spcBef>
                  <a:spcPct val="0"/>
                </a:spcBef>
                <a:spcAft>
                  <a:spcPct val="0"/>
                </a:spcAft>
                <a:buNone/>
              </a:pPr>
              <a:r>
                <a:rPr lang="en-US" altLang="en-US" sz="1299" dirty="0">
                  <a:solidFill>
                    <a:schemeClr val="bg1"/>
                  </a:solidFill>
                </a:rPr>
                <a:t>Znf484 98kDa</a:t>
              </a:r>
            </a:p>
          </p:txBody>
        </p:sp>
      </p:grpSp>
      <p:grpSp>
        <p:nvGrpSpPr>
          <p:cNvPr id="2" name="Group 1">
            <a:extLst>
              <a:ext uri="{FF2B5EF4-FFF2-40B4-BE49-F238E27FC236}">
                <a16:creationId xmlns:a16="http://schemas.microsoft.com/office/drawing/2014/main" id="{5B79B87C-274A-4F31-87D8-07A926666406}"/>
              </a:ext>
            </a:extLst>
          </p:cNvPr>
          <p:cNvGrpSpPr/>
          <p:nvPr/>
        </p:nvGrpSpPr>
        <p:grpSpPr>
          <a:xfrm>
            <a:off x="2217106" y="3018864"/>
            <a:ext cx="734631" cy="3512125"/>
            <a:chOff x="1753644" y="1703634"/>
            <a:chExt cx="734631" cy="3512125"/>
          </a:xfrm>
        </p:grpSpPr>
        <p:sp>
          <p:nvSpPr>
            <p:cNvPr id="13" name="TextBox 12">
              <a:extLst>
                <a:ext uri="{FF2B5EF4-FFF2-40B4-BE49-F238E27FC236}">
                  <a16:creationId xmlns:a16="http://schemas.microsoft.com/office/drawing/2014/main" id="{8899516E-F47D-413D-A332-1E9357387760}"/>
                </a:ext>
              </a:extLst>
            </p:cNvPr>
            <p:cNvSpPr txBox="1">
              <a:spLocks noChangeArrowheads="1"/>
            </p:cNvSpPr>
            <p:nvPr/>
          </p:nvSpPr>
          <p:spPr bwMode="auto">
            <a:xfrm>
              <a:off x="1753644" y="255525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50</a:t>
              </a:r>
            </a:p>
          </p:txBody>
        </p:sp>
        <p:sp>
          <p:nvSpPr>
            <p:cNvPr id="14" name="TextBox 13">
              <a:extLst>
                <a:ext uri="{FF2B5EF4-FFF2-40B4-BE49-F238E27FC236}">
                  <a16:creationId xmlns:a16="http://schemas.microsoft.com/office/drawing/2014/main" id="{F6C369BC-6EED-4CDD-A671-EE4D4306C0F1}"/>
                </a:ext>
              </a:extLst>
            </p:cNvPr>
            <p:cNvSpPr txBox="1">
              <a:spLocks noChangeArrowheads="1"/>
            </p:cNvSpPr>
            <p:nvPr/>
          </p:nvSpPr>
          <p:spPr bwMode="auto">
            <a:xfrm>
              <a:off x="1753644" y="2911755"/>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37</a:t>
              </a:r>
            </a:p>
          </p:txBody>
        </p:sp>
        <p:sp>
          <p:nvSpPr>
            <p:cNvPr id="15" name="TextBox 7">
              <a:extLst>
                <a:ext uri="{FF2B5EF4-FFF2-40B4-BE49-F238E27FC236}">
                  <a16:creationId xmlns:a16="http://schemas.microsoft.com/office/drawing/2014/main" id="{9FF1C6AB-FE22-41BF-9538-77413A00B8E7}"/>
                </a:ext>
              </a:extLst>
            </p:cNvPr>
            <p:cNvSpPr txBox="1">
              <a:spLocks noChangeArrowheads="1"/>
            </p:cNvSpPr>
            <p:nvPr/>
          </p:nvSpPr>
          <p:spPr bwMode="auto">
            <a:xfrm>
              <a:off x="1766171" y="340575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5</a:t>
              </a:r>
            </a:p>
          </p:txBody>
        </p:sp>
        <p:sp>
          <p:nvSpPr>
            <p:cNvPr id="16" name="TextBox 4">
              <a:extLst>
                <a:ext uri="{FF2B5EF4-FFF2-40B4-BE49-F238E27FC236}">
                  <a16:creationId xmlns:a16="http://schemas.microsoft.com/office/drawing/2014/main" id="{FBFC9005-E8A3-43A7-A940-50871551F99E}"/>
                </a:ext>
              </a:extLst>
            </p:cNvPr>
            <p:cNvSpPr txBox="1">
              <a:spLocks noChangeArrowheads="1"/>
            </p:cNvSpPr>
            <p:nvPr/>
          </p:nvSpPr>
          <p:spPr bwMode="auto">
            <a:xfrm>
              <a:off x="1753644" y="2165008"/>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75</a:t>
              </a:r>
            </a:p>
          </p:txBody>
        </p:sp>
        <p:sp>
          <p:nvSpPr>
            <p:cNvPr id="18" name="TextBox 4">
              <a:extLst>
                <a:ext uri="{FF2B5EF4-FFF2-40B4-BE49-F238E27FC236}">
                  <a16:creationId xmlns:a16="http://schemas.microsoft.com/office/drawing/2014/main" id="{9AA93526-509F-4194-9050-01073673D0E0}"/>
                </a:ext>
              </a:extLst>
            </p:cNvPr>
            <p:cNvSpPr txBox="1">
              <a:spLocks noChangeArrowheads="1"/>
            </p:cNvSpPr>
            <p:nvPr/>
          </p:nvSpPr>
          <p:spPr bwMode="auto">
            <a:xfrm>
              <a:off x="1753644" y="1968767"/>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0</a:t>
              </a:r>
            </a:p>
          </p:txBody>
        </p:sp>
        <p:sp>
          <p:nvSpPr>
            <p:cNvPr id="19" name="TextBox 4">
              <a:extLst>
                <a:ext uri="{FF2B5EF4-FFF2-40B4-BE49-F238E27FC236}">
                  <a16:creationId xmlns:a16="http://schemas.microsoft.com/office/drawing/2014/main" id="{A83BA2BA-C55A-4CBF-B7B2-C446355F09FF}"/>
                </a:ext>
              </a:extLst>
            </p:cNvPr>
            <p:cNvSpPr txBox="1">
              <a:spLocks noChangeArrowheads="1"/>
            </p:cNvSpPr>
            <p:nvPr/>
          </p:nvSpPr>
          <p:spPr bwMode="auto">
            <a:xfrm>
              <a:off x="1753644" y="1703634"/>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chemeClr val="bg1"/>
                  </a:solidFill>
                </a:rPr>
                <a:t>kDa</a:t>
              </a:r>
              <a:endParaRPr lang="en-US" altLang="en-US" sz="1299" dirty="0">
                <a:solidFill>
                  <a:schemeClr val="bg1"/>
                </a:solidFill>
              </a:endParaRPr>
            </a:p>
          </p:txBody>
        </p:sp>
        <p:sp>
          <p:nvSpPr>
            <p:cNvPr id="20" name="TextBox 11">
              <a:extLst>
                <a:ext uri="{FF2B5EF4-FFF2-40B4-BE49-F238E27FC236}">
                  <a16:creationId xmlns:a16="http://schemas.microsoft.com/office/drawing/2014/main" id="{54C4587E-2F54-4F20-84F0-5B3E8C740858}"/>
                </a:ext>
              </a:extLst>
            </p:cNvPr>
            <p:cNvSpPr txBox="1">
              <a:spLocks noChangeArrowheads="1"/>
            </p:cNvSpPr>
            <p:nvPr/>
          </p:nvSpPr>
          <p:spPr bwMode="auto">
            <a:xfrm>
              <a:off x="1753644" y="4923500"/>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a:t>
              </a:r>
            </a:p>
          </p:txBody>
        </p:sp>
        <p:sp>
          <p:nvSpPr>
            <p:cNvPr id="21" name="TextBox 20">
              <a:extLst>
                <a:ext uri="{FF2B5EF4-FFF2-40B4-BE49-F238E27FC236}">
                  <a16:creationId xmlns:a16="http://schemas.microsoft.com/office/drawing/2014/main" id="{2FC11035-6157-48AE-A09A-23EE31DFB15C}"/>
                </a:ext>
              </a:extLst>
            </p:cNvPr>
            <p:cNvSpPr txBox="1">
              <a:spLocks noChangeArrowheads="1"/>
            </p:cNvSpPr>
            <p:nvPr/>
          </p:nvSpPr>
          <p:spPr bwMode="auto">
            <a:xfrm>
              <a:off x="1753644" y="4325601"/>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a:t>
              </a:r>
            </a:p>
          </p:txBody>
        </p:sp>
        <p:sp>
          <p:nvSpPr>
            <p:cNvPr id="22" name="TextBox 7">
              <a:extLst>
                <a:ext uri="{FF2B5EF4-FFF2-40B4-BE49-F238E27FC236}">
                  <a16:creationId xmlns:a16="http://schemas.microsoft.com/office/drawing/2014/main" id="{B13CB6E9-EBC4-4695-BBBB-F26CF22651E6}"/>
                </a:ext>
              </a:extLst>
            </p:cNvPr>
            <p:cNvSpPr txBox="1">
              <a:spLocks noChangeArrowheads="1"/>
            </p:cNvSpPr>
            <p:nvPr/>
          </p:nvSpPr>
          <p:spPr bwMode="auto">
            <a:xfrm>
              <a:off x="1766171" y="3778161"/>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0</a:t>
              </a:r>
            </a:p>
          </p:txBody>
        </p:sp>
      </p:grpSp>
      <p:sp>
        <p:nvSpPr>
          <p:cNvPr id="28" name="Rectangle 27">
            <a:extLst>
              <a:ext uri="{FF2B5EF4-FFF2-40B4-BE49-F238E27FC236}">
                <a16:creationId xmlns:a16="http://schemas.microsoft.com/office/drawing/2014/main" id="{6A11280C-4F58-4CDD-8985-AB8E6DEF8980}"/>
              </a:ext>
            </a:extLst>
          </p:cNvPr>
          <p:cNvSpPr/>
          <p:nvPr/>
        </p:nvSpPr>
        <p:spPr>
          <a:xfrm>
            <a:off x="3281819" y="3983273"/>
            <a:ext cx="1766170" cy="33820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9" name="Rectangle 28">
            <a:extLst>
              <a:ext uri="{FF2B5EF4-FFF2-40B4-BE49-F238E27FC236}">
                <a16:creationId xmlns:a16="http://schemas.microsoft.com/office/drawing/2014/main" id="{6E35AEE7-D84A-4EC5-8D5B-8B49FD62023A}"/>
              </a:ext>
            </a:extLst>
          </p:cNvPr>
          <p:cNvSpPr/>
          <p:nvPr/>
        </p:nvSpPr>
        <p:spPr>
          <a:xfrm>
            <a:off x="3281819" y="3482236"/>
            <a:ext cx="1741118" cy="31523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17721528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DDC36C8-E00F-46F7-9501-2DD2798B8DCA}"/>
              </a:ext>
            </a:extLst>
          </p:cNvPr>
          <p:cNvSpPr txBox="1"/>
          <p:nvPr/>
        </p:nvSpPr>
        <p:spPr>
          <a:xfrm>
            <a:off x="926924" y="7556605"/>
            <a:ext cx="623796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8 - Full blots corresponding to Figure 6B Ndufa11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Anti-NDUFA11 polyclonal antibody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 6B</a:t>
            </a:r>
            <a:r>
              <a:rPr lang="en-US" sz="1200" dirty="0">
                <a:latin typeface="Times New Roman" panose="02020603050405020304" pitchFamily="18" charset="0"/>
                <a:cs typeface="Times New Roman" panose="02020603050405020304" pitchFamily="18" charset="0"/>
              </a:rPr>
              <a:t>.</a:t>
            </a:r>
            <a:endParaRPr lang="en-US" sz="1200" kern="1200" dirty="0">
              <a:effectLst/>
              <a:latin typeface="Times New Roman" panose="02020603050405020304" pitchFamily="18" charset="0"/>
              <a:cs typeface="Times New Roman" panose="02020603050405020304" pitchFamily="18" charset="0"/>
            </a:endParaRPr>
          </a:p>
        </p:txBody>
      </p:sp>
      <p:pic>
        <p:nvPicPr>
          <p:cNvPr id="4" name="Picture 3" descr="A picture containing text, white&#10;&#10;Description automatically generated">
            <a:extLst>
              <a:ext uri="{FF2B5EF4-FFF2-40B4-BE49-F238E27FC236}">
                <a16:creationId xmlns:a16="http://schemas.microsoft.com/office/drawing/2014/main" id="{9DB19AAE-2E04-4986-B8B4-65F7AE005B5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06604" y="3160514"/>
            <a:ext cx="5325306" cy="4254892"/>
          </a:xfrm>
          <a:prstGeom prst="rect">
            <a:avLst/>
          </a:prstGeom>
        </p:spPr>
      </p:pic>
      <p:grpSp>
        <p:nvGrpSpPr>
          <p:cNvPr id="11" name="Group 10">
            <a:extLst>
              <a:ext uri="{FF2B5EF4-FFF2-40B4-BE49-F238E27FC236}">
                <a16:creationId xmlns:a16="http://schemas.microsoft.com/office/drawing/2014/main" id="{141B4968-AA10-4A59-B6FE-410FFD4EA1CB}"/>
              </a:ext>
            </a:extLst>
          </p:cNvPr>
          <p:cNvGrpSpPr/>
          <p:nvPr/>
        </p:nvGrpSpPr>
        <p:grpSpPr>
          <a:xfrm>
            <a:off x="1966587" y="3557484"/>
            <a:ext cx="795171" cy="2588550"/>
            <a:chOff x="1056269" y="2217202"/>
            <a:chExt cx="795171" cy="2588550"/>
          </a:xfrm>
        </p:grpSpPr>
        <p:sp>
          <p:nvSpPr>
            <p:cNvPr id="12" name="TextBox 4">
              <a:extLst>
                <a:ext uri="{FF2B5EF4-FFF2-40B4-BE49-F238E27FC236}">
                  <a16:creationId xmlns:a16="http://schemas.microsoft.com/office/drawing/2014/main" id="{C61D9882-14A6-4411-9277-FBEB76A117D0}"/>
                </a:ext>
              </a:extLst>
            </p:cNvPr>
            <p:cNvSpPr txBox="1">
              <a:spLocks noChangeArrowheads="1"/>
            </p:cNvSpPr>
            <p:nvPr/>
          </p:nvSpPr>
          <p:spPr bwMode="auto">
            <a:xfrm>
              <a:off x="1104285" y="2918514"/>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50</a:t>
              </a:r>
            </a:p>
          </p:txBody>
        </p:sp>
        <p:sp>
          <p:nvSpPr>
            <p:cNvPr id="13" name="TextBox 5">
              <a:extLst>
                <a:ext uri="{FF2B5EF4-FFF2-40B4-BE49-F238E27FC236}">
                  <a16:creationId xmlns:a16="http://schemas.microsoft.com/office/drawing/2014/main" id="{CBE86A7F-F30F-4F26-94C0-E1D46A73DFD8}"/>
                </a:ext>
              </a:extLst>
            </p:cNvPr>
            <p:cNvSpPr txBox="1">
              <a:spLocks noChangeArrowheads="1"/>
            </p:cNvSpPr>
            <p:nvPr/>
          </p:nvSpPr>
          <p:spPr bwMode="auto">
            <a:xfrm>
              <a:off x="1116811" y="3400273"/>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37</a:t>
              </a:r>
            </a:p>
          </p:txBody>
        </p:sp>
        <p:sp>
          <p:nvSpPr>
            <p:cNvPr id="14" name="TextBox 7">
              <a:extLst>
                <a:ext uri="{FF2B5EF4-FFF2-40B4-BE49-F238E27FC236}">
                  <a16:creationId xmlns:a16="http://schemas.microsoft.com/office/drawing/2014/main" id="{89409F9F-E46D-4981-9439-08382A75594F}"/>
                </a:ext>
              </a:extLst>
            </p:cNvPr>
            <p:cNvSpPr txBox="1">
              <a:spLocks noChangeArrowheads="1"/>
            </p:cNvSpPr>
            <p:nvPr/>
          </p:nvSpPr>
          <p:spPr bwMode="auto">
            <a:xfrm>
              <a:off x="1116812" y="3743961"/>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5</a:t>
              </a:r>
            </a:p>
          </p:txBody>
        </p:sp>
        <p:sp>
          <p:nvSpPr>
            <p:cNvPr id="16" name="TextBox 15">
              <a:extLst>
                <a:ext uri="{FF2B5EF4-FFF2-40B4-BE49-F238E27FC236}">
                  <a16:creationId xmlns:a16="http://schemas.microsoft.com/office/drawing/2014/main" id="{4E941C80-3CE6-4784-BBAB-73C60ABB184C}"/>
                </a:ext>
              </a:extLst>
            </p:cNvPr>
            <p:cNvSpPr txBox="1">
              <a:spLocks noChangeArrowheads="1"/>
            </p:cNvSpPr>
            <p:nvPr/>
          </p:nvSpPr>
          <p:spPr bwMode="auto">
            <a:xfrm>
              <a:off x="1116811" y="4513493"/>
              <a:ext cx="546031"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15</a:t>
              </a:r>
            </a:p>
          </p:txBody>
        </p:sp>
        <p:sp>
          <p:nvSpPr>
            <p:cNvPr id="18" name="TextBox 7">
              <a:extLst>
                <a:ext uri="{FF2B5EF4-FFF2-40B4-BE49-F238E27FC236}">
                  <a16:creationId xmlns:a16="http://schemas.microsoft.com/office/drawing/2014/main" id="{9E5C0F92-4FCC-44F5-8FAF-CDBF560753AF}"/>
                </a:ext>
              </a:extLst>
            </p:cNvPr>
            <p:cNvSpPr txBox="1">
              <a:spLocks noChangeArrowheads="1"/>
            </p:cNvSpPr>
            <p:nvPr/>
          </p:nvSpPr>
          <p:spPr bwMode="auto">
            <a:xfrm>
              <a:off x="1129337" y="4066261"/>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20</a:t>
              </a:r>
            </a:p>
          </p:txBody>
        </p:sp>
        <p:sp>
          <p:nvSpPr>
            <p:cNvPr id="21" name="TextBox 4">
              <a:extLst>
                <a:ext uri="{FF2B5EF4-FFF2-40B4-BE49-F238E27FC236}">
                  <a16:creationId xmlns:a16="http://schemas.microsoft.com/office/drawing/2014/main" id="{E6538EFA-7F08-4EA9-A6F1-C218FEF49087}"/>
                </a:ext>
              </a:extLst>
            </p:cNvPr>
            <p:cNvSpPr txBox="1">
              <a:spLocks noChangeArrowheads="1"/>
            </p:cNvSpPr>
            <p:nvPr/>
          </p:nvSpPr>
          <p:spPr bwMode="auto">
            <a:xfrm>
              <a:off x="1056269" y="2217202"/>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kDa</a:t>
              </a:r>
              <a:endParaRPr lang="en-US" altLang="en-US" sz="1299" dirty="0">
                <a:solidFill>
                  <a:srgbClr val="000000"/>
                </a:solidFill>
              </a:endParaRPr>
            </a:p>
          </p:txBody>
        </p:sp>
      </p:grpSp>
      <p:sp>
        <p:nvSpPr>
          <p:cNvPr id="22" name="TextBox 14">
            <a:extLst>
              <a:ext uri="{FF2B5EF4-FFF2-40B4-BE49-F238E27FC236}">
                <a16:creationId xmlns:a16="http://schemas.microsoft.com/office/drawing/2014/main" id="{FF164BD7-51D2-411D-9006-FF480847CE6A}"/>
              </a:ext>
            </a:extLst>
          </p:cNvPr>
          <p:cNvSpPr txBox="1">
            <a:spLocks noChangeArrowheads="1"/>
          </p:cNvSpPr>
          <p:nvPr/>
        </p:nvSpPr>
        <p:spPr bwMode="auto">
          <a:xfrm>
            <a:off x="5329109" y="5734444"/>
            <a:ext cx="908853"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rgbClr val="000000"/>
                </a:solidFill>
              </a:rPr>
              <a:t>Ndufa11</a:t>
            </a:r>
          </a:p>
          <a:p>
            <a:pPr eaLnBrk="0" fontAlgn="base" hangingPunct="0">
              <a:spcBef>
                <a:spcPct val="0"/>
              </a:spcBef>
              <a:spcAft>
                <a:spcPct val="0"/>
              </a:spcAft>
              <a:buNone/>
            </a:pPr>
            <a:r>
              <a:rPr lang="en-US" altLang="en-US" sz="1299" dirty="0">
                <a:solidFill>
                  <a:srgbClr val="000000"/>
                </a:solidFill>
              </a:rPr>
              <a:t>14.7kDa</a:t>
            </a:r>
          </a:p>
        </p:txBody>
      </p:sp>
      <p:sp>
        <p:nvSpPr>
          <p:cNvPr id="23" name="TextBox 13">
            <a:extLst>
              <a:ext uri="{FF2B5EF4-FFF2-40B4-BE49-F238E27FC236}">
                <a16:creationId xmlns:a16="http://schemas.microsoft.com/office/drawing/2014/main" id="{34532B50-85C1-4F81-B91B-8C054C37D343}"/>
              </a:ext>
            </a:extLst>
          </p:cNvPr>
          <p:cNvSpPr txBox="1">
            <a:spLocks noChangeArrowheads="1"/>
          </p:cNvSpPr>
          <p:nvPr/>
        </p:nvSpPr>
        <p:spPr bwMode="auto">
          <a:xfrm>
            <a:off x="5306625" y="4507761"/>
            <a:ext cx="758893"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t>β</a:t>
            </a:r>
            <a:r>
              <a:rPr lang="en-US" altLang="en-US" sz="1299" dirty="0"/>
              <a:t>-actin</a:t>
            </a:r>
          </a:p>
          <a:p>
            <a:pPr eaLnBrk="0" fontAlgn="base" hangingPunct="0">
              <a:spcBef>
                <a:spcPct val="0"/>
              </a:spcBef>
              <a:spcAft>
                <a:spcPct val="0"/>
              </a:spcAft>
              <a:buNone/>
            </a:pPr>
            <a:r>
              <a:rPr lang="en-US" altLang="en-US" sz="1299" dirty="0"/>
              <a:t>42kDa</a:t>
            </a:r>
          </a:p>
        </p:txBody>
      </p:sp>
      <p:sp>
        <p:nvSpPr>
          <p:cNvPr id="24" name="Rectangle 23">
            <a:extLst>
              <a:ext uri="{FF2B5EF4-FFF2-40B4-BE49-F238E27FC236}">
                <a16:creationId xmlns:a16="http://schemas.microsoft.com/office/drawing/2014/main" id="{AE966E9C-5841-4B25-B4C2-E204DD0064D5}"/>
              </a:ext>
            </a:extLst>
          </p:cNvPr>
          <p:cNvSpPr/>
          <p:nvPr/>
        </p:nvSpPr>
        <p:spPr>
          <a:xfrm>
            <a:off x="2818356" y="5699336"/>
            <a:ext cx="1315233" cy="33820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5" name="Rectangle 24">
            <a:extLst>
              <a:ext uri="{FF2B5EF4-FFF2-40B4-BE49-F238E27FC236}">
                <a16:creationId xmlns:a16="http://schemas.microsoft.com/office/drawing/2014/main" id="{40158B20-83DE-4193-A1CF-1DBFA13649F6}"/>
              </a:ext>
            </a:extLst>
          </p:cNvPr>
          <p:cNvSpPr/>
          <p:nvPr/>
        </p:nvSpPr>
        <p:spPr>
          <a:xfrm>
            <a:off x="2830882" y="4546945"/>
            <a:ext cx="1302707" cy="31523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grpSp>
        <p:nvGrpSpPr>
          <p:cNvPr id="34" name="Group 33">
            <a:extLst>
              <a:ext uri="{FF2B5EF4-FFF2-40B4-BE49-F238E27FC236}">
                <a16:creationId xmlns:a16="http://schemas.microsoft.com/office/drawing/2014/main" id="{D720D761-D8C3-4992-9163-537313A65F82}"/>
              </a:ext>
            </a:extLst>
          </p:cNvPr>
          <p:cNvGrpSpPr/>
          <p:nvPr/>
        </p:nvGrpSpPr>
        <p:grpSpPr>
          <a:xfrm>
            <a:off x="3018059" y="1250516"/>
            <a:ext cx="2590907" cy="2132993"/>
            <a:chOff x="3018059" y="60546"/>
            <a:chExt cx="2590907" cy="2132993"/>
          </a:xfrm>
        </p:grpSpPr>
        <p:sp>
          <p:nvSpPr>
            <p:cNvPr id="27" name="TextBox 26">
              <a:extLst>
                <a:ext uri="{FF2B5EF4-FFF2-40B4-BE49-F238E27FC236}">
                  <a16:creationId xmlns:a16="http://schemas.microsoft.com/office/drawing/2014/main" id="{9F590C0A-7889-404C-B35B-07869ADB6A50}"/>
                </a:ext>
              </a:extLst>
            </p:cNvPr>
            <p:cNvSpPr txBox="1"/>
            <p:nvPr/>
          </p:nvSpPr>
          <p:spPr>
            <a:xfrm rot="18305062">
              <a:off x="2204581" y="1082670"/>
              <a:ext cx="1903956" cy="276999"/>
            </a:xfrm>
            <a:prstGeom prst="rect">
              <a:avLst/>
            </a:prstGeom>
            <a:noFill/>
          </p:spPr>
          <p:txBody>
            <a:bodyPr wrap="square" rtlCol="0">
              <a:spAutoFit/>
            </a:bodyPr>
            <a:lstStyle/>
            <a:p>
              <a:r>
                <a:rPr lang="en-US" sz="1200" dirty="0"/>
                <a:t>Protein Standard</a:t>
              </a:r>
              <a:endParaRPr lang="en-CA" sz="1200" dirty="0"/>
            </a:p>
          </p:txBody>
        </p:sp>
        <p:sp>
          <p:nvSpPr>
            <p:cNvPr id="28" name="TextBox 27">
              <a:extLst>
                <a:ext uri="{FF2B5EF4-FFF2-40B4-BE49-F238E27FC236}">
                  <a16:creationId xmlns:a16="http://schemas.microsoft.com/office/drawing/2014/main" id="{02C3E9E9-D2CF-4BE7-9F8C-EBE9DDE33A97}"/>
                </a:ext>
              </a:extLst>
            </p:cNvPr>
            <p:cNvSpPr txBox="1"/>
            <p:nvPr/>
          </p:nvSpPr>
          <p:spPr>
            <a:xfrm rot="18305062">
              <a:off x="2682315" y="1002319"/>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29" name="TextBox 28">
              <a:extLst>
                <a:ext uri="{FF2B5EF4-FFF2-40B4-BE49-F238E27FC236}">
                  <a16:creationId xmlns:a16="http://schemas.microsoft.com/office/drawing/2014/main" id="{169A13F7-BF2F-4D78-A78D-6DD913E8ABCE}"/>
                </a:ext>
              </a:extLst>
            </p:cNvPr>
            <p:cNvSpPr txBox="1"/>
            <p:nvPr/>
          </p:nvSpPr>
          <p:spPr>
            <a:xfrm rot="18305062">
              <a:off x="3260792" y="974767"/>
              <a:ext cx="2105441" cy="276999"/>
            </a:xfrm>
            <a:prstGeom prst="rect">
              <a:avLst/>
            </a:prstGeom>
            <a:noFill/>
          </p:spPr>
          <p:txBody>
            <a:bodyPr wrap="square" rtlCol="0">
              <a:spAutoFit/>
            </a:bodyPr>
            <a:lstStyle/>
            <a:p>
              <a:r>
                <a:rPr lang="en-US" sz="1200" dirty="0"/>
                <a:t>Donor-1 + NDUFA11 siRNA</a:t>
              </a:r>
              <a:endParaRPr lang="en-CA" sz="1200" dirty="0"/>
            </a:p>
          </p:txBody>
        </p:sp>
        <p:sp>
          <p:nvSpPr>
            <p:cNvPr id="32" name="TextBox 31">
              <a:extLst>
                <a:ext uri="{FF2B5EF4-FFF2-40B4-BE49-F238E27FC236}">
                  <a16:creationId xmlns:a16="http://schemas.microsoft.com/office/drawing/2014/main" id="{A6AF8001-5684-4918-906B-B84839C0A950}"/>
                </a:ext>
              </a:extLst>
            </p:cNvPr>
            <p:cNvSpPr txBox="1"/>
            <p:nvPr/>
          </p:nvSpPr>
          <p:spPr>
            <a:xfrm rot="18305062">
              <a:off x="3839269" y="979355"/>
              <a:ext cx="2105441" cy="276999"/>
            </a:xfrm>
            <a:prstGeom prst="rect">
              <a:avLst/>
            </a:prstGeom>
            <a:noFill/>
          </p:spPr>
          <p:txBody>
            <a:bodyPr wrap="square" rtlCol="0">
              <a:spAutoFit/>
            </a:bodyPr>
            <a:lstStyle/>
            <a:p>
              <a:r>
                <a:rPr lang="en-US" sz="1200" dirty="0"/>
                <a:t>Donor-2 + Non-target siRNA</a:t>
              </a:r>
              <a:endParaRPr lang="en-CA" sz="1200" dirty="0"/>
            </a:p>
          </p:txBody>
        </p:sp>
        <p:sp>
          <p:nvSpPr>
            <p:cNvPr id="33" name="TextBox 32">
              <a:extLst>
                <a:ext uri="{FF2B5EF4-FFF2-40B4-BE49-F238E27FC236}">
                  <a16:creationId xmlns:a16="http://schemas.microsoft.com/office/drawing/2014/main" id="{6EEF4BCE-3881-4BFC-804A-549759B3FBBF}"/>
                </a:ext>
              </a:extLst>
            </p:cNvPr>
            <p:cNvSpPr txBox="1"/>
            <p:nvPr/>
          </p:nvSpPr>
          <p:spPr>
            <a:xfrm rot="18305062">
              <a:off x="4417746" y="976852"/>
              <a:ext cx="2105441" cy="276999"/>
            </a:xfrm>
            <a:prstGeom prst="rect">
              <a:avLst/>
            </a:prstGeom>
            <a:noFill/>
          </p:spPr>
          <p:txBody>
            <a:bodyPr wrap="square" rtlCol="0">
              <a:spAutoFit/>
            </a:bodyPr>
            <a:lstStyle/>
            <a:p>
              <a:r>
                <a:rPr lang="en-US" sz="1200" dirty="0"/>
                <a:t>Donor-2 + NDUFA11 siRNA</a:t>
              </a:r>
              <a:endParaRPr lang="en-CA" sz="1200" dirty="0"/>
            </a:p>
          </p:txBody>
        </p:sp>
      </p:grpSp>
    </p:spTree>
    <p:extLst>
      <p:ext uri="{BB962C8B-B14F-4D97-AF65-F5344CB8AC3E}">
        <p14:creationId xmlns:p14="http://schemas.microsoft.com/office/powerpoint/2010/main" val="18217960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 name="Picture 25">
            <a:extLst>
              <a:ext uri="{FF2B5EF4-FFF2-40B4-BE49-F238E27FC236}">
                <a16:creationId xmlns:a16="http://schemas.microsoft.com/office/drawing/2014/main" id="{4122D89A-29E4-4866-AFBB-D95915AED6A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45315" y="2551196"/>
            <a:ext cx="5180746" cy="5871511"/>
          </a:xfrm>
          <a:prstGeom prst="rect">
            <a:avLst/>
          </a:prstGeom>
        </p:spPr>
      </p:pic>
      <p:grpSp>
        <p:nvGrpSpPr>
          <p:cNvPr id="28" name="Group 27">
            <a:extLst>
              <a:ext uri="{FF2B5EF4-FFF2-40B4-BE49-F238E27FC236}">
                <a16:creationId xmlns:a16="http://schemas.microsoft.com/office/drawing/2014/main" id="{6837091D-B36F-4AA4-9A63-C99CDACCD68B}"/>
              </a:ext>
            </a:extLst>
          </p:cNvPr>
          <p:cNvGrpSpPr/>
          <p:nvPr/>
        </p:nvGrpSpPr>
        <p:grpSpPr>
          <a:xfrm>
            <a:off x="1402916" y="2217196"/>
            <a:ext cx="839014" cy="4503762"/>
            <a:chOff x="1402916" y="2217196"/>
            <a:chExt cx="839014" cy="4503762"/>
          </a:xfrm>
        </p:grpSpPr>
        <p:sp>
          <p:nvSpPr>
            <p:cNvPr id="5" name="TextBox 4">
              <a:extLst>
                <a:ext uri="{FF2B5EF4-FFF2-40B4-BE49-F238E27FC236}">
                  <a16:creationId xmlns:a16="http://schemas.microsoft.com/office/drawing/2014/main" id="{7AA2C46C-A044-4322-B883-9DEEFA7520FB}"/>
                </a:ext>
              </a:extLst>
            </p:cNvPr>
            <p:cNvSpPr txBox="1">
              <a:spLocks noChangeArrowheads="1"/>
            </p:cNvSpPr>
            <p:nvPr/>
          </p:nvSpPr>
          <p:spPr bwMode="auto">
            <a:xfrm>
              <a:off x="1503124" y="377027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50</a:t>
              </a:r>
            </a:p>
          </p:txBody>
        </p:sp>
        <p:sp>
          <p:nvSpPr>
            <p:cNvPr id="6" name="TextBox 5">
              <a:extLst>
                <a:ext uri="{FF2B5EF4-FFF2-40B4-BE49-F238E27FC236}">
                  <a16:creationId xmlns:a16="http://schemas.microsoft.com/office/drawing/2014/main" id="{72727A91-6947-4042-A121-DB7E8F862D53}"/>
                </a:ext>
              </a:extLst>
            </p:cNvPr>
            <p:cNvSpPr txBox="1">
              <a:spLocks noChangeArrowheads="1"/>
            </p:cNvSpPr>
            <p:nvPr/>
          </p:nvSpPr>
          <p:spPr bwMode="auto">
            <a:xfrm>
              <a:off x="1490597" y="4214456"/>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37</a:t>
              </a:r>
            </a:p>
          </p:txBody>
        </p:sp>
        <p:sp>
          <p:nvSpPr>
            <p:cNvPr id="7" name="TextBox 7">
              <a:extLst>
                <a:ext uri="{FF2B5EF4-FFF2-40B4-BE49-F238E27FC236}">
                  <a16:creationId xmlns:a16="http://schemas.microsoft.com/office/drawing/2014/main" id="{AB34E1AA-E761-429E-980E-968971F34514}"/>
                </a:ext>
              </a:extLst>
            </p:cNvPr>
            <p:cNvSpPr txBox="1">
              <a:spLocks noChangeArrowheads="1"/>
            </p:cNvSpPr>
            <p:nvPr/>
          </p:nvSpPr>
          <p:spPr bwMode="auto">
            <a:xfrm>
              <a:off x="1503124" y="5059187"/>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5</a:t>
              </a:r>
            </a:p>
          </p:txBody>
        </p:sp>
        <p:sp>
          <p:nvSpPr>
            <p:cNvPr id="8" name="TextBox 4">
              <a:extLst>
                <a:ext uri="{FF2B5EF4-FFF2-40B4-BE49-F238E27FC236}">
                  <a16:creationId xmlns:a16="http://schemas.microsoft.com/office/drawing/2014/main" id="{F0114DAC-1C89-4D95-BF49-B26F8F0C18C2}"/>
                </a:ext>
              </a:extLst>
            </p:cNvPr>
            <p:cNvSpPr txBox="1">
              <a:spLocks noChangeArrowheads="1"/>
            </p:cNvSpPr>
            <p:nvPr/>
          </p:nvSpPr>
          <p:spPr bwMode="auto">
            <a:xfrm>
              <a:off x="1478073" y="3267292"/>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75</a:t>
              </a:r>
            </a:p>
          </p:txBody>
        </p:sp>
        <p:sp>
          <p:nvSpPr>
            <p:cNvPr id="9" name="TextBox 4">
              <a:extLst>
                <a:ext uri="{FF2B5EF4-FFF2-40B4-BE49-F238E27FC236}">
                  <a16:creationId xmlns:a16="http://schemas.microsoft.com/office/drawing/2014/main" id="{2161B6B5-1F9B-44E1-AE0D-85D1C81B09EC}"/>
                </a:ext>
              </a:extLst>
            </p:cNvPr>
            <p:cNvSpPr txBox="1">
              <a:spLocks noChangeArrowheads="1"/>
            </p:cNvSpPr>
            <p:nvPr/>
          </p:nvSpPr>
          <p:spPr bwMode="auto">
            <a:xfrm>
              <a:off x="1402916" y="2818444"/>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0</a:t>
              </a:r>
            </a:p>
          </p:txBody>
        </p:sp>
        <p:sp>
          <p:nvSpPr>
            <p:cNvPr id="10" name="TextBox 4">
              <a:extLst>
                <a:ext uri="{FF2B5EF4-FFF2-40B4-BE49-F238E27FC236}">
                  <a16:creationId xmlns:a16="http://schemas.microsoft.com/office/drawing/2014/main" id="{5C9868BD-E3A2-4A9B-9FB5-223883157DE7}"/>
                </a:ext>
              </a:extLst>
            </p:cNvPr>
            <p:cNvSpPr txBox="1">
              <a:spLocks noChangeArrowheads="1"/>
            </p:cNvSpPr>
            <p:nvPr/>
          </p:nvSpPr>
          <p:spPr bwMode="auto">
            <a:xfrm>
              <a:off x="1402916" y="3033475"/>
              <a:ext cx="722103"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0</a:t>
              </a:r>
            </a:p>
          </p:txBody>
        </p:sp>
        <p:sp>
          <p:nvSpPr>
            <p:cNvPr id="11" name="TextBox 4">
              <a:extLst>
                <a:ext uri="{FF2B5EF4-FFF2-40B4-BE49-F238E27FC236}">
                  <a16:creationId xmlns:a16="http://schemas.microsoft.com/office/drawing/2014/main" id="{DFD23B46-D6C5-497A-AD52-0C91482CE90A}"/>
                </a:ext>
              </a:extLst>
            </p:cNvPr>
            <p:cNvSpPr txBox="1">
              <a:spLocks noChangeArrowheads="1"/>
            </p:cNvSpPr>
            <p:nvPr/>
          </p:nvSpPr>
          <p:spPr bwMode="auto">
            <a:xfrm>
              <a:off x="1405004" y="2217196"/>
              <a:ext cx="509485"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t>kDa</a:t>
              </a:r>
              <a:endParaRPr lang="en-US" altLang="en-US" sz="1299" dirty="0"/>
            </a:p>
          </p:txBody>
        </p:sp>
        <p:sp>
          <p:nvSpPr>
            <p:cNvPr id="12" name="TextBox 7">
              <a:extLst>
                <a:ext uri="{FF2B5EF4-FFF2-40B4-BE49-F238E27FC236}">
                  <a16:creationId xmlns:a16="http://schemas.microsoft.com/office/drawing/2014/main" id="{ADC61AFF-EDA0-40C3-95BF-1289BD2DCA80}"/>
                </a:ext>
              </a:extLst>
            </p:cNvPr>
            <p:cNvSpPr txBox="1">
              <a:spLocks noChangeArrowheads="1"/>
            </p:cNvSpPr>
            <p:nvPr/>
          </p:nvSpPr>
          <p:spPr bwMode="auto">
            <a:xfrm>
              <a:off x="1505211" y="6125988"/>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5</a:t>
              </a:r>
            </a:p>
          </p:txBody>
        </p:sp>
        <p:sp>
          <p:nvSpPr>
            <p:cNvPr id="13" name="TextBox 7">
              <a:extLst>
                <a:ext uri="{FF2B5EF4-FFF2-40B4-BE49-F238E27FC236}">
                  <a16:creationId xmlns:a16="http://schemas.microsoft.com/office/drawing/2014/main" id="{3C9F54FF-8BA5-4143-86DD-974BB7A4B7FD}"/>
                </a:ext>
              </a:extLst>
            </p:cNvPr>
            <p:cNvSpPr txBox="1">
              <a:spLocks noChangeArrowheads="1"/>
            </p:cNvSpPr>
            <p:nvPr/>
          </p:nvSpPr>
          <p:spPr bwMode="auto">
            <a:xfrm>
              <a:off x="1517737" y="5524738"/>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20</a:t>
              </a:r>
            </a:p>
          </p:txBody>
        </p:sp>
        <p:sp>
          <p:nvSpPr>
            <p:cNvPr id="14" name="TextBox 7">
              <a:extLst>
                <a:ext uri="{FF2B5EF4-FFF2-40B4-BE49-F238E27FC236}">
                  <a16:creationId xmlns:a16="http://schemas.microsoft.com/office/drawing/2014/main" id="{246EF169-BF36-495F-9EB0-06DB1DC2CEBC}"/>
                </a:ext>
              </a:extLst>
            </p:cNvPr>
            <p:cNvSpPr txBox="1">
              <a:spLocks noChangeArrowheads="1"/>
            </p:cNvSpPr>
            <p:nvPr/>
          </p:nvSpPr>
          <p:spPr bwMode="auto">
            <a:xfrm>
              <a:off x="1519826" y="6428699"/>
              <a:ext cx="722104" cy="29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a:solidFill>
                    <a:schemeClr val="bg1"/>
                  </a:solidFill>
                </a:rPr>
                <a:t>10</a:t>
              </a:r>
            </a:p>
          </p:txBody>
        </p:sp>
      </p:grpSp>
      <p:sp>
        <p:nvSpPr>
          <p:cNvPr id="15" name="TextBox 14">
            <a:extLst>
              <a:ext uri="{FF2B5EF4-FFF2-40B4-BE49-F238E27FC236}">
                <a16:creationId xmlns:a16="http://schemas.microsoft.com/office/drawing/2014/main" id="{5DC67747-ACD7-458C-B2AD-B6827C1F385C}"/>
              </a:ext>
            </a:extLst>
          </p:cNvPr>
          <p:cNvSpPr txBox="1">
            <a:spLocks noChangeArrowheads="1"/>
          </p:cNvSpPr>
          <p:nvPr/>
        </p:nvSpPr>
        <p:spPr bwMode="auto">
          <a:xfrm>
            <a:off x="5396147" y="3236537"/>
            <a:ext cx="890836"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n-US" altLang="en-US" sz="1299" dirty="0" err="1">
                <a:solidFill>
                  <a:srgbClr val="000000"/>
                </a:solidFill>
              </a:rPr>
              <a:t>Sdha</a:t>
            </a:r>
            <a:endParaRPr lang="en-US" altLang="en-US" sz="1299" dirty="0">
              <a:solidFill>
                <a:srgbClr val="000000"/>
              </a:solidFill>
            </a:endParaRPr>
          </a:p>
          <a:p>
            <a:pPr eaLnBrk="0" fontAlgn="base" hangingPunct="0">
              <a:spcBef>
                <a:spcPct val="0"/>
              </a:spcBef>
              <a:spcAft>
                <a:spcPct val="0"/>
              </a:spcAft>
              <a:buNone/>
            </a:pPr>
            <a:r>
              <a:rPr lang="en-US" altLang="en-US" sz="1299" dirty="0">
                <a:solidFill>
                  <a:srgbClr val="000000"/>
                </a:solidFill>
              </a:rPr>
              <a:t>72.7kDa</a:t>
            </a:r>
          </a:p>
        </p:txBody>
      </p:sp>
      <p:sp>
        <p:nvSpPr>
          <p:cNvPr id="16" name="TextBox 13">
            <a:extLst>
              <a:ext uri="{FF2B5EF4-FFF2-40B4-BE49-F238E27FC236}">
                <a16:creationId xmlns:a16="http://schemas.microsoft.com/office/drawing/2014/main" id="{8E6ACC51-C26E-478D-A127-0F7BC57607E5}"/>
              </a:ext>
            </a:extLst>
          </p:cNvPr>
          <p:cNvSpPr txBox="1">
            <a:spLocks noChangeArrowheads="1"/>
          </p:cNvSpPr>
          <p:nvPr/>
        </p:nvSpPr>
        <p:spPr bwMode="auto">
          <a:xfrm>
            <a:off x="5375208" y="3809428"/>
            <a:ext cx="758894" cy="4921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0" fontAlgn="base" hangingPunct="0">
              <a:spcBef>
                <a:spcPct val="0"/>
              </a:spcBef>
              <a:spcAft>
                <a:spcPct val="0"/>
              </a:spcAft>
              <a:buNone/>
            </a:pPr>
            <a:r>
              <a:rPr lang="el-GR" altLang="en-US" sz="1299" dirty="0"/>
              <a:t>β</a:t>
            </a:r>
            <a:r>
              <a:rPr lang="en-US" altLang="en-US" sz="1299" dirty="0"/>
              <a:t>-actin</a:t>
            </a:r>
          </a:p>
          <a:p>
            <a:pPr eaLnBrk="0" fontAlgn="base" hangingPunct="0">
              <a:spcBef>
                <a:spcPct val="0"/>
              </a:spcBef>
              <a:spcAft>
                <a:spcPct val="0"/>
              </a:spcAft>
              <a:buNone/>
            </a:pPr>
            <a:r>
              <a:rPr lang="en-US" altLang="en-US" sz="1299" dirty="0"/>
              <a:t>42kDa</a:t>
            </a:r>
          </a:p>
        </p:txBody>
      </p:sp>
      <p:grpSp>
        <p:nvGrpSpPr>
          <p:cNvPr id="17" name="Group 16">
            <a:extLst>
              <a:ext uri="{FF2B5EF4-FFF2-40B4-BE49-F238E27FC236}">
                <a16:creationId xmlns:a16="http://schemas.microsoft.com/office/drawing/2014/main" id="{B64A4DA6-2F08-4791-BBDE-72B0CE3C8148}"/>
              </a:ext>
            </a:extLst>
          </p:cNvPr>
          <p:cNvGrpSpPr/>
          <p:nvPr/>
        </p:nvGrpSpPr>
        <p:grpSpPr>
          <a:xfrm>
            <a:off x="2780065" y="616276"/>
            <a:ext cx="2914305" cy="2165984"/>
            <a:chOff x="3018059" y="27555"/>
            <a:chExt cx="2914305" cy="2165984"/>
          </a:xfrm>
        </p:grpSpPr>
        <p:sp>
          <p:nvSpPr>
            <p:cNvPr id="18" name="TextBox 17">
              <a:extLst>
                <a:ext uri="{FF2B5EF4-FFF2-40B4-BE49-F238E27FC236}">
                  <a16:creationId xmlns:a16="http://schemas.microsoft.com/office/drawing/2014/main" id="{52F8CCAA-8B98-4736-BAC9-5DDFCB4872D2}"/>
                </a:ext>
              </a:extLst>
            </p:cNvPr>
            <p:cNvSpPr txBox="1"/>
            <p:nvPr/>
          </p:nvSpPr>
          <p:spPr>
            <a:xfrm rot="18305062">
              <a:off x="2204581" y="1082670"/>
              <a:ext cx="1903956" cy="276999"/>
            </a:xfrm>
            <a:prstGeom prst="rect">
              <a:avLst/>
            </a:prstGeom>
            <a:noFill/>
          </p:spPr>
          <p:txBody>
            <a:bodyPr wrap="square" rtlCol="0">
              <a:spAutoFit/>
            </a:bodyPr>
            <a:lstStyle/>
            <a:p>
              <a:r>
                <a:rPr lang="en-US" sz="1200" dirty="0"/>
                <a:t>Protein Standard</a:t>
              </a:r>
              <a:endParaRPr lang="en-CA" sz="1200" dirty="0"/>
            </a:p>
          </p:txBody>
        </p:sp>
        <p:sp>
          <p:nvSpPr>
            <p:cNvPr id="19" name="TextBox 18">
              <a:extLst>
                <a:ext uri="{FF2B5EF4-FFF2-40B4-BE49-F238E27FC236}">
                  <a16:creationId xmlns:a16="http://schemas.microsoft.com/office/drawing/2014/main" id="{50A859B4-B2A8-499B-BCBE-0549C0BC1865}"/>
                </a:ext>
              </a:extLst>
            </p:cNvPr>
            <p:cNvSpPr txBox="1"/>
            <p:nvPr/>
          </p:nvSpPr>
          <p:spPr>
            <a:xfrm rot="18305062">
              <a:off x="2982940" y="1002319"/>
              <a:ext cx="2105441" cy="276999"/>
            </a:xfrm>
            <a:prstGeom prst="rect">
              <a:avLst/>
            </a:prstGeom>
            <a:noFill/>
          </p:spPr>
          <p:txBody>
            <a:bodyPr wrap="square" rtlCol="0">
              <a:spAutoFit/>
            </a:bodyPr>
            <a:lstStyle/>
            <a:p>
              <a:r>
                <a:rPr lang="en-US" sz="1200" dirty="0"/>
                <a:t>Donor-1 + Non-target siRNA</a:t>
              </a:r>
              <a:endParaRPr lang="en-CA" sz="1200" dirty="0"/>
            </a:p>
          </p:txBody>
        </p:sp>
        <p:sp>
          <p:nvSpPr>
            <p:cNvPr id="20" name="TextBox 19">
              <a:extLst>
                <a:ext uri="{FF2B5EF4-FFF2-40B4-BE49-F238E27FC236}">
                  <a16:creationId xmlns:a16="http://schemas.microsoft.com/office/drawing/2014/main" id="{6EBC1FD8-8DF3-4548-B6F8-9EDCF19CCD8C}"/>
                </a:ext>
              </a:extLst>
            </p:cNvPr>
            <p:cNvSpPr txBox="1"/>
            <p:nvPr/>
          </p:nvSpPr>
          <p:spPr>
            <a:xfrm rot="18305062">
              <a:off x="3862042" y="974767"/>
              <a:ext cx="2105441" cy="276999"/>
            </a:xfrm>
            <a:prstGeom prst="rect">
              <a:avLst/>
            </a:prstGeom>
            <a:noFill/>
          </p:spPr>
          <p:txBody>
            <a:bodyPr wrap="square" rtlCol="0">
              <a:spAutoFit/>
            </a:bodyPr>
            <a:lstStyle/>
            <a:p>
              <a:r>
                <a:rPr lang="en-US" sz="1200" dirty="0"/>
                <a:t>Donor-1 + SDHA siRNA</a:t>
              </a:r>
              <a:endParaRPr lang="en-CA" sz="1200" dirty="0"/>
            </a:p>
          </p:txBody>
        </p:sp>
        <p:sp>
          <p:nvSpPr>
            <p:cNvPr id="21" name="TextBox 20">
              <a:extLst>
                <a:ext uri="{FF2B5EF4-FFF2-40B4-BE49-F238E27FC236}">
                  <a16:creationId xmlns:a16="http://schemas.microsoft.com/office/drawing/2014/main" id="{5E742EDE-2FD0-441E-8BA5-0B6C2EE700FF}"/>
                </a:ext>
              </a:extLst>
            </p:cNvPr>
            <p:cNvSpPr txBox="1"/>
            <p:nvPr/>
          </p:nvSpPr>
          <p:spPr>
            <a:xfrm rot="18305062">
              <a:off x="4741144" y="941776"/>
              <a:ext cx="2105441" cy="276999"/>
            </a:xfrm>
            <a:prstGeom prst="rect">
              <a:avLst/>
            </a:prstGeom>
            <a:noFill/>
          </p:spPr>
          <p:txBody>
            <a:bodyPr wrap="square" rtlCol="0">
              <a:spAutoFit/>
            </a:bodyPr>
            <a:lstStyle/>
            <a:p>
              <a:r>
                <a:rPr lang="en-US" sz="1200" dirty="0"/>
                <a:t>Donor-2 + Non-target siRNA</a:t>
              </a:r>
              <a:endParaRPr lang="en-CA" sz="1200" dirty="0"/>
            </a:p>
          </p:txBody>
        </p:sp>
      </p:grpSp>
      <p:sp>
        <p:nvSpPr>
          <p:cNvPr id="23" name="Rectangle 22">
            <a:extLst>
              <a:ext uri="{FF2B5EF4-FFF2-40B4-BE49-F238E27FC236}">
                <a16:creationId xmlns:a16="http://schemas.microsoft.com/office/drawing/2014/main" id="{B88F499C-2F5E-4E77-9A69-ED606D7CE37F}"/>
              </a:ext>
            </a:extLst>
          </p:cNvPr>
          <p:cNvSpPr/>
          <p:nvPr/>
        </p:nvSpPr>
        <p:spPr>
          <a:xfrm>
            <a:off x="2981195" y="4008320"/>
            <a:ext cx="1628384" cy="33820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4" name="Rectangle 23">
            <a:extLst>
              <a:ext uri="{FF2B5EF4-FFF2-40B4-BE49-F238E27FC236}">
                <a16:creationId xmlns:a16="http://schemas.microsoft.com/office/drawing/2014/main" id="{894C239C-5CA3-41EF-A1C5-558BD39311D7}"/>
              </a:ext>
            </a:extLst>
          </p:cNvPr>
          <p:cNvSpPr/>
          <p:nvPr/>
        </p:nvSpPr>
        <p:spPr>
          <a:xfrm>
            <a:off x="2968669" y="3369496"/>
            <a:ext cx="1628384" cy="31523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7" name="TextBox 26">
            <a:extLst>
              <a:ext uri="{FF2B5EF4-FFF2-40B4-BE49-F238E27FC236}">
                <a16:creationId xmlns:a16="http://schemas.microsoft.com/office/drawing/2014/main" id="{EAA81835-A83F-4EF4-96D8-684DAEADB838}"/>
              </a:ext>
            </a:extLst>
          </p:cNvPr>
          <p:cNvSpPr txBox="1"/>
          <p:nvPr/>
        </p:nvSpPr>
        <p:spPr>
          <a:xfrm>
            <a:off x="751561" y="8483528"/>
            <a:ext cx="6237964" cy="830997"/>
          </a:xfrm>
          <a:prstGeom prst="rect">
            <a:avLst/>
          </a:prstGeom>
          <a:noFill/>
        </p:spPr>
        <p:txBody>
          <a:bodyPr wrap="square">
            <a:spAutoFit/>
          </a:bodyPr>
          <a:lstStyle/>
          <a:p>
            <a:r>
              <a:rPr lang="en-CA" sz="1200" b="1" kern="1200" dirty="0">
                <a:effectLst/>
                <a:latin typeface="Times New Roman" panose="02020603050405020304" pitchFamily="18" charset="0"/>
                <a:cs typeface="Times New Roman" panose="02020603050405020304" pitchFamily="18" charset="0"/>
              </a:rPr>
              <a:t>Supplementary Figure 9 - Full blots corresponding to Figure 6B </a:t>
            </a:r>
            <a:r>
              <a:rPr lang="en-CA" sz="1200" b="1" kern="1200" dirty="0" err="1">
                <a:effectLst/>
                <a:latin typeface="Times New Roman" panose="02020603050405020304" pitchFamily="18" charset="0"/>
                <a:cs typeface="Times New Roman" panose="02020603050405020304" pitchFamily="18" charset="0"/>
              </a:rPr>
              <a:t>Sdha</a:t>
            </a:r>
            <a:r>
              <a:rPr lang="en-CA" sz="1200" b="1" kern="1200" dirty="0">
                <a:effectLst/>
                <a:latin typeface="Times New Roman" panose="02020603050405020304" pitchFamily="18" charset="0"/>
                <a:cs typeface="Times New Roman" panose="02020603050405020304" pitchFamily="18" charset="0"/>
              </a:rPr>
              <a:t> siRNA silencing.  </a:t>
            </a:r>
            <a:r>
              <a:rPr lang="en-CA" sz="1200" kern="1200" dirty="0">
                <a:effectLst/>
                <a:latin typeface="Times New Roman" panose="02020603050405020304" pitchFamily="18" charset="0"/>
                <a:cs typeface="Times New Roman" panose="02020603050405020304" pitchFamily="18" charset="0"/>
              </a:rPr>
              <a:t>PVDF membranes was blotted with </a:t>
            </a:r>
            <a:r>
              <a:rPr lang="en-US" sz="1200" dirty="0">
                <a:effectLst/>
                <a:latin typeface="Times New Roman" panose="02020603050405020304" pitchFamily="18" charset="0"/>
                <a:ea typeface="SimSun" panose="02010600030101010101" pitchFamily="2" charset="-122"/>
              </a:rPr>
              <a:t>Anti-SDHA polyclonal antibody </a:t>
            </a:r>
            <a:r>
              <a:rPr lang="en-US" sz="1200" kern="1200" dirty="0">
                <a:effectLst/>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rabbit anti-β-actin (13E5) monoclonal antibody simultaneously. The rectangles depict the approximative area used in the manuscript Fig. 6B.</a:t>
            </a:r>
            <a:endParaRPr lang="en-US" sz="1200" kern="12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41065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7</TotalTime>
  <Words>1394</Words>
  <Application>Microsoft Office PowerPoint</Application>
  <PresentationFormat>Custom</PresentationFormat>
  <Paragraphs>243</Paragraphs>
  <Slides>14</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4</vt:i4>
      </vt:variant>
    </vt:vector>
  </HeadingPairs>
  <TitlesOfParts>
    <vt:vector size="20" baseType="lpstr">
      <vt:lpstr>Arial</vt:lpstr>
      <vt:lpstr>Calibri</vt:lpstr>
      <vt:lpstr>Calibri Light</vt:lpstr>
      <vt:lpstr>Times New Roman</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 Dong</dc:creator>
  <cp:lastModifiedBy>Simon Dong</cp:lastModifiedBy>
  <cp:revision>20</cp:revision>
  <dcterms:created xsi:type="dcterms:W3CDTF">2021-05-20T00:05:35Z</dcterms:created>
  <dcterms:modified xsi:type="dcterms:W3CDTF">2021-06-29T15:37:09Z</dcterms:modified>
</cp:coreProperties>
</file>